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3.xml" ContentType="application/vnd.openxmlformats-officedocument.presentationml.notesSlide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notesSlides/notesSlide4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748" r:id="rId2"/>
    <p:sldId id="746" r:id="rId3"/>
    <p:sldId id="749" r:id="rId4"/>
    <p:sldId id="745" r:id="rId5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2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B5BE83C-7560-4F98-9470-99AAEA62643D}" v="2" dt="2021-08-17T16:01:31.89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84" autoAdjust="0"/>
    <p:restoredTop sz="75932" autoAdjust="0"/>
  </p:normalViewPr>
  <p:slideViewPr>
    <p:cSldViewPr snapToGrid="0">
      <p:cViewPr varScale="1">
        <p:scale>
          <a:sx n="55" d="100"/>
          <a:sy n="55" d="100"/>
        </p:scale>
        <p:origin x="90" y="6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6BD44C91-1E07-4C76-A038-9B12972016B7}" type="doc">
      <dgm:prSet loTypeId="urn:microsoft.com/office/officeart/2005/8/layout/orgChart1" loCatId="hierarchy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GB"/>
        </a:p>
      </dgm:t>
    </dgm:pt>
    <dgm:pt modelId="{AE8828E0-C571-4F8A-9003-C6EADEAC1B46}">
      <dgm:prSet phldrT="[テキスト]"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AED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6</a:t>
          </a:r>
        </a:p>
      </dgm:t>
    </dgm:pt>
    <dgm:pt modelId="{250AB9AA-6031-496F-B7F1-6F0DB8F8D34D}" type="parTrans" cxnId="{8A04F2E9-B3C3-477D-81C1-C4C55D06F5AC}">
      <dgm:prSet/>
      <dgm:spPr/>
      <dgm:t>
        <a:bodyPr/>
        <a:lstStyle/>
        <a:p>
          <a:endParaRPr lang="en-GB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23EE6B3-9394-4A9C-BC80-CD2D7E190BEE}" type="sibTrans" cxnId="{8A04F2E9-B3C3-477D-81C1-C4C55D06F5AC}">
      <dgm:prSet/>
      <dgm:spPr/>
      <dgm:t>
        <a:bodyPr/>
        <a:lstStyle/>
        <a:p>
          <a:endParaRPr lang="en-GB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E83BC88-359D-47C4-9BBC-5EFD9E609921}">
      <dgm:prSet phldrT="[テキスト]"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ilateral frontal lesions (+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1</a:t>
          </a:r>
        </a:p>
      </dgm:t>
    </dgm:pt>
    <dgm:pt modelId="{349DFFB7-BC3E-496C-9A61-DB19C5510C78}" type="parTrans" cxnId="{A90AE4A2-BCC2-473B-8C01-9C25A61576FD}">
      <dgm:prSet/>
      <dgm:spPr>
        <a:ln w="38100">
          <a:solidFill>
            <a:schemeClr val="tx1"/>
          </a:solidFill>
        </a:ln>
      </dgm:spPr>
      <dgm:t>
        <a:bodyPr/>
        <a:lstStyle/>
        <a:p>
          <a:endParaRPr lang="en-GB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8914FDC-1103-4794-9FC5-BBCE7D31505E}" type="sibTrans" cxnId="{A90AE4A2-BCC2-473B-8C01-9C25A61576FD}">
      <dgm:prSet/>
      <dgm:spPr/>
      <dgm:t>
        <a:bodyPr/>
        <a:lstStyle/>
        <a:p>
          <a:endParaRPr lang="en-GB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F8E4E8F-2702-4226-B47E-68170BE88C0D}">
      <dgm:prSet phldrT="[テキスト]"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ilateral frontal lesions (-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4</a:t>
          </a:r>
          <a:endParaRPr lang="en-GB" sz="1200" b="1" dirty="0">
            <a:solidFill>
              <a:srgbClr val="FF0000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D8232B4-3BCE-40FA-A9D1-F6EE9E34EB34}" type="parTrans" cxnId="{028A7CDE-6550-4045-963A-6A713CF1D98F}">
      <dgm:prSet/>
      <dgm:spPr>
        <a:ln w="38100">
          <a:solidFill>
            <a:schemeClr val="tx1"/>
          </a:solidFill>
        </a:ln>
      </dgm:spPr>
      <dgm:t>
        <a:bodyPr/>
        <a:lstStyle/>
        <a:p>
          <a:endParaRPr lang="en-GB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AF3179A-5447-46D1-A265-947BF4F4C0FD}" type="sibTrans" cxnId="{028A7CDE-6550-4045-963A-6A713CF1D98F}">
      <dgm:prSet/>
      <dgm:spPr/>
      <dgm:t>
        <a:bodyPr/>
        <a:lstStyle/>
        <a:p>
          <a:endParaRPr lang="en-GB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BA59BEF-F7D1-47B1-A43A-3B0DA8C93D02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+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</a:p>
      </dgm:t>
    </dgm:pt>
    <dgm:pt modelId="{591BECE1-B841-4D57-8D99-F9DC0D22DBF9}" type="parTrans" cxnId="{0E5B4B47-2492-40A1-83E6-BD47B39E6303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FBA63D2-4340-4F0B-9F4C-41BDAD04658C}" type="sibTrans" cxnId="{0E5B4B47-2492-40A1-83E6-BD47B39E6303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AC4D152-DFE4-4D71-BCD7-D8DC7E5B64B5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ilateral prefrontal lesions (+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7</a:t>
          </a:r>
        </a:p>
      </dgm:t>
    </dgm:pt>
    <dgm:pt modelId="{7FCCC78F-80A8-4888-9D91-58DF6A1A42BD}" type="parTrans" cxnId="{F053260C-5125-40E2-83C8-B6354C9C4C46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35D1D55-2F16-48B8-97A0-0C788CA076BB}" type="sibTrans" cxnId="{F053260C-5125-40E2-83C8-B6354C9C4C46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E694C0F-8AB1-4632-B2DA-D1247D8BE18F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ilateral prefrontal lesions (-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4</a:t>
          </a:r>
        </a:p>
      </dgm:t>
    </dgm:pt>
    <dgm:pt modelId="{4D248CC2-3184-460B-A00A-1B722842C143}" type="parTrans" cxnId="{4C2220C4-39F9-457D-B555-599D9E5B3164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82A1D0C-24B1-4AA0-9246-BA20D4269306}" type="sibTrans" cxnId="{4C2220C4-39F9-457D-B555-599D9E5B3164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FFD01EC-C5E6-4176-BD08-620332168957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Unilateral prefrontal lesions (+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3</a:t>
          </a:r>
        </a:p>
      </dgm:t>
    </dgm:pt>
    <dgm:pt modelId="{7AADD620-BE27-4CB5-8F13-7068209BE0C5}" type="parTrans" cxnId="{421E0758-A6F9-40E4-86D1-293A81E629F9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4603734-B7F8-4E31-901B-271F7283D999}" type="sibTrans" cxnId="{421E0758-A6F9-40E4-86D1-293A81E629F9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DF8FFD9-511F-4065-B81C-2BDE61A38242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Unilateral prefrontal lesions (-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</dgm:t>
    </dgm:pt>
    <dgm:pt modelId="{19FF45C4-3579-490B-A008-D47EF4CD004F}" type="parTrans" cxnId="{19EEB9C4-B242-4CB5-92E4-4D2981B163D1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8C57F33-F806-47F2-A95F-1914F7DC09C7}" type="sibTrans" cxnId="{19EEB9C4-B242-4CB5-92E4-4D2981B163D1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FEE63E5-11CD-444D-8D11-C0DC2DC8DF75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-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</dgm:t>
    </dgm:pt>
    <dgm:pt modelId="{E5C4179A-71E8-45A5-B4BC-AF19A0263B90}" type="parTrans" cxnId="{D0ACC6AA-8B5E-4DA2-9FA8-EC91A72ADF5C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DD65A69-9C43-4552-8E24-00216623EE64}" type="sibTrans" cxnId="{D0ACC6AA-8B5E-4DA2-9FA8-EC91A72ADF5C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FBCC1F0-E3EC-4DCD-8958-8723179380D0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+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</dgm:t>
    </dgm:pt>
    <dgm:pt modelId="{7FE9781B-758D-43A9-BF49-F99B7DA53302}" type="parTrans" cxnId="{4E3B132E-5E83-4452-831D-EADDB423A434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A620AB7-A3C0-4989-9D19-BE876326B5B7}" type="sibTrans" cxnId="{4E3B132E-5E83-4452-831D-EADDB423A434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7231A88-C874-4EB5-96BF-70679CFA0F73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-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</a:p>
      </dgm:t>
    </dgm:pt>
    <dgm:pt modelId="{664A54DC-2232-409D-850E-C500F4B66703}" type="parTrans" cxnId="{BD77B140-E536-451C-A2FF-1699BBD35635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8A255CA-B801-4465-9F05-9B5E885049E8}" type="sibTrans" cxnId="{BD77B140-E536-451C-A2FF-1699BBD35635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41C7643-26C4-48E0-99CB-5FC5DCAC7830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-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5</a:t>
          </a:r>
        </a:p>
      </dgm:t>
    </dgm:pt>
    <dgm:pt modelId="{E86315E3-7891-43B4-99E6-516075C79111}" type="parTrans" cxnId="{17868BB7-CB52-4CDA-9509-7EFCBF4B4C27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06E2D13-A208-43B3-8FB0-B3FE31798FFE}" type="sibTrans" cxnId="{17868BB7-CB52-4CDA-9509-7EFCBF4B4C27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06D8CC5-78C9-4B43-BDE8-4BE5804CEA04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+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</dgm:t>
    </dgm:pt>
    <dgm:pt modelId="{18F20645-7764-43F0-9163-9C3DC9EAF423}" type="parTrans" cxnId="{04C8A5AB-850E-479A-8F07-F496BE4E5EB3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EFFC32F-6ECF-4E60-9223-BF8D7C294614}" type="sibTrans" cxnId="{04C8A5AB-850E-479A-8F07-F496BE4E5EB3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8EC778F-CAF8-4E63-A99F-097796D79286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-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3</a:t>
          </a:r>
        </a:p>
      </dgm:t>
    </dgm:pt>
    <dgm:pt modelId="{52154CCD-C50F-4D8D-9A4D-62AFF7D488F1}" type="parTrans" cxnId="{5E70174C-6009-4769-8D39-AFF08AF778BD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BFB09D3-CF38-4FA8-9B22-519CCB2BA430}" type="sibTrans" cxnId="{5E70174C-6009-4769-8D39-AFF08AF778BD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43255AD-71E5-496C-B47C-0F72C36EA1B4}">
      <dgm:prSet custT="1"/>
      <dgm:spPr>
        <a:noFill/>
        <a:ln w="38100"/>
      </dgm:spPr>
      <dgm:t>
        <a:bodyPr/>
        <a:lstStyle/>
        <a:p>
          <a:endParaRPr lang="en-GB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N.D.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 n = 2</a:t>
          </a:r>
        </a:p>
        <a:p>
          <a:r>
            <a:rPr kumimoji="1" lang="en-GB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3, 8</a:t>
          </a:r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endParaRPr lang="en-GB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endParaRPr lang="en-GB" sz="105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4BEDA4B-4676-4447-BB1C-BF24E40AC4B9}" type="parTrans" cxnId="{DDCA8081-CC22-4775-9F38-EE9CEF9657E8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E9B234F-4C6A-449C-B75C-3D5AE4352F45}" type="sibTrans" cxnId="{DDCA8081-CC22-4775-9F38-EE9CEF9657E8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8AF9B9F-7B15-49F9-BF7C-6D4318F4863B}">
      <dgm:prSet custT="1"/>
      <dgm:spPr>
        <a:noFill/>
        <a:ln w="38100"/>
      </dgm:spPr>
      <dgm:t>
        <a:bodyPr/>
        <a:lstStyle/>
        <a:p>
          <a:endParaRPr lang="en-GB" sz="105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endParaRPr lang="en-GB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N.D.</a:t>
          </a:r>
          <a:r>
            <a:rPr lang="en-GB" altLang="ja-JP" sz="1200" dirty="0">
              <a:solidFill>
                <a:schemeClr val="tx1"/>
              </a:solidFill>
              <a:latin typeface="Arial" panose="020B0604020202020204" pitchFamily="34" charset="0"/>
              <a:cs typeface="Times New Roman" panose="02020603050405020304" pitchFamily="18" charset="0"/>
            </a:rPr>
            <a:t> </a:t>
          </a:r>
          <a:endParaRPr lang="en-GB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4</a:t>
          </a:r>
        </a:p>
        <a:p>
          <a:r>
            <a:rPr kumimoji="1" lang="en-GB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1, 2, 6, 10</a:t>
          </a:r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endParaRPr lang="en-GB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endParaRPr lang="en-GB" sz="105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4C2A03C-C688-44D6-BE9F-79D692427471}" type="parTrans" cxnId="{3184C26B-B320-4CA8-A628-A64217B4A891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E74A5D7-2717-46EF-AD36-086EE5C2C81E}" type="sibTrans" cxnId="{3184C26B-B320-4CA8-A628-A64217B4A891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8C5AF4C-1B14-41B0-9771-7EBCD0929A3D}">
      <dgm:prSet custT="1"/>
      <dgm:spPr>
        <a:noFill/>
        <a:ln w="38100"/>
      </dgm:spPr>
      <dgm:t>
        <a:bodyPr/>
        <a:lstStyle/>
        <a:p>
          <a:endParaRPr lang="en-GB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N.D.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  <a:p>
          <a:r>
            <a:rPr kumimoji="1" lang="en-GB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11</a:t>
          </a:r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6A51C83-6AE4-4C7F-B92D-66DA6A6372CE}" type="parTrans" cxnId="{F0B55482-2913-4322-9F85-F3FE7C1FF605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1D04D08-E5FA-4F84-8D48-EABDD9E66973}" type="sibTrans" cxnId="{F0B55482-2913-4322-9F85-F3FE7C1FF605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67E51DC-DAFD-4334-BA70-BAFEED137B42}">
      <dgm:prSet custT="1"/>
      <dgm:spPr>
        <a:noFill/>
        <a:ln w="38100"/>
      </dgm:spPr>
      <dgm:t>
        <a:bodyPr/>
        <a:lstStyle/>
        <a:p>
          <a:endParaRPr lang="en-GB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N.D.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  <a:p>
          <a:r>
            <a:rPr kumimoji="1" lang="en-GB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4</a:t>
          </a:r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5AFF031-A5C1-4EBA-AE0C-FA89BF21DCD1}" type="parTrans" cxnId="{EE47F85D-811C-47A3-AE46-6667EA124E94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07FCAF4-D9AC-484E-B9AA-E20584E8A3A6}" type="sibTrans" cxnId="{EE47F85D-811C-47A3-AE46-6667EA124E94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7C7148A-F0C3-445B-A39D-01DE0724E6F2}">
      <dgm:prSet custT="1"/>
      <dgm:spPr>
        <a:noFill/>
        <a:ln w="38100"/>
      </dgm:spPr>
      <dgm:t>
        <a:bodyPr/>
        <a:lstStyle/>
        <a:p>
          <a:endParaRPr lang="en-GB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N.D.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  <a:p>
          <a:r>
            <a:rPr kumimoji="1" lang="en-GB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13</a:t>
          </a:r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644E4B2-A944-479A-96C3-135272B6EA85}" type="parTrans" cxnId="{B37EB204-2508-4E45-BFB4-83ADAD099872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340FFFA-3787-4062-A13F-06CF93938761}" type="sibTrans" cxnId="{B37EB204-2508-4E45-BFB4-83ADAD099872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DA4B7B4-A002-442D-8908-F302D486C218}">
      <dgm:prSet custT="1"/>
      <dgm:spPr>
        <a:noFill/>
        <a:ln w="38100"/>
      </dgm:spPr>
      <dgm:t>
        <a:bodyPr/>
        <a:lstStyle/>
        <a:p>
          <a:endParaRPr lang="en-GB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(-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</a:p>
        <a:p>
          <a:r>
            <a:rPr kumimoji="1" lang="en-GB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12, 14</a:t>
          </a:r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endParaRPr kumimoji="1" lang="en-US" altLang="ja-JP" sz="1200" b="1" dirty="0">
            <a:solidFill>
              <a:srgbClr val="FF0000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12224F7-2DFB-44CA-86DF-11C60E308278}" type="parTrans" cxnId="{297188D3-FB6D-4920-9528-A2C1691C06D1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D1A0940-815C-426C-B995-248B5137F279}" type="sibTrans" cxnId="{297188D3-FB6D-4920-9528-A2C1691C06D1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C3011BAC-C634-4F6A-B626-BB4C0EF26321}">
      <dgm:prSet custT="1"/>
      <dgm:spPr>
        <a:noFill/>
        <a:ln w="38100"/>
      </dgm:spPr>
      <dgm:t>
        <a:bodyPr/>
        <a:lstStyle/>
        <a:p>
          <a:endParaRPr lang="en-GB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(-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  <a:p>
          <a:r>
            <a:rPr kumimoji="1" lang="en-GB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15</a:t>
          </a:r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25A9166-8B18-4E7E-9D25-0E123E908A76}" type="parTrans" cxnId="{297DC841-C465-4448-B21A-7BD2AE080A8C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68B86C4-3FCA-4B9C-8561-D4B1A910662F}" type="sibTrans" cxnId="{297DC841-C465-4448-B21A-7BD2AE080A8C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F20E12C0-1577-4413-9C78-797ED501311E}">
      <dgm:prSet custT="1"/>
      <dgm:spPr>
        <a:noFill/>
        <a:ln w="38100"/>
      </dgm:spPr>
      <dgm:t>
        <a:bodyPr/>
        <a:lstStyle/>
        <a:p>
          <a:endParaRPr kumimoji="1" lang="en-GB" altLang="ja-JP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r>
            <a:rPr kumimoji="1" lang="en-GB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(-)</a:t>
          </a:r>
        </a:p>
        <a:p>
          <a:r>
            <a:rPr kumimoji="1" lang="en-GB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r>
            <a:rPr kumimoji="1" lang="en-GB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5, 7</a:t>
          </a:r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endParaRPr lang="en-GB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34C6499-965E-4A1C-AD6B-41DBACE3B9DD}" type="parTrans" cxnId="{0506235D-C8EB-453A-A3D9-32B951F747DE}">
      <dgm:prSet/>
      <dgm:spPr>
        <a:ln w="38100"/>
      </dgm:spPr>
      <dgm:t>
        <a:bodyPr/>
        <a:lstStyle/>
        <a:p>
          <a:endParaRPr lang="en-GB"/>
        </a:p>
      </dgm:t>
    </dgm:pt>
    <dgm:pt modelId="{64430280-6112-4F39-B5B5-3CC456A25121}" type="sibTrans" cxnId="{0506235D-C8EB-453A-A3D9-32B951F747DE}">
      <dgm:prSet/>
      <dgm:spPr/>
      <dgm:t>
        <a:bodyPr/>
        <a:lstStyle/>
        <a:p>
          <a:endParaRPr lang="en-GB"/>
        </a:p>
      </dgm:t>
    </dgm:pt>
    <dgm:pt modelId="{3B0E29A3-C1A2-4639-AB0E-1A346F1A0E04}">
      <dgm:prSet custT="1"/>
      <dgm:spPr>
        <a:noFill/>
        <a:ln w="38100">
          <a:solidFill>
            <a:schemeClr val="tx1"/>
          </a:solidFill>
        </a:ln>
      </dgm:spPr>
      <dgm:t>
        <a:bodyPr/>
        <a:lstStyle/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(+)</a:t>
          </a:r>
        </a:p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9</a:t>
          </a:r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7865882-2A58-4BA6-8A69-252504164606}" type="parTrans" cxnId="{FA299A8D-470C-47D4-99FA-542D8FE4225C}">
      <dgm:prSet/>
      <dgm:spPr>
        <a:noFill/>
        <a:ln w="38100">
          <a:solidFill>
            <a:schemeClr val="tx1"/>
          </a:solidFill>
        </a:ln>
      </dgm:spPr>
      <dgm:t>
        <a:bodyPr/>
        <a:lstStyle/>
        <a:p>
          <a:endParaRPr kumimoji="1" lang="ja-JP" altLang="en-US"/>
        </a:p>
      </dgm:t>
    </dgm:pt>
    <dgm:pt modelId="{ABFA5A72-A3DA-4C0E-8B61-D6E435F44C50}" type="sibTrans" cxnId="{FA299A8D-470C-47D4-99FA-542D8FE4225C}">
      <dgm:prSet/>
      <dgm:spPr/>
      <dgm:t>
        <a:bodyPr/>
        <a:lstStyle/>
        <a:p>
          <a:endParaRPr kumimoji="1" lang="ja-JP" altLang="en-US"/>
        </a:p>
      </dgm:t>
    </dgm:pt>
    <dgm:pt modelId="{BFF39B8D-4745-486C-BE1F-E29AF29508A6}" type="asst">
      <dgm:prSet/>
      <dgm:spPr>
        <a:noFill/>
        <a:ln w="38100">
          <a:solidFill>
            <a:schemeClr val="tx1"/>
          </a:solidFill>
        </a:ln>
      </dgm:spPr>
      <dgm:t>
        <a:bodyPr/>
        <a:lstStyle/>
        <a:p>
          <a:r>
            <a:rPr kumimoji="1" lang="en-US" altLang="ja-JP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Instability could not be evaluated in a sitting position due to insufficient development milestones</a:t>
          </a:r>
        </a:p>
        <a:p>
          <a:r>
            <a:rPr kumimoji="1" lang="en-US" altLang="ja-JP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</dgm:t>
    </dgm:pt>
    <dgm:pt modelId="{70077C60-346B-48F3-A4A6-74BBDB759C76}" type="parTrans" cxnId="{195D5CE0-F24A-42C2-8BC4-39E577E63818}">
      <dgm:prSet/>
      <dgm:spPr>
        <a:ln w="38100">
          <a:solidFill>
            <a:schemeClr val="tx1"/>
          </a:solidFill>
        </a:ln>
      </dgm:spPr>
      <dgm:t>
        <a:bodyPr/>
        <a:lstStyle/>
        <a:p>
          <a:endParaRPr kumimoji="1" lang="ja-JP" altLang="en-US"/>
        </a:p>
      </dgm:t>
    </dgm:pt>
    <dgm:pt modelId="{35AAD9C9-69B4-4AE9-9EA4-E94B5AA94A29}" type="sibTrans" cxnId="{195D5CE0-F24A-42C2-8BC4-39E577E63818}">
      <dgm:prSet/>
      <dgm:spPr/>
      <dgm:t>
        <a:bodyPr/>
        <a:lstStyle/>
        <a:p>
          <a:endParaRPr kumimoji="1" lang="ja-JP" altLang="en-US"/>
        </a:p>
      </dgm:t>
    </dgm:pt>
    <dgm:pt modelId="{ABC3CB6A-0357-4894-9BAA-929B77021C52}" type="pres">
      <dgm:prSet presAssocID="{6BD44C91-1E07-4C76-A038-9B12972016B7}" presName="hierChild1" presStyleCnt="0">
        <dgm:presLayoutVars>
          <dgm:orgChart val="1"/>
          <dgm:chPref val="1"/>
          <dgm:dir/>
          <dgm:animOne val="branch"/>
          <dgm:animLvl val="lvl"/>
          <dgm:resizeHandles/>
        </dgm:presLayoutVars>
      </dgm:prSet>
      <dgm:spPr/>
    </dgm:pt>
    <dgm:pt modelId="{AEAB85E9-A70C-4405-877A-25C8499667A5}" type="pres">
      <dgm:prSet presAssocID="{AE8828E0-C571-4F8A-9003-C6EADEAC1B46}" presName="hierRoot1" presStyleCnt="0">
        <dgm:presLayoutVars>
          <dgm:hierBranch val="init"/>
        </dgm:presLayoutVars>
      </dgm:prSet>
      <dgm:spPr/>
    </dgm:pt>
    <dgm:pt modelId="{1E669895-E92B-4739-8C7B-84CB31B48474}" type="pres">
      <dgm:prSet presAssocID="{AE8828E0-C571-4F8A-9003-C6EADEAC1B46}" presName="rootComposite1" presStyleCnt="0"/>
      <dgm:spPr/>
    </dgm:pt>
    <dgm:pt modelId="{356AF28E-5690-4043-AF44-3ACC12D0BDB0}" type="pres">
      <dgm:prSet presAssocID="{AE8828E0-C571-4F8A-9003-C6EADEAC1B46}" presName="rootText1" presStyleLbl="node0" presStyleIdx="0" presStyleCnt="1" custLinFactNeighborX="-67131" custLinFactNeighborY="85219">
        <dgm:presLayoutVars>
          <dgm:chPref val="3"/>
        </dgm:presLayoutVars>
      </dgm:prSet>
      <dgm:spPr/>
    </dgm:pt>
    <dgm:pt modelId="{CC1F212B-4033-4ACE-91CA-24A1CE845C0F}" type="pres">
      <dgm:prSet presAssocID="{AE8828E0-C571-4F8A-9003-C6EADEAC1B46}" presName="rootConnector1" presStyleLbl="node1" presStyleIdx="0" presStyleCnt="0"/>
      <dgm:spPr/>
    </dgm:pt>
    <dgm:pt modelId="{2620BDDE-FA0E-4A4C-8A0C-B5CB145438F5}" type="pres">
      <dgm:prSet presAssocID="{AE8828E0-C571-4F8A-9003-C6EADEAC1B46}" presName="hierChild2" presStyleCnt="0"/>
      <dgm:spPr/>
    </dgm:pt>
    <dgm:pt modelId="{FFFD1586-C99D-4845-8FB7-33978BBFEBB3}" type="pres">
      <dgm:prSet presAssocID="{349DFFB7-BC3E-496C-9A61-DB19C5510C78}" presName="Name37" presStyleLbl="parChTrans1D2" presStyleIdx="0" presStyleCnt="3"/>
      <dgm:spPr/>
    </dgm:pt>
    <dgm:pt modelId="{238AEF1C-EA40-47B2-AD6F-C7FBDF9862A4}" type="pres">
      <dgm:prSet presAssocID="{8E83BC88-359D-47C4-9BBC-5EFD9E609921}" presName="hierRoot2" presStyleCnt="0">
        <dgm:presLayoutVars>
          <dgm:hierBranch val="init"/>
        </dgm:presLayoutVars>
      </dgm:prSet>
      <dgm:spPr/>
    </dgm:pt>
    <dgm:pt modelId="{DAF59CE7-69D3-4E3E-9105-8DF6BE16B2E9}" type="pres">
      <dgm:prSet presAssocID="{8E83BC88-359D-47C4-9BBC-5EFD9E609921}" presName="rootComposite" presStyleCnt="0"/>
      <dgm:spPr/>
    </dgm:pt>
    <dgm:pt modelId="{C6924E3E-37F0-45BB-A9D6-33A3FF05B21C}" type="pres">
      <dgm:prSet presAssocID="{8E83BC88-359D-47C4-9BBC-5EFD9E609921}" presName="rootText" presStyleLbl="node2" presStyleIdx="0" presStyleCnt="2" custScaleX="216035" custLinFactNeighborY="-6844">
        <dgm:presLayoutVars>
          <dgm:chPref val="3"/>
        </dgm:presLayoutVars>
      </dgm:prSet>
      <dgm:spPr/>
    </dgm:pt>
    <dgm:pt modelId="{3B4C3098-684A-4D58-8815-D0CCA3C2AA08}" type="pres">
      <dgm:prSet presAssocID="{8E83BC88-359D-47C4-9BBC-5EFD9E609921}" presName="rootConnector" presStyleLbl="node2" presStyleIdx="0" presStyleCnt="2"/>
      <dgm:spPr/>
    </dgm:pt>
    <dgm:pt modelId="{C6A7C44F-2A3F-4F38-BFAD-45072B23DE07}" type="pres">
      <dgm:prSet presAssocID="{8E83BC88-359D-47C4-9BBC-5EFD9E609921}" presName="hierChild4" presStyleCnt="0"/>
      <dgm:spPr/>
    </dgm:pt>
    <dgm:pt modelId="{16F95800-F6FC-432A-8192-5DDFB4692B6C}" type="pres">
      <dgm:prSet presAssocID="{7FCCC78F-80A8-4888-9D91-58DF6A1A42BD}" presName="Name37" presStyleLbl="parChTrans1D3" presStyleIdx="0" presStyleCnt="4"/>
      <dgm:spPr/>
    </dgm:pt>
    <dgm:pt modelId="{9E716B29-2216-4651-A18A-EAC68AA05A24}" type="pres">
      <dgm:prSet presAssocID="{AAC4D152-DFE4-4D71-BCD7-D8DC7E5B64B5}" presName="hierRoot2" presStyleCnt="0">
        <dgm:presLayoutVars>
          <dgm:hierBranch val="init"/>
        </dgm:presLayoutVars>
      </dgm:prSet>
      <dgm:spPr/>
    </dgm:pt>
    <dgm:pt modelId="{14C6D8F7-4917-4327-8461-C2A64ACA6B89}" type="pres">
      <dgm:prSet presAssocID="{AAC4D152-DFE4-4D71-BCD7-D8DC7E5B64B5}" presName="rootComposite" presStyleCnt="0"/>
      <dgm:spPr/>
    </dgm:pt>
    <dgm:pt modelId="{0296FC5F-E378-4904-93B2-00D4ACF73593}" type="pres">
      <dgm:prSet presAssocID="{AAC4D152-DFE4-4D71-BCD7-D8DC7E5B64B5}" presName="rootText" presStyleLbl="node3" presStyleIdx="0" presStyleCnt="4" custScaleX="170988" custScaleY="128519">
        <dgm:presLayoutVars>
          <dgm:chPref val="3"/>
        </dgm:presLayoutVars>
      </dgm:prSet>
      <dgm:spPr/>
    </dgm:pt>
    <dgm:pt modelId="{2A3B2C18-117F-4F18-8DA1-0C7AC429375D}" type="pres">
      <dgm:prSet presAssocID="{AAC4D152-DFE4-4D71-BCD7-D8DC7E5B64B5}" presName="rootConnector" presStyleLbl="node3" presStyleIdx="0" presStyleCnt="4"/>
      <dgm:spPr/>
    </dgm:pt>
    <dgm:pt modelId="{106E37BA-F771-4BE8-8846-0F3D21A3D507}" type="pres">
      <dgm:prSet presAssocID="{AAC4D152-DFE4-4D71-BCD7-D8DC7E5B64B5}" presName="hierChild4" presStyleCnt="0"/>
      <dgm:spPr/>
    </dgm:pt>
    <dgm:pt modelId="{05F4DF28-B57F-4699-9BED-B162015FDD41}" type="pres">
      <dgm:prSet presAssocID="{591BECE1-B841-4D57-8D99-F9DC0D22DBF9}" presName="Name37" presStyleLbl="parChTrans1D4" presStyleIdx="0" presStyleCnt="16"/>
      <dgm:spPr/>
    </dgm:pt>
    <dgm:pt modelId="{825D8AFF-14D3-43E5-AD31-216B21801723}" type="pres">
      <dgm:prSet presAssocID="{DBA59BEF-F7D1-47B1-A43A-3B0DA8C93D02}" presName="hierRoot2" presStyleCnt="0">
        <dgm:presLayoutVars>
          <dgm:hierBranch val="init"/>
        </dgm:presLayoutVars>
      </dgm:prSet>
      <dgm:spPr/>
    </dgm:pt>
    <dgm:pt modelId="{5245F033-2183-451C-8E29-6A85BFAA36EA}" type="pres">
      <dgm:prSet presAssocID="{DBA59BEF-F7D1-47B1-A43A-3B0DA8C93D02}" presName="rootComposite" presStyleCnt="0"/>
      <dgm:spPr/>
    </dgm:pt>
    <dgm:pt modelId="{B8C1EDF1-DB2A-4D33-AA78-22955DE770C3}" type="pres">
      <dgm:prSet presAssocID="{DBA59BEF-F7D1-47B1-A43A-3B0DA8C93D02}" presName="rootText" presStyleLbl="node4" presStyleIdx="0" presStyleCnt="16" custScaleY="142876">
        <dgm:presLayoutVars>
          <dgm:chPref val="3"/>
        </dgm:presLayoutVars>
      </dgm:prSet>
      <dgm:spPr/>
    </dgm:pt>
    <dgm:pt modelId="{A59011C7-6EE2-4BBA-945A-1EA041A7BDF1}" type="pres">
      <dgm:prSet presAssocID="{DBA59BEF-F7D1-47B1-A43A-3B0DA8C93D02}" presName="rootConnector" presStyleLbl="node4" presStyleIdx="0" presStyleCnt="16"/>
      <dgm:spPr/>
    </dgm:pt>
    <dgm:pt modelId="{7C3D7898-B966-40D3-9287-C16DE16BCFA6}" type="pres">
      <dgm:prSet presAssocID="{DBA59BEF-F7D1-47B1-A43A-3B0DA8C93D02}" presName="hierChild4" presStyleCnt="0"/>
      <dgm:spPr/>
    </dgm:pt>
    <dgm:pt modelId="{DD731950-665B-474A-9284-81BABEADB935}" type="pres">
      <dgm:prSet presAssocID="{34BEDA4B-4676-4447-BB1C-BF24E40AC4B9}" presName="Name37" presStyleLbl="parChTrans1D4" presStyleIdx="1" presStyleCnt="16"/>
      <dgm:spPr/>
    </dgm:pt>
    <dgm:pt modelId="{32A235EB-AA7F-4B94-A580-59A6593BE504}" type="pres">
      <dgm:prSet presAssocID="{643255AD-71E5-496C-B47C-0F72C36EA1B4}" presName="hierRoot2" presStyleCnt="0">
        <dgm:presLayoutVars>
          <dgm:hierBranch val="init"/>
        </dgm:presLayoutVars>
      </dgm:prSet>
      <dgm:spPr/>
    </dgm:pt>
    <dgm:pt modelId="{36BAFAB3-940C-4564-B083-4E102C6171B8}" type="pres">
      <dgm:prSet presAssocID="{643255AD-71E5-496C-B47C-0F72C36EA1B4}" presName="rootComposite" presStyleCnt="0"/>
      <dgm:spPr/>
    </dgm:pt>
    <dgm:pt modelId="{53371C62-A9F4-424A-A2C3-5285FF0AAA6F}" type="pres">
      <dgm:prSet presAssocID="{643255AD-71E5-496C-B47C-0F72C36EA1B4}" presName="rootText" presStyleLbl="node4" presStyleIdx="1" presStyleCnt="16" custScaleX="112841" custScaleY="164340" custLinFactNeighborX="-1033" custLinFactNeighborY="22726">
        <dgm:presLayoutVars>
          <dgm:chPref val="3"/>
        </dgm:presLayoutVars>
      </dgm:prSet>
      <dgm:spPr/>
    </dgm:pt>
    <dgm:pt modelId="{C7CDD2F7-9A5D-47CE-9F03-D1B9A9C8458C}" type="pres">
      <dgm:prSet presAssocID="{643255AD-71E5-496C-B47C-0F72C36EA1B4}" presName="rootConnector" presStyleLbl="node4" presStyleIdx="1" presStyleCnt="16"/>
      <dgm:spPr/>
    </dgm:pt>
    <dgm:pt modelId="{7EDA0209-31D1-4079-9185-0D9234A600D0}" type="pres">
      <dgm:prSet presAssocID="{643255AD-71E5-496C-B47C-0F72C36EA1B4}" presName="hierChild4" presStyleCnt="0"/>
      <dgm:spPr/>
    </dgm:pt>
    <dgm:pt modelId="{0DE1086A-45E0-44C3-B843-F09BFB8929BA}" type="pres">
      <dgm:prSet presAssocID="{643255AD-71E5-496C-B47C-0F72C36EA1B4}" presName="hierChild5" presStyleCnt="0"/>
      <dgm:spPr/>
    </dgm:pt>
    <dgm:pt modelId="{D07FC435-ED36-4E66-AF58-BBEA60B14809}" type="pres">
      <dgm:prSet presAssocID="{DBA59BEF-F7D1-47B1-A43A-3B0DA8C93D02}" presName="hierChild5" presStyleCnt="0"/>
      <dgm:spPr/>
    </dgm:pt>
    <dgm:pt modelId="{35E9E6AB-8EBF-4489-A9AD-B18731334C84}" type="pres">
      <dgm:prSet presAssocID="{E86315E3-7891-43B4-99E6-516075C79111}" presName="Name37" presStyleLbl="parChTrans1D4" presStyleIdx="2" presStyleCnt="16"/>
      <dgm:spPr/>
    </dgm:pt>
    <dgm:pt modelId="{DC54E399-9511-4CB6-8C80-71318FE6ECB6}" type="pres">
      <dgm:prSet presAssocID="{941C7643-26C4-48E0-99CB-5FC5DCAC7830}" presName="hierRoot2" presStyleCnt="0">
        <dgm:presLayoutVars>
          <dgm:hierBranch val="init"/>
        </dgm:presLayoutVars>
      </dgm:prSet>
      <dgm:spPr/>
    </dgm:pt>
    <dgm:pt modelId="{16D179C5-A932-40DA-A6D5-65CF1FECF634}" type="pres">
      <dgm:prSet presAssocID="{941C7643-26C4-48E0-99CB-5FC5DCAC7830}" presName="rootComposite" presStyleCnt="0"/>
      <dgm:spPr/>
    </dgm:pt>
    <dgm:pt modelId="{1428E6BE-2F58-417D-9CB2-2888832E0161}" type="pres">
      <dgm:prSet presAssocID="{941C7643-26C4-48E0-99CB-5FC5DCAC7830}" presName="rootText" presStyleLbl="node4" presStyleIdx="2" presStyleCnt="16" custScaleY="142876">
        <dgm:presLayoutVars>
          <dgm:chPref val="3"/>
        </dgm:presLayoutVars>
      </dgm:prSet>
      <dgm:spPr/>
    </dgm:pt>
    <dgm:pt modelId="{38B6D9C8-E9D8-4050-A823-A9F97287CFBA}" type="pres">
      <dgm:prSet presAssocID="{941C7643-26C4-48E0-99CB-5FC5DCAC7830}" presName="rootConnector" presStyleLbl="node4" presStyleIdx="2" presStyleCnt="16"/>
      <dgm:spPr/>
    </dgm:pt>
    <dgm:pt modelId="{A4DE7510-1459-48B1-AFEC-BAA8154AD4F3}" type="pres">
      <dgm:prSet presAssocID="{941C7643-26C4-48E0-99CB-5FC5DCAC7830}" presName="hierChild4" presStyleCnt="0"/>
      <dgm:spPr/>
    </dgm:pt>
    <dgm:pt modelId="{1AAE962B-FC4E-4E88-9802-C684323DA4FE}" type="pres">
      <dgm:prSet presAssocID="{74C2A03C-C688-44D6-BE9F-79D692427471}" presName="Name37" presStyleLbl="parChTrans1D4" presStyleIdx="3" presStyleCnt="16"/>
      <dgm:spPr/>
    </dgm:pt>
    <dgm:pt modelId="{ACAC5505-D3D1-4D57-B32C-9AC3B8D7350A}" type="pres">
      <dgm:prSet presAssocID="{D8AF9B9F-7B15-49F9-BF7C-6D4318F4863B}" presName="hierRoot2" presStyleCnt="0">
        <dgm:presLayoutVars>
          <dgm:hierBranch val="init"/>
        </dgm:presLayoutVars>
      </dgm:prSet>
      <dgm:spPr/>
    </dgm:pt>
    <dgm:pt modelId="{8C21FDB2-B8B8-4BD5-9557-77DA1E527140}" type="pres">
      <dgm:prSet presAssocID="{D8AF9B9F-7B15-49F9-BF7C-6D4318F4863B}" presName="rootComposite" presStyleCnt="0"/>
      <dgm:spPr/>
    </dgm:pt>
    <dgm:pt modelId="{8110C399-8F20-4AB5-BD7D-22095B9142B3}" type="pres">
      <dgm:prSet presAssocID="{D8AF9B9F-7B15-49F9-BF7C-6D4318F4863B}" presName="rootText" presStyleLbl="node4" presStyleIdx="3" presStyleCnt="16" custScaleX="149901" custScaleY="156561" custLinFactNeighborY="22726">
        <dgm:presLayoutVars>
          <dgm:chPref val="3"/>
        </dgm:presLayoutVars>
      </dgm:prSet>
      <dgm:spPr/>
    </dgm:pt>
    <dgm:pt modelId="{16FBCBB6-1A99-419C-ACE8-9066FEE99083}" type="pres">
      <dgm:prSet presAssocID="{D8AF9B9F-7B15-49F9-BF7C-6D4318F4863B}" presName="rootConnector" presStyleLbl="node4" presStyleIdx="3" presStyleCnt="16"/>
      <dgm:spPr/>
    </dgm:pt>
    <dgm:pt modelId="{A55CB61D-63FA-4E1D-A1A0-2BB6AB750FD6}" type="pres">
      <dgm:prSet presAssocID="{D8AF9B9F-7B15-49F9-BF7C-6D4318F4863B}" presName="hierChild4" presStyleCnt="0"/>
      <dgm:spPr/>
    </dgm:pt>
    <dgm:pt modelId="{F426B2E4-1C3C-416C-AB30-9BBCF3844AD0}" type="pres">
      <dgm:prSet presAssocID="{D8AF9B9F-7B15-49F9-BF7C-6D4318F4863B}" presName="hierChild5" presStyleCnt="0"/>
      <dgm:spPr/>
    </dgm:pt>
    <dgm:pt modelId="{E2BB12F0-4365-4D10-BBA4-7BD9CA3A1C8C}" type="pres">
      <dgm:prSet presAssocID="{87865882-2A58-4BA6-8A69-252504164606}" presName="Name37" presStyleLbl="parChTrans1D4" presStyleIdx="4" presStyleCnt="16"/>
      <dgm:spPr/>
    </dgm:pt>
    <dgm:pt modelId="{C633C2DB-CE88-4040-9393-78752B2FB493}" type="pres">
      <dgm:prSet presAssocID="{3B0E29A3-C1A2-4639-AB0E-1A346F1A0E04}" presName="hierRoot2" presStyleCnt="0">
        <dgm:presLayoutVars>
          <dgm:hierBranch val="init"/>
        </dgm:presLayoutVars>
      </dgm:prSet>
      <dgm:spPr/>
    </dgm:pt>
    <dgm:pt modelId="{F44635B9-51C4-4F7E-9469-3276ED75C2B9}" type="pres">
      <dgm:prSet presAssocID="{3B0E29A3-C1A2-4639-AB0E-1A346F1A0E04}" presName="rootComposite" presStyleCnt="0"/>
      <dgm:spPr/>
    </dgm:pt>
    <dgm:pt modelId="{F5F3FF49-23FD-4723-B11F-E4F06DC6090E}" type="pres">
      <dgm:prSet presAssocID="{3B0E29A3-C1A2-4639-AB0E-1A346F1A0E04}" presName="rootText" presStyleLbl="node4" presStyleIdx="4" presStyleCnt="16" custScaleY="132240" custLinFactNeighborY="22726">
        <dgm:presLayoutVars>
          <dgm:chPref val="3"/>
        </dgm:presLayoutVars>
      </dgm:prSet>
      <dgm:spPr/>
    </dgm:pt>
    <dgm:pt modelId="{1CE56615-592A-44D8-BCD1-C90ECF921800}" type="pres">
      <dgm:prSet presAssocID="{3B0E29A3-C1A2-4639-AB0E-1A346F1A0E04}" presName="rootConnector" presStyleLbl="node4" presStyleIdx="4" presStyleCnt="16"/>
      <dgm:spPr/>
    </dgm:pt>
    <dgm:pt modelId="{733019F2-2574-4025-9489-3988519009E7}" type="pres">
      <dgm:prSet presAssocID="{3B0E29A3-C1A2-4639-AB0E-1A346F1A0E04}" presName="hierChild4" presStyleCnt="0"/>
      <dgm:spPr/>
    </dgm:pt>
    <dgm:pt modelId="{1EA58201-FDA9-433A-8E6C-8F697CD654B5}" type="pres">
      <dgm:prSet presAssocID="{3B0E29A3-C1A2-4639-AB0E-1A346F1A0E04}" presName="hierChild5" presStyleCnt="0"/>
      <dgm:spPr/>
    </dgm:pt>
    <dgm:pt modelId="{2DEC6793-A898-4C9E-9382-93EF220C751B}" type="pres">
      <dgm:prSet presAssocID="{941C7643-26C4-48E0-99CB-5FC5DCAC7830}" presName="hierChild5" presStyleCnt="0"/>
      <dgm:spPr/>
    </dgm:pt>
    <dgm:pt modelId="{08ADC29D-B256-4436-AD4B-5D77D4F324EE}" type="pres">
      <dgm:prSet presAssocID="{AAC4D152-DFE4-4D71-BCD7-D8DC7E5B64B5}" presName="hierChild5" presStyleCnt="0"/>
      <dgm:spPr/>
    </dgm:pt>
    <dgm:pt modelId="{B8F3B591-9307-4E9A-BD2C-F5D348511BEA}" type="pres">
      <dgm:prSet presAssocID="{4D248CC2-3184-460B-A00A-1B722842C143}" presName="Name37" presStyleLbl="parChTrans1D3" presStyleIdx="1" presStyleCnt="4"/>
      <dgm:spPr/>
    </dgm:pt>
    <dgm:pt modelId="{62F5DF37-6E28-4E05-936D-856834444042}" type="pres">
      <dgm:prSet presAssocID="{0E694C0F-8AB1-4632-B2DA-D1247D8BE18F}" presName="hierRoot2" presStyleCnt="0">
        <dgm:presLayoutVars>
          <dgm:hierBranch val="init"/>
        </dgm:presLayoutVars>
      </dgm:prSet>
      <dgm:spPr/>
    </dgm:pt>
    <dgm:pt modelId="{01A8AF1A-CEEA-44DB-A97C-C6C9B7EC0A18}" type="pres">
      <dgm:prSet presAssocID="{0E694C0F-8AB1-4632-B2DA-D1247D8BE18F}" presName="rootComposite" presStyleCnt="0"/>
      <dgm:spPr/>
    </dgm:pt>
    <dgm:pt modelId="{87A60063-46AC-4CA6-8AFB-C646FC058C41}" type="pres">
      <dgm:prSet presAssocID="{0E694C0F-8AB1-4632-B2DA-D1247D8BE18F}" presName="rootText" presStyleLbl="node3" presStyleIdx="1" presStyleCnt="4" custScaleX="177015" custScaleY="120344">
        <dgm:presLayoutVars>
          <dgm:chPref val="3"/>
        </dgm:presLayoutVars>
      </dgm:prSet>
      <dgm:spPr/>
    </dgm:pt>
    <dgm:pt modelId="{053C0BA0-4CA6-4511-8C30-0C0AC5E87C55}" type="pres">
      <dgm:prSet presAssocID="{0E694C0F-8AB1-4632-B2DA-D1247D8BE18F}" presName="rootConnector" presStyleLbl="node3" presStyleIdx="1" presStyleCnt="4"/>
      <dgm:spPr/>
    </dgm:pt>
    <dgm:pt modelId="{767A21D5-DB46-4A5E-9683-FA267B1DDAF5}" type="pres">
      <dgm:prSet presAssocID="{0E694C0F-8AB1-4632-B2DA-D1247D8BE18F}" presName="hierChild4" presStyleCnt="0"/>
      <dgm:spPr/>
    </dgm:pt>
    <dgm:pt modelId="{4A5C067F-FEAA-48F0-96BD-C976B883AD03}" type="pres">
      <dgm:prSet presAssocID="{18F20645-7764-43F0-9163-9C3DC9EAF423}" presName="Name37" presStyleLbl="parChTrans1D4" presStyleIdx="5" presStyleCnt="16"/>
      <dgm:spPr/>
    </dgm:pt>
    <dgm:pt modelId="{2C814EFC-153B-4785-A3CE-5DD59685FE5E}" type="pres">
      <dgm:prSet presAssocID="{406D8CC5-78C9-4B43-BDE8-4BE5804CEA04}" presName="hierRoot2" presStyleCnt="0">
        <dgm:presLayoutVars>
          <dgm:hierBranch val="init"/>
        </dgm:presLayoutVars>
      </dgm:prSet>
      <dgm:spPr/>
    </dgm:pt>
    <dgm:pt modelId="{750B0FC5-A6CF-46AF-B159-3DF03239E033}" type="pres">
      <dgm:prSet presAssocID="{406D8CC5-78C9-4B43-BDE8-4BE5804CEA04}" presName="rootComposite" presStyleCnt="0"/>
      <dgm:spPr/>
    </dgm:pt>
    <dgm:pt modelId="{8325B952-ADFE-4612-856B-08695AAA247D}" type="pres">
      <dgm:prSet presAssocID="{406D8CC5-78C9-4B43-BDE8-4BE5804CEA04}" presName="rootText" presStyleLbl="node4" presStyleIdx="5" presStyleCnt="16" custScaleY="142876" custLinFactNeighborY="4132">
        <dgm:presLayoutVars>
          <dgm:chPref val="3"/>
        </dgm:presLayoutVars>
      </dgm:prSet>
      <dgm:spPr/>
    </dgm:pt>
    <dgm:pt modelId="{0B88337F-9D65-422A-B934-C9A276470656}" type="pres">
      <dgm:prSet presAssocID="{406D8CC5-78C9-4B43-BDE8-4BE5804CEA04}" presName="rootConnector" presStyleLbl="node4" presStyleIdx="5" presStyleCnt="16"/>
      <dgm:spPr/>
    </dgm:pt>
    <dgm:pt modelId="{B670C011-D1C4-408A-9650-A6CD88DA3311}" type="pres">
      <dgm:prSet presAssocID="{406D8CC5-78C9-4B43-BDE8-4BE5804CEA04}" presName="hierChild4" presStyleCnt="0"/>
      <dgm:spPr/>
    </dgm:pt>
    <dgm:pt modelId="{19F787B1-4285-40D5-A18E-FE58585EB3EA}" type="pres">
      <dgm:prSet presAssocID="{36A51C83-6AE4-4C7F-B92D-66DA6A6372CE}" presName="Name37" presStyleLbl="parChTrans1D4" presStyleIdx="6" presStyleCnt="16"/>
      <dgm:spPr/>
    </dgm:pt>
    <dgm:pt modelId="{A2EE4AA3-5240-40E4-A00C-BDED462B1FE6}" type="pres">
      <dgm:prSet presAssocID="{08C5AF4C-1B14-41B0-9771-7EBCD0929A3D}" presName="hierRoot2" presStyleCnt="0">
        <dgm:presLayoutVars>
          <dgm:hierBranch val="init"/>
        </dgm:presLayoutVars>
      </dgm:prSet>
      <dgm:spPr/>
    </dgm:pt>
    <dgm:pt modelId="{18D96C6D-3F0D-4F37-BFF0-2495EC9FC332}" type="pres">
      <dgm:prSet presAssocID="{08C5AF4C-1B14-41B0-9771-7EBCD0929A3D}" presName="rootComposite" presStyleCnt="0"/>
      <dgm:spPr/>
    </dgm:pt>
    <dgm:pt modelId="{765E4F2B-E403-446B-A07D-1C67F1398557}" type="pres">
      <dgm:prSet presAssocID="{08C5AF4C-1B14-41B0-9771-7EBCD0929A3D}" presName="rootText" presStyleLbl="node4" presStyleIdx="6" presStyleCnt="16" custScaleX="111218" custScaleY="165285" custLinFactNeighborY="29146">
        <dgm:presLayoutVars>
          <dgm:chPref val="3"/>
        </dgm:presLayoutVars>
      </dgm:prSet>
      <dgm:spPr/>
    </dgm:pt>
    <dgm:pt modelId="{39B12912-CB9D-4827-8B54-2FC5C8E01B9F}" type="pres">
      <dgm:prSet presAssocID="{08C5AF4C-1B14-41B0-9771-7EBCD0929A3D}" presName="rootConnector" presStyleLbl="node4" presStyleIdx="6" presStyleCnt="16"/>
      <dgm:spPr/>
    </dgm:pt>
    <dgm:pt modelId="{B9E0BA34-B290-415C-BB46-0772C6B4E0CF}" type="pres">
      <dgm:prSet presAssocID="{08C5AF4C-1B14-41B0-9771-7EBCD0929A3D}" presName="hierChild4" presStyleCnt="0"/>
      <dgm:spPr/>
    </dgm:pt>
    <dgm:pt modelId="{ACDA745B-C116-4217-B3C6-2ACFED7CAB73}" type="pres">
      <dgm:prSet presAssocID="{08C5AF4C-1B14-41B0-9771-7EBCD0929A3D}" presName="hierChild5" presStyleCnt="0"/>
      <dgm:spPr/>
    </dgm:pt>
    <dgm:pt modelId="{AC36F49D-E3BB-437E-ADDF-0936C7DCE46F}" type="pres">
      <dgm:prSet presAssocID="{406D8CC5-78C9-4B43-BDE8-4BE5804CEA04}" presName="hierChild5" presStyleCnt="0"/>
      <dgm:spPr/>
    </dgm:pt>
    <dgm:pt modelId="{98026F8C-44C8-445C-A43A-3675FF2FF054}" type="pres">
      <dgm:prSet presAssocID="{52154CCD-C50F-4D8D-9A4D-62AFF7D488F1}" presName="Name37" presStyleLbl="parChTrans1D4" presStyleIdx="7" presStyleCnt="16"/>
      <dgm:spPr/>
    </dgm:pt>
    <dgm:pt modelId="{087C07FD-A518-440C-87AD-772923F59E5B}" type="pres">
      <dgm:prSet presAssocID="{98EC778F-CAF8-4E63-A99F-097796D79286}" presName="hierRoot2" presStyleCnt="0">
        <dgm:presLayoutVars>
          <dgm:hierBranch val="init"/>
        </dgm:presLayoutVars>
      </dgm:prSet>
      <dgm:spPr/>
    </dgm:pt>
    <dgm:pt modelId="{480D0C00-1E82-488A-B442-6D592E18F16C}" type="pres">
      <dgm:prSet presAssocID="{98EC778F-CAF8-4E63-A99F-097796D79286}" presName="rootComposite" presStyleCnt="0"/>
      <dgm:spPr/>
    </dgm:pt>
    <dgm:pt modelId="{A458EDC1-D4A9-4E83-B3D9-1337FCD6336E}" type="pres">
      <dgm:prSet presAssocID="{98EC778F-CAF8-4E63-A99F-097796D79286}" presName="rootText" presStyleLbl="node4" presStyleIdx="7" presStyleCnt="16" custScaleY="142876" custLinFactNeighborY="4132">
        <dgm:presLayoutVars>
          <dgm:chPref val="3"/>
        </dgm:presLayoutVars>
      </dgm:prSet>
      <dgm:spPr/>
    </dgm:pt>
    <dgm:pt modelId="{B9FCC3FA-094E-47AD-A43F-10C485D8E237}" type="pres">
      <dgm:prSet presAssocID="{98EC778F-CAF8-4E63-A99F-097796D79286}" presName="rootConnector" presStyleLbl="node4" presStyleIdx="7" presStyleCnt="16"/>
      <dgm:spPr/>
    </dgm:pt>
    <dgm:pt modelId="{A22749D5-7F38-45A7-A9DD-B33265A9444C}" type="pres">
      <dgm:prSet presAssocID="{98EC778F-CAF8-4E63-A99F-097796D79286}" presName="hierChild4" presStyleCnt="0"/>
      <dgm:spPr/>
    </dgm:pt>
    <dgm:pt modelId="{8CB00494-7F74-4467-A3BD-5E2ABAF8B091}" type="pres">
      <dgm:prSet presAssocID="{15AFF031-A5C1-4EBA-AE0C-FA89BF21DCD1}" presName="Name37" presStyleLbl="parChTrans1D4" presStyleIdx="8" presStyleCnt="16"/>
      <dgm:spPr/>
    </dgm:pt>
    <dgm:pt modelId="{B60FFF0B-C117-4A61-864D-ADE17A9EA5B9}" type="pres">
      <dgm:prSet presAssocID="{967E51DC-DAFD-4334-BA70-BAFEED137B42}" presName="hierRoot2" presStyleCnt="0">
        <dgm:presLayoutVars>
          <dgm:hierBranch val="init"/>
        </dgm:presLayoutVars>
      </dgm:prSet>
      <dgm:spPr/>
    </dgm:pt>
    <dgm:pt modelId="{A2F2D1A3-B6D3-4323-8440-D5673C97A4E7}" type="pres">
      <dgm:prSet presAssocID="{967E51DC-DAFD-4334-BA70-BAFEED137B42}" presName="rootComposite" presStyleCnt="0"/>
      <dgm:spPr/>
    </dgm:pt>
    <dgm:pt modelId="{84ECF355-7DD3-4860-A18D-4CDD20866068}" type="pres">
      <dgm:prSet presAssocID="{967E51DC-DAFD-4334-BA70-BAFEED137B42}" presName="rootText" presStyleLbl="node4" presStyleIdx="8" presStyleCnt="16" custScaleX="108101" custScaleY="170261" custLinFactNeighborY="22726">
        <dgm:presLayoutVars>
          <dgm:chPref val="3"/>
        </dgm:presLayoutVars>
      </dgm:prSet>
      <dgm:spPr/>
    </dgm:pt>
    <dgm:pt modelId="{052E7182-A4A9-4292-A937-78185AFB7B85}" type="pres">
      <dgm:prSet presAssocID="{967E51DC-DAFD-4334-BA70-BAFEED137B42}" presName="rootConnector" presStyleLbl="node4" presStyleIdx="8" presStyleCnt="16"/>
      <dgm:spPr/>
    </dgm:pt>
    <dgm:pt modelId="{2DE09D10-E54C-4D6C-A141-3BA1DC724018}" type="pres">
      <dgm:prSet presAssocID="{967E51DC-DAFD-4334-BA70-BAFEED137B42}" presName="hierChild4" presStyleCnt="0"/>
      <dgm:spPr/>
    </dgm:pt>
    <dgm:pt modelId="{907FC41C-A721-498A-AECD-ED77F1D5B9D4}" type="pres">
      <dgm:prSet presAssocID="{967E51DC-DAFD-4334-BA70-BAFEED137B42}" presName="hierChild5" presStyleCnt="0"/>
      <dgm:spPr/>
    </dgm:pt>
    <dgm:pt modelId="{51F999EF-5198-4604-9932-B54113933E43}" type="pres">
      <dgm:prSet presAssocID="{234C6499-965E-4A1C-AD6B-41DBACE3B9DD}" presName="Name37" presStyleLbl="parChTrans1D4" presStyleIdx="9" presStyleCnt="16"/>
      <dgm:spPr/>
    </dgm:pt>
    <dgm:pt modelId="{97EF0324-4423-4D69-A166-3FA5AC6CA5A7}" type="pres">
      <dgm:prSet presAssocID="{F20E12C0-1577-4413-9C78-797ED501311E}" presName="hierRoot2" presStyleCnt="0">
        <dgm:presLayoutVars>
          <dgm:hierBranch val="init"/>
        </dgm:presLayoutVars>
      </dgm:prSet>
      <dgm:spPr/>
    </dgm:pt>
    <dgm:pt modelId="{B0C66A13-5826-48B1-9646-C2CB4BC6FEED}" type="pres">
      <dgm:prSet presAssocID="{F20E12C0-1577-4413-9C78-797ED501311E}" presName="rootComposite" presStyleCnt="0"/>
      <dgm:spPr/>
    </dgm:pt>
    <dgm:pt modelId="{8766715A-D510-4EE8-AD86-94BC512AC9E6}" type="pres">
      <dgm:prSet presAssocID="{F20E12C0-1577-4413-9C78-797ED501311E}" presName="rootText" presStyleLbl="node4" presStyleIdx="9" presStyleCnt="16" custScaleX="106480" custScaleY="140788" custLinFactNeighborY="22726">
        <dgm:presLayoutVars>
          <dgm:chPref val="3"/>
        </dgm:presLayoutVars>
      </dgm:prSet>
      <dgm:spPr/>
    </dgm:pt>
    <dgm:pt modelId="{507C2284-9152-4E39-973E-897171EB7CBA}" type="pres">
      <dgm:prSet presAssocID="{F20E12C0-1577-4413-9C78-797ED501311E}" presName="rootConnector" presStyleLbl="node4" presStyleIdx="9" presStyleCnt="16"/>
      <dgm:spPr/>
    </dgm:pt>
    <dgm:pt modelId="{0A43A259-7C18-4EFF-A8A5-308E6DA3EAB2}" type="pres">
      <dgm:prSet presAssocID="{F20E12C0-1577-4413-9C78-797ED501311E}" presName="hierChild4" presStyleCnt="0"/>
      <dgm:spPr/>
    </dgm:pt>
    <dgm:pt modelId="{3D2C1DCE-5652-4192-A86D-CA5825EB4F1A}" type="pres">
      <dgm:prSet presAssocID="{F20E12C0-1577-4413-9C78-797ED501311E}" presName="hierChild5" presStyleCnt="0"/>
      <dgm:spPr/>
    </dgm:pt>
    <dgm:pt modelId="{4684B430-7C74-4512-A400-9E8B497CA81D}" type="pres">
      <dgm:prSet presAssocID="{98EC778F-CAF8-4E63-A99F-097796D79286}" presName="hierChild5" presStyleCnt="0"/>
      <dgm:spPr/>
    </dgm:pt>
    <dgm:pt modelId="{3720040D-3AE9-4331-B7F0-6E6FC0A11B66}" type="pres">
      <dgm:prSet presAssocID="{0E694C0F-8AB1-4632-B2DA-D1247D8BE18F}" presName="hierChild5" presStyleCnt="0"/>
      <dgm:spPr/>
    </dgm:pt>
    <dgm:pt modelId="{47FB9601-75D0-40F0-80FD-CB6CE639BD01}" type="pres">
      <dgm:prSet presAssocID="{8E83BC88-359D-47C4-9BBC-5EFD9E609921}" presName="hierChild5" presStyleCnt="0"/>
      <dgm:spPr/>
    </dgm:pt>
    <dgm:pt modelId="{A34C4E21-1952-4E8E-9318-1E0F6325910B}" type="pres">
      <dgm:prSet presAssocID="{DD8232B4-3BCE-40FA-A9D1-F6EE9E34EB34}" presName="Name37" presStyleLbl="parChTrans1D2" presStyleIdx="1" presStyleCnt="3"/>
      <dgm:spPr/>
    </dgm:pt>
    <dgm:pt modelId="{C0C776D2-B6FD-4813-A723-50E62672EB30}" type="pres">
      <dgm:prSet presAssocID="{6F8E4E8F-2702-4226-B47E-68170BE88C0D}" presName="hierRoot2" presStyleCnt="0">
        <dgm:presLayoutVars>
          <dgm:hierBranch val="init"/>
        </dgm:presLayoutVars>
      </dgm:prSet>
      <dgm:spPr/>
    </dgm:pt>
    <dgm:pt modelId="{DBA89F9D-73E8-4A0D-8327-077481BD0AEC}" type="pres">
      <dgm:prSet presAssocID="{6F8E4E8F-2702-4226-B47E-68170BE88C0D}" presName="rootComposite" presStyleCnt="0"/>
      <dgm:spPr/>
    </dgm:pt>
    <dgm:pt modelId="{D29044B6-296F-43E9-9A97-6C76EB922610}" type="pres">
      <dgm:prSet presAssocID="{6F8E4E8F-2702-4226-B47E-68170BE88C0D}" presName="rootText" presStyleLbl="node2" presStyleIdx="1" presStyleCnt="2" custScaleX="234409" custLinFactNeighborY="-6844">
        <dgm:presLayoutVars>
          <dgm:chPref val="3"/>
        </dgm:presLayoutVars>
      </dgm:prSet>
      <dgm:spPr/>
    </dgm:pt>
    <dgm:pt modelId="{A054C64C-5610-4BB3-99DE-F3FB705E364F}" type="pres">
      <dgm:prSet presAssocID="{6F8E4E8F-2702-4226-B47E-68170BE88C0D}" presName="rootConnector" presStyleLbl="node2" presStyleIdx="1" presStyleCnt="2"/>
      <dgm:spPr/>
    </dgm:pt>
    <dgm:pt modelId="{223A5FD3-3627-4485-AE36-0CC4C7731A2C}" type="pres">
      <dgm:prSet presAssocID="{6F8E4E8F-2702-4226-B47E-68170BE88C0D}" presName="hierChild4" presStyleCnt="0"/>
      <dgm:spPr/>
    </dgm:pt>
    <dgm:pt modelId="{3967BE9E-1271-4178-BBCF-D43AA34D64C1}" type="pres">
      <dgm:prSet presAssocID="{7AADD620-BE27-4CB5-8F13-7068209BE0C5}" presName="Name37" presStyleLbl="parChTrans1D3" presStyleIdx="2" presStyleCnt="4"/>
      <dgm:spPr/>
    </dgm:pt>
    <dgm:pt modelId="{6B1B42A0-991C-47C1-AD45-D36147154766}" type="pres">
      <dgm:prSet presAssocID="{AFFD01EC-C5E6-4176-BD08-620332168957}" presName="hierRoot2" presStyleCnt="0">
        <dgm:presLayoutVars>
          <dgm:hierBranch val="init"/>
        </dgm:presLayoutVars>
      </dgm:prSet>
      <dgm:spPr/>
    </dgm:pt>
    <dgm:pt modelId="{12D7D4C6-B926-43DD-B16B-137ACE55459B}" type="pres">
      <dgm:prSet presAssocID="{AFFD01EC-C5E6-4176-BD08-620332168957}" presName="rootComposite" presStyleCnt="0"/>
      <dgm:spPr/>
    </dgm:pt>
    <dgm:pt modelId="{F3963130-01C5-4F4B-8C80-55CA0768ED6D}" type="pres">
      <dgm:prSet presAssocID="{AFFD01EC-C5E6-4176-BD08-620332168957}" presName="rootText" presStyleLbl="node3" presStyleIdx="2" presStyleCnt="4" custScaleX="177716" custScaleY="120344">
        <dgm:presLayoutVars>
          <dgm:chPref val="3"/>
        </dgm:presLayoutVars>
      </dgm:prSet>
      <dgm:spPr/>
    </dgm:pt>
    <dgm:pt modelId="{54540217-D25C-482C-9400-2728C8279265}" type="pres">
      <dgm:prSet presAssocID="{AFFD01EC-C5E6-4176-BD08-620332168957}" presName="rootConnector" presStyleLbl="node3" presStyleIdx="2" presStyleCnt="4"/>
      <dgm:spPr/>
    </dgm:pt>
    <dgm:pt modelId="{3072B601-3295-4BFE-999E-17F60EB33BA1}" type="pres">
      <dgm:prSet presAssocID="{AFFD01EC-C5E6-4176-BD08-620332168957}" presName="hierChild4" presStyleCnt="0"/>
      <dgm:spPr/>
    </dgm:pt>
    <dgm:pt modelId="{8A06E381-8819-4037-A125-902EA70F0BD6}" type="pres">
      <dgm:prSet presAssocID="{7FE9781B-758D-43A9-BF49-F99B7DA53302}" presName="Name37" presStyleLbl="parChTrans1D4" presStyleIdx="10" presStyleCnt="16"/>
      <dgm:spPr/>
    </dgm:pt>
    <dgm:pt modelId="{89760EFB-4C29-48C8-BCB6-86D811875309}" type="pres">
      <dgm:prSet presAssocID="{1FBCC1F0-E3EC-4DCD-8958-8723179380D0}" presName="hierRoot2" presStyleCnt="0">
        <dgm:presLayoutVars>
          <dgm:hierBranch val="init"/>
        </dgm:presLayoutVars>
      </dgm:prSet>
      <dgm:spPr/>
    </dgm:pt>
    <dgm:pt modelId="{F1012AB4-6951-42DE-A288-0F784ED23728}" type="pres">
      <dgm:prSet presAssocID="{1FBCC1F0-E3EC-4DCD-8958-8723179380D0}" presName="rootComposite" presStyleCnt="0"/>
      <dgm:spPr/>
    </dgm:pt>
    <dgm:pt modelId="{FEEE0391-2F66-4C25-B135-60F552ABA19C}" type="pres">
      <dgm:prSet presAssocID="{1FBCC1F0-E3EC-4DCD-8958-8723179380D0}" presName="rootText" presStyleLbl="node4" presStyleIdx="10" presStyleCnt="16" custScaleY="142876" custLinFactNeighborY="4132">
        <dgm:presLayoutVars>
          <dgm:chPref val="3"/>
        </dgm:presLayoutVars>
      </dgm:prSet>
      <dgm:spPr/>
    </dgm:pt>
    <dgm:pt modelId="{60E711BD-EF5A-4B03-B99F-FDA386DAAAC5}" type="pres">
      <dgm:prSet presAssocID="{1FBCC1F0-E3EC-4DCD-8958-8723179380D0}" presName="rootConnector" presStyleLbl="node4" presStyleIdx="10" presStyleCnt="16"/>
      <dgm:spPr/>
    </dgm:pt>
    <dgm:pt modelId="{19D00B09-4BA9-40A2-93DA-08BC8B7B3F08}" type="pres">
      <dgm:prSet presAssocID="{1FBCC1F0-E3EC-4DCD-8958-8723179380D0}" presName="hierChild4" presStyleCnt="0"/>
      <dgm:spPr/>
    </dgm:pt>
    <dgm:pt modelId="{1230424A-EF84-4B61-94B6-A21103AF4BEC}" type="pres">
      <dgm:prSet presAssocID="{0644E4B2-A944-479A-96C3-135272B6EA85}" presName="Name37" presStyleLbl="parChTrans1D4" presStyleIdx="11" presStyleCnt="16"/>
      <dgm:spPr/>
    </dgm:pt>
    <dgm:pt modelId="{20B5AC95-B176-474F-8827-4ECF7F2F0FFB}" type="pres">
      <dgm:prSet presAssocID="{87C7148A-F0C3-445B-A39D-01DE0724E6F2}" presName="hierRoot2" presStyleCnt="0">
        <dgm:presLayoutVars>
          <dgm:hierBranch val="init"/>
        </dgm:presLayoutVars>
      </dgm:prSet>
      <dgm:spPr/>
    </dgm:pt>
    <dgm:pt modelId="{4A66845B-F979-4341-99E0-09091175AA32}" type="pres">
      <dgm:prSet presAssocID="{87C7148A-F0C3-445B-A39D-01DE0724E6F2}" presName="rootComposite" presStyleCnt="0"/>
      <dgm:spPr/>
    </dgm:pt>
    <dgm:pt modelId="{148A377F-FBE0-41AA-9F47-1AD7E47589A0}" type="pres">
      <dgm:prSet presAssocID="{87C7148A-F0C3-445B-A39D-01DE0724E6F2}" presName="rootText" presStyleLbl="node4" presStyleIdx="11" presStyleCnt="16" custScaleX="109933" custScaleY="171416" custLinFactNeighborY="22726">
        <dgm:presLayoutVars>
          <dgm:chPref val="3"/>
        </dgm:presLayoutVars>
      </dgm:prSet>
      <dgm:spPr/>
    </dgm:pt>
    <dgm:pt modelId="{5C142C8B-C534-4D51-A3A2-288A16925F33}" type="pres">
      <dgm:prSet presAssocID="{87C7148A-F0C3-445B-A39D-01DE0724E6F2}" presName="rootConnector" presStyleLbl="node4" presStyleIdx="11" presStyleCnt="16"/>
      <dgm:spPr/>
    </dgm:pt>
    <dgm:pt modelId="{96683D4B-DACA-4D4F-9786-7413C95D3A38}" type="pres">
      <dgm:prSet presAssocID="{87C7148A-F0C3-445B-A39D-01DE0724E6F2}" presName="hierChild4" presStyleCnt="0"/>
      <dgm:spPr/>
    </dgm:pt>
    <dgm:pt modelId="{660DD28E-E052-49E4-A187-5277F8E9DAED}" type="pres">
      <dgm:prSet presAssocID="{87C7148A-F0C3-445B-A39D-01DE0724E6F2}" presName="hierChild5" presStyleCnt="0"/>
      <dgm:spPr/>
    </dgm:pt>
    <dgm:pt modelId="{720F7BE9-AE14-4F37-AB2C-77B79AEA8070}" type="pres">
      <dgm:prSet presAssocID="{1FBCC1F0-E3EC-4DCD-8958-8723179380D0}" presName="hierChild5" presStyleCnt="0"/>
      <dgm:spPr/>
    </dgm:pt>
    <dgm:pt modelId="{862E9566-7B2C-4E20-9072-A206352353D9}" type="pres">
      <dgm:prSet presAssocID="{664A54DC-2232-409D-850E-C500F4B66703}" presName="Name37" presStyleLbl="parChTrans1D4" presStyleIdx="12" presStyleCnt="16"/>
      <dgm:spPr/>
    </dgm:pt>
    <dgm:pt modelId="{C30A18BD-A4F2-4095-A080-21F6B04E3B3F}" type="pres">
      <dgm:prSet presAssocID="{07231A88-C874-4EB5-96BF-70679CFA0F73}" presName="hierRoot2" presStyleCnt="0">
        <dgm:presLayoutVars>
          <dgm:hierBranch val="init"/>
        </dgm:presLayoutVars>
      </dgm:prSet>
      <dgm:spPr/>
    </dgm:pt>
    <dgm:pt modelId="{5CBB7CA5-DED0-4D01-930C-3CA8512F5366}" type="pres">
      <dgm:prSet presAssocID="{07231A88-C874-4EB5-96BF-70679CFA0F73}" presName="rootComposite" presStyleCnt="0"/>
      <dgm:spPr/>
    </dgm:pt>
    <dgm:pt modelId="{EF31350D-14A7-44C8-A461-3E7A3A6B8F1A}" type="pres">
      <dgm:prSet presAssocID="{07231A88-C874-4EB5-96BF-70679CFA0F73}" presName="rootText" presStyleLbl="node4" presStyleIdx="12" presStyleCnt="16" custScaleY="142876" custLinFactNeighborY="4132">
        <dgm:presLayoutVars>
          <dgm:chPref val="3"/>
        </dgm:presLayoutVars>
      </dgm:prSet>
      <dgm:spPr/>
    </dgm:pt>
    <dgm:pt modelId="{A0711F13-4E75-4C6C-B889-A20EAE4F3AEB}" type="pres">
      <dgm:prSet presAssocID="{07231A88-C874-4EB5-96BF-70679CFA0F73}" presName="rootConnector" presStyleLbl="node4" presStyleIdx="12" presStyleCnt="16"/>
      <dgm:spPr/>
    </dgm:pt>
    <dgm:pt modelId="{8F44FF39-E9D5-48BB-AB19-4EAB28B092EA}" type="pres">
      <dgm:prSet presAssocID="{07231A88-C874-4EB5-96BF-70679CFA0F73}" presName="hierChild4" presStyleCnt="0"/>
      <dgm:spPr/>
    </dgm:pt>
    <dgm:pt modelId="{E3C6DA40-0164-4E21-A22C-6CE63583D97D}" type="pres">
      <dgm:prSet presAssocID="{A12224F7-2DFB-44CA-86DF-11C60E308278}" presName="Name37" presStyleLbl="parChTrans1D4" presStyleIdx="13" presStyleCnt="16"/>
      <dgm:spPr/>
    </dgm:pt>
    <dgm:pt modelId="{275CA3C6-9FF7-4BAD-9FB9-2136FFC4B979}" type="pres">
      <dgm:prSet presAssocID="{5DA4B7B4-A002-442D-8908-F302D486C218}" presName="hierRoot2" presStyleCnt="0">
        <dgm:presLayoutVars>
          <dgm:hierBranch val="init"/>
        </dgm:presLayoutVars>
      </dgm:prSet>
      <dgm:spPr/>
    </dgm:pt>
    <dgm:pt modelId="{6C218261-1D93-43D0-A2FC-479208F5E867}" type="pres">
      <dgm:prSet presAssocID="{5DA4B7B4-A002-442D-8908-F302D486C218}" presName="rootComposite" presStyleCnt="0"/>
      <dgm:spPr/>
    </dgm:pt>
    <dgm:pt modelId="{AF4ED730-3812-4A53-9CB4-52489E7CD8D0}" type="pres">
      <dgm:prSet presAssocID="{5DA4B7B4-A002-442D-8908-F302D486C218}" presName="rootText" presStyleLbl="node4" presStyleIdx="13" presStyleCnt="16" custScaleX="125120" custScaleY="170115" custLinFactNeighborY="22726">
        <dgm:presLayoutVars>
          <dgm:chPref val="3"/>
        </dgm:presLayoutVars>
      </dgm:prSet>
      <dgm:spPr/>
    </dgm:pt>
    <dgm:pt modelId="{2B200D36-77CA-4FDF-8C79-0399DDE7CCE7}" type="pres">
      <dgm:prSet presAssocID="{5DA4B7B4-A002-442D-8908-F302D486C218}" presName="rootConnector" presStyleLbl="node4" presStyleIdx="13" presStyleCnt="16"/>
      <dgm:spPr/>
    </dgm:pt>
    <dgm:pt modelId="{23120E76-D6D5-4C9A-838B-9EF6E87C0967}" type="pres">
      <dgm:prSet presAssocID="{5DA4B7B4-A002-442D-8908-F302D486C218}" presName="hierChild4" presStyleCnt="0"/>
      <dgm:spPr/>
    </dgm:pt>
    <dgm:pt modelId="{482686A4-B53D-4B3A-9B73-49C1E9400922}" type="pres">
      <dgm:prSet presAssocID="{5DA4B7B4-A002-442D-8908-F302D486C218}" presName="hierChild5" presStyleCnt="0"/>
      <dgm:spPr/>
    </dgm:pt>
    <dgm:pt modelId="{62724D82-971F-4B96-8488-86B7ECC1E3B5}" type="pres">
      <dgm:prSet presAssocID="{07231A88-C874-4EB5-96BF-70679CFA0F73}" presName="hierChild5" presStyleCnt="0"/>
      <dgm:spPr/>
    </dgm:pt>
    <dgm:pt modelId="{3F96B487-6BDE-46D3-9829-B49F1F94E8E5}" type="pres">
      <dgm:prSet presAssocID="{AFFD01EC-C5E6-4176-BD08-620332168957}" presName="hierChild5" presStyleCnt="0"/>
      <dgm:spPr/>
    </dgm:pt>
    <dgm:pt modelId="{ADF92AF4-0D65-40DE-8D71-D58D9EEA2B1F}" type="pres">
      <dgm:prSet presAssocID="{19FF45C4-3579-490B-A008-D47EF4CD004F}" presName="Name37" presStyleLbl="parChTrans1D3" presStyleIdx="3" presStyleCnt="4"/>
      <dgm:spPr/>
    </dgm:pt>
    <dgm:pt modelId="{A3979363-5C51-45D1-9B04-88AB11B6A951}" type="pres">
      <dgm:prSet presAssocID="{DDF8FFD9-511F-4065-B81C-2BDE61A38242}" presName="hierRoot2" presStyleCnt="0">
        <dgm:presLayoutVars>
          <dgm:hierBranch val="init"/>
        </dgm:presLayoutVars>
      </dgm:prSet>
      <dgm:spPr/>
    </dgm:pt>
    <dgm:pt modelId="{8F63FCDB-12E4-41A1-9C12-376835AFC24C}" type="pres">
      <dgm:prSet presAssocID="{DDF8FFD9-511F-4065-B81C-2BDE61A38242}" presName="rootComposite" presStyleCnt="0"/>
      <dgm:spPr/>
    </dgm:pt>
    <dgm:pt modelId="{9735BBE2-731E-4A6A-A9DC-FABB30A5B699}" type="pres">
      <dgm:prSet presAssocID="{DDF8FFD9-511F-4065-B81C-2BDE61A38242}" presName="rootText" presStyleLbl="node3" presStyleIdx="3" presStyleCnt="4" custScaleX="193088" custScaleY="120344">
        <dgm:presLayoutVars>
          <dgm:chPref val="3"/>
        </dgm:presLayoutVars>
      </dgm:prSet>
      <dgm:spPr/>
    </dgm:pt>
    <dgm:pt modelId="{0E1B9CD5-FDC2-4DA7-A527-596D7E53B6A0}" type="pres">
      <dgm:prSet presAssocID="{DDF8FFD9-511F-4065-B81C-2BDE61A38242}" presName="rootConnector" presStyleLbl="node3" presStyleIdx="3" presStyleCnt="4"/>
      <dgm:spPr/>
    </dgm:pt>
    <dgm:pt modelId="{A919E197-3725-4185-B9D5-79210BB8F151}" type="pres">
      <dgm:prSet presAssocID="{DDF8FFD9-511F-4065-B81C-2BDE61A38242}" presName="hierChild4" presStyleCnt="0"/>
      <dgm:spPr/>
    </dgm:pt>
    <dgm:pt modelId="{98947DF3-F26C-4AA9-A2A9-A7D9763CF728}" type="pres">
      <dgm:prSet presAssocID="{E5C4179A-71E8-45A5-B4BC-AF19A0263B90}" presName="Name37" presStyleLbl="parChTrans1D4" presStyleIdx="14" presStyleCnt="16"/>
      <dgm:spPr/>
    </dgm:pt>
    <dgm:pt modelId="{7C26DFB7-6126-4CC0-B2FA-D1E7734D9148}" type="pres">
      <dgm:prSet presAssocID="{2FEE63E5-11CD-444D-8D11-C0DC2DC8DF75}" presName="hierRoot2" presStyleCnt="0">
        <dgm:presLayoutVars>
          <dgm:hierBranch val="init"/>
        </dgm:presLayoutVars>
      </dgm:prSet>
      <dgm:spPr/>
    </dgm:pt>
    <dgm:pt modelId="{3919AEF1-18DB-4724-9EDD-3BC181EC3339}" type="pres">
      <dgm:prSet presAssocID="{2FEE63E5-11CD-444D-8D11-C0DC2DC8DF75}" presName="rootComposite" presStyleCnt="0"/>
      <dgm:spPr/>
    </dgm:pt>
    <dgm:pt modelId="{7608DE48-B886-49F4-839C-63DDC3306FE1}" type="pres">
      <dgm:prSet presAssocID="{2FEE63E5-11CD-444D-8D11-C0DC2DC8DF75}" presName="rootText" presStyleLbl="node4" presStyleIdx="14" presStyleCnt="16" custScaleY="142876" custLinFactNeighborY="2066">
        <dgm:presLayoutVars>
          <dgm:chPref val="3"/>
        </dgm:presLayoutVars>
      </dgm:prSet>
      <dgm:spPr/>
    </dgm:pt>
    <dgm:pt modelId="{6FEDFC57-8674-49DE-8913-5BF6C3337ADF}" type="pres">
      <dgm:prSet presAssocID="{2FEE63E5-11CD-444D-8D11-C0DC2DC8DF75}" presName="rootConnector" presStyleLbl="node4" presStyleIdx="14" presStyleCnt="16"/>
      <dgm:spPr/>
    </dgm:pt>
    <dgm:pt modelId="{D9CF026C-5730-4E63-8B31-29296DD0A140}" type="pres">
      <dgm:prSet presAssocID="{2FEE63E5-11CD-444D-8D11-C0DC2DC8DF75}" presName="hierChild4" presStyleCnt="0"/>
      <dgm:spPr/>
    </dgm:pt>
    <dgm:pt modelId="{B4664688-559F-4662-A72A-DF835209CD27}" type="pres">
      <dgm:prSet presAssocID="{225A9166-8B18-4E7E-9D25-0E123E908A76}" presName="Name37" presStyleLbl="parChTrans1D4" presStyleIdx="15" presStyleCnt="16"/>
      <dgm:spPr/>
    </dgm:pt>
    <dgm:pt modelId="{BA3C62C7-309C-4326-9B03-2895ADB525F4}" type="pres">
      <dgm:prSet presAssocID="{C3011BAC-C634-4F6A-B626-BB4C0EF26321}" presName="hierRoot2" presStyleCnt="0">
        <dgm:presLayoutVars>
          <dgm:hierBranch val="init"/>
        </dgm:presLayoutVars>
      </dgm:prSet>
      <dgm:spPr/>
    </dgm:pt>
    <dgm:pt modelId="{8ECB819B-55FA-406E-B3A9-1B9D552DD96D}" type="pres">
      <dgm:prSet presAssocID="{C3011BAC-C634-4F6A-B626-BB4C0EF26321}" presName="rootComposite" presStyleCnt="0"/>
      <dgm:spPr/>
    </dgm:pt>
    <dgm:pt modelId="{BD750659-6154-46D5-BA03-1754BA762AEF}" type="pres">
      <dgm:prSet presAssocID="{C3011BAC-C634-4F6A-B626-BB4C0EF26321}" presName="rootText" presStyleLbl="node4" presStyleIdx="15" presStyleCnt="16" custScaleX="124795" custScaleY="170817" custLinFactNeighborY="22726">
        <dgm:presLayoutVars>
          <dgm:chPref val="3"/>
        </dgm:presLayoutVars>
      </dgm:prSet>
      <dgm:spPr/>
    </dgm:pt>
    <dgm:pt modelId="{F37FF3B3-7FDA-4BD1-B6C6-904B1B101FA4}" type="pres">
      <dgm:prSet presAssocID="{C3011BAC-C634-4F6A-B626-BB4C0EF26321}" presName="rootConnector" presStyleLbl="node4" presStyleIdx="15" presStyleCnt="16"/>
      <dgm:spPr/>
    </dgm:pt>
    <dgm:pt modelId="{5C50C3BA-09B3-41FC-AF41-D602E80403B4}" type="pres">
      <dgm:prSet presAssocID="{C3011BAC-C634-4F6A-B626-BB4C0EF26321}" presName="hierChild4" presStyleCnt="0"/>
      <dgm:spPr/>
    </dgm:pt>
    <dgm:pt modelId="{BF19FAC6-4B32-48C8-8F43-FDCE8ADEC8E6}" type="pres">
      <dgm:prSet presAssocID="{C3011BAC-C634-4F6A-B626-BB4C0EF26321}" presName="hierChild5" presStyleCnt="0"/>
      <dgm:spPr/>
    </dgm:pt>
    <dgm:pt modelId="{3F1C98B9-75BC-4603-B00E-2AC51D6EEA91}" type="pres">
      <dgm:prSet presAssocID="{2FEE63E5-11CD-444D-8D11-C0DC2DC8DF75}" presName="hierChild5" presStyleCnt="0"/>
      <dgm:spPr/>
    </dgm:pt>
    <dgm:pt modelId="{7671C0A1-4FA8-4929-B6E0-CFF8755448F4}" type="pres">
      <dgm:prSet presAssocID="{DDF8FFD9-511F-4065-B81C-2BDE61A38242}" presName="hierChild5" presStyleCnt="0"/>
      <dgm:spPr/>
    </dgm:pt>
    <dgm:pt modelId="{81465FEB-EE36-435D-81BF-7B2635A2FE04}" type="pres">
      <dgm:prSet presAssocID="{6F8E4E8F-2702-4226-B47E-68170BE88C0D}" presName="hierChild5" presStyleCnt="0"/>
      <dgm:spPr/>
    </dgm:pt>
    <dgm:pt modelId="{95B5BBEB-17E4-4B5B-83D2-81DDC4ED57BB}" type="pres">
      <dgm:prSet presAssocID="{AE8828E0-C571-4F8A-9003-C6EADEAC1B46}" presName="hierChild3" presStyleCnt="0"/>
      <dgm:spPr/>
    </dgm:pt>
    <dgm:pt modelId="{5B8F574D-2549-48EE-A494-3BDF5EFAFDFB}" type="pres">
      <dgm:prSet presAssocID="{70077C60-346B-48F3-A4A6-74BBDB759C76}" presName="Name111" presStyleLbl="parChTrans1D2" presStyleIdx="2" presStyleCnt="3"/>
      <dgm:spPr/>
    </dgm:pt>
    <dgm:pt modelId="{CBBAE37C-EB00-4ED5-B7A4-993A7D7D2827}" type="pres">
      <dgm:prSet presAssocID="{BFF39B8D-4745-486C-BE1F-E29AF29508A6}" presName="hierRoot3" presStyleCnt="0">
        <dgm:presLayoutVars>
          <dgm:hierBranch val="init"/>
        </dgm:presLayoutVars>
      </dgm:prSet>
      <dgm:spPr/>
    </dgm:pt>
    <dgm:pt modelId="{BEAFE833-502B-4DB3-90FA-0A2D4FA2E75C}" type="pres">
      <dgm:prSet presAssocID="{BFF39B8D-4745-486C-BE1F-E29AF29508A6}" presName="rootComposite3" presStyleCnt="0"/>
      <dgm:spPr/>
    </dgm:pt>
    <dgm:pt modelId="{4F790CF3-DC77-46DD-959C-2556C4356DAC}" type="pres">
      <dgm:prSet presAssocID="{BFF39B8D-4745-486C-BE1F-E29AF29508A6}" presName="rootText3" presStyleLbl="asst1" presStyleIdx="0" presStyleCnt="1" custScaleX="273946" custScaleY="172326" custLinFactX="142288" custLinFactNeighborX="200000" custLinFactNeighborY="-10257">
        <dgm:presLayoutVars>
          <dgm:chPref val="3"/>
        </dgm:presLayoutVars>
      </dgm:prSet>
      <dgm:spPr/>
    </dgm:pt>
    <dgm:pt modelId="{A91D837E-D072-4DD7-B633-05F60A2CBEDD}" type="pres">
      <dgm:prSet presAssocID="{BFF39B8D-4745-486C-BE1F-E29AF29508A6}" presName="rootConnector3" presStyleLbl="asst1" presStyleIdx="0" presStyleCnt="1"/>
      <dgm:spPr/>
    </dgm:pt>
    <dgm:pt modelId="{B7DBF302-AF9D-46BD-A338-181BD46A6831}" type="pres">
      <dgm:prSet presAssocID="{BFF39B8D-4745-486C-BE1F-E29AF29508A6}" presName="hierChild6" presStyleCnt="0"/>
      <dgm:spPr/>
    </dgm:pt>
    <dgm:pt modelId="{7EF8D043-6770-4FEB-8B74-488B9AE9E338}" type="pres">
      <dgm:prSet presAssocID="{BFF39B8D-4745-486C-BE1F-E29AF29508A6}" presName="hierChild7" presStyleCnt="0"/>
      <dgm:spPr/>
    </dgm:pt>
  </dgm:ptLst>
  <dgm:cxnLst>
    <dgm:cxn modelId="{0BA1A701-64D8-4F16-87E6-0F21F3B388CB}" type="presOf" srcId="{F20E12C0-1577-4413-9C78-797ED501311E}" destId="{8766715A-D510-4EE8-AD86-94BC512AC9E6}" srcOrd="0" destOrd="0" presId="urn:microsoft.com/office/officeart/2005/8/layout/orgChart1"/>
    <dgm:cxn modelId="{B37EB204-2508-4E45-BFB4-83ADAD099872}" srcId="{1FBCC1F0-E3EC-4DCD-8958-8723179380D0}" destId="{87C7148A-F0C3-445B-A39D-01DE0724E6F2}" srcOrd="0" destOrd="0" parTransId="{0644E4B2-A944-479A-96C3-135272B6EA85}" sibTransId="{2340FFFA-3787-4062-A13F-06CF93938761}"/>
    <dgm:cxn modelId="{DD066A06-3E61-4C24-A380-CB6D15D0C7E4}" type="presOf" srcId="{07231A88-C874-4EB5-96BF-70679CFA0F73}" destId="{A0711F13-4E75-4C6C-B889-A20EAE4F3AEB}" srcOrd="1" destOrd="0" presId="urn:microsoft.com/office/officeart/2005/8/layout/orgChart1"/>
    <dgm:cxn modelId="{F053260C-5125-40E2-83C8-B6354C9C4C46}" srcId="{8E83BC88-359D-47C4-9BBC-5EFD9E609921}" destId="{AAC4D152-DFE4-4D71-BCD7-D8DC7E5B64B5}" srcOrd="0" destOrd="0" parTransId="{7FCCC78F-80A8-4888-9D91-58DF6A1A42BD}" sibTransId="{835D1D55-2F16-48B8-97A0-0C788CA076BB}"/>
    <dgm:cxn modelId="{ACC8440D-F0F8-4B23-892C-798056C07BEA}" type="presOf" srcId="{F20E12C0-1577-4413-9C78-797ED501311E}" destId="{507C2284-9152-4E39-973E-897171EB7CBA}" srcOrd="1" destOrd="0" presId="urn:microsoft.com/office/officeart/2005/8/layout/orgChart1"/>
    <dgm:cxn modelId="{E9014414-A709-4B48-8023-8C24E6B53862}" type="presOf" srcId="{E5C4179A-71E8-45A5-B4BC-AF19A0263B90}" destId="{98947DF3-F26C-4AA9-A2A9-A7D9763CF728}" srcOrd="0" destOrd="0" presId="urn:microsoft.com/office/officeart/2005/8/layout/orgChart1"/>
    <dgm:cxn modelId="{821CB117-A5BE-43FE-B43D-FD08C2ED3024}" type="presOf" srcId="{52154CCD-C50F-4D8D-9A4D-62AFF7D488F1}" destId="{98026F8C-44C8-445C-A43A-3675FF2FF054}" srcOrd="0" destOrd="0" presId="urn:microsoft.com/office/officeart/2005/8/layout/orgChart1"/>
    <dgm:cxn modelId="{0A9EA41B-B61D-47AA-94AD-D9D5BAAE0595}" type="presOf" srcId="{1FBCC1F0-E3EC-4DCD-8958-8723179380D0}" destId="{FEEE0391-2F66-4C25-B135-60F552ABA19C}" srcOrd="0" destOrd="0" presId="urn:microsoft.com/office/officeart/2005/8/layout/orgChart1"/>
    <dgm:cxn modelId="{1E9E911C-5D69-4A20-8104-CB8D1A461CBD}" type="presOf" srcId="{87865882-2A58-4BA6-8A69-252504164606}" destId="{E2BB12F0-4365-4D10-BBA4-7BD9CA3A1C8C}" srcOrd="0" destOrd="0" presId="urn:microsoft.com/office/officeart/2005/8/layout/orgChart1"/>
    <dgm:cxn modelId="{2065DB22-B9DC-4AD5-B4CB-BA535DC8151E}" type="presOf" srcId="{2FEE63E5-11CD-444D-8D11-C0DC2DC8DF75}" destId="{6FEDFC57-8674-49DE-8913-5BF6C3337ADF}" srcOrd="1" destOrd="0" presId="urn:microsoft.com/office/officeart/2005/8/layout/orgChart1"/>
    <dgm:cxn modelId="{E2FD0026-969A-437B-AC17-46B9A5B9F38C}" type="presOf" srcId="{87C7148A-F0C3-445B-A39D-01DE0724E6F2}" destId="{148A377F-FBE0-41AA-9F47-1AD7E47589A0}" srcOrd="0" destOrd="0" presId="urn:microsoft.com/office/officeart/2005/8/layout/orgChart1"/>
    <dgm:cxn modelId="{9EE0D62D-7966-448A-9DD4-E76F38F8FA4B}" type="presOf" srcId="{BFF39B8D-4745-486C-BE1F-E29AF29508A6}" destId="{A91D837E-D072-4DD7-B633-05F60A2CBEDD}" srcOrd="1" destOrd="0" presId="urn:microsoft.com/office/officeart/2005/8/layout/orgChart1"/>
    <dgm:cxn modelId="{4E3B132E-5E83-4452-831D-EADDB423A434}" srcId="{AFFD01EC-C5E6-4176-BD08-620332168957}" destId="{1FBCC1F0-E3EC-4DCD-8958-8723179380D0}" srcOrd="0" destOrd="0" parTransId="{7FE9781B-758D-43A9-BF49-F99B7DA53302}" sibTransId="{6A620AB7-A3C0-4989-9D19-BE876326B5B7}"/>
    <dgm:cxn modelId="{943B0732-7AB8-4869-B8A3-C1D94FDAD7D4}" type="presOf" srcId="{941C7643-26C4-48E0-99CB-5FC5DCAC7830}" destId="{1428E6BE-2F58-417D-9CB2-2888832E0161}" srcOrd="0" destOrd="0" presId="urn:microsoft.com/office/officeart/2005/8/layout/orgChart1"/>
    <dgm:cxn modelId="{0E219334-D9B9-42D5-81CF-A63FF425881F}" type="presOf" srcId="{406D8CC5-78C9-4B43-BDE8-4BE5804CEA04}" destId="{0B88337F-9D65-422A-B934-C9A276470656}" srcOrd="1" destOrd="0" presId="urn:microsoft.com/office/officeart/2005/8/layout/orgChart1"/>
    <dgm:cxn modelId="{1C5A713B-44AE-4486-8D63-E8E360F0BDF2}" type="presOf" srcId="{07231A88-C874-4EB5-96BF-70679CFA0F73}" destId="{EF31350D-14A7-44C8-A461-3E7A3A6B8F1A}" srcOrd="0" destOrd="0" presId="urn:microsoft.com/office/officeart/2005/8/layout/orgChart1"/>
    <dgm:cxn modelId="{438FEF3B-B27E-451D-ACFB-E749BCA8C910}" type="presOf" srcId="{AE8828E0-C571-4F8A-9003-C6EADEAC1B46}" destId="{356AF28E-5690-4043-AF44-3ACC12D0BDB0}" srcOrd="0" destOrd="0" presId="urn:microsoft.com/office/officeart/2005/8/layout/orgChart1"/>
    <dgm:cxn modelId="{BD77B140-E536-451C-A2FF-1699BBD35635}" srcId="{AFFD01EC-C5E6-4176-BD08-620332168957}" destId="{07231A88-C874-4EB5-96BF-70679CFA0F73}" srcOrd="1" destOrd="0" parTransId="{664A54DC-2232-409D-850E-C500F4B66703}" sibTransId="{38A255CA-B801-4465-9F05-9B5E885049E8}"/>
    <dgm:cxn modelId="{41BFEB5B-1B65-4111-9D52-F968E86CF25D}" type="presOf" srcId="{DBA59BEF-F7D1-47B1-A43A-3B0DA8C93D02}" destId="{B8C1EDF1-DB2A-4D33-AA78-22955DE770C3}" srcOrd="0" destOrd="0" presId="urn:microsoft.com/office/officeart/2005/8/layout/orgChart1"/>
    <dgm:cxn modelId="{0506235D-C8EB-453A-A3D9-32B951F747DE}" srcId="{98EC778F-CAF8-4E63-A99F-097796D79286}" destId="{F20E12C0-1577-4413-9C78-797ED501311E}" srcOrd="1" destOrd="0" parTransId="{234C6499-965E-4A1C-AD6B-41DBACE3B9DD}" sibTransId="{64430280-6112-4F39-B5B5-3CC456A25121}"/>
    <dgm:cxn modelId="{EE47F85D-811C-47A3-AE46-6667EA124E94}" srcId="{98EC778F-CAF8-4E63-A99F-097796D79286}" destId="{967E51DC-DAFD-4334-BA70-BAFEED137B42}" srcOrd="0" destOrd="0" parTransId="{15AFF031-A5C1-4EBA-AE0C-FA89BF21DCD1}" sibTransId="{307FCAF4-D9AC-484E-B9AA-E20584E8A3A6}"/>
    <dgm:cxn modelId="{B857AE5E-9A02-48AE-BD82-F3FA73908546}" type="presOf" srcId="{1FBCC1F0-E3EC-4DCD-8958-8723179380D0}" destId="{60E711BD-EF5A-4B03-B99F-FDA386DAAAC5}" srcOrd="1" destOrd="0" presId="urn:microsoft.com/office/officeart/2005/8/layout/orgChart1"/>
    <dgm:cxn modelId="{E6375A60-1F0B-408D-A6C8-2C2A9220B18D}" type="presOf" srcId="{AFFD01EC-C5E6-4176-BD08-620332168957}" destId="{54540217-D25C-482C-9400-2728C8279265}" srcOrd="1" destOrd="0" presId="urn:microsoft.com/office/officeart/2005/8/layout/orgChart1"/>
    <dgm:cxn modelId="{297DC841-C465-4448-B21A-7BD2AE080A8C}" srcId="{2FEE63E5-11CD-444D-8D11-C0DC2DC8DF75}" destId="{C3011BAC-C634-4F6A-B626-BB4C0EF26321}" srcOrd="0" destOrd="0" parTransId="{225A9166-8B18-4E7E-9D25-0E123E908A76}" sibTransId="{B68B86C4-3FCA-4B9C-8561-D4B1A910662F}"/>
    <dgm:cxn modelId="{40381D42-CDA4-4DB2-9F1D-1BFC27D776DB}" type="presOf" srcId="{19FF45C4-3579-490B-A008-D47EF4CD004F}" destId="{ADF92AF4-0D65-40DE-8D71-D58D9EEA2B1F}" srcOrd="0" destOrd="0" presId="urn:microsoft.com/office/officeart/2005/8/layout/orgChart1"/>
    <dgm:cxn modelId="{196CB562-9E3B-4CDD-9CF7-292F1DC57520}" type="presOf" srcId="{98EC778F-CAF8-4E63-A99F-097796D79286}" destId="{A458EDC1-D4A9-4E83-B3D9-1337FCD6336E}" srcOrd="0" destOrd="0" presId="urn:microsoft.com/office/officeart/2005/8/layout/orgChart1"/>
    <dgm:cxn modelId="{390EC942-E1C9-4437-8AE2-0CD759B9E6FC}" type="presOf" srcId="{74C2A03C-C688-44D6-BE9F-79D692427471}" destId="{1AAE962B-FC4E-4E88-9802-C684323DA4FE}" srcOrd="0" destOrd="0" presId="urn:microsoft.com/office/officeart/2005/8/layout/orgChart1"/>
    <dgm:cxn modelId="{85893A63-EAE0-47BB-8BDE-C486CADDAE81}" type="presOf" srcId="{5DA4B7B4-A002-442D-8908-F302D486C218}" destId="{AF4ED730-3812-4A53-9CB4-52489E7CD8D0}" srcOrd="0" destOrd="0" presId="urn:microsoft.com/office/officeart/2005/8/layout/orgChart1"/>
    <dgm:cxn modelId="{D2936467-756F-4559-A7FD-4A08561BD574}" type="presOf" srcId="{AAC4D152-DFE4-4D71-BCD7-D8DC7E5B64B5}" destId="{0296FC5F-E378-4904-93B2-00D4ACF73593}" srcOrd="0" destOrd="0" presId="urn:microsoft.com/office/officeart/2005/8/layout/orgChart1"/>
    <dgm:cxn modelId="{66926767-3D67-4592-99F7-E106794C488C}" type="presOf" srcId="{8E83BC88-359D-47C4-9BBC-5EFD9E609921}" destId="{C6924E3E-37F0-45BB-A9D6-33A3FF05B21C}" srcOrd="0" destOrd="0" presId="urn:microsoft.com/office/officeart/2005/8/layout/orgChart1"/>
    <dgm:cxn modelId="{0E5B4B47-2492-40A1-83E6-BD47B39E6303}" srcId="{AAC4D152-DFE4-4D71-BCD7-D8DC7E5B64B5}" destId="{DBA59BEF-F7D1-47B1-A43A-3B0DA8C93D02}" srcOrd="0" destOrd="0" parTransId="{591BECE1-B841-4D57-8D99-F9DC0D22DBF9}" sibTransId="{DFBA63D2-4340-4F0B-9F4C-41BDAD04658C}"/>
    <dgm:cxn modelId="{A3769D68-6972-4F05-83C5-A1AB5B8C3A79}" type="presOf" srcId="{34BEDA4B-4676-4447-BB1C-BF24E40AC4B9}" destId="{DD731950-665B-474A-9284-81BABEADB935}" srcOrd="0" destOrd="0" presId="urn:microsoft.com/office/officeart/2005/8/layout/orgChart1"/>
    <dgm:cxn modelId="{2228A568-E66A-4F2F-8F91-3D65206C145D}" type="presOf" srcId="{6F8E4E8F-2702-4226-B47E-68170BE88C0D}" destId="{D29044B6-296F-43E9-9A97-6C76EB922610}" srcOrd="0" destOrd="0" presId="urn:microsoft.com/office/officeart/2005/8/layout/orgChart1"/>
    <dgm:cxn modelId="{B765374A-13EF-4ACB-BC9E-638AB0AD5889}" type="presOf" srcId="{E86315E3-7891-43B4-99E6-516075C79111}" destId="{35E9E6AB-8EBF-4489-A9AD-B18731334C84}" srcOrd="0" destOrd="0" presId="urn:microsoft.com/office/officeart/2005/8/layout/orgChart1"/>
    <dgm:cxn modelId="{3184C26B-B320-4CA8-A628-A64217B4A891}" srcId="{941C7643-26C4-48E0-99CB-5FC5DCAC7830}" destId="{D8AF9B9F-7B15-49F9-BF7C-6D4318F4863B}" srcOrd="0" destOrd="0" parTransId="{74C2A03C-C688-44D6-BE9F-79D692427471}" sibTransId="{2E74A5D7-2717-46EF-AD36-086EE5C2C81E}"/>
    <dgm:cxn modelId="{5E70174C-6009-4769-8D39-AFF08AF778BD}" srcId="{0E694C0F-8AB1-4632-B2DA-D1247D8BE18F}" destId="{98EC778F-CAF8-4E63-A99F-097796D79286}" srcOrd="1" destOrd="0" parTransId="{52154CCD-C50F-4D8D-9A4D-62AFF7D488F1}" sibTransId="{EBFB09D3-CF38-4FA8-9B22-519CCB2BA430}"/>
    <dgm:cxn modelId="{CC098450-C4A5-4DC4-B3A6-C3FA8A8910D7}" type="presOf" srcId="{AAC4D152-DFE4-4D71-BCD7-D8DC7E5B64B5}" destId="{2A3B2C18-117F-4F18-8DA1-0C7AC429375D}" srcOrd="1" destOrd="0" presId="urn:microsoft.com/office/officeart/2005/8/layout/orgChart1"/>
    <dgm:cxn modelId="{CBE48452-5B13-4B2B-BA0B-ADEC19CD4527}" type="presOf" srcId="{234C6499-965E-4A1C-AD6B-41DBACE3B9DD}" destId="{51F999EF-5198-4604-9932-B54113933E43}" srcOrd="0" destOrd="0" presId="urn:microsoft.com/office/officeart/2005/8/layout/orgChart1"/>
    <dgm:cxn modelId="{9BD13474-4CDC-4E5E-A53B-A2B7BB86ED85}" type="presOf" srcId="{643255AD-71E5-496C-B47C-0F72C36EA1B4}" destId="{53371C62-A9F4-424A-A2C3-5285FF0AAA6F}" srcOrd="0" destOrd="0" presId="urn:microsoft.com/office/officeart/2005/8/layout/orgChart1"/>
    <dgm:cxn modelId="{02A75974-0CDB-4F26-8D41-67A8D165D4F8}" type="presOf" srcId="{A12224F7-2DFB-44CA-86DF-11C60E308278}" destId="{E3C6DA40-0164-4E21-A22C-6CE63583D97D}" srcOrd="0" destOrd="0" presId="urn:microsoft.com/office/officeart/2005/8/layout/orgChart1"/>
    <dgm:cxn modelId="{DD910776-114C-4E0F-A8D7-B5C1051825B4}" type="presOf" srcId="{0E694C0F-8AB1-4632-B2DA-D1247D8BE18F}" destId="{053C0BA0-4CA6-4511-8C30-0C0AC5E87C55}" srcOrd="1" destOrd="0" presId="urn:microsoft.com/office/officeart/2005/8/layout/orgChart1"/>
    <dgm:cxn modelId="{F307EE76-5ED9-40BE-B0BA-AA5BF559BB22}" type="presOf" srcId="{4D248CC2-3184-460B-A00A-1B722842C143}" destId="{B8F3B591-9307-4E9A-BD2C-F5D348511BEA}" srcOrd="0" destOrd="0" presId="urn:microsoft.com/office/officeart/2005/8/layout/orgChart1"/>
    <dgm:cxn modelId="{246A5F57-7B13-4DA3-87AF-9BDA0B755801}" type="presOf" srcId="{6BD44C91-1E07-4C76-A038-9B12972016B7}" destId="{ABC3CB6A-0357-4894-9BAA-929B77021C52}" srcOrd="0" destOrd="0" presId="urn:microsoft.com/office/officeart/2005/8/layout/orgChart1"/>
    <dgm:cxn modelId="{421E0758-A6F9-40E4-86D1-293A81E629F9}" srcId="{6F8E4E8F-2702-4226-B47E-68170BE88C0D}" destId="{AFFD01EC-C5E6-4176-BD08-620332168957}" srcOrd="0" destOrd="0" parTransId="{7AADD620-BE27-4CB5-8F13-7068209BE0C5}" sibTransId="{A4603734-B7F8-4E31-901B-271F7283D999}"/>
    <dgm:cxn modelId="{E2833B78-2C57-4B1F-8904-83AAEF835366}" type="presOf" srcId="{3B0E29A3-C1A2-4639-AB0E-1A346F1A0E04}" destId="{F5F3FF49-23FD-4723-B11F-E4F06DC6090E}" srcOrd="0" destOrd="0" presId="urn:microsoft.com/office/officeart/2005/8/layout/orgChart1"/>
    <dgm:cxn modelId="{A2C75D7B-67A1-4A6A-8987-0CEADD36842A}" type="presOf" srcId="{D8AF9B9F-7B15-49F9-BF7C-6D4318F4863B}" destId="{8110C399-8F20-4AB5-BD7D-22095B9142B3}" srcOrd="0" destOrd="0" presId="urn:microsoft.com/office/officeart/2005/8/layout/orgChart1"/>
    <dgm:cxn modelId="{BD515E7D-DDED-47E3-B233-BF4CB2DE6B61}" type="presOf" srcId="{2FEE63E5-11CD-444D-8D11-C0DC2DC8DF75}" destId="{7608DE48-B886-49F4-839C-63DDC3306FE1}" srcOrd="0" destOrd="0" presId="urn:microsoft.com/office/officeart/2005/8/layout/orgChart1"/>
    <dgm:cxn modelId="{62493D80-A7BC-40D9-8F37-7BF589A6236A}" type="presOf" srcId="{941C7643-26C4-48E0-99CB-5FC5DCAC7830}" destId="{38B6D9C8-E9D8-4050-A823-A9F97287CFBA}" srcOrd="1" destOrd="0" presId="urn:microsoft.com/office/officeart/2005/8/layout/orgChart1"/>
    <dgm:cxn modelId="{DDCA8081-CC22-4775-9F38-EE9CEF9657E8}" srcId="{DBA59BEF-F7D1-47B1-A43A-3B0DA8C93D02}" destId="{643255AD-71E5-496C-B47C-0F72C36EA1B4}" srcOrd="0" destOrd="0" parTransId="{34BEDA4B-4676-4447-BB1C-BF24E40AC4B9}" sibTransId="{0E9B234F-4C6A-449C-B75C-3D5AE4352F45}"/>
    <dgm:cxn modelId="{F0B55482-2913-4322-9F85-F3FE7C1FF605}" srcId="{406D8CC5-78C9-4B43-BDE8-4BE5804CEA04}" destId="{08C5AF4C-1B14-41B0-9771-7EBCD0929A3D}" srcOrd="0" destOrd="0" parTransId="{36A51C83-6AE4-4C7F-B92D-66DA6A6372CE}" sibTransId="{01D04D08-E5FA-4F84-8D48-EABDD9E66973}"/>
    <dgm:cxn modelId="{A6C56C88-A221-4572-830F-47EFD6C983AB}" type="presOf" srcId="{664A54DC-2232-409D-850E-C500F4B66703}" destId="{862E9566-7B2C-4E20-9072-A206352353D9}" srcOrd="0" destOrd="0" presId="urn:microsoft.com/office/officeart/2005/8/layout/orgChart1"/>
    <dgm:cxn modelId="{42D57389-D4B4-490E-873C-9F283818EFB8}" type="presOf" srcId="{643255AD-71E5-496C-B47C-0F72C36EA1B4}" destId="{C7CDD2F7-9A5D-47CE-9F03-D1B9A9C8458C}" srcOrd="1" destOrd="0" presId="urn:microsoft.com/office/officeart/2005/8/layout/orgChart1"/>
    <dgm:cxn modelId="{3050568D-8A38-48D5-95EB-52242F9C59DA}" type="presOf" srcId="{349DFFB7-BC3E-496C-9A61-DB19C5510C78}" destId="{FFFD1586-C99D-4845-8FB7-33978BBFEBB3}" srcOrd="0" destOrd="0" presId="urn:microsoft.com/office/officeart/2005/8/layout/orgChart1"/>
    <dgm:cxn modelId="{FA299A8D-470C-47D4-99FA-542D8FE4225C}" srcId="{941C7643-26C4-48E0-99CB-5FC5DCAC7830}" destId="{3B0E29A3-C1A2-4639-AB0E-1A346F1A0E04}" srcOrd="1" destOrd="0" parTransId="{87865882-2A58-4BA6-8A69-252504164606}" sibTransId="{ABFA5A72-A3DA-4C0E-8B61-D6E435F44C50}"/>
    <dgm:cxn modelId="{40493F8F-A78F-4321-8690-EACE6573621F}" type="presOf" srcId="{AE8828E0-C571-4F8A-9003-C6EADEAC1B46}" destId="{CC1F212B-4033-4ACE-91CA-24A1CE845C0F}" srcOrd="1" destOrd="0" presId="urn:microsoft.com/office/officeart/2005/8/layout/orgChart1"/>
    <dgm:cxn modelId="{1F68F994-C77B-4EB0-925B-E1166B86620A}" type="presOf" srcId="{967E51DC-DAFD-4334-BA70-BAFEED137B42}" destId="{052E7182-A4A9-4292-A937-78185AFB7B85}" srcOrd="1" destOrd="0" presId="urn:microsoft.com/office/officeart/2005/8/layout/orgChart1"/>
    <dgm:cxn modelId="{7F7F0297-6133-4C74-B6CD-E4F8B3EFC961}" type="presOf" srcId="{C3011BAC-C634-4F6A-B626-BB4C0EF26321}" destId="{F37FF3B3-7FDA-4BD1-B6C6-904B1B101FA4}" srcOrd="1" destOrd="0" presId="urn:microsoft.com/office/officeart/2005/8/layout/orgChart1"/>
    <dgm:cxn modelId="{39C61397-4B01-49DD-BE66-F612C6956896}" type="presOf" srcId="{98EC778F-CAF8-4E63-A99F-097796D79286}" destId="{B9FCC3FA-094E-47AD-A43F-10C485D8E237}" srcOrd="1" destOrd="0" presId="urn:microsoft.com/office/officeart/2005/8/layout/orgChart1"/>
    <dgm:cxn modelId="{7489239A-9BEF-41C8-9876-F8E7B9EC0976}" type="presOf" srcId="{18F20645-7764-43F0-9163-9C3DC9EAF423}" destId="{4A5C067F-FEAA-48F0-96BD-C976B883AD03}" srcOrd="0" destOrd="0" presId="urn:microsoft.com/office/officeart/2005/8/layout/orgChart1"/>
    <dgm:cxn modelId="{050FB89C-A447-4E22-8E0C-2FD459DF42E1}" type="presOf" srcId="{7AADD620-BE27-4CB5-8F13-7068209BE0C5}" destId="{3967BE9E-1271-4178-BBCF-D43AA34D64C1}" srcOrd="0" destOrd="0" presId="urn:microsoft.com/office/officeart/2005/8/layout/orgChart1"/>
    <dgm:cxn modelId="{EA7AC5A2-3C53-4B4A-BB95-3CD4BF315C1A}" type="presOf" srcId="{DDF8FFD9-511F-4065-B81C-2BDE61A38242}" destId="{0E1B9CD5-FDC2-4DA7-A527-596D7E53B6A0}" srcOrd="1" destOrd="0" presId="urn:microsoft.com/office/officeart/2005/8/layout/orgChart1"/>
    <dgm:cxn modelId="{A90AE4A2-BCC2-473B-8C01-9C25A61576FD}" srcId="{AE8828E0-C571-4F8A-9003-C6EADEAC1B46}" destId="{8E83BC88-359D-47C4-9BBC-5EFD9E609921}" srcOrd="0" destOrd="0" parTransId="{349DFFB7-BC3E-496C-9A61-DB19C5510C78}" sibTransId="{98914FDC-1103-4794-9FC5-BBCE7D31505E}"/>
    <dgm:cxn modelId="{C2D06FAA-F96D-4F27-AC5B-DC6284EC6372}" type="presOf" srcId="{6F8E4E8F-2702-4226-B47E-68170BE88C0D}" destId="{A054C64C-5610-4BB3-99DE-F3FB705E364F}" srcOrd="1" destOrd="0" presId="urn:microsoft.com/office/officeart/2005/8/layout/orgChart1"/>
    <dgm:cxn modelId="{D0ACC6AA-8B5E-4DA2-9FA8-EC91A72ADF5C}" srcId="{DDF8FFD9-511F-4065-B81C-2BDE61A38242}" destId="{2FEE63E5-11CD-444D-8D11-C0DC2DC8DF75}" srcOrd="0" destOrd="0" parTransId="{E5C4179A-71E8-45A5-B4BC-AF19A0263B90}" sibTransId="{8DD65A69-9C43-4552-8E24-00216623EE64}"/>
    <dgm:cxn modelId="{04C8A5AB-850E-479A-8F07-F496BE4E5EB3}" srcId="{0E694C0F-8AB1-4632-B2DA-D1247D8BE18F}" destId="{406D8CC5-78C9-4B43-BDE8-4BE5804CEA04}" srcOrd="0" destOrd="0" parTransId="{18F20645-7764-43F0-9163-9C3DC9EAF423}" sibTransId="{2EFFC32F-6ECF-4E60-9223-BF8D7C294614}"/>
    <dgm:cxn modelId="{3EBB4DB5-815A-4B06-9D3D-F50AC969662D}" type="presOf" srcId="{DDF8FFD9-511F-4065-B81C-2BDE61A38242}" destId="{9735BBE2-731E-4A6A-A9DC-FABB30A5B699}" srcOrd="0" destOrd="0" presId="urn:microsoft.com/office/officeart/2005/8/layout/orgChart1"/>
    <dgm:cxn modelId="{8AC7A6B6-5DF2-43C2-9654-5BB6D4656C22}" type="presOf" srcId="{0E694C0F-8AB1-4632-B2DA-D1247D8BE18F}" destId="{87A60063-46AC-4CA6-8AFB-C646FC058C41}" srcOrd="0" destOrd="0" presId="urn:microsoft.com/office/officeart/2005/8/layout/orgChart1"/>
    <dgm:cxn modelId="{896C4AB7-59A2-4756-ADAB-2E3FE2DD063F}" type="presOf" srcId="{406D8CC5-78C9-4B43-BDE8-4BE5804CEA04}" destId="{8325B952-ADFE-4612-856B-08695AAA247D}" srcOrd="0" destOrd="0" presId="urn:microsoft.com/office/officeart/2005/8/layout/orgChart1"/>
    <dgm:cxn modelId="{17868BB7-CB52-4CDA-9509-7EFCBF4B4C27}" srcId="{AAC4D152-DFE4-4D71-BCD7-D8DC7E5B64B5}" destId="{941C7643-26C4-48E0-99CB-5FC5DCAC7830}" srcOrd="1" destOrd="0" parTransId="{E86315E3-7891-43B4-99E6-516075C79111}" sibTransId="{106E2D13-A208-43B3-8FB0-B3FE31798FFE}"/>
    <dgm:cxn modelId="{B875A9B9-1A71-4C6B-A0DF-DE5A81D10F78}" type="presOf" srcId="{70077C60-346B-48F3-A4A6-74BBDB759C76}" destId="{5B8F574D-2549-48EE-A494-3BDF5EFAFDFB}" srcOrd="0" destOrd="0" presId="urn:microsoft.com/office/officeart/2005/8/layout/orgChart1"/>
    <dgm:cxn modelId="{C07673BF-720B-4727-A83E-AAF548949911}" type="presOf" srcId="{3B0E29A3-C1A2-4639-AB0E-1A346F1A0E04}" destId="{1CE56615-592A-44D8-BCD1-C90ECF921800}" srcOrd="1" destOrd="0" presId="urn:microsoft.com/office/officeart/2005/8/layout/orgChart1"/>
    <dgm:cxn modelId="{990F76C0-D86F-498A-8311-ADE4C4D140ED}" type="presOf" srcId="{15AFF031-A5C1-4EBA-AE0C-FA89BF21DCD1}" destId="{8CB00494-7F74-4467-A3BD-5E2ABAF8B091}" srcOrd="0" destOrd="0" presId="urn:microsoft.com/office/officeart/2005/8/layout/orgChart1"/>
    <dgm:cxn modelId="{D715C7C0-CD63-446F-8892-EBE8943C748A}" type="presOf" srcId="{D8AF9B9F-7B15-49F9-BF7C-6D4318F4863B}" destId="{16FBCBB6-1A99-419C-ACE8-9066FEE99083}" srcOrd="1" destOrd="0" presId="urn:microsoft.com/office/officeart/2005/8/layout/orgChart1"/>
    <dgm:cxn modelId="{4C2220C4-39F9-457D-B555-599D9E5B3164}" srcId="{8E83BC88-359D-47C4-9BBC-5EFD9E609921}" destId="{0E694C0F-8AB1-4632-B2DA-D1247D8BE18F}" srcOrd="1" destOrd="0" parTransId="{4D248CC2-3184-460B-A00A-1B722842C143}" sibTransId="{B82A1D0C-24B1-4AA0-9246-BA20D4269306}"/>
    <dgm:cxn modelId="{19EEB9C4-B242-4CB5-92E4-4D2981B163D1}" srcId="{6F8E4E8F-2702-4226-B47E-68170BE88C0D}" destId="{DDF8FFD9-511F-4065-B81C-2BDE61A38242}" srcOrd="1" destOrd="0" parTransId="{19FF45C4-3579-490B-A008-D47EF4CD004F}" sibTransId="{B8C57F33-F806-47F2-A95F-1914F7DC09C7}"/>
    <dgm:cxn modelId="{94C457C5-A5CF-49DB-B104-84899CD29F82}" type="presOf" srcId="{0644E4B2-A944-479A-96C3-135272B6EA85}" destId="{1230424A-EF84-4B61-94B6-A21103AF4BEC}" srcOrd="0" destOrd="0" presId="urn:microsoft.com/office/officeart/2005/8/layout/orgChart1"/>
    <dgm:cxn modelId="{6456EAC5-5F71-4A17-B8BF-9A4B3E0D82B1}" type="presOf" srcId="{08C5AF4C-1B14-41B0-9771-7EBCD0929A3D}" destId="{765E4F2B-E403-446B-A07D-1C67F1398557}" srcOrd="0" destOrd="0" presId="urn:microsoft.com/office/officeart/2005/8/layout/orgChart1"/>
    <dgm:cxn modelId="{345BF5C9-5A57-4513-9337-7F8B89D76727}" type="presOf" srcId="{967E51DC-DAFD-4334-BA70-BAFEED137B42}" destId="{84ECF355-7DD3-4860-A18D-4CDD20866068}" srcOrd="0" destOrd="0" presId="urn:microsoft.com/office/officeart/2005/8/layout/orgChart1"/>
    <dgm:cxn modelId="{2935FBCC-8405-416D-AD1F-4AD0866D7975}" type="presOf" srcId="{225A9166-8B18-4E7E-9D25-0E123E908A76}" destId="{B4664688-559F-4662-A72A-DF835209CD27}" srcOrd="0" destOrd="0" presId="urn:microsoft.com/office/officeart/2005/8/layout/orgChart1"/>
    <dgm:cxn modelId="{297188D3-FB6D-4920-9528-A2C1691C06D1}" srcId="{07231A88-C874-4EB5-96BF-70679CFA0F73}" destId="{5DA4B7B4-A002-442D-8908-F302D486C218}" srcOrd="0" destOrd="0" parTransId="{A12224F7-2DFB-44CA-86DF-11C60E308278}" sibTransId="{6D1A0940-815C-426C-B995-248B5137F279}"/>
    <dgm:cxn modelId="{0713A7D8-9BD6-4A8C-B150-4AD9DD1E37CB}" type="presOf" srcId="{36A51C83-6AE4-4C7F-B92D-66DA6A6372CE}" destId="{19F787B1-4285-40D5-A18E-FE58585EB3EA}" srcOrd="0" destOrd="0" presId="urn:microsoft.com/office/officeart/2005/8/layout/orgChart1"/>
    <dgm:cxn modelId="{BF59B9D9-9468-43F5-A6E3-4614382B3EFF}" type="presOf" srcId="{5DA4B7B4-A002-442D-8908-F302D486C218}" destId="{2B200D36-77CA-4FDF-8C79-0399DDE7CCE7}" srcOrd="1" destOrd="0" presId="urn:microsoft.com/office/officeart/2005/8/layout/orgChart1"/>
    <dgm:cxn modelId="{22C277DB-DEC4-4BEE-B695-7FEECA779191}" type="presOf" srcId="{DBA59BEF-F7D1-47B1-A43A-3B0DA8C93D02}" destId="{A59011C7-6EE2-4BBA-945A-1EA041A7BDF1}" srcOrd="1" destOrd="0" presId="urn:microsoft.com/office/officeart/2005/8/layout/orgChart1"/>
    <dgm:cxn modelId="{7DE31FDD-A7A9-4976-8AB0-247AF1E07294}" type="presOf" srcId="{8E83BC88-359D-47C4-9BBC-5EFD9E609921}" destId="{3B4C3098-684A-4D58-8815-D0CCA3C2AA08}" srcOrd="1" destOrd="0" presId="urn:microsoft.com/office/officeart/2005/8/layout/orgChart1"/>
    <dgm:cxn modelId="{028A7CDE-6550-4045-963A-6A713CF1D98F}" srcId="{AE8828E0-C571-4F8A-9003-C6EADEAC1B46}" destId="{6F8E4E8F-2702-4226-B47E-68170BE88C0D}" srcOrd="1" destOrd="0" parTransId="{DD8232B4-3BCE-40FA-A9D1-F6EE9E34EB34}" sibTransId="{1AF3179A-5447-46D1-A265-947BF4F4C0FD}"/>
    <dgm:cxn modelId="{195D5CE0-F24A-42C2-8BC4-39E577E63818}" srcId="{AE8828E0-C571-4F8A-9003-C6EADEAC1B46}" destId="{BFF39B8D-4745-486C-BE1F-E29AF29508A6}" srcOrd="2" destOrd="0" parTransId="{70077C60-346B-48F3-A4A6-74BBDB759C76}" sibTransId="{35AAD9C9-69B4-4AE9-9EA4-E94B5AA94A29}"/>
    <dgm:cxn modelId="{C1D23BE9-EE58-4AD3-935F-9DA90C61A233}" type="presOf" srcId="{BFF39B8D-4745-486C-BE1F-E29AF29508A6}" destId="{4F790CF3-DC77-46DD-959C-2556C4356DAC}" srcOrd="0" destOrd="0" presId="urn:microsoft.com/office/officeart/2005/8/layout/orgChart1"/>
    <dgm:cxn modelId="{8A04F2E9-B3C3-477D-81C1-C4C55D06F5AC}" srcId="{6BD44C91-1E07-4C76-A038-9B12972016B7}" destId="{AE8828E0-C571-4F8A-9003-C6EADEAC1B46}" srcOrd="0" destOrd="0" parTransId="{250AB9AA-6031-496F-B7F1-6F0DB8F8D34D}" sibTransId="{D23EE6B3-9394-4A9C-BC80-CD2D7E190BEE}"/>
    <dgm:cxn modelId="{35AB8BEA-1679-4755-A2A4-C49EFB6422AD}" type="presOf" srcId="{DD8232B4-3BCE-40FA-A9D1-F6EE9E34EB34}" destId="{A34C4E21-1952-4E8E-9318-1E0F6325910B}" srcOrd="0" destOrd="0" presId="urn:microsoft.com/office/officeart/2005/8/layout/orgChart1"/>
    <dgm:cxn modelId="{412D44F0-631F-42A1-9985-92046F7BEBF3}" type="presOf" srcId="{87C7148A-F0C3-445B-A39D-01DE0724E6F2}" destId="{5C142C8B-C534-4D51-A3A2-288A16925F33}" srcOrd="1" destOrd="0" presId="urn:microsoft.com/office/officeart/2005/8/layout/orgChart1"/>
    <dgm:cxn modelId="{01692AF1-FC59-47FF-A0F2-9CBF26CD7A41}" type="presOf" srcId="{7FE9781B-758D-43A9-BF49-F99B7DA53302}" destId="{8A06E381-8819-4037-A125-902EA70F0BD6}" srcOrd="0" destOrd="0" presId="urn:microsoft.com/office/officeart/2005/8/layout/orgChart1"/>
    <dgm:cxn modelId="{AA2958F1-C74D-4C82-822A-33028699D8F6}" type="presOf" srcId="{7FCCC78F-80A8-4888-9D91-58DF6A1A42BD}" destId="{16F95800-F6FC-432A-8192-5DDFB4692B6C}" srcOrd="0" destOrd="0" presId="urn:microsoft.com/office/officeart/2005/8/layout/orgChart1"/>
    <dgm:cxn modelId="{B89BA3F3-B722-494F-9589-673EF950FE56}" type="presOf" srcId="{AFFD01EC-C5E6-4176-BD08-620332168957}" destId="{F3963130-01C5-4F4B-8C80-55CA0768ED6D}" srcOrd="0" destOrd="0" presId="urn:microsoft.com/office/officeart/2005/8/layout/orgChart1"/>
    <dgm:cxn modelId="{FB6D91F8-718C-4032-B6FE-CD66A03E396A}" type="presOf" srcId="{C3011BAC-C634-4F6A-B626-BB4C0EF26321}" destId="{BD750659-6154-46D5-BA03-1754BA762AEF}" srcOrd="0" destOrd="0" presId="urn:microsoft.com/office/officeart/2005/8/layout/orgChart1"/>
    <dgm:cxn modelId="{95D842FB-3ADE-4596-801C-F252AAA1CC77}" type="presOf" srcId="{08C5AF4C-1B14-41B0-9771-7EBCD0929A3D}" destId="{39B12912-CB9D-4827-8B54-2FC5C8E01B9F}" srcOrd="1" destOrd="0" presId="urn:microsoft.com/office/officeart/2005/8/layout/orgChart1"/>
    <dgm:cxn modelId="{E75143FD-E7DB-4964-B3FC-45B8D5180559}" type="presOf" srcId="{591BECE1-B841-4D57-8D99-F9DC0D22DBF9}" destId="{05F4DF28-B57F-4699-9BED-B162015FDD41}" srcOrd="0" destOrd="0" presId="urn:microsoft.com/office/officeart/2005/8/layout/orgChart1"/>
    <dgm:cxn modelId="{0A6EC9F8-B151-462D-A8A1-024642DE638A}" type="presParOf" srcId="{ABC3CB6A-0357-4894-9BAA-929B77021C52}" destId="{AEAB85E9-A70C-4405-877A-25C8499667A5}" srcOrd="0" destOrd="0" presId="urn:microsoft.com/office/officeart/2005/8/layout/orgChart1"/>
    <dgm:cxn modelId="{FC24232E-6306-4052-8B8A-8C7E4E8FB040}" type="presParOf" srcId="{AEAB85E9-A70C-4405-877A-25C8499667A5}" destId="{1E669895-E92B-4739-8C7B-84CB31B48474}" srcOrd="0" destOrd="0" presId="urn:microsoft.com/office/officeart/2005/8/layout/orgChart1"/>
    <dgm:cxn modelId="{24A8B27D-8321-4585-8D20-55DB667F6E81}" type="presParOf" srcId="{1E669895-E92B-4739-8C7B-84CB31B48474}" destId="{356AF28E-5690-4043-AF44-3ACC12D0BDB0}" srcOrd="0" destOrd="0" presId="urn:microsoft.com/office/officeart/2005/8/layout/orgChart1"/>
    <dgm:cxn modelId="{CFC17408-66EB-4251-BBA5-913FAEF1435B}" type="presParOf" srcId="{1E669895-E92B-4739-8C7B-84CB31B48474}" destId="{CC1F212B-4033-4ACE-91CA-24A1CE845C0F}" srcOrd="1" destOrd="0" presId="urn:microsoft.com/office/officeart/2005/8/layout/orgChart1"/>
    <dgm:cxn modelId="{41F09C12-10EA-489C-819F-3B652CDBFF6D}" type="presParOf" srcId="{AEAB85E9-A70C-4405-877A-25C8499667A5}" destId="{2620BDDE-FA0E-4A4C-8A0C-B5CB145438F5}" srcOrd="1" destOrd="0" presId="urn:microsoft.com/office/officeart/2005/8/layout/orgChart1"/>
    <dgm:cxn modelId="{B402D5EB-6E8C-4F41-B6DB-6DE2AA54EE74}" type="presParOf" srcId="{2620BDDE-FA0E-4A4C-8A0C-B5CB145438F5}" destId="{FFFD1586-C99D-4845-8FB7-33978BBFEBB3}" srcOrd="0" destOrd="0" presId="urn:microsoft.com/office/officeart/2005/8/layout/orgChart1"/>
    <dgm:cxn modelId="{A4425AF2-C129-48E0-92A8-260960A19451}" type="presParOf" srcId="{2620BDDE-FA0E-4A4C-8A0C-B5CB145438F5}" destId="{238AEF1C-EA40-47B2-AD6F-C7FBDF9862A4}" srcOrd="1" destOrd="0" presId="urn:microsoft.com/office/officeart/2005/8/layout/orgChart1"/>
    <dgm:cxn modelId="{3EDF783F-2C18-46B2-9345-244C9FE64A78}" type="presParOf" srcId="{238AEF1C-EA40-47B2-AD6F-C7FBDF9862A4}" destId="{DAF59CE7-69D3-4E3E-9105-8DF6BE16B2E9}" srcOrd="0" destOrd="0" presId="urn:microsoft.com/office/officeart/2005/8/layout/orgChart1"/>
    <dgm:cxn modelId="{FE88E0BA-291A-453E-A613-1313BABC4166}" type="presParOf" srcId="{DAF59CE7-69D3-4E3E-9105-8DF6BE16B2E9}" destId="{C6924E3E-37F0-45BB-A9D6-33A3FF05B21C}" srcOrd="0" destOrd="0" presId="urn:microsoft.com/office/officeart/2005/8/layout/orgChart1"/>
    <dgm:cxn modelId="{173843FF-7617-4494-8F7B-33D1427A1B72}" type="presParOf" srcId="{DAF59CE7-69D3-4E3E-9105-8DF6BE16B2E9}" destId="{3B4C3098-684A-4D58-8815-D0CCA3C2AA08}" srcOrd="1" destOrd="0" presId="urn:microsoft.com/office/officeart/2005/8/layout/orgChart1"/>
    <dgm:cxn modelId="{48CF687F-8F85-4AA4-9000-D61F0C1CE454}" type="presParOf" srcId="{238AEF1C-EA40-47B2-AD6F-C7FBDF9862A4}" destId="{C6A7C44F-2A3F-4F38-BFAD-45072B23DE07}" srcOrd="1" destOrd="0" presId="urn:microsoft.com/office/officeart/2005/8/layout/orgChart1"/>
    <dgm:cxn modelId="{3B03B9C7-8071-4845-B523-9C35B9652E77}" type="presParOf" srcId="{C6A7C44F-2A3F-4F38-BFAD-45072B23DE07}" destId="{16F95800-F6FC-432A-8192-5DDFB4692B6C}" srcOrd="0" destOrd="0" presId="urn:microsoft.com/office/officeart/2005/8/layout/orgChart1"/>
    <dgm:cxn modelId="{ADF2FF40-1AE6-4E35-92C4-09B94B3706D7}" type="presParOf" srcId="{C6A7C44F-2A3F-4F38-BFAD-45072B23DE07}" destId="{9E716B29-2216-4651-A18A-EAC68AA05A24}" srcOrd="1" destOrd="0" presId="urn:microsoft.com/office/officeart/2005/8/layout/orgChart1"/>
    <dgm:cxn modelId="{5BF7977E-90C5-48C7-8BF8-5A8E3EF4250D}" type="presParOf" srcId="{9E716B29-2216-4651-A18A-EAC68AA05A24}" destId="{14C6D8F7-4917-4327-8461-C2A64ACA6B89}" srcOrd="0" destOrd="0" presId="urn:microsoft.com/office/officeart/2005/8/layout/orgChart1"/>
    <dgm:cxn modelId="{49FDCD33-B0FB-464D-B97B-AFC7530E3682}" type="presParOf" srcId="{14C6D8F7-4917-4327-8461-C2A64ACA6B89}" destId="{0296FC5F-E378-4904-93B2-00D4ACF73593}" srcOrd="0" destOrd="0" presId="urn:microsoft.com/office/officeart/2005/8/layout/orgChart1"/>
    <dgm:cxn modelId="{3D735F56-F569-4DAE-8F86-CEC54E5D6D75}" type="presParOf" srcId="{14C6D8F7-4917-4327-8461-C2A64ACA6B89}" destId="{2A3B2C18-117F-4F18-8DA1-0C7AC429375D}" srcOrd="1" destOrd="0" presId="urn:microsoft.com/office/officeart/2005/8/layout/orgChart1"/>
    <dgm:cxn modelId="{3BB64069-57EC-4776-9924-EE4EFAB9F7AE}" type="presParOf" srcId="{9E716B29-2216-4651-A18A-EAC68AA05A24}" destId="{106E37BA-F771-4BE8-8846-0F3D21A3D507}" srcOrd="1" destOrd="0" presId="urn:microsoft.com/office/officeart/2005/8/layout/orgChart1"/>
    <dgm:cxn modelId="{5EE432FE-F245-4DC9-938B-F4E8D74095B4}" type="presParOf" srcId="{106E37BA-F771-4BE8-8846-0F3D21A3D507}" destId="{05F4DF28-B57F-4699-9BED-B162015FDD41}" srcOrd="0" destOrd="0" presId="urn:microsoft.com/office/officeart/2005/8/layout/orgChart1"/>
    <dgm:cxn modelId="{707E9630-F317-4074-9F37-E95B7726AD61}" type="presParOf" srcId="{106E37BA-F771-4BE8-8846-0F3D21A3D507}" destId="{825D8AFF-14D3-43E5-AD31-216B21801723}" srcOrd="1" destOrd="0" presId="urn:microsoft.com/office/officeart/2005/8/layout/orgChart1"/>
    <dgm:cxn modelId="{0CB40676-B3CD-496D-9853-0F45299FF125}" type="presParOf" srcId="{825D8AFF-14D3-43E5-AD31-216B21801723}" destId="{5245F033-2183-451C-8E29-6A85BFAA36EA}" srcOrd="0" destOrd="0" presId="urn:microsoft.com/office/officeart/2005/8/layout/orgChart1"/>
    <dgm:cxn modelId="{12346772-D8BF-451B-9848-DC0F7C5FB803}" type="presParOf" srcId="{5245F033-2183-451C-8E29-6A85BFAA36EA}" destId="{B8C1EDF1-DB2A-4D33-AA78-22955DE770C3}" srcOrd="0" destOrd="0" presId="urn:microsoft.com/office/officeart/2005/8/layout/orgChart1"/>
    <dgm:cxn modelId="{314C8179-AE97-4DEF-AC8C-5D0294CE65FC}" type="presParOf" srcId="{5245F033-2183-451C-8E29-6A85BFAA36EA}" destId="{A59011C7-6EE2-4BBA-945A-1EA041A7BDF1}" srcOrd="1" destOrd="0" presId="urn:microsoft.com/office/officeart/2005/8/layout/orgChart1"/>
    <dgm:cxn modelId="{704A7C58-0B74-4B99-AB58-86A582B2B16B}" type="presParOf" srcId="{825D8AFF-14D3-43E5-AD31-216B21801723}" destId="{7C3D7898-B966-40D3-9287-C16DE16BCFA6}" srcOrd="1" destOrd="0" presId="urn:microsoft.com/office/officeart/2005/8/layout/orgChart1"/>
    <dgm:cxn modelId="{C0F9D79D-03DF-472E-A352-66E4FD4547C6}" type="presParOf" srcId="{7C3D7898-B966-40D3-9287-C16DE16BCFA6}" destId="{DD731950-665B-474A-9284-81BABEADB935}" srcOrd="0" destOrd="0" presId="urn:microsoft.com/office/officeart/2005/8/layout/orgChart1"/>
    <dgm:cxn modelId="{61FA540C-242F-41F6-86A2-614C52B2B0A6}" type="presParOf" srcId="{7C3D7898-B966-40D3-9287-C16DE16BCFA6}" destId="{32A235EB-AA7F-4B94-A580-59A6593BE504}" srcOrd="1" destOrd="0" presId="urn:microsoft.com/office/officeart/2005/8/layout/orgChart1"/>
    <dgm:cxn modelId="{74DBBF58-7F90-40F8-B16F-CC3A2F296C03}" type="presParOf" srcId="{32A235EB-AA7F-4B94-A580-59A6593BE504}" destId="{36BAFAB3-940C-4564-B083-4E102C6171B8}" srcOrd="0" destOrd="0" presId="urn:microsoft.com/office/officeart/2005/8/layout/orgChart1"/>
    <dgm:cxn modelId="{5404F91D-864B-400A-A511-65EE94C72842}" type="presParOf" srcId="{36BAFAB3-940C-4564-B083-4E102C6171B8}" destId="{53371C62-A9F4-424A-A2C3-5285FF0AAA6F}" srcOrd="0" destOrd="0" presId="urn:microsoft.com/office/officeart/2005/8/layout/orgChart1"/>
    <dgm:cxn modelId="{8AECF878-07F7-42A6-84CE-5EF090539A5B}" type="presParOf" srcId="{36BAFAB3-940C-4564-B083-4E102C6171B8}" destId="{C7CDD2F7-9A5D-47CE-9F03-D1B9A9C8458C}" srcOrd="1" destOrd="0" presId="urn:microsoft.com/office/officeart/2005/8/layout/orgChart1"/>
    <dgm:cxn modelId="{7C7032E4-207E-4E77-96C4-44C7FAB95487}" type="presParOf" srcId="{32A235EB-AA7F-4B94-A580-59A6593BE504}" destId="{7EDA0209-31D1-4079-9185-0D9234A600D0}" srcOrd="1" destOrd="0" presId="urn:microsoft.com/office/officeart/2005/8/layout/orgChart1"/>
    <dgm:cxn modelId="{A219515E-256C-4D8B-858C-9A372E7A523C}" type="presParOf" srcId="{32A235EB-AA7F-4B94-A580-59A6593BE504}" destId="{0DE1086A-45E0-44C3-B843-F09BFB8929BA}" srcOrd="2" destOrd="0" presId="urn:microsoft.com/office/officeart/2005/8/layout/orgChart1"/>
    <dgm:cxn modelId="{A2F14676-6F53-4744-A636-15448042503E}" type="presParOf" srcId="{825D8AFF-14D3-43E5-AD31-216B21801723}" destId="{D07FC435-ED36-4E66-AF58-BBEA60B14809}" srcOrd="2" destOrd="0" presId="urn:microsoft.com/office/officeart/2005/8/layout/orgChart1"/>
    <dgm:cxn modelId="{A1817E57-2149-4129-8869-6AAD56B0066A}" type="presParOf" srcId="{106E37BA-F771-4BE8-8846-0F3D21A3D507}" destId="{35E9E6AB-8EBF-4489-A9AD-B18731334C84}" srcOrd="2" destOrd="0" presId="urn:microsoft.com/office/officeart/2005/8/layout/orgChart1"/>
    <dgm:cxn modelId="{607F70C9-A076-4B8A-BED4-6A2D69760C93}" type="presParOf" srcId="{106E37BA-F771-4BE8-8846-0F3D21A3D507}" destId="{DC54E399-9511-4CB6-8C80-71318FE6ECB6}" srcOrd="3" destOrd="0" presId="urn:microsoft.com/office/officeart/2005/8/layout/orgChart1"/>
    <dgm:cxn modelId="{41DBBA6E-8CF0-4964-9467-A57F5DD38D0B}" type="presParOf" srcId="{DC54E399-9511-4CB6-8C80-71318FE6ECB6}" destId="{16D179C5-A932-40DA-A6D5-65CF1FECF634}" srcOrd="0" destOrd="0" presId="urn:microsoft.com/office/officeart/2005/8/layout/orgChart1"/>
    <dgm:cxn modelId="{FCC8FE39-6EDA-4BF5-9232-760F7747E0E3}" type="presParOf" srcId="{16D179C5-A932-40DA-A6D5-65CF1FECF634}" destId="{1428E6BE-2F58-417D-9CB2-2888832E0161}" srcOrd="0" destOrd="0" presId="urn:microsoft.com/office/officeart/2005/8/layout/orgChart1"/>
    <dgm:cxn modelId="{3C152A9B-6501-4F4E-AC8B-FF1CBC56CD95}" type="presParOf" srcId="{16D179C5-A932-40DA-A6D5-65CF1FECF634}" destId="{38B6D9C8-E9D8-4050-A823-A9F97287CFBA}" srcOrd="1" destOrd="0" presId="urn:microsoft.com/office/officeart/2005/8/layout/orgChart1"/>
    <dgm:cxn modelId="{819271C8-62B3-4981-9DB8-659E1F27555E}" type="presParOf" srcId="{DC54E399-9511-4CB6-8C80-71318FE6ECB6}" destId="{A4DE7510-1459-48B1-AFEC-BAA8154AD4F3}" srcOrd="1" destOrd="0" presId="urn:microsoft.com/office/officeart/2005/8/layout/orgChart1"/>
    <dgm:cxn modelId="{17163940-BFFE-450E-A925-02FAC0E9EA3B}" type="presParOf" srcId="{A4DE7510-1459-48B1-AFEC-BAA8154AD4F3}" destId="{1AAE962B-FC4E-4E88-9802-C684323DA4FE}" srcOrd="0" destOrd="0" presId="urn:microsoft.com/office/officeart/2005/8/layout/orgChart1"/>
    <dgm:cxn modelId="{A462E005-9C8D-4550-A0FE-FD5A18D81295}" type="presParOf" srcId="{A4DE7510-1459-48B1-AFEC-BAA8154AD4F3}" destId="{ACAC5505-D3D1-4D57-B32C-9AC3B8D7350A}" srcOrd="1" destOrd="0" presId="urn:microsoft.com/office/officeart/2005/8/layout/orgChart1"/>
    <dgm:cxn modelId="{56156E4E-8E0A-4806-BF33-39F264E18E2E}" type="presParOf" srcId="{ACAC5505-D3D1-4D57-B32C-9AC3B8D7350A}" destId="{8C21FDB2-B8B8-4BD5-9557-77DA1E527140}" srcOrd="0" destOrd="0" presId="urn:microsoft.com/office/officeart/2005/8/layout/orgChart1"/>
    <dgm:cxn modelId="{870BDFF4-A041-4ECF-B57F-035DA118F8B2}" type="presParOf" srcId="{8C21FDB2-B8B8-4BD5-9557-77DA1E527140}" destId="{8110C399-8F20-4AB5-BD7D-22095B9142B3}" srcOrd="0" destOrd="0" presId="urn:microsoft.com/office/officeart/2005/8/layout/orgChart1"/>
    <dgm:cxn modelId="{E3C798C2-3AD9-4B3F-B610-712015A4C1F5}" type="presParOf" srcId="{8C21FDB2-B8B8-4BD5-9557-77DA1E527140}" destId="{16FBCBB6-1A99-419C-ACE8-9066FEE99083}" srcOrd="1" destOrd="0" presId="urn:microsoft.com/office/officeart/2005/8/layout/orgChart1"/>
    <dgm:cxn modelId="{2B948853-DF90-40CC-847B-BC1F413F5074}" type="presParOf" srcId="{ACAC5505-D3D1-4D57-B32C-9AC3B8D7350A}" destId="{A55CB61D-63FA-4E1D-A1A0-2BB6AB750FD6}" srcOrd="1" destOrd="0" presId="urn:microsoft.com/office/officeart/2005/8/layout/orgChart1"/>
    <dgm:cxn modelId="{33BCCC5F-13D2-4A2F-9C02-D22297627617}" type="presParOf" srcId="{ACAC5505-D3D1-4D57-B32C-9AC3B8D7350A}" destId="{F426B2E4-1C3C-416C-AB30-9BBCF3844AD0}" srcOrd="2" destOrd="0" presId="urn:microsoft.com/office/officeart/2005/8/layout/orgChart1"/>
    <dgm:cxn modelId="{E6511DF4-8CBB-4A4B-A1C9-D083D581FD0A}" type="presParOf" srcId="{A4DE7510-1459-48B1-AFEC-BAA8154AD4F3}" destId="{E2BB12F0-4365-4D10-BBA4-7BD9CA3A1C8C}" srcOrd="2" destOrd="0" presId="urn:microsoft.com/office/officeart/2005/8/layout/orgChart1"/>
    <dgm:cxn modelId="{D13BAE9A-3C71-429A-89D8-AE8DBE2F5A5F}" type="presParOf" srcId="{A4DE7510-1459-48B1-AFEC-BAA8154AD4F3}" destId="{C633C2DB-CE88-4040-9393-78752B2FB493}" srcOrd="3" destOrd="0" presId="urn:microsoft.com/office/officeart/2005/8/layout/orgChart1"/>
    <dgm:cxn modelId="{5DAC19A3-50D3-47FE-9894-A1161496FD56}" type="presParOf" srcId="{C633C2DB-CE88-4040-9393-78752B2FB493}" destId="{F44635B9-51C4-4F7E-9469-3276ED75C2B9}" srcOrd="0" destOrd="0" presId="urn:microsoft.com/office/officeart/2005/8/layout/orgChart1"/>
    <dgm:cxn modelId="{1A3B723C-CC58-4EED-85E5-1060F7F0DF1F}" type="presParOf" srcId="{F44635B9-51C4-4F7E-9469-3276ED75C2B9}" destId="{F5F3FF49-23FD-4723-B11F-E4F06DC6090E}" srcOrd="0" destOrd="0" presId="urn:microsoft.com/office/officeart/2005/8/layout/orgChart1"/>
    <dgm:cxn modelId="{5A756EA2-7AB4-4917-BF87-9DBE18EB1EB7}" type="presParOf" srcId="{F44635B9-51C4-4F7E-9469-3276ED75C2B9}" destId="{1CE56615-592A-44D8-BCD1-C90ECF921800}" srcOrd="1" destOrd="0" presId="urn:microsoft.com/office/officeart/2005/8/layout/orgChart1"/>
    <dgm:cxn modelId="{9ADDBB79-8E94-49FC-A868-37B4F8A80B5C}" type="presParOf" srcId="{C633C2DB-CE88-4040-9393-78752B2FB493}" destId="{733019F2-2574-4025-9489-3988519009E7}" srcOrd="1" destOrd="0" presId="urn:microsoft.com/office/officeart/2005/8/layout/orgChart1"/>
    <dgm:cxn modelId="{274D7E00-6979-4D76-B1CD-39E95146C1B0}" type="presParOf" srcId="{C633C2DB-CE88-4040-9393-78752B2FB493}" destId="{1EA58201-FDA9-433A-8E6C-8F697CD654B5}" srcOrd="2" destOrd="0" presId="urn:microsoft.com/office/officeart/2005/8/layout/orgChart1"/>
    <dgm:cxn modelId="{F8FCC9DB-7E22-4504-AC9F-7A9271E0AEA6}" type="presParOf" srcId="{DC54E399-9511-4CB6-8C80-71318FE6ECB6}" destId="{2DEC6793-A898-4C9E-9382-93EF220C751B}" srcOrd="2" destOrd="0" presId="urn:microsoft.com/office/officeart/2005/8/layout/orgChart1"/>
    <dgm:cxn modelId="{E1DFA751-6F03-438A-B026-F2B7DD777B06}" type="presParOf" srcId="{9E716B29-2216-4651-A18A-EAC68AA05A24}" destId="{08ADC29D-B256-4436-AD4B-5D77D4F324EE}" srcOrd="2" destOrd="0" presId="urn:microsoft.com/office/officeart/2005/8/layout/orgChart1"/>
    <dgm:cxn modelId="{20594724-D9B5-44B9-8DCE-C689C73D5721}" type="presParOf" srcId="{C6A7C44F-2A3F-4F38-BFAD-45072B23DE07}" destId="{B8F3B591-9307-4E9A-BD2C-F5D348511BEA}" srcOrd="2" destOrd="0" presId="urn:microsoft.com/office/officeart/2005/8/layout/orgChart1"/>
    <dgm:cxn modelId="{902D5067-8EBF-446F-AF34-F5F8E125A788}" type="presParOf" srcId="{C6A7C44F-2A3F-4F38-BFAD-45072B23DE07}" destId="{62F5DF37-6E28-4E05-936D-856834444042}" srcOrd="3" destOrd="0" presId="urn:microsoft.com/office/officeart/2005/8/layout/orgChart1"/>
    <dgm:cxn modelId="{E42BFB90-AD70-4F6E-B862-93A614F86F08}" type="presParOf" srcId="{62F5DF37-6E28-4E05-936D-856834444042}" destId="{01A8AF1A-CEEA-44DB-A97C-C6C9B7EC0A18}" srcOrd="0" destOrd="0" presId="urn:microsoft.com/office/officeart/2005/8/layout/orgChart1"/>
    <dgm:cxn modelId="{6E45A340-D85D-402F-ACBD-87030956F215}" type="presParOf" srcId="{01A8AF1A-CEEA-44DB-A97C-C6C9B7EC0A18}" destId="{87A60063-46AC-4CA6-8AFB-C646FC058C41}" srcOrd="0" destOrd="0" presId="urn:microsoft.com/office/officeart/2005/8/layout/orgChart1"/>
    <dgm:cxn modelId="{9017F14F-A581-424E-BFE4-867A7B444492}" type="presParOf" srcId="{01A8AF1A-CEEA-44DB-A97C-C6C9B7EC0A18}" destId="{053C0BA0-4CA6-4511-8C30-0C0AC5E87C55}" srcOrd="1" destOrd="0" presId="urn:microsoft.com/office/officeart/2005/8/layout/orgChart1"/>
    <dgm:cxn modelId="{8A0500A7-C209-4AC0-A178-44B2F6DD7AAA}" type="presParOf" srcId="{62F5DF37-6E28-4E05-936D-856834444042}" destId="{767A21D5-DB46-4A5E-9683-FA267B1DDAF5}" srcOrd="1" destOrd="0" presId="urn:microsoft.com/office/officeart/2005/8/layout/orgChart1"/>
    <dgm:cxn modelId="{7789AC7A-D575-4FCC-827F-036A89827F4C}" type="presParOf" srcId="{767A21D5-DB46-4A5E-9683-FA267B1DDAF5}" destId="{4A5C067F-FEAA-48F0-96BD-C976B883AD03}" srcOrd="0" destOrd="0" presId="urn:microsoft.com/office/officeart/2005/8/layout/orgChart1"/>
    <dgm:cxn modelId="{FD27EF85-F3F5-49B6-B3E0-39A39497DC0A}" type="presParOf" srcId="{767A21D5-DB46-4A5E-9683-FA267B1DDAF5}" destId="{2C814EFC-153B-4785-A3CE-5DD59685FE5E}" srcOrd="1" destOrd="0" presId="urn:microsoft.com/office/officeart/2005/8/layout/orgChart1"/>
    <dgm:cxn modelId="{6C512D5B-0711-4AD1-9176-1C45C9541C40}" type="presParOf" srcId="{2C814EFC-153B-4785-A3CE-5DD59685FE5E}" destId="{750B0FC5-A6CF-46AF-B159-3DF03239E033}" srcOrd="0" destOrd="0" presId="urn:microsoft.com/office/officeart/2005/8/layout/orgChart1"/>
    <dgm:cxn modelId="{D3A21DC6-034F-4AD7-B9AA-EA78ED7EDDE2}" type="presParOf" srcId="{750B0FC5-A6CF-46AF-B159-3DF03239E033}" destId="{8325B952-ADFE-4612-856B-08695AAA247D}" srcOrd="0" destOrd="0" presId="urn:microsoft.com/office/officeart/2005/8/layout/orgChart1"/>
    <dgm:cxn modelId="{E2B8C6E2-A68B-4EF8-8200-62972E2E26C2}" type="presParOf" srcId="{750B0FC5-A6CF-46AF-B159-3DF03239E033}" destId="{0B88337F-9D65-422A-B934-C9A276470656}" srcOrd="1" destOrd="0" presId="urn:microsoft.com/office/officeart/2005/8/layout/orgChart1"/>
    <dgm:cxn modelId="{C93C16EE-1F2D-4DA9-8761-1B161A10BB4B}" type="presParOf" srcId="{2C814EFC-153B-4785-A3CE-5DD59685FE5E}" destId="{B670C011-D1C4-408A-9650-A6CD88DA3311}" srcOrd="1" destOrd="0" presId="urn:microsoft.com/office/officeart/2005/8/layout/orgChart1"/>
    <dgm:cxn modelId="{50CB921B-5BA7-468B-B0D4-8A7646CD03AF}" type="presParOf" srcId="{B670C011-D1C4-408A-9650-A6CD88DA3311}" destId="{19F787B1-4285-40D5-A18E-FE58585EB3EA}" srcOrd="0" destOrd="0" presId="urn:microsoft.com/office/officeart/2005/8/layout/orgChart1"/>
    <dgm:cxn modelId="{E215EBD1-6F77-460A-809D-185119DCD725}" type="presParOf" srcId="{B670C011-D1C4-408A-9650-A6CD88DA3311}" destId="{A2EE4AA3-5240-40E4-A00C-BDED462B1FE6}" srcOrd="1" destOrd="0" presId="urn:microsoft.com/office/officeart/2005/8/layout/orgChart1"/>
    <dgm:cxn modelId="{B9CC1447-669C-4711-AE46-FDB9214BC1F6}" type="presParOf" srcId="{A2EE4AA3-5240-40E4-A00C-BDED462B1FE6}" destId="{18D96C6D-3F0D-4F37-BFF0-2495EC9FC332}" srcOrd="0" destOrd="0" presId="urn:microsoft.com/office/officeart/2005/8/layout/orgChart1"/>
    <dgm:cxn modelId="{49C91BEE-43F9-478A-9049-4DA28AE2C186}" type="presParOf" srcId="{18D96C6D-3F0D-4F37-BFF0-2495EC9FC332}" destId="{765E4F2B-E403-446B-A07D-1C67F1398557}" srcOrd="0" destOrd="0" presId="urn:microsoft.com/office/officeart/2005/8/layout/orgChart1"/>
    <dgm:cxn modelId="{8A4F13A3-781F-45BA-B9FC-2D027C39719F}" type="presParOf" srcId="{18D96C6D-3F0D-4F37-BFF0-2495EC9FC332}" destId="{39B12912-CB9D-4827-8B54-2FC5C8E01B9F}" srcOrd="1" destOrd="0" presId="urn:microsoft.com/office/officeart/2005/8/layout/orgChart1"/>
    <dgm:cxn modelId="{98F22C91-7871-46A6-9A71-87A333D50DAE}" type="presParOf" srcId="{A2EE4AA3-5240-40E4-A00C-BDED462B1FE6}" destId="{B9E0BA34-B290-415C-BB46-0772C6B4E0CF}" srcOrd="1" destOrd="0" presId="urn:microsoft.com/office/officeart/2005/8/layout/orgChart1"/>
    <dgm:cxn modelId="{B44E5578-B771-4C16-ACF9-A1D08F417715}" type="presParOf" srcId="{A2EE4AA3-5240-40E4-A00C-BDED462B1FE6}" destId="{ACDA745B-C116-4217-B3C6-2ACFED7CAB73}" srcOrd="2" destOrd="0" presId="urn:microsoft.com/office/officeart/2005/8/layout/orgChart1"/>
    <dgm:cxn modelId="{5A39775B-7C61-4258-91D8-6AD5A63DB0E0}" type="presParOf" srcId="{2C814EFC-153B-4785-A3CE-5DD59685FE5E}" destId="{AC36F49D-E3BB-437E-ADDF-0936C7DCE46F}" srcOrd="2" destOrd="0" presId="urn:microsoft.com/office/officeart/2005/8/layout/orgChart1"/>
    <dgm:cxn modelId="{AD6800FC-DB32-461D-B74A-50F9D87E1437}" type="presParOf" srcId="{767A21D5-DB46-4A5E-9683-FA267B1DDAF5}" destId="{98026F8C-44C8-445C-A43A-3675FF2FF054}" srcOrd="2" destOrd="0" presId="urn:microsoft.com/office/officeart/2005/8/layout/orgChart1"/>
    <dgm:cxn modelId="{2187C651-B73C-4ED9-A3D9-5A9AED260395}" type="presParOf" srcId="{767A21D5-DB46-4A5E-9683-FA267B1DDAF5}" destId="{087C07FD-A518-440C-87AD-772923F59E5B}" srcOrd="3" destOrd="0" presId="urn:microsoft.com/office/officeart/2005/8/layout/orgChart1"/>
    <dgm:cxn modelId="{0A584097-DF70-42C1-9DAA-AE20CF84AF05}" type="presParOf" srcId="{087C07FD-A518-440C-87AD-772923F59E5B}" destId="{480D0C00-1E82-488A-B442-6D592E18F16C}" srcOrd="0" destOrd="0" presId="urn:microsoft.com/office/officeart/2005/8/layout/orgChart1"/>
    <dgm:cxn modelId="{60225020-937A-4764-B346-28FD72CB359C}" type="presParOf" srcId="{480D0C00-1E82-488A-B442-6D592E18F16C}" destId="{A458EDC1-D4A9-4E83-B3D9-1337FCD6336E}" srcOrd="0" destOrd="0" presId="urn:microsoft.com/office/officeart/2005/8/layout/orgChart1"/>
    <dgm:cxn modelId="{4D8EC0AF-B55C-4564-8B2D-B20A4E228F42}" type="presParOf" srcId="{480D0C00-1E82-488A-B442-6D592E18F16C}" destId="{B9FCC3FA-094E-47AD-A43F-10C485D8E237}" srcOrd="1" destOrd="0" presId="urn:microsoft.com/office/officeart/2005/8/layout/orgChart1"/>
    <dgm:cxn modelId="{D7482077-50B2-44F4-9E0B-EC185FB09414}" type="presParOf" srcId="{087C07FD-A518-440C-87AD-772923F59E5B}" destId="{A22749D5-7F38-45A7-A9DD-B33265A9444C}" srcOrd="1" destOrd="0" presId="urn:microsoft.com/office/officeart/2005/8/layout/orgChart1"/>
    <dgm:cxn modelId="{1EC9CFBD-44F4-4E05-B07F-06E91031F9E9}" type="presParOf" srcId="{A22749D5-7F38-45A7-A9DD-B33265A9444C}" destId="{8CB00494-7F74-4467-A3BD-5E2ABAF8B091}" srcOrd="0" destOrd="0" presId="urn:microsoft.com/office/officeart/2005/8/layout/orgChart1"/>
    <dgm:cxn modelId="{D76CDF55-AA54-4A7A-BCC0-7AA894A66DD6}" type="presParOf" srcId="{A22749D5-7F38-45A7-A9DD-B33265A9444C}" destId="{B60FFF0B-C117-4A61-864D-ADE17A9EA5B9}" srcOrd="1" destOrd="0" presId="urn:microsoft.com/office/officeart/2005/8/layout/orgChart1"/>
    <dgm:cxn modelId="{CD01D375-3A61-4C27-BFA4-3D4DDB3C67BE}" type="presParOf" srcId="{B60FFF0B-C117-4A61-864D-ADE17A9EA5B9}" destId="{A2F2D1A3-B6D3-4323-8440-D5673C97A4E7}" srcOrd="0" destOrd="0" presId="urn:microsoft.com/office/officeart/2005/8/layout/orgChart1"/>
    <dgm:cxn modelId="{F99DA69A-AF23-4D78-B7E3-96C11E26AB9B}" type="presParOf" srcId="{A2F2D1A3-B6D3-4323-8440-D5673C97A4E7}" destId="{84ECF355-7DD3-4860-A18D-4CDD20866068}" srcOrd="0" destOrd="0" presId="urn:microsoft.com/office/officeart/2005/8/layout/orgChart1"/>
    <dgm:cxn modelId="{EC8A5EE5-C796-4763-A279-A58A2DDC11E6}" type="presParOf" srcId="{A2F2D1A3-B6D3-4323-8440-D5673C97A4E7}" destId="{052E7182-A4A9-4292-A937-78185AFB7B85}" srcOrd="1" destOrd="0" presId="urn:microsoft.com/office/officeart/2005/8/layout/orgChart1"/>
    <dgm:cxn modelId="{FC4DB10D-21E4-47EC-A3D4-A93B0CA2BBE6}" type="presParOf" srcId="{B60FFF0B-C117-4A61-864D-ADE17A9EA5B9}" destId="{2DE09D10-E54C-4D6C-A141-3BA1DC724018}" srcOrd="1" destOrd="0" presId="urn:microsoft.com/office/officeart/2005/8/layout/orgChart1"/>
    <dgm:cxn modelId="{ED589C9F-89E3-4990-9B16-F068C6D7ED0D}" type="presParOf" srcId="{B60FFF0B-C117-4A61-864D-ADE17A9EA5B9}" destId="{907FC41C-A721-498A-AECD-ED77F1D5B9D4}" srcOrd="2" destOrd="0" presId="urn:microsoft.com/office/officeart/2005/8/layout/orgChart1"/>
    <dgm:cxn modelId="{3A2F8A18-D89A-47A5-978C-1A07F5BAE767}" type="presParOf" srcId="{A22749D5-7F38-45A7-A9DD-B33265A9444C}" destId="{51F999EF-5198-4604-9932-B54113933E43}" srcOrd="2" destOrd="0" presId="urn:microsoft.com/office/officeart/2005/8/layout/orgChart1"/>
    <dgm:cxn modelId="{544EAE4D-407C-4F3D-BD8D-911FB948ECBC}" type="presParOf" srcId="{A22749D5-7F38-45A7-A9DD-B33265A9444C}" destId="{97EF0324-4423-4D69-A166-3FA5AC6CA5A7}" srcOrd="3" destOrd="0" presId="urn:microsoft.com/office/officeart/2005/8/layout/orgChart1"/>
    <dgm:cxn modelId="{FB62EC4A-E676-400C-AAC6-F7C95085EACE}" type="presParOf" srcId="{97EF0324-4423-4D69-A166-3FA5AC6CA5A7}" destId="{B0C66A13-5826-48B1-9646-C2CB4BC6FEED}" srcOrd="0" destOrd="0" presId="urn:microsoft.com/office/officeart/2005/8/layout/orgChart1"/>
    <dgm:cxn modelId="{009626E6-EB83-4EEF-ABE2-86965984F046}" type="presParOf" srcId="{B0C66A13-5826-48B1-9646-C2CB4BC6FEED}" destId="{8766715A-D510-4EE8-AD86-94BC512AC9E6}" srcOrd="0" destOrd="0" presId="urn:microsoft.com/office/officeart/2005/8/layout/orgChart1"/>
    <dgm:cxn modelId="{A464BF22-95F1-4AB6-9C7B-B7F817D68FE2}" type="presParOf" srcId="{B0C66A13-5826-48B1-9646-C2CB4BC6FEED}" destId="{507C2284-9152-4E39-973E-897171EB7CBA}" srcOrd="1" destOrd="0" presId="urn:microsoft.com/office/officeart/2005/8/layout/orgChart1"/>
    <dgm:cxn modelId="{1F43A50A-DE4F-4AB9-98AC-011B0D80FD0C}" type="presParOf" srcId="{97EF0324-4423-4D69-A166-3FA5AC6CA5A7}" destId="{0A43A259-7C18-4EFF-A8A5-308E6DA3EAB2}" srcOrd="1" destOrd="0" presId="urn:microsoft.com/office/officeart/2005/8/layout/orgChart1"/>
    <dgm:cxn modelId="{758198D1-BDD8-4C99-9516-15A55F2D41F7}" type="presParOf" srcId="{97EF0324-4423-4D69-A166-3FA5AC6CA5A7}" destId="{3D2C1DCE-5652-4192-A86D-CA5825EB4F1A}" srcOrd="2" destOrd="0" presId="urn:microsoft.com/office/officeart/2005/8/layout/orgChart1"/>
    <dgm:cxn modelId="{03EF3CD1-E52E-4FB3-9332-B1789922CBF1}" type="presParOf" srcId="{087C07FD-A518-440C-87AD-772923F59E5B}" destId="{4684B430-7C74-4512-A400-9E8B497CA81D}" srcOrd="2" destOrd="0" presId="urn:microsoft.com/office/officeart/2005/8/layout/orgChart1"/>
    <dgm:cxn modelId="{FAE63F27-AC5E-4173-A2C1-F578E64BA76A}" type="presParOf" srcId="{62F5DF37-6E28-4E05-936D-856834444042}" destId="{3720040D-3AE9-4331-B7F0-6E6FC0A11B66}" srcOrd="2" destOrd="0" presId="urn:microsoft.com/office/officeart/2005/8/layout/orgChart1"/>
    <dgm:cxn modelId="{60436BA5-6C3D-42F2-96E9-EBC3899A2934}" type="presParOf" srcId="{238AEF1C-EA40-47B2-AD6F-C7FBDF9862A4}" destId="{47FB9601-75D0-40F0-80FD-CB6CE639BD01}" srcOrd="2" destOrd="0" presId="urn:microsoft.com/office/officeart/2005/8/layout/orgChart1"/>
    <dgm:cxn modelId="{335D6E38-09B9-4F4A-99ED-55CECDDA0BBC}" type="presParOf" srcId="{2620BDDE-FA0E-4A4C-8A0C-B5CB145438F5}" destId="{A34C4E21-1952-4E8E-9318-1E0F6325910B}" srcOrd="2" destOrd="0" presId="urn:microsoft.com/office/officeart/2005/8/layout/orgChart1"/>
    <dgm:cxn modelId="{CD177C01-BC39-471E-AE88-ECF63F27306A}" type="presParOf" srcId="{2620BDDE-FA0E-4A4C-8A0C-B5CB145438F5}" destId="{C0C776D2-B6FD-4813-A723-50E62672EB30}" srcOrd="3" destOrd="0" presId="urn:microsoft.com/office/officeart/2005/8/layout/orgChart1"/>
    <dgm:cxn modelId="{3710CB49-17BF-4F1A-9216-3713800DBA93}" type="presParOf" srcId="{C0C776D2-B6FD-4813-A723-50E62672EB30}" destId="{DBA89F9D-73E8-4A0D-8327-077481BD0AEC}" srcOrd="0" destOrd="0" presId="urn:microsoft.com/office/officeart/2005/8/layout/orgChart1"/>
    <dgm:cxn modelId="{E769CD8E-AFAA-4756-80E1-3B35AD640BD5}" type="presParOf" srcId="{DBA89F9D-73E8-4A0D-8327-077481BD0AEC}" destId="{D29044B6-296F-43E9-9A97-6C76EB922610}" srcOrd="0" destOrd="0" presId="urn:microsoft.com/office/officeart/2005/8/layout/orgChart1"/>
    <dgm:cxn modelId="{B038375D-F665-45B2-9554-5A24D157E0FD}" type="presParOf" srcId="{DBA89F9D-73E8-4A0D-8327-077481BD0AEC}" destId="{A054C64C-5610-4BB3-99DE-F3FB705E364F}" srcOrd="1" destOrd="0" presId="urn:microsoft.com/office/officeart/2005/8/layout/orgChart1"/>
    <dgm:cxn modelId="{4AE98C9B-EEE6-4434-BD15-10066AC67A55}" type="presParOf" srcId="{C0C776D2-B6FD-4813-A723-50E62672EB30}" destId="{223A5FD3-3627-4485-AE36-0CC4C7731A2C}" srcOrd="1" destOrd="0" presId="urn:microsoft.com/office/officeart/2005/8/layout/orgChart1"/>
    <dgm:cxn modelId="{62F471E5-22B6-402A-B0E3-EDD11BA0FC21}" type="presParOf" srcId="{223A5FD3-3627-4485-AE36-0CC4C7731A2C}" destId="{3967BE9E-1271-4178-BBCF-D43AA34D64C1}" srcOrd="0" destOrd="0" presId="urn:microsoft.com/office/officeart/2005/8/layout/orgChart1"/>
    <dgm:cxn modelId="{3898C55B-F8F5-45E4-88D3-D93E5CCCD407}" type="presParOf" srcId="{223A5FD3-3627-4485-AE36-0CC4C7731A2C}" destId="{6B1B42A0-991C-47C1-AD45-D36147154766}" srcOrd="1" destOrd="0" presId="urn:microsoft.com/office/officeart/2005/8/layout/orgChart1"/>
    <dgm:cxn modelId="{6CC44EE7-2672-4B1A-9E4C-1F9FF418E7B7}" type="presParOf" srcId="{6B1B42A0-991C-47C1-AD45-D36147154766}" destId="{12D7D4C6-B926-43DD-B16B-137ACE55459B}" srcOrd="0" destOrd="0" presId="urn:microsoft.com/office/officeart/2005/8/layout/orgChart1"/>
    <dgm:cxn modelId="{7068803A-4D3C-4706-B891-4246A3301432}" type="presParOf" srcId="{12D7D4C6-B926-43DD-B16B-137ACE55459B}" destId="{F3963130-01C5-4F4B-8C80-55CA0768ED6D}" srcOrd="0" destOrd="0" presId="urn:microsoft.com/office/officeart/2005/8/layout/orgChart1"/>
    <dgm:cxn modelId="{752D3FF0-2231-48B7-B082-4FB8E8C07F9C}" type="presParOf" srcId="{12D7D4C6-B926-43DD-B16B-137ACE55459B}" destId="{54540217-D25C-482C-9400-2728C8279265}" srcOrd="1" destOrd="0" presId="urn:microsoft.com/office/officeart/2005/8/layout/orgChart1"/>
    <dgm:cxn modelId="{7A544946-14BB-4000-BDE2-BF43437A6354}" type="presParOf" srcId="{6B1B42A0-991C-47C1-AD45-D36147154766}" destId="{3072B601-3295-4BFE-999E-17F60EB33BA1}" srcOrd="1" destOrd="0" presId="urn:microsoft.com/office/officeart/2005/8/layout/orgChart1"/>
    <dgm:cxn modelId="{7FBFEEDC-74C0-4163-B1F5-0E195365889F}" type="presParOf" srcId="{3072B601-3295-4BFE-999E-17F60EB33BA1}" destId="{8A06E381-8819-4037-A125-902EA70F0BD6}" srcOrd="0" destOrd="0" presId="urn:microsoft.com/office/officeart/2005/8/layout/orgChart1"/>
    <dgm:cxn modelId="{0B5807C9-B73D-4B9D-BA1B-048F4D3128D9}" type="presParOf" srcId="{3072B601-3295-4BFE-999E-17F60EB33BA1}" destId="{89760EFB-4C29-48C8-BCB6-86D811875309}" srcOrd="1" destOrd="0" presId="urn:microsoft.com/office/officeart/2005/8/layout/orgChart1"/>
    <dgm:cxn modelId="{6EDCF2A5-5721-4A28-8E6E-F48C13043C5B}" type="presParOf" srcId="{89760EFB-4C29-48C8-BCB6-86D811875309}" destId="{F1012AB4-6951-42DE-A288-0F784ED23728}" srcOrd="0" destOrd="0" presId="urn:microsoft.com/office/officeart/2005/8/layout/orgChart1"/>
    <dgm:cxn modelId="{5E1B2157-ABE5-48C3-AF37-D0402D470EEC}" type="presParOf" srcId="{F1012AB4-6951-42DE-A288-0F784ED23728}" destId="{FEEE0391-2F66-4C25-B135-60F552ABA19C}" srcOrd="0" destOrd="0" presId="urn:microsoft.com/office/officeart/2005/8/layout/orgChart1"/>
    <dgm:cxn modelId="{AB90A865-5780-4A8D-A6CF-DEDDF05FBE72}" type="presParOf" srcId="{F1012AB4-6951-42DE-A288-0F784ED23728}" destId="{60E711BD-EF5A-4B03-B99F-FDA386DAAAC5}" srcOrd="1" destOrd="0" presId="urn:microsoft.com/office/officeart/2005/8/layout/orgChart1"/>
    <dgm:cxn modelId="{A272AEC9-841F-4BAC-9243-2810B42B28DD}" type="presParOf" srcId="{89760EFB-4C29-48C8-BCB6-86D811875309}" destId="{19D00B09-4BA9-40A2-93DA-08BC8B7B3F08}" srcOrd="1" destOrd="0" presId="urn:microsoft.com/office/officeart/2005/8/layout/orgChart1"/>
    <dgm:cxn modelId="{26072E99-3763-4858-A6D3-1AE51A35BF93}" type="presParOf" srcId="{19D00B09-4BA9-40A2-93DA-08BC8B7B3F08}" destId="{1230424A-EF84-4B61-94B6-A21103AF4BEC}" srcOrd="0" destOrd="0" presId="urn:microsoft.com/office/officeart/2005/8/layout/orgChart1"/>
    <dgm:cxn modelId="{3F62F81C-1CB3-487E-8256-0122A064F892}" type="presParOf" srcId="{19D00B09-4BA9-40A2-93DA-08BC8B7B3F08}" destId="{20B5AC95-B176-474F-8827-4ECF7F2F0FFB}" srcOrd="1" destOrd="0" presId="urn:microsoft.com/office/officeart/2005/8/layout/orgChart1"/>
    <dgm:cxn modelId="{DBB48C44-3D69-428C-AEB7-4438F8750782}" type="presParOf" srcId="{20B5AC95-B176-474F-8827-4ECF7F2F0FFB}" destId="{4A66845B-F979-4341-99E0-09091175AA32}" srcOrd="0" destOrd="0" presId="urn:microsoft.com/office/officeart/2005/8/layout/orgChart1"/>
    <dgm:cxn modelId="{F135C5C0-E250-415E-98E0-D6F477B791FC}" type="presParOf" srcId="{4A66845B-F979-4341-99E0-09091175AA32}" destId="{148A377F-FBE0-41AA-9F47-1AD7E47589A0}" srcOrd="0" destOrd="0" presId="urn:microsoft.com/office/officeart/2005/8/layout/orgChart1"/>
    <dgm:cxn modelId="{53DC99E1-52A9-412C-94EC-AD43D85CE918}" type="presParOf" srcId="{4A66845B-F979-4341-99E0-09091175AA32}" destId="{5C142C8B-C534-4D51-A3A2-288A16925F33}" srcOrd="1" destOrd="0" presId="urn:microsoft.com/office/officeart/2005/8/layout/orgChart1"/>
    <dgm:cxn modelId="{CB3B610E-64CF-4552-9C74-B48C83C05706}" type="presParOf" srcId="{20B5AC95-B176-474F-8827-4ECF7F2F0FFB}" destId="{96683D4B-DACA-4D4F-9786-7413C95D3A38}" srcOrd="1" destOrd="0" presId="urn:microsoft.com/office/officeart/2005/8/layout/orgChart1"/>
    <dgm:cxn modelId="{11B0284A-CFA2-48EB-9A22-4F87509F765E}" type="presParOf" srcId="{20B5AC95-B176-474F-8827-4ECF7F2F0FFB}" destId="{660DD28E-E052-49E4-A187-5277F8E9DAED}" srcOrd="2" destOrd="0" presId="urn:microsoft.com/office/officeart/2005/8/layout/orgChart1"/>
    <dgm:cxn modelId="{0E8000A4-277D-4E2F-B343-2B3E4DA6DBD3}" type="presParOf" srcId="{89760EFB-4C29-48C8-BCB6-86D811875309}" destId="{720F7BE9-AE14-4F37-AB2C-77B79AEA8070}" srcOrd="2" destOrd="0" presId="urn:microsoft.com/office/officeart/2005/8/layout/orgChart1"/>
    <dgm:cxn modelId="{9A6778CE-80F1-4DF5-B119-80C209E6C7CC}" type="presParOf" srcId="{3072B601-3295-4BFE-999E-17F60EB33BA1}" destId="{862E9566-7B2C-4E20-9072-A206352353D9}" srcOrd="2" destOrd="0" presId="urn:microsoft.com/office/officeart/2005/8/layout/orgChart1"/>
    <dgm:cxn modelId="{4769E750-0061-4237-9E2B-C9CB9B16BD11}" type="presParOf" srcId="{3072B601-3295-4BFE-999E-17F60EB33BA1}" destId="{C30A18BD-A4F2-4095-A080-21F6B04E3B3F}" srcOrd="3" destOrd="0" presId="urn:microsoft.com/office/officeart/2005/8/layout/orgChart1"/>
    <dgm:cxn modelId="{A84E8F6B-1D86-4783-A230-BA14AF0F4AE9}" type="presParOf" srcId="{C30A18BD-A4F2-4095-A080-21F6B04E3B3F}" destId="{5CBB7CA5-DED0-4D01-930C-3CA8512F5366}" srcOrd="0" destOrd="0" presId="urn:microsoft.com/office/officeart/2005/8/layout/orgChart1"/>
    <dgm:cxn modelId="{F1910ADB-63D4-4B33-BFD3-DB1054FB6E88}" type="presParOf" srcId="{5CBB7CA5-DED0-4D01-930C-3CA8512F5366}" destId="{EF31350D-14A7-44C8-A461-3E7A3A6B8F1A}" srcOrd="0" destOrd="0" presId="urn:microsoft.com/office/officeart/2005/8/layout/orgChart1"/>
    <dgm:cxn modelId="{23CCFA48-4E3C-4188-A045-5F061F7552FE}" type="presParOf" srcId="{5CBB7CA5-DED0-4D01-930C-3CA8512F5366}" destId="{A0711F13-4E75-4C6C-B889-A20EAE4F3AEB}" srcOrd="1" destOrd="0" presId="urn:microsoft.com/office/officeart/2005/8/layout/orgChart1"/>
    <dgm:cxn modelId="{E3EABA7C-7257-43B4-8721-131BF3736D0D}" type="presParOf" srcId="{C30A18BD-A4F2-4095-A080-21F6B04E3B3F}" destId="{8F44FF39-E9D5-48BB-AB19-4EAB28B092EA}" srcOrd="1" destOrd="0" presId="urn:microsoft.com/office/officeart/2005/8/layout/orgChart1"/>
    <dgm:cxn modelId="{1AF337EB-0235-4BE3-BAF2-2F157A72BB7D}" type="presParOf" srcId="{8F44FF39-E9D5-48BB-AB19-4EAB28B092EA}" destId="{E3C6DA40-0164-4E21-A22C-6CE63583D97D}" srcOrd="0" destOrd="0" presId="urn:microsoft.com/office/officeart/2005/8/layout/orgChart1"/>
    <dgm:cxn modelId="{AD08223C-BDED-41A5-817C-4CD289E402E8}" type="presParOf" srcId="{8F44FF39-E9D5-48BB-AB19-4EAB28B092EA}" destId="{275CA3C6-9FF7-4BAD-9FB9-2136FFC4B979}" srcOrd="1" destOrd="0" presId="urn:microsoft.com/office/officeart/2005/8/layout/orgChart1"/>
    <dgm:cxn modelId="{77316C97-69DE-426C-ADF7-F6D0BC2AE563}" type="presParOf" srcId="{275CA3C6-9FF7-4BAD-9FB9-2136FFC4B979}" destId="{6C218261-1D93-43D0-A2FC-479208F5E867}" srcOrd="0" destOrd="0" presId="urn:microsoft.com/office/officeart/2005/8/layout/orgChart1"/>
    <dgm:cxn modelId="{FFDD7B8D-514D-4151-A8A2-F85706490A61}" type="presParOf" srcId="{6C218261-1D93-43D0-A2FC-479208F5E867}" destId="{AF4ED730-3812-4A53-9CB4-52489E7CD8D0}" srcOrd="0" destOrd="0" presId="urn:microsoft.com/office/officeart/2005/8/layout/orgChart1"/>
    <dgm:cxn modelId="{5E7B4B9E-C8EF-45A1-B2F3-A5FEEA0717BC}" type="presParOf" srcId="{6C218261-1D93-43D0-A2FC-479208F5E867}" destId="{2B200D36-77CA-4FDF-8C79-0399DDE7CCE7}" srcOrd="1" destOrd="0" presId="urn:microsoft.com/office/officeart/2005/8/layout/orgChart1"/>
    <dgm:cxn modelId="{BBEAB4C5-FC93-4499-94CC-7DDB0BDC6621}" type="presParOf" srcId="{275CA3C6-9FF7-4BAD-9FB9-2136FFC4B979}" destId="{23120E76-D6D5-4C9A-838B-9EF6E87C0967}" srcOrd="1" destOrd="0" presId="urn:microsoft.com/office/officeart/2005/8/layout/orgChart1"/>
    <dgm:cxn modelId="{5B05B95E-BF33-4526-9F0E-817E8BC5CB11}" type="presParOf" srcId="{275CA3C6-9FF7-4BAD-9FB9-2136FFC4B979}" destId="{482686A4-B53D-4B3A-9B73-49C1E9400922}" srcOrd="2" destOrd="0" presId="urn:microsoft.com/office/officeart/2005/8/layout/orgChart1"/>
    <dgm:cxn modelId="{46BF53B4-5404-408F-83FD-811A6E80F04C}" type="presParOf" srcId="{C30A18BD-A4F2-4095-A080-21F6B04E3B3F}" destId="{62724D82-971F-4B96-8488-86B7ECC1E3B5}" srcOrd="2" destOrd="0" presId="urn:microsoft.com/office/officeart/2005/8/layout/orgChart1"/>
    <dgm:cxn modelId="{FA7F488F-3070-44DE-8EFE-6978CE0612DB}" type="presParOf" srcId="{6B1B42A0-991C-47C1-AD45-D36147154766}" destId="{3F96B487-6BDE-46D3-9829-B49F1F94E8E5}" srcOrd="2" destOrd="0" presId="urn:microsoft.com/office/officeart/2005/8/layout/orgChart1"/>
    <dgm:cxn modelId="{7F01DDB7-C152-4082-84D1-20DB7B4CE7AE}" type="presParOf" srcId="{223A5FD3-3627-4485-AE36-0CC4C7731A2C}" destId="{ADF92AF4-0D65-40DE-8D71-D58D9EEA2B1F}" srcOrd="2" destOrd="0" presId="urn:microsoft.com/office/officeart/2005/8/layout/orgChart1"/>
    <dgm:cxn modelId="{C35844D6-123C-4FEB-87C1-818A1AB0CAE3}" type="presParOf" srcId="{223A5FD3-3627-4485-AE36-0CC4C7731A2C}" destId="{A3979363-5C51-45D1-9B04-88AB11B6A951}" srcOrd="3" destOrd="0" presId="urn:microsoft.com/office/officeart/2005/8/layout/orgChart1"/>
    <dgm:cxn modelId="{76323ADA-85C4-4402-A3CA-0FC647C6203F}" type="presParOf" srcId="{A3979363-5C51-45D1-9B04-88AB11B6A951}" destId="{8F63FCDB-12E4-41A1-9C12-376835AFC24C}" srcOrd="0" destOrd="0" presId="urn:microsoft.com/office/officeart/2005/8/layout/orgChart1"/>
    <dgm:cxn modelId="{BD0327FB-1E3C-401C-A59C-0FD1472A7628}" type="presParOf" srcId="{8F63FCDB-12E4-41A1-9C12-376835AFC24C}" destId="{9735BBE2-731E-4A6A-A9DC-FABB30A5B699}" srcOrd="0" destOrd="0" presId="urn:microsoft.com/office/officeart/2005/8/layout/orgChart1"/>
    <dgm:cxn modelId="{3866A678-BC7F-40F6-9D6C-84A09F92F200}" type="presParOf" srcId="{8F63FCDB-12E4-41A1-9C12-376835AFC24C}" destId="{0E1B9CD5-FDC2-4DA7-A527-596D7E53B6A0}" srcOrd="1" destOrd="0" presId="urn:microsoft.com/office/officeart/2005/8/layout/orgChart1"/>
    <dgm:cxn modelId="{527B08A5-A192-4DD1-B0CD-9AD4C7908ACE}" type="presParOf" srcId="{A3979363-5C51-45D1-9B04-88AB11B6A951}" destId="{A919E197-3725-4185-B9D5-79210BB8F151}" srcOrd="1" destOrd="0" presId="urn:microsoft.com/office/officeart/2005/8/layout/orgChart1"/>
    <dgm:cxn modelId="{BAD776F0-EE3A-4A6A-8CD0-D130DF7829BF}" type="presParOf" srcId="{A919E197-3725-4185-B9D5-79210BB8F151}" destId="{98947DF3-F26C-4AA9-A2A9-A7D9763CF728}" srcOrd="0" destOrd="0" presId="urn:microsoft.com/office/officeart/2005/8/layout/orgChart1"/>
    <dgm:cxn modelId="{26932E11-DEC2-4E5E-8B37-46E0CC8FF12C}" type="presParOf" srcId="{A919E197-3725-4185-B9D5-79210BB8F151}" destId="{7C26DFB7-6126-4CC0-B2FA-D1E7734D9148}" srcOrd="1" destOrd="0" presId="urn:microsoft.com/office/officeart/2005/8/layout/orgChart1"/>
    <dgm:cxn modelId="{FDDB20F4-CB96-4F08-BD37-456BFD061194}" type="presParOf" srcId="{7C26DFB7-6126-4CC0-B2FA-D1E7734D9148}" destId="{3919AEF1-18DB-4724-9EDD-3BC181EC3339}" srcOrd="0" destOrd="0" presId="urn:microsoft.com/office/officeart/2005/8/layout/orgChart1"/>
    <dgm:cxn modelId="{9213049F-D393-4C55-A444-11E2719FB80E}" type="presParOf" srcId="{3919AEF1-18DB-4724-9EDD-3BC181EC3339}" destId="{7608DE48-B886-49F4-839C-63DDC3306FE1}" srcOrd="0" destOrd="0" presId="urn:microsoft.com/office/officeart/2005/8/layout/orgChart1"/>
    <dgm:cxn modelId="{622D1139-B321-4E82-BAEC-7222D8116E10}" type="presParOf" srcId="{3919AEF1-18DB-4724-9EDD-3BC181EC3339}" destId="{6FEDFC57-8674-49DE-8913-5BF6C3337ADF}" srcOrd="1" destOrd="0" presId="urn:microsoft.com/office/officeart/2005/8/layout/orgChart1"/>
    <dgm:cxn modelId="{A392CF22-E25F-4CD6-AD00-D397B4BF8F7C}" type="presParOf" srcId="{7C26DFB7-6126-4CC0-B2FA-D1E7734D9148}" destId="{D9CF026C-5730-4E63-8B31-29296DD0A140}" srcOrd="1" destOrd="0" presId="urn:microsoft.com/office/officeart/2005/8/layout/orgChart1"/>
    <dgm:cxn modelId="{54A1B6D4-0774-4E2E-BEBE-DE28085B7A83}" type="presParOf" srcId="{D9CF026C-5730-4E63-8B31-29296DD0A140}" destId="{B4664688-559F-4662-A72A-DF835209CD27}" srcOrd="0" destOrd="0" presId="urn:microsoft.com/office/officeart/2005/8/layout/orgChart1"/>
    <dgm:cxn modelId="{24708D6E-76D0-4DFF-9C93-787872ED2EB8}" type="presParOf" srcId="{D9CF026C-5730-4E63-8B31-29296DD0A140}" destId="{BA3C62C7-309C-4326-9B03-2895ADB525F4}" srcOrd="1" destOrd="0" presId="urn:microsoft.com/office/officeart/2005/8/layout/orgChart1"/>
    <dgm:cxn modelId="{541E3771-80C7-468B-A984-AF2E559F74F0}" type="presParOf" srcId="{BA3C62C7-309C-4326-9B03-2895ADB525F4}" destId="{8ECB819B-55FA-406E-B3A9-1B9D552DD96D}" srcOrd="0" destOrd="0" presId="urn:microsoft.com/office/officeart/2005/8/layout/orgChart1"/>
    <dgm:cxn modelId="{67B19F5E-745E-4BEE-859D-4E0D39742E81}" type="presParOf" srcId="{8ECB819B-55FA-406E-B3A9-1B9D552DD96D}" destId="{BD750659-6154-46D5-BA03-1754BA762AEF}" srcOrd="0" destOrd="0" presId="urn:microsoft.com/office/officeart/2005/8/layout/orgChart1"/>
    <dgm:cxn modelId="{7EF4A6D5-87D2-4570-8CA0-51AC530E45E5}" type="presParOf" srcId="{8ECB819B-55FA-406E-B3A9-1B9D552DD96D}" destId="{F37FF3B3-7FDA-4BD1-B6C6-904B1B101FA4}" srcOrd="1" destOrd="0" presId="urn:microsoft.com/office/officeart/2005/8/layout/orgChart1"/>
    <dgm:cxn modelId="{8BF3A10B-0039-4B2B-92D1-6EA93D4F4813}" type="presParOf" srcId="{BA3C62C7-309C-4326-9B03-2895ADB525F4}" destId="{5C50C3BA-09B3-41FC-AF41-D602E80403B4}" srcOrd="1" destOrd="0" presId="urn:microsoft.com/office/officeart/2005/8/layout/orgChart1"/>
    <dgm:cxn modelId="{28922FB4-A427-4C04-9900-22E54D1370A3}" type="presParOf" srcId="{BA3C62C7-309C-4326-9B03-2895ADB525F4}" destId="{BF19FAC6-4B32-48C8-8F43-FDCE8ADEC8E6}" srcOrd="2" destOrd="0" presId="urn:microsoft.com/office/officeart/2005/8/layout/orgChart1"/>
    <dgm:cxn modelId="{5A350D66-5323-4161-87A8-85D22FFA6EAA}" type="presParOf" srcId="{7C26DFB7-6126-4CC0-B2FA-D1E7734D9148}" destId="{3F1C98B9-75BC-4603-B00E-2AC51D6EEA91}" srcOrd="2" destOrd="0" presId="urn:microsoft.com/office/officeart/2005/8/layout/orgChart1"/>
    <dgm:cxn modelId="{71F6B7B3-0327-4941-9B8C-24EB0408F4D8}" type="presParOf" srcId="{A3979363-5C51-45D1-9B04-88AB11B6A951}" destId="{7671C0A1-4FA8-4929-B6E0-CFF8755448F4}" srcOrd="2" destOrd="0" presId="urn:microsoft.com/office/officeart/2005/8/layout/orgChart1"/>
    <dgm:cxn modelId="{A0AF0DEC-F3EE-4F5B-BE81-79FC448DF8A3}" type="presParOf" srcId="{C0C776D2-B6FD-4813-A723-50E62672EB30}" destId="{81465FEB-EE36-435D-81BF-7B2635A2FE04}" srcOrd="2" destOrd="0" presId="urn:microsoft.com/office/officeart/2005/8/layout/orgChart1"/>
    <dgm:cxn modelId="{4E60A771-C976-4697-A918-305A59E1FBCA}" type="presParOf" srcId="{AEAB85E9-A70C-4405-877A-25C8499667A5}" destId="{95B5BBEB-17E4-4B5B-83D2-81DDC4ED57BB}" srcOrd="2" destOrd="0" presId="urn:microsoft.com/office/officeart/2005/8/layout/orgChart1"/>
    <dgm:cxn modelId="{E4B5E039-A49C-4EB7-A7A9-506773B6CE6A}" type="presParOf" srcId="{95B5BBEB-17E4-4B5B-83D2-81DDC4ED57BB}" destId="{5B8F574D-2549-48EE-A494-3BDF5EFAFDFB}" srcOrd="0" destOrd="0" presId="urn:microsoft.com/office/officeart/2005/8/layout/orgChart1"/>
    <dgm:cxn modelId="{2E070511-83F5-4AD5-BE84-EC6E60D3F78E}" type="presParOf" srcId="{95B5BBEB-17E4-4B5B-83D2-81DDC4ED57BB}" destId="{CBBAE37C-EB00-4ED5-B7A4-993A7D7D2827}" srcOrd="1" destOrd="0" presId="urn:microsoft.com/office/officeart/2005/8/layout/orgChart1"/>
    <dgm:cxn modelId="{9493CF9E-CC04-47E5-BCEB-CF11E409D8DF}" type="presParOf" srcId="{CBBAE37C-EB00-4ED5-B7A4-993A7D7D2827}" destId="{BEAFE833-502B-4DB3-90FA-0A2D4FA2E75C}" srcOrd="0" destOrd="0" presId="urn:microsoft.com/office/officeart/2005/8/layout/orgChart1"/>
    <dgm:cxn modelId="{7055288D-8F5F-4C66-ACDE-445A16D1CBC4}" type="presParOf" srcId="{BEAFE833-502B-4DB3-90FA-0A2D4FA2E75C}" destId="{4F790CF3-DC77-46DD-959C-2556C4356DAC}" srcOrd="0" destOrd="0" presId="urn:microsoft.com/office/officeart/2005/8/layout/orgChart1"/>
    <dgm:cxn modelId="{7A56EA80-81EB-4D00-9B0A-04DD0F64D515}" type="presParOf" srcId="{BEAFE833-502B-4DB3-90FA-0A2D4FA2E75C}" destId="{A91D837E-D072-4DD7-B633-05F60A2CBEDD}" srcOrd="1" destOrd="0" presId="urn:microsoft.com/office/officeart/2005/8/layout/orgChart1"/>
    <dgm:cxn modelId="{F24A012F-5701-47E1-9C83-1ADA2B222D49}" type="presParOf" srcId="{CBBAE37C-EB00-4ED5-B7A4-993A7D7D2827}" destId="{B7DBF302-AF9D-46BD-A338-181BD46A6831}" srcOrd="1" destOrd="0" presId="urn:microsoft.com/office/officeart/2005/8/layout/orgChart1"/>
    <dgm:cxn modelId="{51E7F726-8D6B-4075-AFEE-928E4D9E7422}" type="presParOf" srcId="{CBBAE37C-EB00-4ED5-B7A4-993A7D7D2827}" destId="{7EF8D043-6770-4FEB-8B74-488B9AE9E338}" srcOrd="2" destOrd="0" presId="urn:microsoft.com/office/officeart/2005/8/layout/orgChart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6BD44C91-1E07-4C76-A038-9B12972016B7}" type="doc">
      <dgm:prSet loTypeId="urn:microsoft.com/office/officeart/2005/8/layout/orgChart1" loCatId="hierarchy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GB"/>
        </a:p>
      </dgm:t>
    </dgm:pt>
    <dgm:pt modelId="{AE8828E0-C571-4F8A-9003-C6EADEAC1B46}">
      <dgm:prSet phldrT="[テキスト]"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AED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6</a:t>
          </a:r>
        </a:p>
      </dgm:t>
    </dgm:pt>
    <dgm:pt modelId="{250AB9AA-6031-496F-B7F1-6F0DB8F8D34D}" type="parTrans" cxnId="{8A04F2E9-B3C3-477D-81C1-C4C55D06F5AC}">
      <dgm:prSet/>
      <dgm:spPr/>
      <dgm:t>
        <a:bodyPr/>
        <a:lstStyle/>
        <a:p>
          <a:endParaRPr lang="en-GB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23EE6B3-9394-4A9C-BC80-CD2D7E190BEE}" type="sibTrans" cxnId="{8A04F2E9-B3C3-477D-81C1-C4C55D06F5AC}">
      <dgm:prSet/>
      <dgm:spPr/>
      <dgm:t>
        <a:bodyPr/>
        <a:lstStyle/>
        <a:p>
          <a:endParaRPr lang="en-GB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E83BC88-359D-47C4-9BBC-5EFD9E609921}">
      <dgm:prSet phldrT="[テキスト]"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cond phase (+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0</a:t>
          </a:r>
        </a:p>
      </dgm:t>
    </dgm:pt>
    <dgm:pt modelId="{349DFFB7-BC3E-496C-9A61-DB19C5510C78}" type="parTrans" cxnId="{A90AE4A2-BCC2-473B-8C01-9C25A61576FD}">
      <dgm:prSet/>
      <dgm:spPr>
        <a:ln w="38100">
          <a:solidFill>
            <a:schemeClr val="tx1"/>
          </a:solidFill>
        </a:ln>
      </dgm:spPr>
      <dgm:t>
        <a:bodyPr/>
        <a:lstStyle/>
        <a:p>
          <a:endParaRPr lang="en-GB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8914FDC-1103-4794-9FC5-BBCE7D31505E}" type="sibTrans" cxnId="{A90AE4A2-BCC2-473B-8C01-9C25A61576FD}">
      <dgm:prSet/>
      <dgm:spPr/>
      <dgm:t>
        <a:bodyPr/>
        <a:lstStyle/>
        <a:p>
          <a:endParaRPr lang="en-GB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F8E4E8F-2702-4226-B47E-68170BE88C0D}">
      <dgm:prSet phldrT="[テキスト]" custT="1"/>
      <dgm:spPr>
        <a:noFill/>
        <a:ln w="38100"/>
      </dgm:spPr>
      <dgm:t>
        <a:bodyPr/>
        <a:lstStyle/>
        <a:p>
          <a:endParaRPr lang="en-GB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cond phase (-) 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(including the Early-Hypo group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5, </a:t>
          </a:r>
          <a:r>
            <a:rPr kumimoji="1" lang="en-GB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8, 9, 11, 13, 14</a:t>
          </a:r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endParaRPr lang="en-GB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D8232B4-3BCE-40FA-A9D1-F6EE9E34EB34}" type="parTrans" cxnId="{028A7CDE-6550-4045-963A-6A713CF1D98F}">
      <dgm:prSet/>
      <dgm:spPr>
        <a:ln w="38100">
          <a:solidFill>
            <a:schemeClr val="tx1"/>
          </a:solidFill>
        </a:ln>
      </dgm:spPr>
      <dgm:t>
        <a:bodyPr/>
        <a:lstStyle/>
        <a:p>
          <a:endParaRPr lang="en-GB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AF3179A-5447-46D1-A265-947BF4F4C0FD}" type="sibTrans" cxnId="{028A7CDE-6550-4045-963A-6A713CF1D98F}">
      <dgm:prSet/>
      <dgm:spPr/>
      <dgm:t>
        <a:bodyPr/>
        <a:lstStyle/>
        <a:p>
          <a:endParaRPr lang="en-GB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BA59BEF-F7D1-47B1-A43A-3B0DA8C93D02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ilateral prefrontal lesions (+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5</a:t>
          </a:r>
        </a:p>
      </dgm:t>
    </dgm:pt>
    <dgm:pt modelId="{591BECE1-B841-4D57-8D99-F9DC0D22DBF9}" type="parTrans" cxnId="{0E5B4B47-2492-40A1-83E6-BD47B39E6303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FBA63D2-4340-4F0B-9F4C-41BDAD04658C}" type="sibTrans" cxnId="{0E5B4B47-2492-40A1-83E6-BD47B39E6303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AC4D152-DFE4-4D71-BCD7-D8DC7E5B64B5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ilateral frontal lesions (+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8</a:t>
          </a:r>
        </a:p>
      </dgm:t>
    </dgm:pt>
    <dgm:pt modelId="{7FCCC78F-80A8-4888-9D91-58DF6A1A42BD}" type="parTrans" cxnId="{F053260C-5125-40E2-83C8-B6354C9C4C46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835D1D55-2F16-48B8-97A0-0C788CA076BB}" type="sibTrans" cxnId="{F053260C-5125-40E2-83C8-B6354C9C4C46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E694C0F-8AB1-4632-B2DA-D1247D8BE18F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ilateral frontal lesions (-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  <a:endParaRPr lang="en-GB" sz="1200" b="1" dirty="0">
            <a:solidFill>
              <a:srgbClr val="FF0000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D248CC2-3184-460B-A00A-1B722842C143}" type="parTrans" cxnId="{4C2220C4-39F9-457D-B555-599D9E5B3164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82A1D0C-24B1-4AA0-9246-BA20D4269306}" type="sibTrans" cxnId="{4C2220C4-39F9-457D-B555-599D9E5B3164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41C7643-26C4-48E0-99CB-5FC5DCAC7830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ilateral prefrontal lesions (-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3</a:t>
          </a:r>
        </a:p>
      </dgm:t>
    </dgm:pt>
    <dgm:pt modelId="{E86315E3-7891-43B4-99E6-516075C79111}" type="parTrans" cxnId="{17868BB7-CB52-4CDA-9509-7EFCBF4B4C27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06E2D13-A208-43B3-8FB0-B3FE31798FFE}" type="sibTrans" cxnId="{17868BB7-CB52-4CDA-9509-7EFCBF4B4C27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406D8CC5-78C9-4B43-BDE8-4BE5804CEA04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Unilateral prefrontal lesion (+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  <a:endParaRPr lang="en-GB" sz="1200" b="1" dirty="0">
            <a:solidFill>
              <a:srgbClr val="FF0000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8F20645-7764-43F0-9163-9C3DC9EAF423}" type="parTrans" cxnId="{04C8A5AB-850E-479A-8F07-F496BE4E5EB3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EFFC32F-6ECF-4E60-9223-BF8D7C294614}" type="sibTrans" cxnId="{04C8A5AB-850E-479A-8F07-F496BE4E5EB3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8EC778F-CAF8-4E63-A99F-097796D79286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Unilateral prefrontal lesion (-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  <a:endParaRPr lang="en-GB" sz="1200" b="1" dirty="0">
            <a:solidFill>
              <a:srgbClr val="FF0000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2154CCD-C50F-4D8D-9A4D-62AFF7D488F1}" type="parTrans" cxnId="{5E70174C-6009-4769-8D39-AFF08AF778BD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BFB09D3-CF38-4FA8-9B22-519CCB2BA430}" type="sibTrans" cxnId="{5E70174C-6009-4769-8D39-AFF08AF778BD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43255AD-71E5-496C-B47C-0F72C36EA1B4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+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3</a:t>
          </a:r>
          <a:endParaRPr lang="en-GB" sz="105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4BEDA4B-4676-4447-BB1C-BF24E40AC4B9}" type="parTrans" cxnId="{DDCA8081-CC22-4775-9F38-EE9CEF9657E8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E9B234F-4C6A-449C-B75C-3D5AE4352F45}" type="sibTrans" cxnId="{DDCA8081-CC22-4775-9F38-EE9CEF9657E8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8AF9B9F-7B15-49F9-BF7C-6D4318F4863B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+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  <a:endParaRPr lang="en-GB" sz="105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4C2A03C-C688-44D6-BE9F-79D692427471}" type="parTrans" cxnId="{3184C26B-B320-4CA8-A628-A64217B4A891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2E74A5D7-2717-46EF-AD36-086EE5C2C81E}" type="sibTrans" cxnId="{3184C26B-B320-4CA8-A628-A64217B4A891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8C5AF4C-1B14-41B0-9771-7EBCD0929A3D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-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  <a:endParaRPr kumimoji="1" lang="ja-JP" altLang="en-US" sz="1200" b="1" dirty="0">
            <a:solidFill>
              <a:srgbClr val="FF0000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6A51C83-6AE4-4C7F-B92D-66DA6A6372CE}" type="parTrans" cxnId="{F0B55482-2913-4322-9F85-F3FE7C1FF605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1D04D08-E5FA-4F84-8D48-EABDD9E66973}" type="sibTrans" cxnId="{F0B55482-2913-4322-9F85-F3FE7C1FF605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67E51DC-DAFD-4334-BA70-BAFEED137B42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+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5AFF031-A5C1-4EBA-AE0C-FA89BF21DCD1}" type="parTrans" cxnId="{EE47F85D-811C-47A3-AE46-6667EA124E94}">
      <dgm:prSet/>
      <dgm:spPr>
        <a:ln w="38100"/>
      </dgm:spPr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07FCAF4-D9AC-484E-B9AA-E20584E8A3A6}" type="sibTrans" cxnId="{EE47F85D-811C-47A3-AE46-6667EA124E94}">
      <dgm:prSet/>
      <dgm:spPr/>
      <dgm:t>
        <a:bodyPr/>
        <a:lstStyle/>
        <a:p>
          <a:endParaRPr kumimoji="1" lang="ja-JP" altLang="en-US" sz="2400" b="1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CBC7456-BBE3-4FCD-A60F-3D45646DC9A6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-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</a:p>
      </dgm:t>
    </dgm:pt>
    <dgm:pt modelId="{5C99D483-FDFA-4AFB-9580-398D96E942BB}" type="parTrans" cxnId="{ACBA532A-F136-46B4-8934-B3FEA2972971}">
      <dgm:prSet/>
      <dgm:spPr>
        <a:ln w="38100"/>
      </dgm:spPr>
      <dgm:t>
        <a:bodyPr/>
        <a:lstStyle/>
        <a:p>
          <a:endParaRPr lang="en-GB"/>
        </a:p>
      </dgm:t>
    </dgm:pt>
    <dgm:pt modelId="{04943231-5EFF-4FAA-9C46-80E17EA2135C}" type="sibTrans" cxnId="{ACBA532A-F136-46B4-8934-B3FEA2972971}">
      <dgm:prSet/>
      <dgm:spPr/>
      <dgm:t>
        <a:bodyPr/>
        <a:lstStyle/>
        <a:p>
          <a:endParaRPr lang="en-GB"/>
        </a:p>
      </dgm:t>
    </dgm:pt>
    <dgm:pt modelId="{8907B98A-A738-4643-9CDA-6C3076424EFB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N.D.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3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</a:t>
          </a:r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ent No. 3</a:t>
          </a:r>
          <a:r>
            <a:rPr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, 6, 10</a:t>
          </a:r>
          <a:endParaRPr lang="en-GB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B653F36C-3674-47B7-ADB3-1DD12D8C7A46}" type="parTrans" cxnId="{BBA34364-3A36-42C4-A737-F87462C62AE4}">
      <dgm:prSet/>
      <dgm:spPr>
        <a:ln w="38100"/>
      </dgm:spPr>
      <dgm:t>
        <a:bodyPr/>
        <a:lstStyle/>
        <a:p>
          <a:endParaRPr lang="en-GB"/>
        </a:p>
      </dgm:t>
    </dgm:pt>
    <dgm:pt modelId="{CDD829A5-2CD9-45A6-B7FC-C3CDDCCCF21F}" type="sibTrans" cxnId="{BBA34364-3A36-42C4-A737-F87462C62AE4}">
      <dgm:prSet/>
      <dgm:spPr/>
      <dgm:t>
        <a:bodyPr/>
        <a:lstStyle/>
        <a:p>
          <a:endParaRPr lang="en-GB"/>
        </a:p>
      </dgm:t>
    </dgm:pt>
    <dgm:pt modelId="{5A77A874-A08C-4C9C-A684-15F52CC18144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(+)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</a:p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1</a:t>
          </a:r>
          <a:r>
            <a:rPr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, 2</a:t>
          </a:r>
          <a:endParaRPr lang="en-GB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70F5A549-3C08-4956-A019-7F38601CA326}" type="parTrans" cxnId="{6E484D63-6EA9-45DC-8264-079AE4365F0D}">
      <dgm:prSet/>
      <dgm:spPr>
        <a:ln w="38100"/>
      </dgm:spPr>
      <dgm:t>
        <a:bodyPr/>
        <a:lstStyle/>
        <a:p>
          <a:endParaRPr lang="en-GB"/>
        </a:p>
      </dgm:t>
    </dgm:pt>
    <dgm:pt modelId="{79BF739C-7B5F-4ABE-9B87-E2C4A1997187}" type="sibTrans" cxnId="{6E484D63-6EA9-45DC-8264-079AE4365F0D}">
      <dgm:prSet/>
      <dgm:spPr/>
      <dgm:t>
        <a:bodyPr/>
        <a:lstStyle/>
        <a:p>
          <a:endParaRPr lang="en-GB"/>
        </a:p>
      </dgm:t>
    </dgm:pt>
    <dgm:pt modelId="{86E33352-56F3-4DB2-BDC0-98AA119D33B2}">
      <dgm:prSet custT="1"/>
      <dgm:spPr>
        <a:noFill/>
        <a:ln w="38100"/>
      </dgm:spPr>
      <dgm:t>
        <a:bodyPr/>
        <a:lstStyle/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N.D.</a:t>
          </a:r>
        </a:p>
        <a:p>
          <a:r>
            <a: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</a:p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4</a:t>
          </a:r>
          <a:r>
            <a:rPr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, 5</a:t>
          </a:r>
          <a:endParaRPr lang="en-GB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194E672-B269-4B91-B72D-73B24272F92A}" type="parTrans" cxnId="{C222EB73-A5C7-46F4-9F30-AFA6F8FC8E57}">
      <dgm:prSet/>
      <dgm:spPr>
        <a:ln w="38100"/>
      </dgm:spPr>
      <dgm:t>
        <a:bodyPr/>
        <a:lstStyle/>
        <a:p>
          <a:endParaRPr lang="en-GB"/>
        </a:p>
      </dgm:t>
    </dgm:pt>
    <dgm:pt modelId="{77FC897D-51B2-4D68-8756-B971D4671A78}" type="sibTrans" cxnId="{C222EB73-A5C7-46F4-9F30-AFA6F8FC8E57}">
      <dgm:prSet/>
      <dgm:spPr/>
      <dgm:t>
        <a:bodyPr/>
        <a:lstStyle/>
        <a:p>
          <a:endParaRPr lang="en-GB"/>
        </a:p>
      </dgm:t>
    </dgm:pt>
    <dgm:pt modelId="{4D8F43DD-2C06-4C3A-B53C-BCFDCEF851CB}">
      <dgm:prSet custT="1"/>
      <dgm:spPr>
        <a:noFill/>
        <a:ln w="38100"/>
      </dgm:spPr>
      <dgm:t>
        <a:bodyPr/>
        <a:lstStyle/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(-)</a:t>
          </a:r>
        </a:p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12</a:t>
          </a:r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AFE5621-66D4-4879-AA57-BBB251AE6F50}" type="parTrans" cxnId="{3C1F5DBB-5B23-48DB-9202-078993D3109B}">
      <dgm:prSet/>
      <dgm:spPr>
        <a:ln w="38100"/>
      </dgm:spPr>
      <dgm:t>
        <a:bodyPr/>
        <a:lstStyle/>
        <a:p>
          <a:endParaRPr kumimoji="1" lang="ja-JP" altLang="en-US"/>
        </a:p>
      </dgm:t>
    </dgm:pt>
    <dgm:pt modelId="{BBF55649-09EB-402D-80C8-8DBA2D7E926E}" type="sibTrans" cxnId="{3C1F5DBB-5B23-48DB-9202-078993D3109B}">
      <dgm:prSet/>
      <dgm:spPr/>
      <dgm:t>
        <a:bodyPr/>
        <a:lstStyle/>
        <a:p>
          <a:endParaRPr kumimoji="1" lang="ja-JP" altLang="en-US"/>
        </a:p>
      </dgm:t>
    </dgm:pt>
    <dgm:pt modelId="{62E2A0BC-E9DB-4CF1-8F6E-90C940CDA799}">
      <dgm:prSet custT="1"/>
      <dgm:spPr>
        <a:noFill/>
        <a:ln w="38100"/>
      </dgm:spPr>
      <dgm:t>
        <a:bodyPr/>
        <a:lstStyle/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N.D.</a:t>
          </a:r>
        </a:p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</a:t>
          </a:r>
          <a:r>
            <a:rPr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15</a:t>
          </a:r>
          <a:r>
            <a:rPr lang="en-US" altLang="ja-JP" sz="1200" b="1" dirty="0">
              <a:latin typeface="Arial" panose="020B0604020202020204" pitchFamily="34" charset="0"/>
              <a:cs typeface="Arial" panose="020B0604020202020204" pitchFamily="34" charset="0"/>
            </a:rPr>
            <a:t>6</a:t>
          </a:r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9347631-5FF9-487A-9158-BBE7BD60C9A5}" type="parTrans" cxnId="{FF033F5B-2311-4E05-85C1-7998D7131ABE}">
      <dgm:prSet/>
      <dgm:spPr>
        <a:ln w="38100"/>
      </dgm:spPr>
      <dgm:t>
        <a:bodyPr/>
        <a:lstStyle/>
        <a:p>
          <a:endParaRPr kumimoji="1" lang="ja-JP" altLang="en-US"/>
        </a:p>
      </dgm:t>
    </dgm:pt>
    <dgm:pt modelId="{345EB620-6579-4A52-AF1F-8B1F9E27E0C0}" type="sibTrans" cxnId="{FF033F5B-2311-4E05-85C1-7998D7131ABE}">
      <dgm:prSet/>
      <dgm:spPr/>
      <dgm:t>
        <a:bodyPr/>
        <a:lstStyle/>
        <a:p>
          <a:endParaRPr kumimoji="1" lang="ja-JP" altLang="en-US"/>
        </a:p>
      </dgm:t>
    </dgm:pt>
    <dgm:pt modelId="{C21C6336-F2DC-476E-8D65-A690CB2A842A}">
      <dgm:prSet custT="1"/>
      <dgm:spPr>
        <a:noFill/>
        <a:ln w="38100">
          <a:solidFill>
            <a:schemeClr val="tx1"/>
          </a:solidFill>
        </a:ln>
      </dgm:spPr>
      <dgm:t>
        <a:bodyPr/>
        <a:lstStyle/>
        <a:p>
          <a:endParaRPr kumimoji="1" lang="en-US" altLang="ja-JP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</a:t>
          </a:r>
        </a:p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 sitting (-)</a:t>
          </a:r>
        </a:p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  <a:endParaRPr kumimoji="1" lang="ja-JP" altLang="ja-JP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endParaRPr kumimoji="1" lang="ja-JP" altLang="en-US" sz="1000" dirty="0"/>
        </a:p>
      </dgm:t>
    </dgm:pt>
    <dgm:pt modelId="{EC07F7F1-48B1-4750-8894-8B3E1C81B23F}" type="parTrans" cxnId="{8EA8F209-4F8B-4D59-90DD-2ACA235B6C54}">
      <dgm:prSet/>
      <dgm:spPr>
        <a:ln w="38100"/>
      </dgm:spPr>
      <dgm:t>
        <a:bodyPr/>
        <a:lstStyle/>
        <a:p>
          <a:endParaRPr kumimoji="1" lang="ja-JP" altLang="en-US"/>
        </a:p>
      </dgm:t>
    </dgm:pt>
    <dgm:pt modelId="{18131272-8DDF-448E-B4C6-A410B8F9EDFE}" type="sibTrans" cxnId="{8EA8F209-4F8B-4D59-90DD-2ACA235B6C54}">
      <dgm:prSet/>
      <dgm:spPr/>
      <dgm:t>
        <a:bodyPr/>
        <a:lstStyle/>
        <a:p>
          <a:endParaRPr kumimoji="1" lang="ja-JP" altLang="en-US"/>
        </a:p>
      </dgm:t>
    </dgm:pt>
    <dgm:pt modelId="{130EFFA0-5A01-4D2A-8B3D-38C4A7DF0256}">
      <dgm:prSet custT="1"/>
      <dgm:spPr>
        <a:noFill/>
        <a:ln w="38100">
          <a:solidFill>
            <a:schemeClr val="tx1"/>
          </a:solidFill>
        </a:ln>
      </dgm:spPr>
      <dgm:t>
        <a:bodyPr/>
        <a:lstStyle/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(-)</a:t>
          </a:r>
        </a:p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7</a:t>
          </a:r>
          <a:endParaRPr kumimoji="1" lang="ja-JP" altLang="en-US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AD48DCC-EA3C-4D2F-B3F0-AF372ECE432F}" type="parTrans" cxnId="{664EC0FD-9409-46F1-A6B8-E2AF0D1B307E}">
      <dgm:prSet/>
      <dgm:spPr>
        <a:ln w="38100"/>
      </dgm:spPr>
      <dgm:t>
        <a:bodyPr/>
        <a:lstStyle/>
        <a:p>
          <a:endParaRPr kumimoji="1" lang="ja-JP" altLang="en-US"/>
        </a:p>
      </dgm:t>
    </dgm:pt>
    <dgm:pt modelId="{E448A32E-41A6-49B9-873E-D9EA1B2598FC}" type="sibTrans" cxnId="{664EC0FD-9409-46F1-A6B8-E2AF0D1B307E}">
      <dgm:prSet/>
      <dgm:spPr/>
      <dgm:t>
        <a:bodyPr/>
        <a:lstStyle/>
        <a:p>
          <a:endParaRPr kumimoji="1" lang="ja-JP" altLang="en-US"/>
        </a:p>
      </dgm:t>
    </dgm:pt>
    <dgm:pt modelId="{10C5170C-0FA0-419A-9FBF-40708DCE0584}" type="asst">
      <dgm:prSet custT="1"/>
      <dgm:spPr>
        <a:noFill/>
        <a:ln w="38100"/>
      </dgm:spPr>
      <dgm:t>
        <a:bodyPr/>
        <a:lstStyle/>
        <a:p>
          <a:r>
            <a:rPr kumimoji="1" lang="en-US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Instability could not be evaluated due to </a:t>
          </a:r>
          <a:r>
            <a:rPr kumimoji="1" lang="en-GB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insufficient development milestones</a:t>
          </a:r>
        </a:p>
        <a:p>
          <a:r>
            <a:rPr kumimoji="1" lang="en-GB" altLang="ja-JP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  <a:endParaRPr kumimoji="1" lang="ja-JP" altLang="ja-JP" sz="12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8670ED3-53B6-4DE4-BA5A-1007D4D83780}" type="parTrans" cxnId="{17E3B98A-6E55-40AC-A55B-6417489FC639}">
      <dgm:prSet/>
      <dgm:spPr>
        <a:ln w="38100"/>
      </dgm:spPr>
      <dgm:t>
        <a:bodyPr/>
        <a:lstStyle/>
        <a:p>
          <a:endParaRPr kumimoji="1" lang="ja-JP" altLang="en-US"/>
        </a:p>
      </dgm:t>
    </dgm:pt>
    <dgm:pt modelId="{58B3ADD9-9722-4C32-9A9D-AFFB91986C59}" type="sibTrans" cxnId="{17E3B98A-6E55-40AC-A55B-6417489FC639}">
      <dgm:prSet/>
      <dgm:spPr/>
      <dgm:t>
        <a:bodyPr/>
        <a:lstStyle/>
        <a:p>
          <a:endParaRPr kumimoji="1" lang="ja-JP" altLang="en-US"/>
        </a:p>
      </dgm:t>
    </dgm:pt>
    <dgm:pt modelId="{ABC3CB6A-0357-4894-9BAA-929B77021C52}" type="pres">
      <dgm:prSet presAssocID="{6BD44C91-1E07-4C76-A038-9B12972016B7}" presName="hierChild1" presStyleCnt="0">
        <dgm:presLayoutVars>
          <dgm:orgChart val="1"/>
          <dgm:chPref val="1"/>
          <dgm:dir/>
          <dgm:animOne val="branch"/>
          <dgm:animLvl val="lvl"/>
          <dgm:resizeHandles/>
        </dgm:presLayoutVars>
      </dgm:prSet>
      <dgm:spPr/>
    </dgm:pt>
    <dgm:pt modelId="{AEAB85E9-A70C-4405-877A-25C8499667A5}" type="pres">
      <dgm:prSet presAssocID="{AE8828E0-C571-4F8A-9003-C6EADEAC1B46}" presName="hierRoot1" presStyleCnt="0">
        <dgm:presLayoutVars>
          <dgm:hierBranch val="init"/>
        </dgm:presLayoutVars>
      </dgm:prSet>
      <dgm:spPr/>
    </dgm:pt>
    <dgm:pt modelId="{1E669895-E92B-4739-8C7B-84CB31B48474}" type="pres">
      <dgm:prSet presAssocID="{AE8828E0-C571-4F8A-9003-C6EADEAC1B46}" presName="rootComposite1" presStyleCnt="0"/>
      <dgm:spPr/>
    </dgm:pt>
    <dgm:pt modelId="{356AF28E-5690-4043-AF44-3ACC12D0BDB0}" type="pres">
      <dgm:prSet presAssocID="{AE8828E0-C571-4F8A-9003-C6EADEAC1B46}" presName="rootText1" presStyleLbl="node0" presStyleIdx="0" presStyleCnt="1" custScaleX="78784" custScaleY="65444" custLinFactX="-9676" custLinFactNeighborX="-100000" custLinFactNeighborY="67545">
        <dgm:presLayoutVars>
          <dgm:chPref val="3"/>
        </dgm:presLayoutVars>
      </dgm:prSet>
      <dgm:spPr/>
    </dgm:pt>
    <dgm:pt modelId="{CC1F212B-4033-4ACE-91CA-24A1CE845C0F}" type="pres">
      <dgm:prSet presAssocID="{AE8828E0-C571-4F8A-9003-C6EADEAC1B46}" presName="rootConnector1" presStyleLbl="node1" presStyleIdx="0" presStyleCnt="0"/>
      <dgm:spPr/>
    </dgm:pt>
    <dgm:pt modelId="{2620BDDE-FA0E-4A4C-8A0C-B5CB145438F5}" type="pres">
      <dgm:prSet presAssocID="{AE8828E0-C571-4F8A-9003-C6EADEAC1B46}" presName="hierChild2" presStyleCnt="0"/>
      <dgm:spPr/>
    </dgm:pt>
    <dgm:pt modelId="{FFFD1586-C99D-4845-8FB7-33978BBFEBB3}" type="pres">
      <dgm:prSet presAssocID="{349DFFB7-BC3E-496C-9A61-DB19C5510C78}" presName="Name37" presStyleLbl="parChTrans1D2" presStyleIdx="0" presStyleCnt="3"/>
      <dgm:spPr/>
    </dgm:pt>
    <dgm:pt modelId="{238AEF1C-EA40-47B2-AD6F-C7FBDF9862A4}" type="pres">
      <dgm:prSet presAssocID="{8E83BC88-359D-47C4-9BBC-5EFD9E609921}" presName="hierRoot2" presStyleCnt="0">
        <dgm:presLayoutVars>
          <dgm:hierBranch val="init"/>
        </dgm:presLayoutVars>
      </dgm:prSet>
      <dgm:spPr/>
    </dgm:pt>
    <dgm:pt modelId="{DAF59CE7-69D3-4E3E-9105-8DF6BE16B2E9}" type="pres">
      <dgm:prSet presAssocID="{8E83BC88-359D-47C4-9BBC-5EFD9E609921}" presName="rootComposite" presStyleCnt="0"/>
      <dgm:spPr/>
    </dgm:pt>
    <dgm:pt modelId="{C6924E3E-37F0-45BB-A9D6-33A3FF05B21C}" type="pres">
      <dgm:prSet presAssocID="{8E83BC88-359D-47C4-9BBC-5EFD9E609921}" presName="rootText" presStyleLbl="node2" presStyleIdx="0" presStyleCnt="2" custScaleX="107947" custScaleY="73675" custLinFactNeighborX="4476" custLinFactNeighborY="-3858">
        <dgm:presLayoutVars>
          <dgm:chPref val="3"/>
        </dgm:presLayoutVars>
      </dgm:prSet>
      <dgm:spPr/>
    </dgm:pt>
    <dgm:pt modelId="{3B4C3098-684A-4D58-8815-D0CCA3C2AA08}" type="pres">
      <dgm:prSet presAssocID="{8E83BC88-359D-47C4-9BBC-5EFD9E609921}" presName="rootConnector" presStyleLbl="node2" presStyleIdx="0" presStyleCnt="2"/>
      <dgm:spPr/>
    </dgm:pt>
    <dgm:pt modelId="{C6A7C44F-2A3F-4F38-BFAD-45072B23DE07}" type="pres">
      <dgm:prSet presAssocID="{8E83BC88-359D-47C4-9BBC-5EFD9E609921}" presName="hierChild4" presStyleCnt="0"/>
      <dgm:spPr/>
    </dgm:pt>
    <dgm:pt modelId="{16F95800-F6FC-432A-8192-5DDFB4692B6C}" type="pres">
      <dgm:prSet presAssocID="{7FCCC78F-80A8-4888-9D91-58DF6A1A42BD}" presName="Name37" presStyleLbl="parChTrans1D3" presStyleIdx="0" presStyleCnt="2"/>
      <dgm:spPr/>
    </dgm:pt>
    <dgm:pt modelId="{9E716B29-2216-4651-A18A-EAC68AA05A24}" type="pres">
      <dgm:prSet presAssocID="{AAC4D152-DFE4-4D71-BCD7-D8DC7E5B64B5}" presName="hierRoot2" presStyleCnt="0">
        <dgm:presLayoutVars>
          <dgm:hierBranch val="init"/>
        </dgm:presLayoutVars>
      </dgm:prSet>
      <dgm:spPr/>
    </dgm:pt>
    <dgm:pt modelId="{14C6D8F7-4917-4327-8461-C2A64ACA6B89}" type="pres">
      <dgm:prSet presAssocID="{AAC4D152-DFE4-4D71-BCD7-D8DC7E5B64B5}" presName="rootComposite" presStyleCnt="0"/>
      <dgm:spPr/>
    </dgm:pt>
    <dgm:pt modelId="{0296FC5F-E378-4904-93B2-00D4ACF73593}" type="pres">
      <dgm:prSet presAssocID="{AAC4D152-DFE4-4D71-BCD7-D8DC7E5B64B5}" presName="rootText" presStyleLbl="node3" presStyleIdx="0" presStyleCnt="2" custScaleX="170988" custScaleY="62962" custLinFactNeighborY="-4999">
        <dgm:presLayoutVars>
          <dgm:chPref val="3"/>
        </dgm:presLayoutVars>
      </dgm:prSet>
      <dgm:spPr/>
    </dgm:pt>
    <dgm:pt modelId="{2A3B2C18-117F-4F18-8DA1-0C7AC429375D}" type="pres">
      <dgm:prSet presAssocID="{AAC4D152-DFE4-4D71-BCD7-D8DC7E5B64B5}" presName="rootConnector" presStyleLbl="node3" presStyleIdx="0" presStyleCnt="2"/>
      <dgm:spPr/>
    </dgm:pt>
    <dgm:pt modelId="{106E37BA-F771-4BE8-8846-0F3D21A3D507}" type="pres">
      <dgm:prSet presAssocID="{AAC4D152-DFE4-4D71-BCD7-D8DC7E5B64B5}" presName="hierChild4" presStyleCnt="0"/>
      <dgm:spPr/>
    </dgm:pt>
    <dgm:pt modelId="{05F4DF28-B57F-4699-9BED-B162015FDD41}" type="pres">
      <dgm:prSet presAssocID="{591BECE1-B841-4D57-8D99-F9DC0D22DBF9}" presName="Name37" presStyleLbl="parChTrans1D4" presStyleIdx="0" presStyleCnt="16"/>
      <dgm:spPr/>
    </dgm:pt>
    <dgm:pt modelId="{825D8AFF-14D3-43E5-AD31-216B21801723}" type="pres">
      <dgm:prSet presAssocID="{DBA59BEF-F7D1-47B1-A43A-3B0DA8C93D02}" presName="hierRoot2" presStyleCnt="0">
        <dgm:presLayoutVars>
          <dgm:hierBranch val="init"/>
        </dgm:presLayoutVars>
      </dgm:prSet>
      <dgm:spPr/>
    </dgm:pt>
    <dgm:pt modelId="{5245F033-2183-451C-8E29-6A85BFAA36EA}" type="pres">
      <dgm:prSet presAssocID="{DBA59BEF-F7D1-47B1-A43A-3B0DA8C93D02}" presName="rootComposite" presStyleCnt="0"/>
      <dgm:spPr/>
    </dgm:pt>
    <dgm:pt modelId="{B8C1EDF1-DB2A-4D33-AA78-22955DE770C3}" type="pres">
      <dgm:prSet presAssocID="{DBA59BEF-F7D1-47B1-A43A-3B0DA8C93D02}" presName="rootText" presStyleLbl="node4" presStyleIdx="0" presStyleCnt="16" custScaleX="106300" custScaleY="86757" custLinFactNeighborY="-4328">
        <dgm:presLayoutVars>
          <dgm:chPref val="3"/>
        </dgm:presLayoutVars>
      </dgm:prSet>
      <dgm:spPr/>
    </dgm:pt>
    <dgm:pt modelId="{A59011C7-6EE2-4BBA-945A-1EA041A7BDF1}" type="pres">
      <dgm:prSet presAssocID="{DBA59BEF-F7D1-47B1-A43A-3B0DA8C93D02}" presName="rootConnector" presStyleLbl="node4" presStyleIdx="0" presStyleCnt="16"/>
      <dgm:spPr/>
    </dgm:pt>
    <dgm:pt modelId="{7C3D7898-B966-40D3-9287-C16DE16BCFA6}" type="pres">
      <dgm:prSet presAssocID="{DBA59BEF-F7D1-47B1-A43A-3B0DA8C93D02}" presName="hierChild4" presStyleCnt="0"/>
      <dgm:spPr/>
    </dgm:pt>
    <dgm:pt modelId="{DD731950-665B-474A-9284-81BABEADB935}" type="pres">
      <dgm:prSet presAssocID="{34BEDA4B-4676-4447-BB1C-BF24E40AC4B9}" presName="Name37" presStyleLbl="parChTrans1D4" presStyleIdx="1" presStyleCnt="16"/>
      <dgm:spPr/>
    </dgm:pt>
    <dgm:pt modelId="{32A235EB-AA7F-4B94-A580-59A6593BE504}" type="pres">
      <dgm:prSet presAssocID="{643255AD-71E5-496C-B47C-0F72C36EA1B4}" presName="hierRoot2" presStyleCnt="0">
        <dgm:presLayoutVars>
          <dgm:hierBranch val="init"/>
        </dgm:presLayoutVars>
      </dgm:prSet>
      <dgm:spPr/>
    </dgm:pt>
    <dgm:pt modelId="{36BAFAB3-940C-4564-B083-4E102C6171B8}" type="pres">
      <dgm:prSet presAssocID="{643255AD-71E5-496C-B47C-0F72C36EA1B4}" presName="rootComposite" presStyleCnt="0"/>
      <dgm:spPr/>
    </dgm:pt>
    <dgm:pt modelId="{53371C62-A9F4-424A-A2C3-5285FF0AAA6F}" type="pres">
      <dgm:prSet presAssocID="{643255AD-71E5-496C-B47C-0F72C36EA1B4}" presName="rootText" presStyleLbl="node4" presStyleIdx="1" presStyleCnt="16" custScaleY="84076" custLinFactNeighborX="1170" custLinFactNeighborY="-1739">
        <dgm:presLayoutVars>
          <dgm:chPref val="3"/>
        </dgm:presLayoutVars>
      </dgm:prSet>
      <dgm:spPr/>
    </dgm:pt>
    <dgm:pt modelId="{C7CDD2F7-9A5D-47CE-9F03-D1B9A9C8458C}" type="pres">
      <dgm:prSet presAssocID="{643255AD-71E5-496C-B47C-0F72C36EA1B4}" presName="rootConnector" presStyleLbl="node4" presStyleIdx="1" presStyleCnt="16"/>
      <dgm:spPr/>
    </dgm:pt>
    <dgm:pt modelId="{7EDA0209-31D1-4079-9185-0D9234A600D0}" type="pres">
      <dgm:prSet presAssocID="{643255AD-71E5-496C-B47C-0F72C36EA1B4}" presName="hierChild4" presStyleCnt="0"/>
      <dgm:spPr/>
    </dgm:pt>
    <dgm:pt modelId="{82CAE2F5-6413-4F95-9925-7BD8906E8C59}" type="pres">
      <dgm:prSet presAssocID="{B653F36C-3674-47B7-ADB3-1DD12D8C7A46}" presName="Name37" presStyleLbl="parChTrans1D4" presStyleIdx="2" presStyleCnt="16"/>
      <dgm:spPr/>
    </dgm:pt>
    <dgm:pt modelId="{7EEA6159-8DAB-453F-9994-A7EDB12A2048}" type="pres">
      <dgm:prSet presAssocID="{8907B98A-A738-4643-9CDA-6C3076424EFB}" presName="hierRoot2" presStyleCnt="0">
        <dgm:presLayoutVars>
          <dgm:hierBranch val="init"/>
        </dgm:presLayoutVars>
      </dgm:prSet>
      <dgm:spPr/>
    </dgm:pt>
    <dgm:pt modelId="{69288EB1-4EFE-4A5A-A258-163621A48976}" type="pres">
      <dgm:prSet presAssocID="{8907B98A-A738-4643-9CDA-6C3076424EFB}" presName="rootComposite" presStyleCnt="0"/>
      <dgm:spPr/>
    </dgm:pt>
    <dgm:pt modelId="{02FBF771-ADB1-4196-8CAA-4A17793F4EA7}" type="pres">
      <dgm:prSet presAssocID="{8907B98A-A738-4643-9CDA-6C3076424EFB}" presName="rootText" presStyleLbl="node4" presStyleIdx="2" presStyleCnt="16" custScaleY="100446" custLinFactNeighborX="-7206" custLinFactNeighborY="3482">
        <dgm:presLayoutVars>
          <dgm:chPref val="3"/>
        </dgm:presLayoutVars>
      </dgm:prSet>
      <dgm:spPr/>
    </dgm:pt>
    <dgm:pt modelId="{17018C8E-E616-4D1D-BADA-97C9473BE7A5}" type="pres">
      <dgm:prSet presAssocID="{8907B98A-A738-4643-9CDA-6C3076424EFB}" presName="rootConnector" presStyleLbl="node4" presStyleIdx="2" presStyleCnt="16"/>
      <dgm:spPr/>
    </dgm:pt>
    <dgm:pt modelId="{CE2B4D1E-3A82-4547-8453-19812BE03CEA}" type="pres">
      <dgm:prSet presAssocID="{8907B98A-A738-4643-9CDA-6C3076424EFB}" presName="hierChild4" presStyleCnt="0"/>
      <dgm:spPr/>
    </dgm:pt>
    <dgm:pt modelId="{A2B04F32-A038-456F-89D6-D77F29B063A8}" type="pres">
      <dgm:prSet presAssocID="{8907B98A-A738-4643-9CDA-6C3076424EFB}" presName="hierChild5" presStyleCnt="0"/>
      <dgm:spPr/>
    </dgm:pt>
    <dgm:pt modelId="{0DE1086A-45E0-44C3-B843-F09BFB8929BA}" type="pres">
      <dgm:prSet presAssocID="{643255AD-71E5-496C-B47C-0F72C36EA1B4}" presName="hierChild5" presStyleCnt="0"/>
      <dgm:spPr/>
    </dgm:pt>
    <dgm:pt modelId="{5E480686-E077-4A2E-87C9-6F692723D508}" type="pres">
      <dgm:prSet presAssocID="{5C99D483-FDFA-4AFB-9580-398D96E942BB}" presName="Name37" presStyleLbl="parChTrans1D4" presStyleIdx="3" presStyleCnt="16"/>
      <dgm:spPr/>
    </dgm:pt>
    <dgm:pt modelId="{617A7464-EFC2-44C7-AFA3-7CC2EA05425A}" type="pres">
      <dgm:prSet presAssocID="{ACBC7456-BBE3-4FCD-A60F-3D45646DC9A6}" presName="hierRoot2" presStyleCnt="0">
        <dgm:presLayoutVars>
          <dgm:hierBranch val="init"/>
        </dgm:presLayoutVars>
      </dgm:prSet>
      <dgm:spPr/>
    </dgm:pt>
    <dgm:pt modelId="{3563A93E-6422-40E2-8ED5-F1C3181CEFF0}" type="pres">
      <dgm:prSet presAssocID="{ACBC7456-BBE3-4FCD-A60F-3D45646DC9A6}" presName="rootComposite" presStyleCnt="0"/>
      <dgm:spPr/>
    </dgm:pt>
    <dgm:pt modelId="{7AAAAC82-FC0D-43C2-9837-370A07F8A35C}" type="pres">
      <dgm:prSet presAssocID="{ACBC7456-BBE3-4FCD-A60F-3D45646DC9A6}" presName="rootText" presStyleLbl="node4" presStyleIdx="3" presStyleCnt="16" custScaleY="84816" custLinFactNeighborY="-1862">
        <dgm:presLayoutVars>
          <dgm:chPref val="3"/>
        </dgm:presLayoutVars>
      </dgm:prSet>
      <dgm:spPr/>
    </dgm:pt>
    <dgm:pt modelId="{7B2932F0-6014-4010-B906-6D3CFBC9F556}" type="pres">
      <dgm:prSet presAssocID="{ACBC7456-BBE3-4FCD-A60F-3D45646DC9A6}" presName="rootConnector" presStyleLbl="node4" presStyleIdx="3" presStyleCnt="16"/>
      <dgm:spPr/>
    </dgm:pt>
    <dgm:pt modelId="{12C2CEED-F85C-413D-B1BC-BE5F76744DED}" type="pres">
      <dgm:prSet presAssocID="{ACBC7456-BBE3-4FCD-A60F-3D45646DC9A6}" presName="hierChild4" presStyleCnt="0"/>
      <dgm:spPr/>
    </dgm:pt>
    <dgm:pt modelId="{13EA5D40-5517-4377-8544-329A518F7557}" type="pres">
      <dgm:prSet presAssocID="{70F5A549-3C08-4956-A019-7F38601CA326}" presName="Name37" presStyleLbl="parChTrans1D4" presStyleIdx="4" presStyleCnt="16"/>
      <dgm:spPr/>
    </dgm:pt>
    <dgm:pt modelId="{4AFF8A63-287F-4175-898B-860B32913B19}" type="pres">
      <dgm:prSet presAssocID="{5A77A874-A08C-4C9C-A684-15F52CC18144}" presName="hierRoot2" presStyleCnt="0">
        <dgm:presLayoutVars>
          <dgm:hierBranch val="init"/>
        </dgm:presLayoutVars>
      </dgm:prSet>
      <dgm:spPr/>
    </dgm:pt>
    <dgm:pt modelId="{A1DB1F57-B7E1-4800-BA01-C8A4507E6953}" type="pres">
      <dgm:prSet presAssocID="{5A77A874-A08C-4C9C-A684-15F52CC18144}" presName="rootComposite" presStyleCnt="0"/>
      <dgm:spPr/>
    </dgm:pt>
    <dgm:pt modelId="{574D0AF8-7A16-4358-A4D4-0A9F71E32AB6}" type="pres">
      <dgm:prSet presAssocID="{5A77A874-A08C-4C9C-A684-15F52CC18144}" presName="rootText" presStyleLbl="node4" presStyleIdx="4" presStyleCnt="16" custScaleY="99639" custLinFactNeighborX="-7206" custLinFactNeighborY="3482">
        <dgm:presLayoutVars>
          <dgm:chPref val="3"/>
        </dgm:presLayoutVars>
      </dgm:prSet>
      <dgm:spPr/>
    </dgm:pt>
    <dgm:pt modelId="{81F07CF8-E94F-4491-972C-D86398C02FC7}" type="pres">
      <dgm:prSet presAssocID="{5A77A874-A08C-4C9C-A684-15F52CC18144}" presName="rootConnector" presStyleLbl="node4" presStyleIdx="4" presStyleCnt="16"/>
      <dgm:spPr/>
    </dgm:pt>
    <dgm:pt modelId="{E0FDC855-6645-44DE-A79A-6A0E7AD14FC1}" type="pres">
      <dgm:prSet presAssocID="{5A77A874-A08C-4C9C-A684-15F52CC18144}" presName="hierChild4" presStyleCnt="0"/>
      <dgm:spPr/>
    </dgm:pt>
    <dgm:pt modelId="{C32261BC-5BC7-4B72-B1B4-A700E1D5E2FC}" type="pres">
      <dgm:prSet presAssocID="{5A77A874-A08C-4C9C-A684-15F52CC18144}" presName="hierChild5" presStyleCnt="0"/>
      <dgm:spPr/>
    </dgm:pt>
    <dgm:pt modelId="{D44EE10B-8767-49EC-944D-35F194000B80}" type="pres">
      <dgm:prSet presAssocID="{ACBC7456-BBE3-4FCD-A60F-3D45646DC9A6}" presName="hierChild5" presStyleCnt="0"/>
      <dgm:spPr/>
    </dgm:pt>
    <dgm:pt modelId="{D07FC435-ED36-4E66-AF58-BBEA60B14809}" type="pres">
      <dgm:prSet presAssocID="{DBA59BEF-F7D1-47B1-A43A-3B0DA8C93D02}" presName="hierChild5" presStyleCnt="0"/>
      <dgm:spPr/>
    </dgm:pt>
    <dgm:pt modelId="{35E9E6AB-8EBF-4489-A9AD-B18731334C84}" type="pres">
      <dgm:prSet presAssocID="{E86315E3-7891-43B4-99E6-516075C79111}" presName="Name37" presStyleLbl="parChTrans1D4" presStyleIdx="5" presStyleCnt="16"/>
      <dgm:spPr/>
    </dgm:pt>
    <dgm:pt modelId="{DC54E399-9511-4CB6-8C80-71318FE6ECB6}" type="pres">
      <dgm:prSet presAssocID="{941C7643-26C4-48E0-99CB-5FC5DCAC7830}" presName="hierRoot2" presStyleCnt="0">
        <dgm:presLayoutVars>
          <dgm:hierBranch val="init"/>
        </dgm:presLayoutVars>
      </dgm:prSet>
      <dgm:spPr/>
    </dgm:pt>
    <dgm:pt modelId="{16D179C5-A932-40DA-A6D5-65CF1FECF634}" type="pres">
      <dgm:prSet presAssocID="{941C7643-26C4-48E0-99CB-5FC5DCAC7830}" presName="rootComposite" presStyleCnt="0"/>
      <dgm:spPr/>
    </dgm:pt>
    <dgm:pt modelId="{1428E6BE-2F58-417D-9CB2-2888832E0161}" type="pres">
      <dgm:prSet presAssocID="{941C7643-26C4-48E0-99CB-5FC5DCAC7830}" presName="rootText" presStyleLbl="node4" presStyleIdx="5" presStyleCnt="16" custScaleX="106300" custScaleY="86757" custLinFactNeighborY="-4328">
        <dgm:presLayoutVars>
          <dgm:chPref val="3"/>
        </dgm:presLayoutVars>
      </dgm:prSet>
      <dgm:spPr/>
    </dgm:pt>
    <dgm:pt modelId="{38B6D9C8-E9D8-4050-A823-A9F97287CFBA}" type="pres">
      <dgm:prSet presAssocID="{941C7643-26C4-48E0-99CB-5FC5DCAC7830}" presName="rootConnector" presStyleLbl="node4" presStyleIdx="5" presStyleCnt="16"/>
      <dgm:spPr/>
    </dgm:pt>
    <dgm:pt modelId="{A4DE7510-1459-48B1-AFEC-BAA8154AD4F3}" type="pres">
      <dgm:prSet presAssocID="{941C7643-26C4-48E0-99CB-5FC5DCAC7830}" presName="hierChild4" presStyleCnt="0"/>
      <dgm:spPr/>
    </dgm:pt>
    <dgm:pt modelId="{1AAE962B-FC4E-4E88-9802-C684323DA4FE}" type="pres">
      <dgm:prSet presAssocID="{74C2A03C-C688-44D6-BE9F-79D692427471}" presName="Name37" presStyleLbl="parChTrans1D4" presStyleIdx="6" presStyleCnt="16"/>
      <dgm:spPr/>
    </dgm:pt>
    <dgm:pt modelId="{ACAC5505-D3D1-4D57-B32C-9AC3B8D7350A}" type="pres">
      <dgm:prSet presAssocID="{D8AF9B9F-7B15-49F9-BF7C-6D4318F4863B}" presName="hierRoot2" presStyleCnt="0">
        <dgm:presLayoutVars>
          <dgm:hierBranch val="init"/>
        </dgm:presLayoutVars>
      </dgm:prSet>
      <dgm:spPr/>
    </dgm:pt>
    <dgm:pt modelId="{8C21FDB2-B8B8-4BD5-9557-77DA1E527140}" type="pres">
      <dgm:prSet presAssocID="{D8AF9B9F-7B15-49F9-BF7C-6D4318F4863B}" presName="rootComposite" presStyleCnt="0"/>
      <dgm:spPr/>
    </dgm:pt>
    <dgm:pt modelId="{8110C399-8F20-4AB5-BD7D-22095B9142B3}" type="pres">
      <dgm:prSet presAssocID="{D8AF9B9F-7B15-49F9-BF7C-6D4318F4863B}" presName="rootText" presStyleLbl="node4" presStyleIdx="6" presStyleCnt="16" custScaleY="86725" custLinFactNeighborX="8931" custLinFactNeighborY="-823">
        <dgm:presLayoutVars>
          <dgm:chPref val="3"/>
        </dgm:presLayoutVars>
      </dgm:prSet>
      <dgm:spPr/>
    </dgm:pt>
    <dgm:pt modelId="{16FBCBB6-1A99-419C-ACE8-9066FEE99083}" type="pres">
      <dgm:prSet presAssocID="{D8AF9B9F-7B15-49F9-BF7C-6D4318F4863B}" presName="rootConnector" presStyleLbl="node4" presStyleIdx="6" presStyleCnt="16"/>
      <dgm:spPr/>
    </dgm:pt>
    <dgm:pt modelId="{A55CB61D-63FA-4E1D-A1A0-2BB6AB750FD6}" type="pres">
      <dgm:prSet presAssocID="{D8AF9B9F-7B15-49F9-BF7C-6D4318F4863B}" presName="hierChild4" presStyleCnt="0"/>
      <dgm:spPr/>
    </dgm:pt>
    <dgm:pt modelId="{75166AAF-32C8-49C3-845B-E6BDE1B03191}" type="pres">
      <dgm:prSet presAssocID="{1194E672-B269-4B91-B72D-73B24272F92A}" presName="Name37" presStyleLbl="parChTrans1D4" presStyleIdx="7" presStyleCnt="16"/>
      <dgm:spPr/>
    </dgm:pt>
    <dgm:pt modelId="{7C6A5747-0D04-43BF-8274-9EFA0B63BAB4}" type="pres">
      <dgm:prSet presAssocID="{86E33352-56F3-4DB2-BDC0-98AA119D33B2}" presName="hierRoot2" presStyleCnt="0">
        <dgm:presLayoutVars>
          <dgm:hierBranch val="init"/>
        </dgm:presLayoutVars>
      </dgm:prSet>
      <dgm:spPr/>
    </dgm:pt>
    <dgm:pt modelId="{89B87839-3B64-4F83-9C04-6B66C6588203}" type="pres">
      <dgm:prSet presAssocID="{86E33352-56F3-4DB2-BDC0-98AA119D33B2}" presName="rootComposite" presStyleCnt="0"/>
      <dgm:spPr/>
    </dgm:pt>
    <dgm:pt modelId="{AD85E944-2472-4D72-9B7F-B6CF170BE523}" type="pres">
      <dgm:prSet presAssocID="{86E33352-56F3-4DB2-BDC0-98AA119D33B2}" presName="rootText" presStyleLbl="node4" presStyleIdx="7" presStyleCnt="16" custScaleX="91223" custScaleY="102137" custLinFactNeighborX="598" custLinFactNeighborY="2937">
        <dgm:presLayoutVars>
          <dgm:chPref val="3"/>
        </dgm:presLayoutVars>
      </dgm:prSet>
      <dgm:spPr/>
    </dgm:pt>
    <dgm:pt modelId="{33119A54-6917-43F0-9A2F-C2C0D9463939}" type="pres">
      <dgm:prSet presAssocID="{86E33352-56F3-4DB2-BDC0-98AA119D33B2}" presName="rootConnector" presStyleLbl="node4" presStyleIdx="7" presStyleCnt="16"/>
      <dgm:spPr/>
    </dgm:pt>
    <dgm:pt modelId="{46E928B4-2AB6-41B6-BA6D-704E4CEF14FC}" type="pres">
      <dgm:prSet presAssocID="{86E33352-56F3-4DB2-BDC0-98AA119D33B2}" presName="hierChild4" presStyleCnt="0"/>
      <dgm:spPr/>
    </dgm:pt>
    <dgm:pt modelId="{84FD804E-328A-4C5F-BBED-6EBB4C1A10D7}" type="pres">
      <dgm:prSet presAssocID="{86E33352-56F3-4DB2-BDC0-98AA119D33B2}" presName="hierChild5" presStyleCnt="0"/>
      <dgm:spPr/>
    </dgm:pt>
    <dgm:pt modelId="{F426B2E4-1C3C-416C-AB30-9BBCF3844AD0}" type="pres">
      <dgm:prSet presAssocID="{D8AF9B9F-7B15-49F9-BF7C-6D4318F4863B}" presName="hierChild5" presStyleCnt="0"/>
      <dgm:spPr/>
    </dgm:pt>
    <dgm:pt modelId="{AACCD6B2-FB3B-4F92-BBD9-D318FF429818}" type="pres">
      <dgm:prSet presAssocID="{EC07F7F1-48B1-4750-8894-8B3E1C81B23F}" presName="Name37" presStyleLbl="parChTrans1D4" presStyleIdx="8" presStyleCnt="16"/>
      <dgm:spPr/>
    </dgm:pt>
    <dgm:pt modelId="{F06B8623-2B21-46DC-ADD2-EC40A74AF137}" type="pres">
      <dgm:prSet presAssocID="{C21C6336-F2DC-476E-8D65-A690CB2A842A}" presName="hierRoot2" presStyleCnt="0">
        <dgm:presLayoutVars>
          <dgm:hierBranch val="init"/>
        </dgm:presLayoutVars>
      </dgm:prSet>
      <dgm:spPr/>
    </dgm:pt>
    <dgm:pt modelId="{19015CC2-8C93-43CC-8B88-CF0871BCBFDA}" type="pres">
      <dgm:prSet presAssocID="{C21C6336-F2DC-476E-8D65-A690CB2A842A}" presName="rootComposite" presStyleCnt="0"/>
      <dgm:spPr/>
    </dgm:pt>
    <dgm:pt modelId="{C73811CB-CB56-4712-8C2D-8D9895AB323B}" type="pres">
      <dgm:prSet presAssocID="{C21C6336-F2DC-476E-8D65-A690CB2A842A}" presName="rootText" presStyleLbl="node4" presStyleIdx="8" presStyleCnt="16" custScaleY="89039" custLinFactNeighborX="5420" custLinFactNeighborY="-1871">
        <dgm:presLayoutVars>
          <dgm:chPref val="3"/>
        </dgm:presLayoutVars>
      </dgm:prSet>
      <dgm:spPr/>
    </dgm:pt>
    <dgm:pt modelId="{D1D2ECBD-20A1-49CA-AC99-E870D7287921}" type="pres">
      <dgm:prSet presAssocID="{C21C6336-F2DC-476E-8D65-A690CB2A842A}" presName="rootConnector" presStyleLbl="node4" presStyleIdx="8" presStyleCnt="16"/>
      <dgm:spPr/>
    </dgm:pt>
    <dgm:pt modelId="{66ABCB7A-39E5-4271-AE9E-34E497D00195}" type="pres">
      <dgm:prSet presAssocID="{C21C6336-F2DC-476E-8D65-A690CB2A842A}" presName="hierChild4" presStyleCnt="0"/>
      <dgm:spPr/>
    </dgm:pt>
    <dgm:pt modelId="{ECD91E9F-914B-4692-AEB7-CF13D6B0301E}" type="pres">
      <dgm:prSet presAssocID="{0AD48DCC-EA3C-4D2F-B3F0-AF372ECE432F}" presName="Name37" presStyleLbl="parChTrans1D4" presStyleIdx="9" presStyleCnt="16"/>
      <dgm:spPr/>
    </dgm:pt>
    <dgm:pt modelId="{99F5DF36-6B38-4433-973D-3D338E0AD8D0}" type="pres">
      <dgm:prSet presAssocID="{130EFFA0-5A01-4D2A-8B3D-38C4A7DF0256}" presName="hierRoot2" presStyleCnt="0">
        <dgm:presLayoutVars>
          <dgm:hierBranch val="init"/>
        </dgm:presLayoutVars>
      </dgm:prSet>
      <dgm:spPr/>
    </dgm:pt>
    <dgm:pt modelId="{E2A72684-DD97-4C18-AF7E-3F9C9751FC87}" type="pres">
      <dgm:prSet presAssocID="{130EFFA0-5A01-4D2A-8B3D-38C4A7DF0256}" presName="rootComposite" presStyleCnt="0"/>
      <dgm:spPr/>
    </dgm:pt>
    <dgm:pt modelId="{B3787398-3726-450B-A2F2-03118F71D247}" type="pres">
      <dgm:prSet presAssocID="{130EFFA0-5A01-4D2A-8B3D-38C4A7DF0256}" presName="rootText" presStyleLbl="node4" presStyleIdx="9" presStyleCnt="16" custLinFactNeighborX="-1492">
        <dgm:presLayoutVars>
          <dgm:chPref val="3"/>
        </dgm:presLayoutVars>
      </dgm:prSet>
      <dgm:spPr/>
    </dgm:pt>
    <dgm:pt modelId="{D853110F-A768-41EF-BD0B-232BC0569048}" type="pres">
      <dgm:prSet presAssocID="{130EFFA0-5A01-4D2A-8B3D-38C4A7DF0256}" presName="rootConnector" presStyleLbl="node4" presStyleIdx="9" presStyleCnt="16"/>
      <dgm:spPr/>
    </dgm:pt>
    <dgm:pt modelId="{69873318-4E53-43BB-BEB3-A19DE4908ED2}" type="pres">
      <dgm:prSet presAssocID="{130EFFA0-5A01-4D2A-8B3D-38C4A7DF0256}" presName="hierChild4" presStyleCnt="0"/>
      <dgm:spPr/>
    </dgm:pt>
    <dgm:pt modelId="{746AB981-E4F0-4CF3-91C2-2A56A8F2EE09}" type="pres">
      <dgm:prSet presAssocID="{130EFFA0-5A01-4D2A-8B3D-38C4A7DF0256}" presName="hierChild5" presStyleCnt="0"/>
      <dgm:spPr/>
    </dgm:pt>
    <dgm:pt modelId="{152CF5B7-EC90-4EC8-996C-8B99BC12A8B8}" type="pres">
      <dgm:prSet presAssocID="{C21C6336-F2DC-476E-8D65-A690CB2A842A}" presName="hierChild5" presStyleCnt="0"/>
      <dgm:spPr/>
    </dgm:pt>
    <dgm:pt modelId="{2DEC6793-A898-4C9E-9382-93EF220C751B}" type="pres">
      <dgm:prSet presAssocID="{941C7643-26C4-48E0-99CB-5FC5DCAC7830}" presName="hierChild5" presStyleCnt="0"/>
      <dgm:spPr/>
    </dgm:pt>
    <dgm:pt modelId="{08ADC29D-B256-4436-AD4B-5D77D4F324EE}" type="pres">
      <dgm:prSet presAssocID="{AAC4D152-DFE4-4D71-BCD7-D8DC7E5B64B5}" presName="hierChild5" presStyleCnt="0"/>
      <dgm:spPr/>
    </dgm:pt>
    <dgm:pt modelId="{B8F3B591-9307-4E9A-BD2C-F5D348511BEA}" type="pres">
      <dgm:prSet presAssocID="{4D248CC2-3184-460B-A00A-1B722842C143}" presName="Name37" presStyleLbl="parChTrans1D3" presStyleIdx="1" presStyleCnt="2"/>
      <dgm:spPr/>
    </dgm:pt>
    <dgm:pt modelId="{62F5DF37-6E28-4E05-936D-856834444042}" type="pres">
      <dgm:prSet presAssocID="{0E694C0F-8AB1-4632-B2DA-D1247D8BE18F}" presName="hierRoot2" presStyleCnt="0">
        <dgm:presLayoutVars>
          <dgm:hierBranch val="init"/>
        </dgm:presLayoutVars>
      </dgm:prSet>
      <dgm:spPr/>
    </dgm:pt>
    <dgm:pt modelId="{01A8AF1A-CEEA-44DB-A97C-C6C9B7EC0A18}" type="pres">
      <dgm:prSet presAssocID="{0E694C0F-8AB1-4632-B2DA-D1247D8BE18F}" presName="rootComposite" presStyleCnt="0"/>
      <dgm:spPr/>
    </dgm:pt>
    <dgm:pt modelId="{87A60063-46AC-4CA6-8AFB-C646FC058C41}" type="pres">
      <dgm:prSet presAssocID="{0E694C0F-8AB1-4632-B2DA-D1247D8BE18F}" presName="rootText" presStyleLbl="node3" presStyleIdx="1" presStyleCnt="2" custScaleX="177015" custScaleY="67094" custLinFactNeighborY="-4999">
        <dgm:presLayoutVars>
          <dgm:chPref val="3"/>
        </dgm:presLayoutVars>
      </dgm:prSet>
      <dgm:spPr/>
    </dgm:pt>
    <dgm:pt modelId="{053C0BA0-4CA6-4511-8C30-0C0AC5E87C55}" type="pres">
      <dgm:prSet presAssocID="{0E694C0F-8AB1-4632-B2DA-D1247D8BE18F}" presName="rootConnector" presStyleLbl="node3" presStyleIdx="1" presStyleCnt="2"/>
      <dgm:spPr/>
    </dgm:pt>
    <dgm:pt modelId="{767A21D5-DB46-4A5E-9683-FA267B1DDAF5}" type="pres">
      <dgm:prSet presAssocID="{0E694C0F-8AB1-4632-B2DA-D1247D8BE18F}" presName="hierChild4" presStyleCnt="0"/>
      <dgm:spPr/>
    </dgm:pt>
    <dgm:pt modelId="{4A5C067F-FEAA-48F0-96BD-C976B883AD03}" type="pres">
      <dgm:prSet presAssocID="{18F20645-7764-43F0-9163-9C3DC9EAF423}" presName="Name37" presStyleLbl="parChTrans1D4" presStyleIdx="10" presStyleCnt="16"/>
      <dgm:spPr/>
    </dgm:pt>
    <dgm:pt modelId="{2C814EFC-153B-4785-A3CE-5DD59685FE5E}" type="pres">
      <dgm:prSet presAssocID="{406D8CC5-78C9-4B43-BDE8-4BE5804CEA04}" presName="hierRoot2" presStyleCnt="0">
        <dgm:presLayoutVars>
          <dgm:hierBranch val="init"/>
        </dgm:presLayoutVars>
      </dgm:prSet>
      <dgm:spPr/>
    </dgm:pt>
    <dgm:pt modelId="{750B0FC5-A6CF-46AF-B159-3DF03239E033}" type="pres">
      <dgm:prSet presAssocID="{406D8CC5-78C9-4B43-BDE8-4BE5804CEA04}" presName="rootComposite" presStyleCnt="0"/>
      <dgm:spPr/>
    </dgm:pt>
    <dgm:pt modelId="{8325B952-ADFE-4612-856B-08695AAA247D}" type="pres">
      <dgm:prSet presAssocID="{406D8CC5-78C9-4B43-BDE8-4BE5804CEA04}" presName="rootText" presStyleLbl="node4" presStyleIdx="10" presStyleCnt="16" custScaleX="106300" custScaleY="86757" custLinFactNeighborY="-4328">
        <dgm:presLayoutVars>
          <dgm:chPref val="3"/>
        </dgm:presLayoutVars>
      </dgm:prSet>
      <dgm:spPr/>
    </dgm:pt>
    <dgm:pt modelId="{0B88337F-9D65-422A-B934-C9A276470656}" type="pres">
      <dgm:prSet presAssocID="{406D8CC5-78C9-4B43-BDE8-4BE5804CEA04}" presName="rootConnector" presStyleLbl="node4" presStyleIdx="10" presStyleCnt="16"/>
      <dgm:spPr/>
    </dgm:pt>
    <dgm:pt modelId="{B670C011-D1C4-408A-9650-A6CD88DA3311}" type="pres">
      <dgm:prSet presAssocID="{406D8CC5-78C9-4B43-BDE8-4BE5804CEA04}" presName="hierChild4" presStyleCnt="0"/>
      <dgm:spPr/>
    </dgm:pt>
    <dgm:pt modelId="{19F787B1-4285-40D5-A18E-FE58585EB3EA}" type="pres">
      <dgm:prSet presAssocID="{36A51C83-6AE4-4C7F-B92D-66DA6A6372CE}" presName="Name37" presStyleLbl="parChTrans1D4" presStyleIdx="11" presStyleCnt="16"/>
      <dgm:spPr/>
    </dgm:pt>
    <dgm:pt modelId="{A2EE4AA3-5240-40E4-A00C-BDED462B1FE6}" type="pres">
      <dgm:prSet presAssocID="{08C5AF4C-1B14-41B0-9771-7EBCD0929A3D}" presName="hierRoot2" presStyleCnt="0">
        <dgm:presLayoutVars>
          <dgm:hierBranch val="init"/>
        </dgm:presLayoutVars>
      </dgm:prSet>
      <dgm:spPr/>
    </dgm:pt>
    <dgm:pt modelId="{18D96C6D-3F0D-4F37-BFF0-2495EC9FC332}" type="pres">
      <dgm:prSet presAssocID="{08C5AF4C-1B14-41B0-9771-7EBCD0929A3D}" presName="rootComposite" presStyleCnt="0"/>
      <dgm:spPr/>
    </dgm:pt>
    <dgm:pt modelId="{765E4F2B-E403-446B-A07D-1C67F1398557}" type="pres">
      <dgm:prSet presAssocID="{08C5AF4C-1B14-41B0-9771-7EBCD0929A3D}" presName="rootText" presStyleLbl="node4" presStyleIdx="11" presStyleCnt="16" custScaleY="87697" custLinFactNeighborX="-85" custLinFactNeighborY="-6471">
        <dgm:presLayoutVars>
          <dgm:chPref val="3"/>
        </dgm:presLayoutVars>
      </dgm:prSet>
      <dgm:spPr/>
    </dgm:pt>
    <dgm:pt modelId="{39B12912-CB9D-4827-8B54-2FC5C8E01B9F}" type="pres">
      <dgm:prSet presAssocID="{08C5AF4C-1B14-41B0-9771-7EBCD0929A3D}" presName="rootConnector" presStyleLbl="node4" presStyleIdx="11" presStyleCnt="16"/>
      <dgm:spPr/>
    </dgm:pt>
    <dgm:pt modelId="{B9E0BA34-B290-415C-BB46-0772C6B4E0CF}" type="pres">
      <dgm:prSet presAssocID="{08C5AF4C-1B14-41B0-9771-7EBCD0929A3D}" presName="hierChild4" presStyleCnt="0"/>
      <dgm:spPr/>
    </dgm:pt>
    <dgm:pt modelId="{5287358E-0C59-473E-8247-5C0CFFAC1AFD}" type="pres">
      <dgm:prSet presAssocID="{3AFE5621-66D4-4879-AA57-BBB251AE6F50}" presName="Name37" presStyleLbl="parChTrans1D4" presStyleIdx="12" presStyleCnt="16"/>
      <dgm:spPr/>
    </dgm:pt>
    <dgm:pt modelId="{15D1F57E-FE12-4DF5-A7C7-E190F99696BA}" type="pres">
      <dgm:prSet presAssocID="{4D8F43DD-2C06-4C3A-B53C-BCFDCEF851CB}" presName="hierRoot2" presStyleCnt="0">
        <dgm:presLayoutVars>
          <dgm:hierBranch val="init"/>
        </dgm:presLayoutVars>
      </dgm:prSet>
      <dgm:spPr/>
    </dgm:pt>
    <dgm:pt modelId="{70A4F32B-DA2D-4C5A-9523-59C35BC80350}" type="pres">
      <dgm:prSet presAssocID="{4D8F43DD-2C06-4C3A-B53C-BCFDCEF851CB}" presName="rootComposite" presStyleCnt="0"/>
      <dgm:spPr/>
    </dgm:pt>
    <dgm:pt modelId="{5A7379F8-0FE0-4810-B536-55D1FA7C51BC}" type="pres">
      <dgm:prSet presAssocID="{4D8F43DD-2C06-4C3A-B53C-BCFDCEF851CB}" presName="rootText" presStyleLbl="node4" presStyleIdx="12" presStyleCnt="16" custScaleY="100434" custLinFactNeighborX="-6902" custLinFactNeighborY="235">
        <dgm:presLayoutVars>
          <dgm:chPref val="3"/>
        </dgm:presLayoutVars>
      </dgm:prSet>
      <dgm:spPr/>
    </dgm:pt>
    <dgm:pt modelId="{5A371F34-CA61-458E-801B-10E19FD404EB}" type="pres">
      <dgm:prSet presAssocID="{4D8F43DD-2C06-4C3A-B53C-BCFDCEF851CB}" presName="rootConnector" presStyleLbl="node4" presStyleIdx="12" presStyleCnt="16"/>
      <dgm:spPr/>
    </dgm:pt>
    <dgm:pt modelId="{CEA0B94E-CFEF-4F29-B20B-257A4CF60265}" type="pres">
      <dgm:prSet presAssocID="{4D8F43DD-2C06-4C3A-B53C-BCFDCEF851CB}" presName="hierChild4" presStyleCnt="0"/>
      <dgm:spPr/>
    </dgm:pt>
    <dgm:pt modelId="{F4124507-7E9E-4DEF-A441-7E0633EC9954}" type="pres">
      <dgm:prSet presAssocID="{4D8F43DD-2C06-4C3A-B53C-BCFDCEF851CB}" presName="hierChild5" presStyleCnt="0"/>
      <dgm:spPr/>
    </dgm:pt>
    <dgm:pt modelId="{ACDA745B-C116-4217-B3C6-2ACFED7CAB73}" type="pres">
      <dgm:prSet presAssocID="{08C5AF4C-1B14-41B0-9771-7EBCD0929A3D}" presName="hierChild5" presStyleCnt="0"/>
      <dgm:spPr/>
    </dgm:pt>
    <dgm:pt modelId="{AC36F49D-E3BB-437E-ADDF-0936C7DCE46F}" type="pres">
      <dgm:prSet presAssocID="{406D8CC5-78C9-4B43-BDE8-4BE5804CEA04}" presName="hierChild5" presStyleCnt="0"/>
      <dgm:spPr/>
    </dgm:pt>
    <dgm:pt modelId="{98026F8C-44C8-445C-A43A-3675FF2FF054}" type="pres">
      <dgm:prSet presAssocID="{52154CCD-C50F-4D8D-9A4D-62AFF7D488F1}" presName="Name37" presStyleLbl="parChTrans1D4" presStyleIdx="13" presStyleCnt="16"/>
      <dgm:spPr/>
    </dgm:pt>
    <dgm:pt modelId="{087C07FD-A518-440C-87AD-772923F59E5B}" type="pres">
      <dgm:prSet presAssocID="{98EC778F-CAF8-4E63-A99F-097796D79286}" presName="hierRoot2" presStyleCnt="0">
        <dgm:presLayoutVars>
          <dgm:hierBranch val="init"/>
        </dgm:presLayoutVars>
      </dgm:prSet>
      <dgm:spPr/>
    </dgm:pt>
    <dgm:pt modelId="{480D0C00-1E82-488A-B442-6D592E18F16C}" type="pres">
      <dgm:prSet presAssocID="{98EC778F-CAF8-4E63-A99F-097796D79286}" presName="rootComposite" presStyleCnt="0"/>
      <dgm:spPr/>
    </dgm:pt>
    <dgm:pt modelId="{A458EDC1-D4A9-4E83-B3D9-1337FCD6336E}" type="pres">
      <dgm:prSet presAssocID="{98EC778F-CAF8-4E63-A99F-097796D79286}" presName="rootText" presStyleLbl="node4" presStyleIdx="13" presStyleCnt="16" custScaleX="106300" custScaleY="86757" custLinFactNeighborY="-4328">
        <dgm:presLayoutVars>
          <dgm:chPref val="3"/>
        </dgm:presLayoutVars>
      </dgm:prSet>
      <dgm:spPr/>
    </dgm:pt>
    <dgm:pt modelId="{B9FCC3FA-094E-47AD-A43F-10C485D8E237}" type="pres">
      <dgm:prSet presAssocID="{98EC778F-CAF8-4E63-A99F-097796D79286}" presName="rootConnector" presStyleLbl="node4" presStyleIdx="13" presStyleCnt="16"/>
      <dgm:spPr/>
    </dgm:pt>
    <dgm:pt modelId="{A22749D5-7F38-45A7-A9DD-B33265A9444C}" type="pres">
      <dgm:prSet presAssocID="{98EC778F-CAF8-4E63-A99F-097796D79286}" presName="hierChild4" presStyleCnt="0"/>
      <dgm:spPr/>
    </dgm:pt>
    <dgm:pt modelId="{8CB00494-7F74-4467-A3BD-5E2ABAF8B091}" type="pres">
      <dgm:prSet presAssocID="{15AFF031-A5C1-4EBA-AE0C-FA89BF21DCD1}" presName="Name37" presStyleLbl="parChTrans1D4" presStyleIdx="14" presStyleCnt="16"/>
      <dgm:spPr/>
    </dgm:pt>
    <dgm:pt modelId="{B60FFF0B-C117-4A61-864D-ADE17A9EA5B9}" type="pres">
      <dgm:prSet presAssocID="{967E51DC-DAFD-4334-BA70-BAFEED137B42}" presName="hierRoot2" presStyleCnt="0">
        <dgm:presLayoutVars>
          <dgm:hierBranch val="init"/>
        </dgm:presLayoutVars>
      </dgm:prSet>
      <dgm:spPr/>
    </dgm:pt>
    <dgm:pt modelId="{A2F2D1A3-B6D3-4323-8440-D5673C97A4E7}" type="pres">
      <dgm:prSet presAssocID="{967E51DC-DAFD-4334-BA70-BAFEED137B42}" presName="rootComposite" presStyleCnt="0"/>
      <dgm:spPr/>
    </dgm:pt>
    <dgm:pt modelId="{84ECF355-7DD3-4860-A18D-4CDD20866068}" type="pres">
      <dgm:prSet presAssocID="{967E51DC-DAFD-4334-BA70-BAFEED137B42}" presName="rootText" presStyleLbl="node4" presStyleIdx="14" presStyleCnt="16" custScaleY="88255" custLinFactNeighborX="-99" custLinFactNeighborY="-5845">
        <dgm:presLayoutVars>
          <dgm:chPref val="3"/>
        </dgm:presLayoutVars>
      </dgm:prSet>
      <dgm:spPr/>
    </dgm:pt>
    <dgm:pt modelId="{052E7182-A4A9-4292-A937-78185AFB7B85}" type="pres">
      <dgm:prSet presAssocID="{967E51DC-DAFD-4334-BA70-BAFEED137B42}" presName="rootConnector" presStyleLbl="node4" presStyleIdx="14" presStyleCnt="16"/>
      <dgm:spPr/>
    </dgm:pt>
    <dgm:pt modelId="{2DE09D10-E54C-4D6C-A141-3BA1DC724018}" type="pres">
      <dgm:prSet presAssocID="{967E51DC-DAFD-4334-BA70-BAFEED137B42}" presName="hierChild4" presStyleCnt="0"/>
      <dgm:spPr/>
    </dgm:pt>
    <dgm:pt modelId="{770CE079-92F9-4FED-AEE1-6E589D8BDEB5}" type="pres">
      <dgm:prSet presAssocID="{99347631-5FF9-487A-9158-BBE7BD60C9A5}" presName="Name37" presStyleLbl="parChTrans1D4" presStyleIdx="15" presStyleCnt="16"/>
      <dgm:spPr/>
    </dgm:pt>
    <dgm:pt modelId="{C29540A5-F226-49FB-9FBA-A761F8562F64}" type="pres">
      <dgm:prSet presAssocID="{62E2A0BC-E9DB-4CF1-8F6E-90C940CDA799}" presName="hierRoot2" presStyleCnt="0">
        <dgm:presLayoutVars>
          <dgm:hierBranch val="init"/>
        </dgm:presLayoutVars>
      </dgm:prSet>
      <dgm:spPr/>
    </dgm:pt>
    <dgm:pt modelId="{B9AE85F7-3294-429A-B238-034F01A8621F}" type="pres">
      <dgm:prSet presAssocID="{62E2A0BC-E9DB-4CF1-8F6E-90C940CDA799}" presName="rootComposite" presStyleCnt="0"/>
      <dgm:spPr/>
    </dgm:pt>
    <dgm:pt modelId="{2367E8B8-6E6D-48A8-BDF8-16FE3316FE75}" type="pres">
      <dgm:prSet presAssocID="{62E2A0BC-E9DB-4CF1-8F6E-90C940CDA799}" presName="rootText" presStyleLbl="node4" presStyleIdx="15" presStyleCnt="16" custScaleY="97936" custLinFactNeighborX="-6902" custLinFactNeighborY="1728">
        <dgm:presLayoutVars>
          <dgm:chPref val="3"/>
        </dgm:presLayoutVars>
      </dgm:prSet>
      <dgm:spPr/>
    </dgm:pt>
    <dgm:pt modelId="{BFAA47A0-E90D-4B58-A71A-AB8D74B7511C}" type="pres">
      <dgm:prSet presAssocID="{62E2A0BC-E9DB-4CF1-8F6E-90C940CDA799}" presName="rootConnector" presStyleLbl="node4" presStyleIdx="15" presStyleCnt="16"/>
      <dgm:spPr/>
    </dgm:pt>
    <dgm:pt modelId="{B6B9C5AA-BD11-4DA6-ABA6-0FDF0C176F66}" type="pres">
      <dgm:prSet presAssocID="{62E2A0BC-E9DB-4CF1-8F6E-90C940CDA799}" presName="hierChild4" presStyleCnt="0"/>
      <dgm:spPr/>
    </dgm:pt>
    <dgm:pt modelId="{DD4EBDA2-4334-4079-9C50-5D0EB715DBFE}" type="pres">
      <dgm:prSet presAssocID="{62E2A0BC-E9DB-4CF1-8F6E-90C940CDA799}" presName="hierChild5" presStyleCnt="0"/>
      <dgm:spPr/>
    </dgm:pt>
    <dgm:pt modelId="{907FC41C-A721-498A-AECD-ED77F1D5B9D4}" type="pres">
      <dgm:prSet presAssocID="{967E51DC-DAFD-4334-BA70-BAFEED137B42}" presName="hierChild5" presStyleCnt="0"/>
      <dgm:spPr/>
    </dgm:pt>
    <dgm:pt modelId="{4684B430-7C74-4512-A400-9E8B497CA81D}" type="pres">
      <dgm:prSet presAssocID="{98EC778F-CAF8-4E63-A99F-097796D79286}" presName="hierChild5" presStyleCnt="0"/>
      <dgm:spPr/>
    </dgm:pt>
    <dgm:pt modelId="{3720040D-3AE9-4331-B7F0-6E6FC0A11B66}" type="pres">
      <dgm:prSet presAssocID="{0E694C0F-8AB1-4632-B2DA-D1247D8BE18F}" presName="hierChild5" presStyleCnt="0"/>
      <dgm:spPr/>
    </dgm:pt>
    <dgm:pt modelId="{47FB9601-75D0-40F0-80FD-CB6CE639BD01}" type="pres">
      <dgm:prSet presAssocID="{8E83BC88-359D-47C4-9BBC-5EFD9E609921}" presName="hierChild5" presStyleCnt="0"/>
      <dgm:spPr/>
    </dgm:pt>
    <dgm:pt modelId="{A34C4E21-1952-4E8E-9318-1E0F6325910B}" type="pres">
      <dgm:prSet presAssocID="{DD8232B4-3BCE-40FA-A9D1-F6EE9E34EB34}" presName="Name37" presStyleLbl="parChTrans1D2" presStyleIdx="1" presStyleCnt="3"/>
      <dgm:spPr/>
    </dgm:pt>
    <dgm:pt modelId="{C0C776D2-B6FD-4813-A723-50E62672EB30}" type="pres">
      <dgm:prSet presAssocID="{6F8E4E8F-2702-4226-B47E-68170BE88C0D}" presName="hierRoot2" presStyleCnt="0">
        <dgm:presLayoutVars>
          <dgm:hierBranch val="init"/>
        </dgm:presLayoutVars>
      </dgm:prSet>
      <dgm:spPr/>
    </dgm:pt>
    <dgm:pt modelId="{DBA89F9D-73E8-4A0D-8327-077481BD0AEC}" type="pres">
      <dgm:prSet presAssocID="{6F8E4E8F-2702-4226-B47E-68170BE88C0D}" presName="rootComposite" presStyleCnt="0"/>
      <dgm:spPr/>
    </dgm:pt>
    <dgm:pt modelId="{D29044B6-296F-43E9-9A97-6C76EB922610}" type="pres">
      <dgm:prSet presAssocID="{6F8E4E8F-2702-4226-B47E-68170BE88C0D}" presName="rootText" presStyleLbl="node2" presStyleIdx="1" presStyleCnt="2" custScaleX="207862" custScaleY="97305" custLinFactNeighborY="-31043">
        <dgm:presLayoutVars>
          <dgm:chPref val="3"/>
        </dgm:presLayoutVars>
      </dgm:prSet>
      <dgm:spPr/>
    </dgm:pt>
    <dgm:pt modelId="{A054C64C-5610-4BB3-99DE-F3FB705E364F}" type="pres">
      <dgm:prSet presAssocID="{6F8E4E8F-2702-4226-B47E-68170BE88C0D}" presName="rootConnector" presStyleLbl="node2" presStyleIdx="1" presStyleCnt="2"/>
      <dgm:spPr/>
    </dgm:pt>
    <dgm:pt modelId="{223A5FD3-3627-4485-AE36-0CC4C7731A2C}" type="pres">
      <dgm:prSet presAssocID="{6F8E4E8F-2702-4226-B47E-68170BE88C0D}" presName="hierChild4" presStyleCnt="0"/>
      <dgm:spPr/>
    </dgm:pt>
    <dgm:pt modelId="{81465FEB-EE36-435D-81BF-7B2635A2FE04}" type="pres">
      <dgm:prSet presAssocID="{6F8E4E8F-2702-4226-B47E-68170BE88C0D}" presName="hierChild5" presStyleCnt="0"/>
      <dgm:spPr/>
    </dgm:pt>
    <dgm:pt modelId="{95B5BBEB-17E4-4B5B-83D2-81DDC4ED57BB}" type="pres">
      <dgm:prSet presAssocID="{AE8828E0-C571-4F8A-9003-C6EADEAC1B46}" presName="hierChild3" presStyleCnt="0"/>
      <dgm:spPr/>
    </dgm:pt>
    <dgm:pt modelId="{41581643-F527-4F9C-957D-21B7BF397099}" type="pres">
      <dgm:prSet presAssocID="{E8670ED3-53B6-4DE4-BA5A-1007D4D83780}" presName="Name111" presStyleLbl="parChTrans1D2" presStyleIdx="2" presStyleCnt="3"/>
      <dgm:spPr/>
    </dgm:pt>
    <dgm:pt modelId="{C5EA1ACB-DEC6-4F8B-811A-104723B463BB}" type="pres">
      <dgm:prSet presAssocID="{10C5170C-0FA0-419A-9FBF-40708DCE0584}" presName="hierRoot3" presStyleCnt="0">
        <dgm:presLayoutVars>
          <dgm:hierBranch val="init"/>
        </dgm:presLayoutVars>
      </dgm:prSet>
      <dgm:spPr/>
    </dgm:pt>
    <dgm:pt modelId="{FB2F67A2-905A-42BF-B413-4F2E541F5E18}" type="pres">
      <dgm:prSet presAssocID="{10C5170C-0FA0-419A-9FBF-40708DCE0584}" presName="rootComposite3" presStyleCnt="0"/>
      <dgm:spPr/>
    </dgm:pt>
    <dgm:pt modelId="{52201AFD-8388-4F09-A422-24B3ED7819C8}" type="pres">
      <dgm:prSet presAssocID="{10C5170C-0FA0-419A-9FBF-40708DCE0584}" presName="rootText3" presStyleLbl="asst1" presStyleIdx="0" presStyleCnt="1" custScaleX="187208" custScaleY="79532" custLinFactX="-54228" custLinFactNeighborX="-100000" custLinFactNeighborY="6493">
        <dgm:presLayoutVars>
          <dgm:chPref val="3"/>
        </dgm:presLayoutVars>
      </dgm:prSet>
      <dgm:spPr/>
    </dgm:pt>
    <dgm:pt modelId="{C3C2DE37-B416-45F4-9DB8-F5463E7725D0}" type="pres">
      <dgm:prSet presAssocID="{10C5170C-0FA0-419A-9FBF-40708DCE0584}" presName="rootConnector3" presStyleLbl="asst1" presStyleIdx="0" presStyleCnt="1"/>
      <dgm:spPr/>
    </dgm:pt>
    <dgm:pt modelId="{4CD26D1C-9196-4A2E-B06C-EF86E7DFABC4}" type="pres">
      <dgm:prSet presAssocID="{10C5170C-0FA0-419A-9FBF-40708DCE0584}" presName="hierChild6" presStyleCnt="0"/>
      <dgm:spPr/>
    </dgm:pt>
    <dgm:pt modelId="{329B6400-28E8-4BB2-9A96-73D1CB749F89}" type="pres">
      <dgm:prSet presAssocID="{10C5170C-0FA0-419A-9FBF-40708DCE0584}" presName="hierChild7" presStyleCnt="0"/>
      <dgm:spPr/>
    </dgm:pt>
  </dgm:ptLst>
  <dgm:cxnLst>
    <dgm:cxn modelId="{8EA8F209-4F8B-4D59-90DD-2ACA235B6C54}" srcId="{941C7643-26C4-48E0-99CB-5FC5DCAC7830}" destId="{C21C6336-F2DC-476E-8D65-A690CB2A842A}" srcOrd="1" destOrd="0" parTransId="{EC07F7F1-48B1-4750-8894-8B3E1C81B23F}" sibTransId="{18131272-8DDF-448E-B4C6-A410B8F9EDFE}"/>
    <dgm:cxn modelId="{F053260C-5125-40E2-83C8-B6354C9C4C46}" srcId="{8E83BC88-359D-47C4-9BBC-5EFD9E609921}" destId="{AAC4D152-DFE4-4D71-BCD7-D8DC7E5B64B5}" srcOrd="0" destOrd="0" parTransId="{7FCCC78F-80A8-4888-9D91-58DF6A1A42BD}" sibTransId="{835D1D55-2F16-48B8-97A0-0C788CA076BB}"/>
    <dgm:cxn modelId="{D4968215-4D65-413A-A4EE-081513DB18E0}" type="presOf" srcId="{99347631-5FF9-487A-9158-BBE7BD60C9A5}" destId="{770CE079-92F9-4FED-AEE1-6E589D8BDEB5}" srcOrd="0" destOrd="0" presId="urn:microsoft.com/office/officeart/2005/8/layout/orgChart1"/>
    <dgm:cxn modelId="{821CB117-A5BE-43FE-B43D-FD08C2ED3024}" type="presOf" srcId="{52154CCD-C50F-4D8D-9A4D-62AFF7D488F1}" destId="{98026F8C-44C8-445C-A43A-3675FF2FF054}" srcOrd="0" destOrd="0" presId="urn:microsoft.com/office/officeart/2005/8/layout/orgChart1"/>
    <dgm:cxn modelId="{0477FF1E-7C03-481D-BD0D-7A70AB8961A1}" type="presOf" srcId="{C21C6336-F2DC-476E-8D65-A690CB2A842A}" destId="{C73811CB-CB56-4712-8C2D-8D9895AB323B}" srcOrd="0" destOrd="0" presId="urn:microsoft.com/office/officeart/2005/8/layout/orgChart1"/>
    <dgm:cxn modelId="{8FD7C624-6334-4D68-986D-7C6CEFB02ED1}" type="presOf" srcId="{4D8F43DD-2C06-4C3A-B53C-BCFDCEF851CB}" destId="{5A7379F8-0FE0-4810-B536-55D1FA7C51BC}" srcOrd="0" destOrd="0" presId="urn:microsoft.com/office/officeart/2005/8/layout/orgChart1"/>
    <dgm:cxn modelId="{ACBA532A-F136-46B4-8934-B3FEA2972971}" srcId="{DBA59BEF-F7D1-47B1-A43A-3B0DA8C93D02}" destId="{ACBC7456-BBE3-4FCD-A60F-3D45646DC9A6}" srcOrd="1" destOrd="0" parTransId="{5C99D483-FDFA-4AFB-9580-398D96E942BB}" sibTransId="{04943231-5EFF-4FAA-9C46-80E17EA2135C}"/>
    <dgm:cxn modelId="{943B0732-7AB8-4869-B8A3-C1D94FDAD7D4}" type="presOf" srcId="{941C7643-26C4-48E0-99CB-5FC5DCAC7830}" destId="{1428E6BE-2F58-417D-9CB2-2888832E0161}" srcOrd="0" destOrd="0" presId="urn:microsoft.com/office/officeart/2005/8/layout/orgChart1"/>
    <dgm:cxn modelId="{B43C9032-CD7D-474F-B7B2-150BA298CF60}" type="presOf" srcId="{3AFE5621-66D4-4879-AA57-BBB251AE6F50}" destId="{5287358E-0C59-473E-8247-5C0CFFAC1AFD}" srcOrd="0" destOrd="0" presId="urn:microsoft.com/office/officeart/2005/8/layout/orgChart1"/>
    <dgm:cxn modelId="{0E219334-D9B9-42D5-81CF-A63FF425881F}" type="presOf" srcId="{406D8CC5-78C9-4B43-BDE8-4BE5804CEA04}" destId="{0B88337F-9D65-422A-B934-C9A276470656}" srcOrd="1" destOrd="0" presId="urn:microsoft.com/office/officeart/2005/8/layout/orgChart1"/>
    <dgm:cxn modelId="{48CA3A37-B220-4CC7-9936-9A34855E87D4}" type="presOf" srcId="{62E2A0BC-E9DB-4CF1-8F6E-90C940CDA799}" destId="{2367E8B8-6E6D-48A8-BDF8-16FE3316FE75}" srcOrd="0" destOrd="0" presId="urn:microsoft.com/office/officeart/2005/8/layout/orgChart1"/>
    <dgm:cxn modelId="{438FEF3B-B27E-451D-ACFB-E749BCA8C910}" type="presOf" srcId="{AE8828E0-C571-4F8A-9003-C6EADEAC1B46}" destId="{356AF28E-5690-4043-AF44-3ACC12D0BDB0}" srcOrd="0" destOrd="0" presId="urn:microsoft.com/office/officeart/2005/8/layout/orgChart1"/>
    <dgm:cxn modelId="{2C91943F-2206-4A58-9EA6-CFEA5A85DAC7}" type="presOf" srcId="{EC07F7F1-48B1-4750-8894-8B3E1C81B23F}" destId="{AACCD6B2-FB3B-4F92-BBD9-D318FF429818}" srcOrd="0" destOrd="0" presId="urn:microsoft.com/office/officeart/2005/8/layout/orgChart1"/>
    <dgm:cxn modelId="{FF033F5B-2311-4E05-85C1-7998D7131ABE}" srcId="{967E51DC-DAFD-4334-BA70-BAFEED137B42}" destId="{62E2A0BC-E9DB-4CF1-8F6E-90C940CDA799}" srcOrd="0" destOrd="0" parTransId="{99347631-5FF9-487A-9158-BBE7BD60C9A5}" sibTransId="{345EB620-6579-4A52-AF1F-8B1F9E27E0C0}"/>
    <dgm:cxn modelId="{41BFEB5B-1B65-4111-9D52-F968E86CF25D}" type="presOf" srcId="{DBA59BEF-F7D1-47B1-A43A-3B0DA8C93D02}" destId="{B8C1EDF1-DB2A-4D33-AA78-22955DE770C3}" srcOrd="0" destOrd="0" presId="urn:microsoft.com/office/officeart/2005/8/layout/orgChart1"/>
    <dgm:cxn modelId="{E4003C5C-3956-404C-9B97-4BF9E4AD6753}" type="presOf" srcId="{C21C6336-F2DC-476E-8D65-A690CB2A842A}" destId="{D1D2ECBD-20A1-49CA-AC99-E870D7287921}" srcOrd="1" destOrd="0" presId="urn:microsoft.com/office/officeart/2005/8/layout/orgChart1"/>
    <dgm:cxn modelId="{EE47F85D-811C-47A3-AE46-6667EA124E94}" srcId="{98EC778F-CAF8-4E63-A99F-097796D79286}" destId="{967E51DC-DAFD-4334-BA70-BAFEED137B42}" srcOrd="0" destOrd="0" parTransId="{15AFF031-A5C1-4EBA-AE0C-FA89BF21DCD1}" sibTransId="{307FCAF4-D9AC-484E-B9AA-E20584E8A3A6}"/>
    <dgm:cxn modelId="{3078FB5F-D189-4865-88C3-C4CC96014BA9}" type="presOf" srcId="{86E33352-56F3-4DB2-BDC0-98AA119D33B2}" destId="{AD85E944-2472-4D72-9B7F-B6CF170BE523}" srcOrd="0" destOrd="0" presId="urn:microsoft.com/office/officeart/2005/8/layout/orgChart1"/>
    <dgm:cxn modelId="{37CABB60-04DA-4BAA-90A8-2B466D150B67}" type="presOf" srcId="{B653F36C-3674-47B7-ADB3-1DD12D8C7A46}" destId="{82CAE2F5-6413-4F95-9925-7BD8906E8C59}" srcOrd="0" destOrd="0" presId="urn:microsoft.com/office/officeart/2005/8/layout/orgChart1"/>
    <dgm:cxn modelId="{196CB562-9E3B-4CDD-9CF7-292F1DC57520}" type="presOf" srcId="{98EC778F-CAF8-4E63-A99F-097796D79286}" destId="{A458EDC1-D4A9-4E83-B3D9-1337FCD6336E}" srcOrd="0" destOrd="0" presId="urn:microsoft.com/office/officeart/2005/8/layout/orgChart1"/>
    <dgm:cxn modelId="{390EC942-E1C9-4437-8AE2-0CD759B9E6FC}" type="presOf" srcId="{74C2A03C-C688-44D6-BE9F-79D692427471}" destId="{1AAE962B-FC4E-4E88-9802-C684323DA4FE}" srcOrd="0" destOrd="0" presId="urn:microsoft.com/office/officeart/2005/8/layout/orgChart1"/>
    <dgm:cxn modelId="{6E484D63-6EA9-45DC-8264-079AE4365F0D}" srcId="{ACBC7456-BBE3-4FCD-A60F-3D45646DC9A6}" destId="{5A77A874-A08C-4C9C-A684-15F52CC18144}" srcOrd="0" destOrd="0" parTransId="{70F5A549-3C08-4956-A019-7F38601CA326}" sibTransId="{79BF739C-7B5F-4ABE-9B87-E2C4A1997187}"/>
    <dgm:cxn modelId="{BBA34364-3A36-42C4-A737-F87462C62AE4}" srcId="{643255AD-71E5-496C-B47C-0F72C36EA1B4}" destId="{8907B98A-A738-4643-9CDA-6C3076424EFB}" srcOrd="0" destOrd="0" parTransId="{B653F36C-3674-47B7-ADB3-1DD12D8C7A46}" sibTransId="{CDD829A5-2CD9-45A6-B7FC-C3CDDCCCF21F}"/>
    <dgm:cxn modelId="{5FFE8D45-82B6-4D8C-B466-90E0262826E0}" type="presOf" srcId="{86E33352-56F3-4DB2-BDC0-98AA119D33B2}" destId="{33119A54-6917-43F0-9A2F-C2C0D9463939}" srcOrd="1" destOrd="0" presId="urn:microsoft.com/office/officeart/2005/8/layout/orgChart1"/>
    <dgm:cxn modelId="{D2936467-756F-4559-A7FD-4A08561BD574}" type="presOf" srcId="{AAC4D152-DFE4-4D71-BCD7-D8DC7E5B64B5}" destId="{0296FC5F-E378-4904-93B2-00D4ACF73593}" srcOrd="0" destOrd="0" presId="urn:microsoft.com/office/officeart/2005/8/layout/orgChart1"/>
    <dgm:cxn modelId="{66926767-3D67-4592-99F7-E106794C488C}" type="presOf" srcId="{8E83BC88-359D-47C4-9BBC-5EFD9E609921}" destId="{C6924E3E-37F0-45BB-A9D6-33A3FF05B21C}" srcOrd="0" destOrd="0" presId="urn:microsoft.com/office/officeart/2005/8/layout/orgChart1"/>
    <dgm:cxn modelId="{0E5B4B47-2492-40A1-83E6-BD47B39E6303}" srcId="{AAC4D152-DFE4-4D71-BCD7-D8DC7E5B64B5}" destId="{DBA59BEF-F7D1-47B1-A43A-3B0DA8C93D02}" srcOrd="0" destOrd="0" parTransId="{591BECE1-B841-4D57-8D99-F9DC0D22DBF9}" sibTransId="{DFBA63D2-4340-4F0B-9F4C-41BDAD04658C}"/>
    <dgm:cxn modelId="{A3769D68-6972-4F05-83C5-A1AB5B8C3A79}" type="presOf" srcId="{34BEDA4B-4676-4447-BB1C-BF24E40AC4B9}" destId="{DD731950-665B-474A-9284-81BABEADB935}" srcOrd="0" destOrd="0" presId="urn:microsoft.com/office/officeart/2005/8/layout/orgChart1"/>
    <dgm:cxn modelId="{2228A568-E66A-4F2F-8F91-3D65206C145D}" type="presOf" srcId="{6F8E4E8F-2702-4226-B47E-68170BE88C0D}" destId="{D29044B6-296F-43E9-9A97-6C76EB922610}" srcOrd="0" destOrd="0" presId="urn:microsoft.com/office/officeart/2005/8/layout/orgChart1"/>
    <dgm:cxn modelId="{B765374A-13EF-4ACB-BC9E-638AB0AD5889}" type="presOf" srcId="{E86315E3-7891-43B4-99E6-516075C79111}" destId="{35E9E6AB-8EBF-4489-A9AD-B18731334C84}" srcOrd="0" destOrd="0" presId="urn:microsoft.com/office/officeart/2005/8/layout/orgChart1"/>
    <dgm:cxn modelId="{3184C26B-B320-4CA8-A628-A64217B4A891}" srcId="{941C7643-26C4-48E0-99CB-5FC5DCAC7830}" destId="{D8AF9B9F-7B15-49F9-BF7C-6D4318F4863B}" srcOrd="0" destOrd="0" parTransId="{74C2A03C-C688-44D6-BE9F-79D692427471}" sibTransId="{2E74A5D7-2717-46EF-AD36-086EE5C2C81E}"/>
    <dgm:cxn modelId="{5E70174C-6009-4769-8D39-AFF08AF778BD}" srcId="{0E694C0F-8AB1-4632-B2DA-D1247D8BE18F}" destId="{98EC778F-CAF8-4E63-A99F-097796D79286}" srcOrd="1" destOrd="0" parTransId="{52154CCD-C50F-4D8D-9A4D-62AFF7D488F1}" sibTransId="{EBFB09D3-CF38-4FA8-9B22-519CCB2BA430}"/>
    <dgm:cxn modelId="{CC098450-C4A5-4DC4-B3A6-C3FA8A8910D7}" type="presOf" srcId="{AAC4D152-DFE4-4D71-BCD7-D8DC7E5B64B5}" destId="{2A3B2C18-117F-4F18-8DA1-0C7AC429375D}" srcOrd="1" destOrd="0" presId="urn:microsoft.com/office/officeart/2005/8/layout/orgChart1"/>
    <dgm:cxn modelId="{C222EB73-A5C7-46F4-9F30-AFA6F8FC8E57}" srcId="{D8AF9B9F-7B15-49F9-BF7C-6D4318F4863B}" destId="{86E33352-56F3-4DB2-BDC0-98AA119D33B2}" srcOrd="0" destOrd="0" parTransId="{1194E672-B269-4B91-B72D-73B24272F92A}" sibTransId="{77FC897D-51B2-4D68-8756-B971D4671A78}"/>
    <dgm:cxn modelId="{9BD13474-4CDC-4E5E-A53B-A2B7BB86ED85}" type="presOf" srcId="{643255AD-71E5-496C-B47C-0F72C36EA1B4}" destId="{53371C62-A9F4-424A-A2C3-5285FF0AAA6F}" srcOrd="0" destOrd="0" presId="urn:microsoft.com/office/officeart/2005/8/layout/orgChart1"/>
    <dgm:cxn modelId="{DD910776-114C-4E0F-A8D7-B5C1051825B4}" type="presOf" srcId="{0E694C0F-8AB1-4632-B2DA-D1247D8BE18F}" destId="{053C0BA0-4CA6-4511-8C30-0C0AC5E87C55}" srcOrd="1" destOrd="0" presId="urn:microsoft.com/office/officeart/2005/8/layout/orgChart1"/>
    <dgm:cxn modelId="{F307EE76-5ED9-40BE-B0BA-AA5BF559BB22}" type="presOf" srcId="{4D248CC2-3184-460B-A00A-1B722842C143}" destId="{B8F3B591-9307-4E9A-BD2C-F5D348511BEA}" srcOrd="0" destOrd="0" presId="urn:microsoft.com/office/officeart/2005/8/layout/orgChart1"/>
    <dgm:cxn modelId="{246A5F57-7B13-4DA3-87AF-9BDA0B755801}" type="presOf" srcId="{6BD44C91-1E07-4C76-A038-9B12972016B7}" destId="{ABC3CB6A-0357-4894-9BAA-929B77021C52}" srcOrd="0" destOrd="0" presId="urn:microsoft.com/office/officeart/2005/8/layout/orgChart1"/>
    <dgm:cxn modelId="{A2C75D7B-67A1-4A6A-8987-0CEADD36842A}" type="presOf" srcId="{D8AF9B9F-7B15-49F9-BF7C-6D4318F4863B}" destId="{8110C399-8F20-4AB5-BD7D-22095B9142B3}" srcOrd="0" destOrd="0" presId="urn:microsoft.com/office/officeart/2005/8/layout/orgChart1"/>
    <dgm:cxn modelId="{9BD1D47B-CC0D-4B7C-B46D-6ACDA79BE8C3}" type="presOf" srcId="{E8670ED3-53B6-4DE4-BA5A-1007D4D83780}" destId="{41581643-F527-4F9C-957D-21B7BF397099}" srcOrd="0" destOrd="0" presId="urn:microsoft.com/office/officeart/2005/8/layout/orgChart1"/>
    <dgm:cxn modelId="{684F9E7C-5665-45AE-BDC7-E926BABBC5B3}" type="presOf" srcId="{10C5170C-0FA0-419A-9FBF-40708DCE0584}" destId="{C3C2DE37-B416-45F4-9DB8-F5463E7725D0}" srcOrd="1" destOrd="0" presId="urn:microsoft.com/office/officeart/2005/8/layout/orgChart1"/>
    <dgm:cxn modelId="{62493D80-A7BC-40D9-8F37-7BF589A6236A}" type="presOf" srcId="{941C7643-26C4-48E0-99CB-5FC5DCAC7830}" destId="{38B6D9C8-E9D8-4050-A823-A9F97287CFBA}" srcOrd="1" destOrd="0" presId="urn:microsoft.com/office/officeart/2005/8/layout/orgChart1"/>
    <dgm:cxn modelId="{DDCA8081-CC22-4775-9F38-EE9CEF9657E8}" srcId="{DBA59BEF-F7D1-47B1-A43A-3B0DA8C93D02}" destId="{643255AD-71E5-496C-B47C-0F72C36EA1B4}" srcOrd="0" destOrd="0" parTransId="{34BEDA4B-4676-4447-BB1C-BF24E40AC4B9}" sibTransId="{0E9B234F-4C6A-449C-B75C-3D5AE4352F45}"/>
    <dgm:cxn modelId="{F0B55482-2913-4322-9F85-F3FE7C1FF605}" srcId="{406D8CC5-78C9-4B43-BDE8-4BE5804CEA04}" destId="{08C5AF4C-1B14-41B0-9771-7EBCD0929A3D}" srcOrd="0" destOrd="0" parTransId="{36A51C83-6AE4-4C7F-B92D-66DA6A6372CE}" sibTransId="{01D04D08-E5FA-4F84-8D48-EABDD9E66973}"/>
    <dgm:cxn modelId="{C534DF88-F68E-4543-BA3D-58EA03180A96}" type="presOf" srcId="{70F5A549-3C08-4956-A019-7F38601CA326}" destId="{13EA5D40-5517-4377-8544-329A518F7557}" srcOrd="0" destOrd="0" presId="urn:microsoft.com/office/officeart/2005/8/layout/orgChart1"/>
    <dgm:cxn modelId="{42D57389-D4B4-490E-873C-9F283818EFB8}" type="presOf" srcId="{643255AD-71E5-496C-B47C-0F72C36EA1B4}" destId="{C7CDD2F7-9A5D-47CE-9F03-D1B9A9C8458C}" srcOrd="1" destOrd="0" presId="urn:microsoft.com/office/officeart/2005/8/layout/orgChart1"/>
    <dgm:cxn modelId="{17E3B98A-6E55-40AC-A55B-6417489FC639}" srcId="{AE8828E0-C571-4F8A-9003-C6EADEAC1B46}" destId="{10C5170C-0FA0-419A-9FBF-40708DCE0584}" srcOrd="2" destOrd="0" parTransId="{E8670ED3-53B6-4DE4-BA5A-1007D4D83780}" sibTransId="{58B3ADD9-9722-4C32-9A9D-AFFB91986C59}"/>
    <dgm:cxn modelId="{3050568D-8A38-48D5-95EB-52242F9C59DA}" type="presOf" srcId="{349DFFB7-BC3E-496C-9A61-DB19C5510C78}" destId="{FFFD1586-C99D-4845-8FB7-33978BBFEBB3}" srcOrd="0" destOrd="0" presId="urn:microsoft.com/office/officeart/2005/8/layout/orgChart1"/>
    <dgm:cxn modelId="{40493F8F-A78F-4321-8690-EACE6573621F}" type="presOf" srcId="{AE8828E0-C571-4F8A-9003-C6EADEAC1B46}" destId="{CC1F212B-4033-4ACE-91CA-24A1CE845C0F}" srcOrd="1" destOrd="0" presId="urn:microsoft.com/office/officeart/2005/8/layout/orgChart1"/>
    <dgm:cxn modelId="{A4746891-142A-410B-A4AB-4F16AD0AC380}" type="presOf" srcId="{1194E672-B269-4B91-B72D-73B24272F92A}" destId="{75166AAF-32C8-49C3-845B-E6BDE1B03191}" srcOrd="0" destOrd="0" presId="urn:microsoft.com/office/officeart/2005/8/layout/orgChart1"/>
    <dgm:cxn modelId="{3B279892-816D-4D9C-99CE-1C5B73DE3E50}" type="presOf" srcId="{ACBC7456-BBE3-4FCD-A60F-3D45646DC9A6}" destId="{7B2932F0-6014-4010-B906-6D3CFBC9F556}" srcOrd="1" destOrd="0" presId="urn:microsoft.com/office/officeart/2005/8/layout/orgChart1"/>
    <dgm:cxn modelId="{6DCBBC92-5958-4E69-AFDA-592EA4912BB2}" type="presOf" srcId="{5C99D483-FDFA-4AFB-9580-398D96E942BB}" destId="{5E480686-E077-4A2E-87C9-6F692723D508}" srcOrd="0" destOrd="0" presId="urn:microsoft.com/office/officeart/2005/8/layout/orgChart1"/>
    <dgm:cxn modelId="{1F68F994-C77B-4EB0-925B-E1166B86620A}" type="presOf" srcId="{967E51DC-DAFD-4334-BA70-BAFEED137B42}" destId="{052E7182-A4A9-4292-A937-78185AFB7B85}" srcOrd="1" destOrd="0" presId="urn:microsoft.com/office/officeart/2005/8/layout/orgChart1"/>
    <dgm:cxn modelId="{39C61397-4B01-49DD-BE66-F612C6956896}" type="presOf" srcId="{98EC778F-CAF8-4E63-A99F-097796D79286}" destId="{B9FCC3FA-094E-47AD-A43F-10C485D8E237}" srcOrd="1" destOrd="0" presId="urn:microsoft.com/office/officeart/2005/8/layout/orgChart1"/>
    <dgm:cxn modelId="{78A54D99-BBCD-4466-A55A-87C98112867B}" type="presOf" srcId="{130EFFA0-5A01-4D2A-8B3D-38C4A7DF0256}" destId="{D853110F-A768-41EF-BD0B-232BC0569048}" srcOrd="1" destOrd="0" presId="urn:microsoft.com/office/officeart/2005/8/layout/orgChart1"/>
    <dgm:cxn modelId="{7489239A-9BEF-41C8-9876-F8E7B9EC0976}" type="presOf" srcId="{18F20645-7764-43F0-9163-9C3DC9EAF423}" destId="{4A5C067F-FEAA-48F0-96BD-C976B883AD03}" srcOrd="0" destOrd="0" presId="urn:microsoft.com/office/officeart/2005/8/layout/orgChart1"/>
    <dgm:cxn modelId="{A90AE4A2-BCC2-473B-8C01-9C25A61576FD}" srcId="{AE8828E0-C571-4F8A-9003-C6EADEAC1B46}" destId="{8E83BC88-359D-47C4-9BBC-5EFD9E609921}" srcOrd="0" destOrd="0" parTransId="{349DFFB7-BC3E-496C-9A61-DB19C5510C78}" sibTransId="{98914FDC-1103-4794-9FC5-BBCE7D31505E}"/>
    <dgm:cxn modelId="{5F19D2A3-562B-4139-9AE4-F23F9903E16A}" type="presOf" srcId="{4D8F43DD-2C06-4C3A-B53C-BCFDCEF851CB}" destId="{5A371F34-CA61-458E-801B-10E19FD404EB}" srcOrd="1" destOrd="0" presId="urn:microsoft.com/office/officeart/2005/8/layout/orgChart1"/>
    <dgm:cxn modelId="{E7FD46A7-11EC-4961-AD23-42C24D4F83B5}" type="presOf" srcId="{5A77A874-A08C-4C9C-A684-15F52CC18144}" destId="{574D0AF8-7A16-4358-A4D4-0A9F71E32AB6}" srcOrd="0" destOrd="0" presId="urn:microsoft.com/office/officeart/2005/8/layout/orgChart1"/>
    <dgm:cxn modelId="{C2D06FAA-F96D-4F27-AC5B-DC6284EC6372}" type="presOf" srcId="{6F8E4E8F-2702-4226-B47E-68170BE88C0D}" destId="{A054C64C-5610-4BB3-99DE-F3FB705E364F}" srcOrd="1" destOrd="0" presId="urn:microsoft.com/office/officeart/2005/8/layout/orgChart1"/>
    <dgm:cxn modelId="{872A89AA-1D85-4848-9BC6-AD6E60575BBC}" type="presOf" srcId="{130EFFA0-5A01-4D2A-8B3D-38C4A7DF0256}" destId="{B3787398-3726-450B-A2F2-03118F71D247}" srcOrd="0" destOrd="0" presId="urn:microsoft.com/office/officeart/2005/8/layout/orgChart1"/>
    <dgm:cxn modelId="{04C8A5AB-850E-479A-8F07-F496BE4E5EB3}" srcId="{0E694C0F-8AB1-4632-B2DA-D1247D8BE18F}" destId="{406D8CC5-78C9-4B43-BDE8-4BE5804CEA04}" srcOrd="0" destOrd="0" parTransId="{18F20645-7764-43F0-9163-9C3DC9EAF423}" sibTransId="{2EFFC32F-6ECF-4E60-9223-BF8D7C294614}"/>
    <dgm:cxn modelId="{E271B3B5-67DC-4938-85CE-5800A65D5C61}" type="presOf" srcId="{8907B98A-A738-4643-9CDA-6C3076424EFB}" destId="{17018C8E-E616-4D1D-BADA-97C9473BE7A5}" srcOrd="1" destOrd="0" presId="urn:microsoft.com/office/officeart/2005/8/layout/orgChart1"/>
    <dgm:cxn modelId="{8AC7A6B6-5DF2-43C2-9654-5BB6D4656C22}" type="presOf" srcId="{0E694C0F-8AB1-4632-B2DA-D1247D8BE18F}" destId="{87A60063-46AC-4CA6-8AFB-C646FC058C41}" srcOrd="0" destOrd="0" presId="urn:microsoft.com/office/officeart/2005/8/layout/orgChart1"/>
    <dgm:cxn modelId="{896C4AB7-59A2-4756-ADAB-2E3FE2DD063F}" type="presOf" srcId="{406D8CC5-78C9-4B43-BDE8-4BE5804CEA04}" destId="{8325B952-ADFE-4612-856B-08695AAA247D}" srcOrd="0" destOrd="0" presId="urn:microsoft.com/office/officeart/2005/8/layout/orgChart1"/>
    <dgm:cxn modelId="{17868BB7-CB52-4CDA-9509-7EFCBF4B4C27}" srcId="{AAC4D152-DFE4-4D71-BCD7-D8DC7E5B64B5}" destId="{941C7643-26C4-48E0-99CB-5FC5DCAC7830}" srcOrd="1" destOrd="0" parTransId="{E86315E3-7891-43B4-99E6-516075C79111}" sibTransId="{106E2D13-A208-43B3-8FB0-B3FE31798FFE}"/>
    <dgm:cxn modelId="{8C91F8B7-5E49-49ED-BC81-D35F478FA2DE}" type="presOf" srcId="{ACBC7456-BBE3-4FCD-A60F-3D45646DC9A6}" destId="{7AAAAC82-FC0D-43C2-9837-370A07F8A35C}" srcOrd="0" destOrd="0" presId="urn:microsoft.com/office/officeart/2005/8/layout/orgChart1"/>
    <dgm:cxn modelId="{3C1F5DBB-5B23-48DB-9202-078993D3109B}" srcId="{08C5AF4C-1B14-41B0-9771-7EBCD0929A3D}" destId="{4D8F43DD-2C06-4C3A-B53C-BCFDCEF851CB}" srcOrd="0" destOrd="0" parTransId="{3AFE5621-66D4-4879-AA57-BBB251AE6F50}" sibTransId="{BBF55649-09EB-402D-80C8-8DBA2D7E926E}"/>
    <dgm:cxn modelId="{990F76C0-D86F-498A-8311-ADE4C4D140ED}" type="presOf" srcId="{15AFF031-A5C1-4EBA-AE0C-FA89BF21DCD1}" destId="{8CB00494-7F74-4467-A3BD-5E2ABAF8B091}" srcOrd="0" destOrd="0" presId="urn:microsoft.com/office/officeart/2005/8/layout/orgChart1"/>
    <dgm:cxn modelId="{D715C7C0-CD63-446F-8892-EBE8943C748A}" type="presOf" srcId="{D8AF9B9F-7B15-49F9-BF7C-6D4318F4863B}" destId="{16FBCBB6-1A99-419C-ACE8-9066FEE99083}" srcOrd="1" destOrd="0" presId="urn:microsoft.com/office/officeart/2005/8/layout/orgChart1"/>
    <dgm:cxn modelId="{064BF8C3-F364-4733-84DB-CF5BA216A39C}" type="presOf" srcId="{8907B98A-A738-4643-9CDA-6C3076424EFB}" destId="{02FBF771-ADB1-4196-8CAA-4A17793F4EA7}" srcOrd="0" destOrd="0" presId="urn:microsoft.com/office/officeart/2005/8/layout/orgChart1"/>
    <dgm:cxn modelId="{4C2220C4-39F9-457D-B555-599D9E5B3164}" srcId="{8E83BC88-359D-47C4-9BBC-5EFD9E609921}" destId="{0E694C0F-8AB1-4632-B2DA-D1247D8BE18F}" srcOrd="1" destOrd="0" parTransId="{4D248CC2-3184-460B-A00A-1B722842C143}" sibTransId="{B82A1D0C-24B1-4AA0-9246-BA20D4269306}"/>
    <dgm:cxn modelId="{6456EAC5-5F71-4A17-B8BF-9A4B3E0D82B1}" type="presOf" srcId="{08C5AF4C-1B14-41B0-9771-7EBCD0929A3D}" destId="{765E4F2B-E403-446B-A07D-1C67F1398557}" srcOrd="0" destOrd="0" presId="urn:microsoft.com/office/officeart/2005/8/layout/orgChart1"/>
    <dgm:cxn modelId="{345BF5C9-5A57-4513-9337-7F8B89D76727}" type="presOf" srcId="{967E51DC-DAFD-4334-BA70-BAFEED137B42}" destId="{84ECF355-7DD3-4860-A18D-4CDD20866068}" srcOrd="0" destOrd="0" presId="urn:microsoft.com/office/officeart/2005/8/layout/orgChart1"/>
    <dgm:cxn modelId="{73CB73D0-53CD-4803-8712-80A1D74335BE}" type="presOf" srcId="{62E2A0BC-E9DB-4CF1-8F6E-90C940CDA799}" destId="{BFAA47A0-E90D-4B58-A71A-AB8D74B7511C}" srcOrd="1" destOrd="0" presId="urn:microsoft.com/office/officeart/2005/8/layout/orgChart1"/>
    <dgm:cxn modelId="{F071FDD2-E611-4FD4-A963-1FD0A9399D17}" type="presOf" srcId="{0AD48DCC-EA3C-4D2F-B3F0-AF372ECE432F}" destId="{ECD91E9F-914B-4692-AEB7-CF13D6B0301E}" srcOrd="0" destOrd="0" presId="urn:microsoft.com/office/officeart/2005/8/layout/orgChart1"/>
    <dgm:cxn modelId="{0713A7D8-9BD6-4A8C-B150-4AD9DD1E37CB}" type="presOf" srcId="{36A51C83-6AE4-4C7F-B92D-66DA6A6372CE}" destId="{19F787B1-4285-40D5-A18E-FE58585EB3EA}" srcOrd="0" destOrd="0" presId="urn:microsoft.com/office/officeart/2005/8/layout/orgChart1"/>
    <dgm:cxn modelId="{22C277DB-DEC4-4BEE-B695-7FEECA779191}" type="presOf" srcId="{DBA59BEF-F7D1-47B1-A43A-3B0DA8C93D02}" destId="{A59011C7-6EE2-4BBA-945A-1EA041A7BDF1}" srcOrd="1" destOrd="0" presId="urn:microsoft.com/office/officeart/2005/8/layout/orgChart1"/>
    <dgm:cxn modelId="{7DE31FDD-A7A9-4976-8AB0-247AF1E07294}" type="presOf" srcId="{8E83BC88-359D-47C4-9BBC-5EFD9E609921}" destId="{3B4C3098-684A-4D58-8815-D0CCA3C2AA08}" srcOrd="1" destOrd="0" presId="urn:microsoft.com/office/officeart/2005/8/layout/orgChart1"/>
    <dgm:cxn modelId="{028A7CDE-6550-4045-963A-6A713CF1D98F}" srcId="{AE8828E0-C571-4F8A-9003-C6EADEAC1B46}" destId="{6F8E4E8F-2702-4226-B47E-68170BE88C0D}" srcOrd="1" destOrd="0" parTransId="{DD8232B4-3BCE-40FA-A9D1-F6EE9E34EB34}" sibTransId="{1AF3179A-5447-46D1-A265-947BF4F4C0FD}"/>
    <dgm:cxn modelId="{8A04F2E9-B3C3-477D-81C1-C4C55D06F5AC}" srcId="{6BD44C91-1E07-4C76-A038-9B12972016B7}" destId="{AE8828E0-C571-4F8A-9003-C6EADEAC1B46}" srcOrd="0" destOrd="0" parTransId="{250AB9AA-6031-496F-B7F1-6F0DB8F8D34D}" sibTransId="{D23EE6B3-9394-4A9C-BC80-CD2D7E190BEE}"/>
    <dgm:cxn modelId="{35AB8BEA-1679-4755-A2A4-C49EFB6422AD}" type="presOf" srcId="{DD8232B4-3BCE-40FA-A9D1-F6EE9E34EB34}" destId="{A34C4E21-1952-4E8E-9318-1E0F6325910B}" srcOrd="0" destOrd="0" presId="urn:microsoft.com/office/officeart/2005/8/layout/orgChart1"/>
    <dgm:cxn modelId="{B744D4F0-3A25-4B02-AE9B-70E43B62728F}" type="presOf" srcId="{5A77A874-A08C-4C9C-A684-15F52CC18144}" destId="{81F07CF8-E94F-4491-972C-D86398C02FC7}" srcOrd="1" destOrd="0" presId="urn:microsoft.com/office/officeart/2005/8/layout/orgChart1"/>
    <dgm:cxn modelId="{AA2958F1-C74D-4C82-822A-33028699D8F6}" type="presOf" srcId="{7FCCC78F-80A8-4888-9D91-58DF6A1A42BD}" destId="{16F95800-F6FC-432A-8192-5DDFB4692B6C}" srcOrd="0" destOrd="0" presId="urn:microsoft.com/office/officeart/2005/8/layout/orgChart1"/>
    <dgm:cxn modelId="{95D842FB-3ADE-4596-801C-F252AAA1CC77}" type="presOf" srcId="{08C5AF4C-1B14-41B0-9771-7EBCD0929A3D}" destId="{39B12912-CB9D-4827-8B54-2FC5C8E01B9F}" srcOrd="1" destOrd="0" presId="urn:microsoft.com/office/officeart/2005/8/layout/orgChart1"/>
    <dgm:cxn modelId="{E75143FD-E7DB-4964-B3FC-45B8D5180559}" type="presOf" srcId="{591BECE1-B841-4D57-8D99-F9DC0D22DBF9}" destId="{05F4DF28-B57F-4699-9BED-B162015FDD41}" srcOrd="0" destOrd="0" presId="urn:microsoft.com/office/officeart/2005/8/layout/orgChart1"/>
    <dgm:cxn modelId="{664EC0FD-9409-46F1-A6B8-E2AF0D1B307E}" srcId="{C21C6336-F2DC-476E-8D65-A690CB2A842A}" destId="{130EFFA0-5A01-4D2A-8B3D-38C4A7DF0256}" srcOrd="0" destOrd="0" parTransId="{0AD48DCC-EA3C-4D2F-B3F0-AF372ECE432F}" sibTransId="{E448A32E-41A6-49B9-873E-D9EA1B2598FC}"/>
    <dgm:cxn modelId="{3349DEFF-0B19-4E83-83A8-B49EBF290C4C}" type="presOf" srcId="{10C5170C-0FA0-419A-9FBF-40708DCE0584}" destId="{52201AFD-8388-4F09-A422-24B3ED7819C8}" srcOrd="0" destOrd="0" presId="urn:microsoft.com/office/officeart/2005/8/layout/orgChart1"/>
    <dgm:cxn modelId="{0A6EC9F8-B151-462D-A8A1-024642DE638A}" type="presParOf" srcId="{ABC3CB6A-0357-4894-9BAA-929B77021C52}" destId="{AEAB85E9-A70C-4405-877A-25C8499667A5}" srcOrd="0" destOrd="0" presId="urn:microsoft.com/office/officeart/2005/8/layout/orgChart1"/>
    <dgm:cxn modelId="{FC24232E-6306-4052-8B8A-8C7E4E8FB040}" type="presParOf" srcId="{AEAB85E9-A70C-4405-877A-25C8499667A5}" destId="{1E669895-E92B-4739-8C7B-84CB31B48474}" srcOrd="0" destOrd="0" presId="urn:microsoft.com/office/officeart/2005/8/layout/orgChart1"/>
    <dgm:cxn modelId="{24A8B27D-8321-4585-8D20-55DB667F6E81}" type="presParOf" srcId="{1E669895-E92B-4739-8C7B-84CB31B48474}" destId="{356AF28E-5690-4043-AF44-3ACC12D0BDB0}" srcOrd="0" destOrd="0" presId="urn:microsoft.com/office/officeart/2005/8/layout/orgChart1"/>
    <dgm:cxn modelId="{CFC17408-66EB-4251-BBA5-913FAEF1435B}" type="presParOf" srcId="{1E669895-E92B-4739-8C7B-84CB31B48474}" destId="{CC1F212B-4033-4ACE-91CA-24A1CE845C0F}" srcOrd="1" destOrd="0" presId="urn:microsoft.com/office/officeart/2005/8/layout/orgChart1"/>
    <dgm:cxn modelId="{41F09C12-10EA-489C-819F-3B652CDBFF6D}" type="presParOf" srcId="{AEAB85E9-A70C-4405-877A-25C8499667A5}" destId="{2620BDDE-FA0E-4A4C-8A0C-B5CB145438F5}" srcOrd="1" destOrd="0" presId="urn:microsoft.com/office/officeart/2005/8/layout/orgChart1"/>
    <dgm:cxn modelId="{B402D5EB-6E8C-4F41-B6DB-6DE2AA54EE74}" type="presParOf" srcId="{2620BDDE-FA0E-4A4C-8A0C-B5CB145438F5}" destId="{FFFD1586-C99D-4845-8FB7-33978BBFEBB3}" srcOrd="0" destOrd="0" presId="urn:microsoft.com/office/officeart/2005/8/layout/orgChart1"/>
    <dgm:cxn modelId="{A4425AF2-C129-48E0-92A8-260960A19451}" type="presParOf" srcId="{2620BDDE-FA0E-4A4C-8A0C-B5CB145438F5}" destId="{238AEF1C-EA40-47B2-AD6F-C7FBDF9862A4}" srcOrd="1" destOrd="0" presId="urn:microsoft.com/office/officeart/2005/8/layout/orgChart1"/>
    <dgm:cxn modelId="{3EDF783F-2C18-46B2-9345-244C9FE64A78}" type="presParOf" srcId="{238AEF1C-EA40-47B2-AD6F-C7FBDF9862A4}" destId="{DAF59CE7-69D3-4E3E-9105-8DF6BE16B2E9}" srcOrd="0" destOrd="0" presId="urn:microsoft.com/office/officeart/2005/8/layout/orgChart1"/>
    <dgm:cxn modelId="{FE88E0BA-291A-453E-A613-1313BABC4166}" type="presParOf" srcId="{DAF59CE7-69D3-4E3E-9105-8DF6BE16B2E9}" destId="{C6924E3E-37F0-45BB-A9D6-33A3FF05B21C}" srcOrd="0" destOrd="0" presId="urn:microsoft.com/office/officeart/2005/8/layout/orgChart1"/>
    <dgm:cxn modelId="{173843FF-7617-4494-8F7B-33D1427A1B72}" type="presParOf" srcId="{DAF59CE7-69D3-4E3E-9105-8DF6BE16B2E9}" destId="{3B4C3098-684A-4D58-8815-D0CCA3C2AA08}" srcOrd="1" destOrd="0" presId="urn:microsoft.com/office/officeart/2005/8/layout/orgChart1"/>
    <dgm:cxn modelId="{48CF687F-8F85-4AA4-9000-D61F0C1CE454}" type="presParOf" srcId="{238AEF1C-EA40-47B2-AD6F-C7FBDF9862A4}" destId="{C6A7C44F-2A3F-4F38-BFAD-45072B23DE07}" srcOrd="1" destOrd="0" presId="urn:microsoft.com/office/officeart/2005/8/layout/orgChart1"/>
    <dgm:cxn modelId="{3B03B9C7-8071-4845-B523-9C35B9652E77}" type="presParOf" srcId="{C6A7C44F-2A3F-4F38-BFAD-45072B23DE07}" destId="{16F95800-F6FC-432A-8192-5DDFB4692B6C}" srcOrd="0" destOrd="0" presId="urn:microsoft.com/office/officeart/2005/8/layout/orgChart1"/>
    <dgm:cxn modelId="{ADF2FF40-1AE6-4E35-92C4-09B94B3706D7}" type="presParOf" srcId="{C6A7C44F-2A3F-4F38-BFAD-45072B23DE07}" destId="{9E716B29-2216-4651-A18A-EAC68AA05A24}" srcOrd="1" destOrd="0" presId="urn:microsoft.com/office/officeart/2005/8/layout/orgChart1"/>
    <dgm:cxn modelId="{5BF7977E-90C5-48C7-8BF8-5A8E3EF4250D}" type="presParOf" srcId="{9E716B29-2216-4651-A18A-EAC68AA05A24}" destId="{14C6D8F7-4917-4327-8461-C2A64ACA6B89}" srcOrd="0" destOrd="0" presId="urn:microsoft.com/office/officeart/2005/8/layout/orgChart1"/>
    <dgm:cxn modelId="{49FDCD33-B0FB-464D-B97B-AFC7530E3682}" type="presParOf" srcId="{14C6D8F7-4917-4327-8461-C2A64ACA6B89}" destId="{0296FC5F-E378-4904-93B2-00D4ACF73593}" srcOrd="0" destOrd="0" presId="urn:microsoft.com/office/officeart/2005/8/layout/orgChart1"/>
    <dgm:cxn modelId="{3D735F56-F569-4DAE-8F86-CEC54E5D6D75}" type="presParOf" srcId="{14C6D8F7-4917-4327-8461-C2A64ACA6B89}" destId="{2A3B2C18-117F-4F18-8DA1-0C7AC429375D}" srcOrd="1" destOrd="0" presId="urn:microsoft.com/office/officeart/2005/8/layout/orgChart1"/>
    <dgm:cxn modelId="{3BB64069-57EC-4776-9924-EE4EFAB9F7AE}" type="presParOf" srcId="{9E716B29-2216-4651-A18A-EAC68AA05A24}" destId="{106E37BA-F771-4BE8-8846-0F3D21A3D507}" srcOrd="1" destOrd="0" presId="urn:microsoft.com/office/officeart/2005/8/layout/orgChart1"/>
    <dgm:cxn modelId="{5EE432FE-F245-4DC9-938B-F4E8D74095B4}" type="presParOf" srcId="{106E37BA-F771-4BE8-8846-0F3D21A3D507}" destId="{05F4DF28-B57F-4699-9BED-B162015FDD41}" srcOrd="0" destOrd="0" presId="urn:microsoft.com/office/officeart/2005/8/layout/orgChart1"/>
    <dgm:cxn modelId="{707E9630-F317-4074-9F37-E95B7726AD61}" type="presParOf" srcId="{106E37BA-F771-4BE8-8846-0F3D21A3D507}" destId="{825D8AFF-14D3-43E5-AD31-216B21801723}" srcOrd="1" destOrd="0" presId="urn:microsoft.com/office/officeart/2005/8/layout/orgChart1"/>
    <dgm:cxn modelId="{0CB40676-B3CD-496D-9853-0F45299FF125}" type="presParOf" srcId="{825D8AFF-14D3-43E5-AD31-216B21801723}" destId="{5245F033-2183-451C-8E29-6A85BFAA36EA}" srcOrd="0" destOrd="0" presId="urn:microsoft.com/office/officeart/2005/8/layout/orgChart1"/>
    <dgm:cxn modelId="{12346772-D8BF-451B-9848-DC0F7C5FB803}" type="presParOf" srcId="{5245F033-2183-451C-8E29-6A85BFAA36EA}" destId="{B8C1EDF1-DB2A-4D33-AA78-22955DE770C3}" srcOrd="0" destOrd="0" presId="urn:microsoft.com/office/officeart/2005/8/layout/orgChart1"/>
    <dgm:cxn modelId="{314C8179-AE97-4DEF-AC8C-5D0294CE65FC}" type="presParOf" srcId="{5245F033-2183-451C-8E29-6A85BFAA36EA}" destId="{A59011C7-6EE2-4BBA-945A-1EA041A7BDF1}" srcOrd="1" destOrd="0" presId="urn:microsoft.com/office/officeart/2005/8/layout/orgChart1"/>
    <dgm:cxn modelId="{704A7C58-0B74-4B99-AB58-86A582B2B16B}" type="presParOf" srcId="{825D8AFF-14D3-43E5-AD31-216B21801723}" destId="{7C3D7898-B966-40D3-9287-C16DE16BCFA6}" srcOrd="1" destOrd="0" presId="urn:microsoft.com/office/officeart/2005/8/layout/orgChart1"/>
    <dgm:cxn modelId="{C0F9D79D-03DF-472E-A352-66E4FD4547C6}" type="presParOf" srcId="{7C3D7898-B966-40D3-9287-C16DE16BCFA6}" destId="{DD731950-665B-474A-9284-81BABEADB935}" srcOrd="0" destOrd="0" presId="urn:microsoft.com/office/officeart/2005/8/layout/orgChart1"/>
    <dgm:cxn modelId="{61FA540C-242F-41F6-86A2-614C52B2B0A6}" type="presParOf" srcId="{7C3D7898-B966-40D3-9287-C16DE16BCFA6}" destId="{32A235EB-AA7F-4B94-A580-59A6593BE504}" srcOrd="1" destOrd="0" presId="urn:microsoft.com/office/officeart/2005/8/layout/orgChart1"/>
    <dgm:cxn modelId="{74DBBF58-7F90-40F8-B16F-CC3A2F296C03}" type="presParOf" srcId="{32A235EB-AA7F-4B94-A580-59A6593BE504}" destId="{36BAFAB3-940C-4564-B083-4E102C6171B8}" srcOrd="0" destOrd="0" presId="urn:microsoft.com/office/officeart/2005/8/layout/orgChart1"/>
    <dgm:cxn modelId="{5404F91D-864B-400A-A511-65EE94C72842}" type="presParOf" srcId="{36BAFAB3-940C-4564-B083-4E102C6171B8}" destId="{53371C62-A9F4-424A-A2C3-5285FF0AAA6F}" srcOrd="0" destOrd="0" presId="urn:microsoft.com/office/officeart/2005/8/layout/orgChart1"/>
    <dgm:cxn modelId="{8AECF878-07F7-42A6-84CE-5EF090539A5B}" type="presParOf" srcId="{36BAFAB3-940C-4564-B083-4E102C6171B8}" destId="{C7CDD2F7-9A5D-47CE-9F03-D1B9A9C8458C}" srcOrd="1" destOrd="0" presId="urn:microsoft.com/office/officeart/2005/8/layout/orgChart1"/>
    <dgm:cxn modelId="{7C7032E4-207E-4E77-96C4-44C7FAB95487}" type="presParOf" srcId="{32A235EB-AA7F-4B94-A580-59A6593BE504}" destId="{7EDA0209-31D1-4079-9185-0D9234A600D0}" srcOrd="1" destOrd="0" presId="urn:microsoft.com/office/officeart/2005/8/layout/orgChart1"/>
    <dgm:cxn modelId="{642C8706-1547-4F96-8899-4019221D1CE9}" type="presParOf" srcId="{7EDA0209-31D1-4079-9185-0D9234A600D0}" destId="{82CAE2F5-6413-4F95-9925-7BD8906E8C59}" srcOrd="0" destOrd="0" presId="urn:microsoft.com/office/officeart/2005/8/layout/orgChart1"/>
    <dgm:cxn modelId="{699CBEFC-112B-403E-9EF2-AE8BD068784B}" type="presParOf" srcId="{7EDA0209-31D1-4079-9185-0D9234A600D0}" destId="{7EEA6159-8DAB-453F-9994-A7EDB12A2048}" srcOrd="1" destOrd="0" presId="urn:microsoft.com/office/officeart/2005/8/layout/orgChart1"/>
    <dgm:cxn modelId="{AD9EFA4B-4964-44FF-960B-7000ECB9B549}" type="presParOf" srcId="{7EEA6159-8DAB-453F-9994-A7EDB12A2048}" destId="{69288EB1-4EFE-4A5A-A258-163621A48976}" srcOrd="0" destOrd="0" presId="urn:microsoft.com/office/officeart/2005/8/layout/orgChart1"/>
    <dgm:cxn modelId="{2BC41AFE-2D02-4B46-B303-ADF948757AC1}" type="presParOf" srcId="{69288EB1-4EFE-4A5A-A258-163621A48976}" destId="{02FBF771-ADB1-4196-8CAA-4A17793F4EA7}" srcOrd="0" destOrd="0" presId="urn:microsoft.com/office/officeart/2005/8/layout/orgChart1"/>
    <dgm:cxn modelId="{F6B65CA9-E9C8-41A6-BB86-626B6697EA24}" type="presParOf" srcId="{69288EB1-4EFE-4A5A-A258-163621A48976}" destId="{17018C8E-E616-4D1D-BADA-97C9473BE7A5}" srcOrd="1" destOrd="0" presId="urn:microsoft.com/office/officeart/2005/8/layout/orgChart1"/>
    <dgm:cxn modelId="{FD2CAF8C-0596-48B4-9386-D415AFAA0E5F}" type="presParOf" srcId="{7EEA6159-8DAB-453F-9994-A7EDB12A2048}" destId="{CE2B4D1E-3A82-4547-8453-19812BE03CEA}" srcOrd="1" destOrd="0" presId="urn:microsoft.com/office/officeart/2005/8/layout/orgChart1"/>
    <dgm:cxn modelId="{4D6A9EB6-8D03-49DF-97DE-44AC065B4E26}" type="presParOf" srcId="{7EEA6159-8DAB-453F-9994-A7EDB12A2048}" destId="{A2B04F32-A038-456F-89D6-D77F29B063A8}" srcOrd="2" destOrd="0" presId="urn:microsoft.com/office/officeart/2005/8/layout/orgChart1"/>
    <dgm:cxn modelId="{A219515E-256C-4D8B-858C-9A372E7A523C}" type="presParOf" srcId="{32A235EB-AA7F-4B94-A580-59A6593BE504}" destId="{0DE1086A-45E0-44C3-B843-F09BFB8929BA}" srcOrd="2" destOrd="0" presId="urn:microsoft.com/office/officeart/2005/8/layout/orgChart1"/>
    <dgm:cxn modelId="{31574AC0-34E8-467A-A6E0-F2505B23F819}" type="presParOf" srcId="{7C3D7898-B966-40D3-9287-C16DE16BCFA6}" destId="{5E480686-E077-4A2E-87C9-6F692723D508}" srcOrd="2" destOrd="0" presId="urn:microsoft.com/office/officeart/2005/8/layout/orgChart1"/>
    <dgm:cxn modelId="{3FC24EFA-54AD-4B78-95D4-07EA6B8EEB3D}" type="presParOf" srcId="{7C3D7898-B966-40D3-9287-C16DE16BCFA6}" destId="{617A7464-EFC2-44C7-AFA3-7CC2EA05425A}" srcOrd="3" destOrd="0" presId="urn:microsoft.com/office/officeart/2005/8/layout/orgChart1"/>
    <dgm:cxn modelId="{773B50A2-DF31-4818-BF67-8515011B10D5}" type="presParOf" srcId="{617A7464-EFC2-44C7-AFA3-7CC2EA05425A}" destId="{3563A93E-6422-40E2-8ED5-F1C3181CEFF0}" srcOrd="0" destOrd="0" presId="urn:microsoft.com/office/officeart/2005/8/layout/orgChart1"/>
    <dgm:cxn modelId="{DAB95655-86AC-4ECC-A2EF-69517ADB4B68}" type="presParOf" srcId="{3563A93E-6422-40E2-8ED5-F1C3181CEFF0}" destId="{7AAAAC82-FC0D-43C2-9837-370A07F8A35C}" srcOrd="0" destOrd="0" presId="urn:microsoft.com/office/officeart/2005/8/layout/orgChart1"/>
    <dgm:cxn modelId="{DB2A1D3C-DB73-4CF9-97E0-72F7209C9D84}" type="presParOf" srcId="{3563A93E-6422-40E2-8ED5-F1C3181CEFF0}" destId="{7B2932F0-6014-4010-B906-6D3CFBC9F556}" srcOrd="1" destOrd="0" presId="urn:microsoft.com/office/officeart/2005/8/layout/orgChart1"/>
    <dgm:cxn modelId="{8903535C-DB16-4EDD-A67C-BBFCCC972C01}" type="presParOf" srcId="{617A7464-EFC2-44C7-AFA3-7CC2EA05425A}" destId="{12C2CEED-F85C-413D-B1BC-BE5F76744DED}" srcOrd="1" destOrd="0" presId="urn:microsoft.com/office/officeart/2005/8/layout/orgChart1"/>
    <dgm:cxn modelId="{5789D180-73DF-4B49-BFC5-CFF1E281EACF}" type="presParOf" srcId="{12C2CEED-F85C-413D-B1BC-BE5F76744DED}" destId="{13EA5D40-5517-4377-8544-329A518F7557}" srcOrd="0" destOrd="0" presId="urn:microsoft.com/office/officeart/2005/8/layout/orgChart1"/>
    <dgm:cxn modelId="{CA994227-9F06-48CD-86D6-658471B9D92D}" type="presParOf" srcId="{12C2CEED-F85C-413D-B1BC-BE5F76744DED}" destId="{4AFF8A63-287F-4175-898B-860B32913B19}" srcOrd="1" destOrd="0" presId="urn:microsoft.com/office/officeart/2005/8/layout/orgChart1"/>
    <dgm:cxn modelId="{A8B95F05-9DC7-4329-9E79-CD02914533D9}" type="presParOf" srcId="{4AFF8A63-287F-4175-898B-860B32913B19}" destId="{A1DB1F57-B7E1-4800-BA01-C8A4507E6953}" srcOrd="0" destOrd="0" presId="urn:microsoft.com/office/officeart/2005/8/layout/orgChart1"/>
    <dgm:cxn modelId="{7F2C7831-E8A0-47BD-BE57-B4A0ECFDBE92}" type="presParOf" srcId="{A1DB1F57-B7E1-4800-BA01-C8A4507E6953}" destId="{574D0AF8-7A16-4358-A4D4-0A9F71E32AB6}" srcOrd="0" destOrd="0" presId="urn:microsoft.com/office/officeart/2005/8/layout/orgChart1"/>
    <dgm:cxn modelId="{C95BA744-8F20-4822-B33D-FB8886EFFE23}" type="presParOf" srcId="{A1DB1F57-B7E1-4800-BA01-C8A4507E6953}" destId="{81F07CF8-E94F-4491-972C-D86398C02FC7}" srcOrd="1" destOrd="0" presId="urn:microsoft.com/office/officeart/2005/8/layout/orgChart1"/>
    <dgm:cxn modelId="{DCBD3FD0-3049-4CBC-8F58-8786923B79FB}" type="presParOf" srcId="{4AFF8A63-287F-4175-898B-860B32913B19}" destId="{E0FDC855-6645-44DE-A79A-6A0E7AD14FC1}" srcOrd="1" destOrd="0" presId="urn:microsoft.com/office/officeart/2005/8/layout/orgChart1"/>
    <dgm:cxn modelId="{0047C36E-A6EE-4E60-83C4-24742490E478}" type="presParOf" srcId="{4AFF8A63-287F-4175-898B-860B32913B19}" destId="{C32261BC-5BC7-4B72-B1B4-A700E1D5E2FC}" srcOrd="2" destOrd="0" presId="urn:microsoft.com/office/officeart/2005/8/layout/orgChart1"/>
    <dgm:cxn modelId="{6B960736-4E46-459C-B19E-3A311AE4FED3}" type="presParOf" srcId="{617A7464-EFC2-44C7-AFA3-7CC2EA05425A}" destId="{D44EE10B-8767-49EC-944D-35F194000B80}" srcOrd="2" destOrd="0" presId="urn:microsoft.com/office/officeart/2005/8/layout/orgChart1"/>
    <dgm:cxn modelId="{A2F14676-6F53-4744-A636-15448042503E}" type="presParOf" srcId="{825D8AFF-14D3-43E5-AD31-216B21801723}" destId="{D07FC435-ED36-4E66-AF58-BBEA60B14809}" srcOrd="2" destOrd="0" presId="urn:microsoft.com/office/officeart/2005/8/layout/orgChart1"/>
    <dgm:cxn modelId="{A1817E57-2149-4129-8869-6AAD56B0066A}" type="presParOf" srcId="{106E37BA-F771-4BE8-8846-0F3D21A3D507}" destId="{35E9E6AB-8EBF-4489-A9AD-B18731334C84}" srcOrd="2" destOrd="0" presId="urn:microsoft.com/office/officeart/2005/8/layout/orgChart1"/>
    <dgm:cxn modelId="{607F70C9-A076-4B8A-BED4-6A2D69760C93}" type="presParOf" srcId="{106E37BA-F771-4BE8-8846-0F3D21A3D507}" destId="{DC54E399-9511-4CB6-8C80-71318FE6ECB6}" srcOrd="3" destOrd="0" presId="urn:microsoft.com/office/officeart/2005/8/layout/orgChart1"/>
    <dgm:cxn modelId="{41DBBA6E-8CF0-4964-9467-A57F5DD38D0B}" type="presParOf" srcId="{DC54E399-9511-4CB6-8C80-71318FE6ECB6}" destId="{16D179C5-A932-40DA-A6D5-65CF1FECF634}" srcOrd="0" destOrd="0" presId="urn:microsoft.com/office/officeart/2005/8/layout/orgChart1"/>
    <dgm:cxn modelId="{FCC8FE39-6EDA-4BF5-9232-760F7747E0E3}" type="presParOf" srcId="{16D179C5-A932-40DA-A6D5-65CF1FECF634}" destId="{1428E6BE-2F58-417D-9CB2-2888832E0161}" srcOrd="0" destOrd="0" presId="urn:microsoft.com/office/officeart/2005/8/layout/orgChart1"/>
    <dgm:cxn modelId="{3C152A9B-6501-4F4E-AC8B-FF1CBC56CD95}" type="presParOf" srcId="{16D179C5-A932-40DA-A6D5-65CF1FECF634}" destId="{38B6D9C8-E9D8-4050-A823-A9F97287CFBA}" srcOrd="1" destOrd="0" presId="urn:microsoft.com/office/officeart/2005/8/layout/orgChart1"/>
    <dgm:cxn modelId="{819271C8-62B3-4981-9DB8-659E1F27555E}" type="presParOf" srcId="{DC54E399-9511-4CB6-8C80-71318FE6ECB6}" destId="{A4DE7510-1459-48B1-AFEC-BAA8154AD4F3}" srcOrd="1" destOrd="0" presId="urn:microsoft.com/office/officeart/2005/8/layout/orgChart1"/>
    <dgm:cxn modelId="{17163940-BFFE-450E-A925-02FAC0E9EA3B}" type="presParOf" srcId="{A4DE7510-1459-48B1-AFEC-BAA8154AD4F3}" destId="{1AAE962B-FC4E-4E88-9802-C684323DA4FE}" srcOrd="0" destOrd="0" presId="urn:microsoft.com/office/officeart/2005/8/layout/orgChart1"/>
    <dgm:cxn modelId="{A462E005-9C8D-4550-A0FE-FD5A18D81295}" type="presParOf" srcId="{A4DE7510-1459-48B1-AFEC-BAA8154AD4F3}" destId="{ACAC5505-D3D1-4D57-B32C-9AC3B8D7350A}" srcOrd="1" destOrd="0" presId="urn:microsoft.com/office/officeart/2005/8/layout/orgChart1"/>
    <dgm:cxn modelId="{56156E4E-8E0A-4806-BF33-39F264E18E2E}" type="presParOf" srcId="{ACAC5505-D3D1-4D57-B32C-9AC3B8D7350A}" destId="{8C21FDB2-B8B8-4BD5-9557-77DA1E527140}" srcOrd="0" destOrd="0" presId="urn:microsoft.com/office/officeart/2005/8/layout/orgChart1"/>
    <dgm:cxn modelId="{870BDFF4-A041-4ECF-B57F-035DA118F8B2}" type="presParOf" srcId="{8C21FDB2-B8B8-4BD5-9557-77DA1E527140}" destId="{8110C399-8F20-4AB5-BD7D-22095B9142B3}" srcOrd="0" destOrd="0" presId="urn:microsoft.com/office/officeart/2005/8/layout/orgChart1"/>
    <dgm:cxn modelId="{E3C798C2-3AD9-4B3F-B610-712015A4C1F5}" type="presParOf" srcId="{8C21FDB2-B8B8-4BD5-9557-77DA1E527140}" destId="{16FBCBB6-1A99-419C-ACE8-9066FEE99083}" srcOrd="1" destOrd="0" presId="urn:microsoft.com/office/officeart/2005/8/layout/orgChart1"/>
    <dgm:cxn modelId="{2B948853-DF90-40CC-847B-BC1F413F5074}" type="presParOf" srcId="{ACAC5505-D3D1-4D57-B32C-9AC3B8D7350A}" destId="{A55CB61D-63FA-4E1D-A1A0-2BB6AB750FD6}" srcOrd="1" destOrd="0" presId="urn:microsoft.com/office/officeart/2005/8/layout/orgChart1"/>
    <dgm:cxn modelId="{05B8D209-34F4-44DA-BD8C-05911AB9AECA}" type="presParOf" srcId="{A55CB61D-63FA-4E1D-A1A0-2BB6AB750FD6}" destId="{75166AAF-32C8-49C3-845B-E6BDE1B03191}" srcOrd="0" destOrd="0" presId="urn:microsoft.com/office/officeart/2005/8/layout/orgChart1"/>
    <dgm:cxn modelId="{E2EF1C1B-2293-4D6E-8B6F-7DF889F82BB3}" type="presParOf" srcId="{A55CB61D-63FA-4E1D-A1A0-2BB6AB750FD6}" destId="{7C6A5747-0D04-43BF-8274-9EFA0B63BAB4}" srcOrd="1" destOrd="0" presId="urn:microsoft.com/office/officeart/2005/8/layout/orgChart1"/>
    <dgm:cxn modelId="{2226123A-728F-48F8-B098-2032D784F040}" type="presParOf" srcId="{7C6A5747-0D04-43BF-8274-9EFA0B63BAB4}" destId="{89B87839-3B64-4F83-9C04-6B66C6588203}" srcOrd="0" destOrd="0" presId="urn:microsoft.com/office/officeart/2005/8/layout/orgChart1"/>
    <dgm:cxn modelId="{72CE3922-8E96-46BE-9603-2DA56274F3B7}" type="presParOf" srcId="{89B87839-3B64-4F83-9C04-6B66C6588203}" destId="{AD85E944-2472-4D72-9B7F-B6CF170BE523}" srcOrd="0" destOrd="0" presId="urn:microsoft.com/office/officeart/2005/8/layout/orgChart1"/>
    <dgm:cxn modelId="{70EFFCF1-E07D-47B2-875C-03292DCD277D}" type="presParOf" srcId="{89B87839-3B64-4F83-9C04-6B66C6588203}" destId="{33119A54-6917-43F0-9A2F-C2C0D9463939}" srcOrd="1" destOrd="0" presId="urn:microsoft.com/office/officeart/2005/8/layout/orgChart1"/>
    <dgm:cxn modelId="{E8E592E0-7876-448D-9630-A9AF56CE6E15}" type="presParOf" srcId="{7C6A5747-0D04-43BF-8274-9EFA0B63BAB4}" destId="{46E928B4-2AB6-41B6-BA6D-704E4CEF14FC}" srcOrd="1" destOrd="0" presId="urn:microsoft.com/office/officeart/2005/8/layout/orgChart1"/>
    <dgm:cxn modelId="{03B2464D-D43A-4EC0-AB40-0F0965695502}" type="presParOf" srcId="{7C6A5747-0D04-43BF-8274-9EFA0B63BAB4}" destId="{84FD804E-328A-4C5F-BBED-6EBB4C1A10D7}" srcOrd="2" destOrd="0" presId="urn:microsoft.com/office/officeart/2005/8/layout/orgChart1"/>
    <dgm:cxn modelId="{33BCCC5F-13D2-4A2F-9C02-D22297627617}" type="presParOf" srcId="{ACAC5505-D3D1-4D57-B32C-9AC3B8D7350A}" destId="{F426B2E4-1C3C-416C-AB30-9BBCF3844AD0}" srcOrd="2" destOrd="0" presId="urn:microsoft.com/office/officeart/2005/8/layout/orgChart1"/>
    <dgm:cxn modelId="{EC8D5F0B-BEA5-4AA4-8E17-9C00B80D9CB8}" type="presParOf" srcId="{A4DE7510-1459-48B1-AFEC-BAA8154AD4F3}" destId="{AACCD6B2-FB3B-4F92-BBD9-D318FF429818}" srcOrd="2" destOrd="0" presId="urn:microsoft.com/office/officeart/2005/8/layout/orgChart1"/>
    <dgm:cxn modelId="{E1171877-8DD8-45A6-99C0-1EFC1669DC9B}" type="presParOf" srcId="{A4DE7510-1459-48B1-AFEC-BAA8154AD4F3}" destId="{F06B8623-2B21-46DC-ADD2-EC40A74AF137}" srcOrd="3" destOrd="0" presId="urn:microsoft.com/office/officeart/2005/8/layout/orgChart1"/>
    <dgm:cxn modelId="{3BE599BE-E88E-406C-AC84-C67DBAD97523}" type="presParOf" srcId="{F06B8623-2B21-46DC-ADD2-EC40A74AF137}" destId="{19015CC2-8C93-43CC-8B88-CF0871BCBFDA}" srcOrd="0" destOrd="0" presId="urn:microsoft.com/office/officeart/2005/8/layout/orgChart1"/>
    <dgm:cxn modelId="{05A6C385-65F2-4F45-9785-C326D7946A01}" type="presParOf" srcId="{19015CC2-8C93-43CC-8B88-CF0871BCBFDA}" destId="{C73811CB-CB56-4712-8C2D-8D9895AB323B}" srcOrd="0" destOrd="0" presId="urn:microsoft.com/office/officeart/2005/8/layout/orgChart1"/>
    <dgm:cxn modelId="{F348D5B7-206D-4F04-B90E-029151E2C150}" type="presParOf" srcId="{19015CC2-8C93-43CC-8B88-CF0871BCBFDA}" destId="{D1D2ECBD-20A1-49CA-AC99-E870D7287921}" srcOrd="1" destOrd="0" presId="urn:microsoft.com/office/officeart/2005/8/layout/orgChart1"/>
    <dgm:cxn modelId="{12B422D5-905E-4C6F-8006-4797F84B4322}" type="presParOf" srcId="{F06B8623-2B21-46DC-ADD2-EC40A74AF137}" destId="{66ABCB7A-39E5-4271-AE9E-34E497D00195}" srcOrd="1" destOrd="0" presId="urn:microsoft.com/office/officeart/2005/8/layout/orgChart1"/>
    <dgm:cxn modelId="{C117855B-7501-448F-A4AD-39204C42D8E7}" type="presParOf" srcId="{66ABCB7A-39E5-4271-AE9E-34E497D00195}" destId="{ECD91E9F-914B-4692-AEB7-CF13D6B0301E}" srcOrd="0" destOrd="0" presId="urn:microsoft.com/office/officeart/2005/8/layout/orgChart1"/>
    <dgm:cxn modelId="{C0E2F1F5-2048-4B98-8ED0-BFA8B0C4904A}" type="presParOf" srcId="{66ABCB7A-39E5-4271-AE9E-34E497D00195}" destId="{99F5DF36-6B38-4433-973D-3D338E0AD8D0}" srcOrd="1" destOrd="0" presId="urn:microsoft.com/office/officeart/2005/8/layout/orgChart1"/>
    <dgm:cxn modelId="{B7963A0E-BAD4-475F-B735-F2F18267EE6E}" type="presParOf" srcId="{99F5DF36-6B38-4433-973D-3D338E0AD8D0}" destId="{E2A72684-DD97-4C18-AF7E-3F9C9751FC87}" srcOrd="0" destOrd="0" presId="urn:microsoft.com/office/officeart/2005/8/layout/orgChart1"/>
    <dgm:cxn modelId="{91B8A362-D63A-4192-9921-981D6633B802}" type="presParOf" srcId="{E2A72684-DD97-4C18-AF7E-3F9C9751FC87}" destId="{B3787398-3726-450B-A2F2-03118F71D247}" srcOrd="0" destOrd="0" presId="urn:microsoft.com/office/officeart/2005/8/layout/orgChart1"/>
    <dgm:cxn modelId="{9DAD5D05-4B1F-4F47-AC95-F92EE768E446}" type="presParOf" srcId="{E2A72684-DD97-4C18-AF7E-3F9C9751FC87}" destId="{D853110F-A768-41EF-BD0B-232BC0569048}" srcOrd="1" destOrd="0" presId="urn:microsoft.com/office/officeart/2005/8/layout/orgChart1"/>
    <dgm:cxn modelId="{BFCB4BF3-7FD1-496E-BC12-AD64FD6F2176}" type="presParOf" srcId="{99F5DF36-6B38-4433-973D-3D338E0AD8D0}" destId="{69873318-4E53-43BB-BEB3-A19DE4908ED2}" srcOrd="1" destOrd="0" presId="urn:microsoft.com/office/officeart/2005/8/layout/orgChart1"/>
    <dgm:cxn modelId="{3AD566BE-27F9-40B9-B57B-C8268595209A}" type="presParOf" srcId="{99F5DF36-6B38-4433-973D-3D338E0AD8D0}" destId="{746AB981-E4F0-4CF3-91C2-2A56A8F2EE09}" srcOrd="2" destOrd="0" presId="urn:microsoft.com/office/officeart/2005/8/layout/orgChart1"/>
    <dgm:cxn modelId="{EF33CD4A-F08B-408B-8CB5-7DA9B7BB619A}" type="presParOf" srcId="{F06B8623-2B21-46DC-ADD2-EC40A74AF137}" destId="{152CF5B7-EC90-4EC8-996C-8B99BC12A8B8}" srcOrd="2" destOrd="0" presId="urn:microsoft.com/office/officeart/2005/8/layout/orgChart1"/>
    <dgm:cxn modelId="{F8FCC9DB-7E22-4504-AC9F-7A9271E0AEA6}" type="presParOf" srcId="{DC54E399-9511-4CB6-8C80-71318FE6ECB6}" destId="{2DEC6793-A898-4C9E-9382-93EF220C751B}" srcOrd="2" destOrd="0" presId="urn:microsoft.com/office/officeart/2005/8/layout/orgChart1"/>
    <dgm:cxn modelId="{E1DFA751-6F03-438A-B026-F2B7DD777B06}" type="presParOf" srcId="{9E716B29-2216-4651-A18A-EAC68AA05A24}" destId="{08ADC29D-B256-4436-AD4B-5D77D4F324EE}" srcOrd="2" destOrd="0" presId="urn:microsoft.com/office/officeart/2005/8/layout/orgChart1"/>
    <dgm:cxn modelId="{20594724-D9B5-44B9-8DCE-C689C73D5721}" type="presParOf" srcId="{C6A7C44F-2A3F-4F38-BFAD-45072B23DE07}" destId="{B8F3B591-9307-4E9A-BD2C-F5D348511BEA}" srcOrd="2" destOrd="0" presId="urn:microsoft.com/office/officeart/2005/8/layout/orgChart1"/>
    <dgm:cxn modelId="{902D5067-8EBF-446F-AF34-F5F8E125A788}" type="presParOf" srcId="{C6A7C44F-2A3F-4F38-BFAD-45072B23DE07}" destId="{62F5DF37-6E28-4E05-936D-856834444042}" srcOrd="3" destOrd="0" presId="urn:microsoft.com/office/officeart/2005/8/layout/orgChart1"/>
    <dgm:cxn modelId="{E42BFB90-AD70-4F6E-B862-93A614F86F08}" type="presParOf" srcId="{62F5DF37-6E28-4E05-936D-856834444042}" destId="{01A8AF1A-CEEA-44DB-A97C-C6C9B7EC0A18}" srcOrd="0" destOrd="0" presId="urn:microsoft.com/office/officeart/2005/8/layout/orgChart1"/>
    <dgm:cxn modelId="{6E45A340-D85D-402F-ACBD-87030956F215}" type="presParOf" srcId="{01A8AF1A-CEEA-44DB-A97C-C6C9B7EC0A18}" destId="{87A60063-46AC-4CA6-8AFB-C646FC058C41}" srcOrd="0" destOrd="0" presId="urn:microsoft.com/office/officeart/2005/8/layout/orgChart1"/>
    <dgm:cxn modelId="{9017F14F-A581-424E-BFE4-867A7B444492}" type="presParOf" srcId="{01A8AF1A-CEEA-44DB-A97C-C6C9B7EC0A18}" destId="{053C0BA0-4CA6-4511-8C30-0C0AC5E87C55}" srcOrd="1" destOrd="0" presId="urn:microsoft.com/office/officeart/2005/8/layout/orgChart1"/>
    <dgm:cxn modelId="{8A0500A7-C209-4AC0-A178-44B2F6DD7AAA}" type="presParOf" srcId="{62F5DF37-6E28-4E05-936D-856834444042}" destId="{767A21D5-DB46-4A5E-9683-FA267B1DDAF5}" srcOrd="1" destOrd="0" presId="urn:microsoft.com/office/officeart/2005/8/layout/orgChart1"/>
    <dgm:cxn modelId="{7789AC7A-D575-4FCC-827F-036A89827F4C}" type="presParOf" srcId="{767A21D5-DB46-4A5E-9683-FA267B1DDAF5}" destId="{4A5C067F-FEAA-48F0-96BD-C976B883AD03}" srcOrd="0" destOrd="0" presId="urn:microsoft.com/office/officeart/2005/8/layout/orgChart1"/>
    <dgm:cxn modelId="{FD27EF85-F3F5-49B6-B3E0-39A39497DC0A}" type="presParOf" srcId="{767A21D5-DB46-4A5E-9683-FA267B1DDAF5}" destId="{2C814EFC-153B-4785-A3CE-5DD59685FE5E}" srcOrd="1" destOrd="0" presId="urn:microsoft.com/office/officeart/2005/8/layout/orgChart1"/>
    <dgm:cxn modelId="{6C512D5B-0711-4AD1-9176-1C45C9541C40}" type="presParOf" srcId="{2C814EFC-153B-4785-A3CE-5DD59685FE5E}" destId="{750B0FC5-A6CF-46AF-B159-3DF03239E033}" srcOrd="0" destOrd="0" presId="urn:microsoft.com/office/officeart/2005/8/layout/orgChart1"/>
    <dgm:cxn modelId="{D3A21DC6-034F-4AD7-B9AA-EA78ED7EDDE2}" type="presParOf" srcId="{750B0FC5-A6CF-46AF-B159-3DF03239E033}" destId="{8325B952-ADFE-4612-856B-08695AAA247D}" srcOrd="0" destOrd="0" presId="urn:microsoft.com/office/officeart/2005/8/layout/orgChart1"/>
    <dgm:cxn modelId="{E2B8C6E2-A68B-4EF8-8200-62972E2E26C2}" type="presParOf" srcId="{750B0FC5-A6CF-46AF-B159-3DF03239E033}" destId="{0B88337F-9D65-422A-B934-C9A276470656}" srcOrd="1" destOrd="0" presId="urn:microsoft.com/office/officeart/2005/8/layout/orgChart1"/>
    <dgm:cxn modelId="{C93C16EE-1F2D-4DA9-8761-1B161A10BB4B}" type="presParOf" srcId="{2C814EFC-153B-4785-A3CE-5DD59685FE5E}" destId="{B670C011-D1C4-408A-9650-A6CD88DA3311}" srcOrd="1" destOrd="0" presId="urn:microsoft.com/office/officeart/2005/8/layout/orgChart1"/>
    <dgm:cxn modelId="{50CB921B-5BA7-468B-B0D4-8A7646CD03AF}" type="presParOf" srcId="{B670C011-D1C4-408A-9650-A6CD88DA3311}" destId="{19F787B1-4285-40D5-A18E-FE58585EB3EA}" srcOrd="0" destOrd="0" presId="urn:microsoft.com/office/officeart/2005/8/layout/orgChart1"/>
    <dgm:cxn modelId="{E215EBD1-6F77-460A-809D-185119DCD725}" type="presParOf" srcId="{B670C011-D1C4-408A-9650-A6CD88DA3311}" destId="{A2EE4AA3-5240-40E4-A00C-BDED462B1FE6}" srcOrd="1" destOrd="0" presId="urn:microsoft.com/office/officeart/2005/8/layout/orgChart1"/>
    <dgm:cxn modelId="{B9CC1447-669C-4711-AE46-FDB9214BC1F6}" type="presParOf" srcId="{A2EE4AA3-5240-40E4-A00C-BDED462B1FE6}" destId="{18D96C6D-3F0D-4F37-BFF0-2495EC9FC332}" srcOrd="0" destOrd="0" presId="urn:microsoft.com/office/officeart/2005/8/layout/orgChart1"/>
    <dgm:cxn modelId="{49C91BEE-43F9-478A-9049-4DA28AE2C186}" type="presParOf" srcId="{18D96C6D-3F0D-4F37-BFF0-2495EC9FC332}" destId="{765E4F2B-E403-446B-A07D-1C67F1398557}" srcOrd="0" destOrd="0" presId="urn:microsoft.com/office/officeart/2005/8/layout/orgChart1"/>
    <dgm:cxn modelId="{8A4F13A3-781F-45BA-B9FC-2D027C39719F}" type="presParOf" srcId="{18D96C6D-3F0D-4F37-BFF0-2495EC9FC332}" destId="{39B12912-CB9D-4827-8B54-2FC5C8E01B9F}" srcOrd="1" destOrd="0" presId="urn:microsoft.com/office/officeart/2005/8/layout/orgChart1"/>
    <dgm:cxn modelId="{98F22C91-7871-46A6-9A71-87A333D50DAE}" type="presParOf" srcId="{A2EE4AA3-5240-40E4-A00C-BDED462B1FE6}" destId="{B9E0BA34-B290-415C-BB46-0772C6B4E0CF}" srcOrd="1" destOrd="0" presId="urn:microsoft.com/office/officeart/2005/8/layout/orgChart1"/>
    <dgm:cxn modelId="{5D6DDC0E-BFF9-45D8-9D61-7207EC0489FF}" type="presParOf" srcId="{B9E0BA34-B290-415C-BB46-0772C6B4E0CF}" destId="{5287358E-0C59-473E-8247-5C0CFFAC1AFD}" srcOrd="0" destOrd="0" presId="urn:microsoft.com/office/officeart/2005/8/layout/orgChart1"/>
    <dgm:cxn modelId="{71688A02-2A53-4EEE-9E61-FAC07ED98BFE}" type="presParOf" srcId="{B9E0BA34-B290-415C-BB46-0772C6B4E0CF}" destId="{15D1F57E-FE12-4DF5-A7C7-E190F99696BA}" srcOrd="1" destOrd="0" presId="urn:microsoft.com/office/officeart/2005/8/layout/orgChart1"/>
    <dgm:cxn modelId="{9BD4B109-BA7E-406A-A7C2-430680BBDCA9}" type="presParOf" srcId="{15D1F57E-FE12-4DF5-A7C7-E190F99696BA}" destId="{70A4F32B-DA2D-4C5A-9523-59C35BC80350}" srcOrd="0" destOrd="0" presId="urn:microsoft.com/office/officeart/2005/8/layout/orgChart1"/>
    <dgm:cxn modelId="{D0D92276-DB0F-4A5A-BC3E-AC85F0D0EDE0}" type="presParOf" srcId="{70A4F32B-DA2D-4C5A-9523-59C35BC80350}" destId="{5A7379F8-0FE0-4810-B536-55D1FA7C51BC}" srcOrd="0" destOrd="0" presId="urn:microsoft.com/office/officeart/2005/8/layout/orgChart1"/>
    <dgm:cxn modelId="{85B2EA01-4A97-4E40-9073-234B0CFE8D50}" type="presParOf" srcId="{70A4F32B-DA2D-4C5A-9523-59C35BC80350}" destId="{5A371F34-CA61-458E-801B-10E19FD404EB}" srcOrd="1" destOrd="0" presId="urn:microsoft.com/office/officeart/2005/8/layout/orgChart1"/>
    <dgm:cxn modelId="{036D619C-D7D9-4B60-933D-9DA3669C87DF}" type="presParOf" srcId="{15D1F57E-FE12-4DF5-A7C7-E190F99696BA}" destId="{CEA0B94E-CFEF-4F29-B20B-257A4CF60265}" srcOrd="1" destOrd="0" presId="urn:microsoft.com/office/officeart/2005/8/layout/orgChart1"/>
    <dgm:cxn modelId="{FB744212-A439-4594-8DE8-8720AB9AB7BF}" type="presParOf" srcId="{15D1F57E-FE12-4DF5-A7C7-E190F99696BA}" destId="{F4124507-7E9E-4DEF-A441-7E0633EC9954}" srcOrd="2" destOrd="0" presId="urn:microsoft.com/office/officeart/2005/8/layout/orgChart1"/>
    <dgm:cxn modelId="{B44E5578-B771-4C16-ACF9-A1D08F417715}" type="presParOf" srcId="{A2EE4AA3-5240-40E4-A00C-BDED462B1FE6}" destId="{ACDA745B-C116-4217-B3C6-2ACFED7CAB73}" srcOrd="2" destOrd="0" presId="urn:microsoft.com/office/officeart/2005/8/layout/orgChart1"/>
    <dgm:cxn modelId="{5A39775B-7C61-4258-91D8-6AD5A63DB0E0}" type="presParOf" srcId="{2C814EFC-153B-4785-A3CE-5DD59685FE5E}" destId="{AC36F49D-E3BB-437E-ADDF-0936C7DCE46F}" srcOrd="2" destOrd="0" presId="urn:microsoft.com/office/officeart/2005/8/layout/orgChart1"/>
    <dgm:cxn modelId="{AD6800FC-DB32-461D-B74A-50F9D87E1437}" type="presParOf" srcId="{767A21D5-DB46-4A5E-9683-FA267B1DDAF5}" destId="{98026F8C-44C8-445C-A43A-3675FF2FF054}" srcOrd="2" destOrd="0" presId="urn:microsoft.com/office/officeart/2005/8/layout/orgChart1"/>
    <dgm:cxn modelId="{2187C651-B73C-4ED9-A3D9-5A9AED260395}" type="presParOf" srcId="{767A21D5-DB46-4A5E-9683-FA267B1DDAF5}" destId="{087C07FD-A518-440C-87AD-772923F59E5B}" srcOrd="3" destOrd="0" presId="urn:microsoft.com/office/officeart/2005/8/layout/orgChart1"/>
    <dgm:cxn modelId="{0A584097-DF70-42C1-9DAA-AE20CF84AF05}" type="presParOf" srcId="{087C07FD-A518-440C-87AD-772923F59E5B}" destId="{480D0C00-1E82-488A-B442-6D592E18F16C}" srcOrd="0" destOrd="0" presId="urn:microsoft.com/office/officeart/2005/8/layout/orgChart1"/>
    <dgm:cxn modelId="{60225020-937A-4764-B346-28FD72CB359C}" type="presParOf" srcId="{480D0C00-1E82-488A-B442-6D592E18F16C}" destId="{A458EDC1-D4A9-4E83-B3D9-1337FCD6336E}" srcOrd="0" destOrd="0" presId="urn:microsoft.com/office/officeart/2005/8/layout/orgChart1"/>
    <dgm:cxn modelId="{4D8EC0AF-B55C-4564-8B2D-B20A4E228F42}" type="presParOf" srcId="{480D0C00-1E82-488A-B442-6D592E18F16C}" destId="{B9FCC3FA-094E-47AD-A43F-10C485D8E237}" srcOrd="1" destOrd="0" presId="urn:microsoft.com/office/officeart/2005/8/layout/orgChart1"/>
    <dgm:cxn modelId="{D7482077-50B2-44F4-9E0B-EC185FB09414}" type="presParOf" srcId="{087C07FD-A518-440C-87AD-772923F59E5B}" destId="{A22749D5-7F38-45A7-A9DD-B33265A9444C}" srcOrd="1" destOrd="0" presId="urn:microsoft.com/office/officeart/2005/8/layout/orgChart1"/>
    <dgm:cxn modelId="{1EC9CFBD-44F4-4E05-B07F-06E91031F9E9}" type="presParOf" srcId="{A22749D5-7F38-45A7-A9DD-B33265A9444C}" destId="{8CB00494-7F74-4467-A3BD-5E2ABAF8B091}" srcOrd="0" destOrd="0" presId="urn:microsoft.com/office/officeart/2005/8/layout/orgChart1"/>
    <dgm:cxn modelId="{D76CDF55-AA54-4A7A-BCC0-7AA894A66DD6}" type="presParOf" srcId="{A22749D5-7F38-45A7-A9DD-B33265A9444C}" destId="{B60FFF0B-C117-4A61-864D-ADE17A9EA5B9}" srcOrd="1" destOrd="0" presId="urn:microsoft.com/office/officeart/2005/8/layout/orgChart1"/>
    <dgm:cxn modelId="{CD01D375-3A61-4C27-BFA4-3D4DDB3C67BE}" type="presParOf" srcId="{B60FFF0B-C117-4A61-864D-ADE17A9EA5B9}" destId="{A2F2D1A3-B6D3-4323-8440-D5673C97A4E7}" srcOrd="0" destOrd="0" presId="urn:microsoft.com/office/officeart/2005/8/layout/orgChart1"/>
    <dgm:cxn modelId="{F99DA69A-AF23-4D78-B7E3-96C11E26AB9B}" type="presParOf" srcId="{A2F2D1A3-B6D3-4323-8440-D5673C97A4E7}" destId="{84ECF355-7DD3-4860-A18D-4CDD20866068}" srcOrd="0" destOrd="0" presId="urn:microsoft.com/office/officeart/2005/8/layout/orgChart1"/>
    <dgm:cxn modelId="{EC8A5EE5-C796-4763-A279-A58A2DDC11E6}" type="presParOf" srcId="{A2F2D1A3-B6D3-4323-8440-D5673C97A4E7}" destId="{052E7182-A4A9-4292-A937-78185AFB7B85}" srcOrd="1" destOrd="0" presId="urn:microsoft.com/office/officeart/2005/8/layout/orgChart1"/>
    <dgm:cxn modelId="{FC4DB10D-21E4-47EC-A3D4-A93B0CA2BBE6}" type="presParOf" srcId="{B60FFF0B-C117-4A61-864D-ADE17A9EA5B9}" destId="{2DE09D10-E54C-4D6C-A141-3BA1DC724018}" srcOrd="1" destOrd="0" presId="urn:microsoft.com/office/officeart/2005/8/layout/orgChart1"/>
    <dgm:cxn modelId="{77BEA661-3ACD-4CD8-80C3-7E17E60DDBE6}" type="presParOf" srcId="{2DE09D10-E54C-4D6C-A141-3BA1DC724018}" destId="{770CE079-92F9-4FED-AEE1-6E589D8BDEB5}" srcOrd="0" destOrd="0" presId="urn:microsoft.com/office/officeart/2005/8/layout/orgChart1"/>
    <dgm:cxn modelId="{151A6931-1DD8-43AF-8051-923EC487A88C}" type="presParOf" srcId="{2DE09D10-E54C-4D6C-A141-3BA1DC724018}" destId="{C29540A5-F226-49FB-9FBA-A761F8562F64}" srcOrd="1" destOrd="0" presId="urn:microsoft.com/office/officeart/2005/8/layout/orgChart1"/>
    <dgm:cxn modelId="{C59A4C07-E05C-4547-95DA-242E22F7FE58}" type="presParOf" srcId="{C29540A5-F226-49FB-9FBA-A761F8562F64}" destId="{B9AE85F7-3294-429A-B238-034F01A8621F}" srcOrd="0" destOrd="0" presId="urn:microsoft.com/office/officeart/2005/8/layout/orgChart1"/>
    <dgm:cxn modelId="{B18D2A38-B81B-408F-8CCC-58E134E0242A}" type="presParOf" srcId="{B9AE85F7-3294-429A-B238-034F01A8621F}" destId="{2367E8B8-6E6D-48A8-BDF8-16FE3316FE75}" srcOrd="0" destOrd="0" presId="urn:microsoft.com/office/officeart/2005/8/layout/orgChart1"/>
    <dgm:cxn modelId="{A2879AAE-3ABE-4928-A995-8A64BBD8BF61}" type="presParOf" srcId="{B9AE85F7-3294-429A-B238-034F01A8621F}" destId="{BFAA47A0-E90D-4B58-A71A-AB8D74B7511C}" srcOrd="1" destOrd="0" presId="urn:microsoft.com/office/officeart/2005/8/layout/orgChart1"/>
    <dgm:cxn modelId="{4B35C6B3-D167-43AD-9FFF-78E828DBB62A}" type="presParOf" srcId="{C29540A5-F226-49FB-9FBA-A761F8562F64}" destId="{B6B9C5AA-BD11-4DA6-ABA6-0FDF0C176F66}" srcOrd="1" destOrd="0" presId="urn:microsoft.com/office/officeart/2005/8/layout/orgChart1"/>
    <dgm:cxn modelId="{9F5A5989-2543-4889-99ED-4BF814DDC4FE}" type="presParOf" srcId="{C29540A5-F226-49FB-9FBA-A761F8562F64}" destId="{DD4EBDA2-4334-4079-9C50-5D0EB715DBFE}" srcOrd="2" destOrd="0" presId="urn:microsoft.com/office/officeart/2005/8/layout/orgChart1"/>
    <dgm:cxn modelId="{ED589C9F-89E3-4990-9B16-F068C6D7ED0D}" type="presParOf" srcId="{B60FFF0B-C117-4A61-864D-ADE17A9EA5B9}" destId="{907FC41C-A721-498A-AECD-ED77F1D5B9D4}" srcOrd="2" destOrd="0" presId="urn:microsoft.com/office/officeart/2005/8/layout/orgChart1"/>
    <dgm:cxn modelId="{03EF3CD1-E52E-4FB3-9332-B1789922CBF1}" type="presParOf" srcId="{087C07FD-A518-440C-87AD-772923F59E5B}" destId="{4684B430-7C74-4512-A400-9E8B497CA81D}" srcOrd="2" destOrd="0" presId="urn:microsoft.com/office/officeart/2005/8/layout/orgChart1"/>
    <dgm:cxn modelId="{FAE63F27-AC5E-4173-A2C1-F578E64BA76A}" type="presParOf" srcId="{62F5DF37-6E28-4E05-936D-856834444042}" destId="{3720040D-3AE9-4331-B7F0-6E6FC0A11B66}" srcOrd="2" destOrd="0" presId="urn:microsoft.com/office/officeart/2005/8/layout/orgChart1"/>
    <dgm:cxn modelId="{60436BA5-6C3D-42F2-96E9-EBC3899A2934}" type="presParOf" srcId="{238AEF1C-EA40-47B2-AD6F-C7FBDF9862A4}" destId="{47FB9601-75D0-40F0-80FD-CB6CE639BD01}" srcOrd="2" destOrd="0" presId="urn:microsoft.com/office/officeart/2005/8/layout/orgChart1"/>
    <dgm:cxn modelId="{335D6E38-09B9-4F4A-99ED-55CECDDA0BBC}" type="presParOf" srcId="{2620BDDE-FA0E-4A4C-8A0C-B5CB145438F5}" destId="{A34C4E21-1952-4E8E-9318-1E0F6325910B}" srcOrd="2" destOrd="0" presId="urn:microsoft.com/office/officeart/2005/8/layout/orgChart1"/>
    <dgm:cxn modelId="{CD177C01-BC39-471E-AE88-ECF63F27306A}" type="presParOf" srcId="{2620BDDE-FA0E-4A4C-8A0C-B5CB145438F5}" destId="{C0C776D2-B6FD-4813-A723-50E62672EB30}" srcOrd="3" destOrd="0" presId="urn:microsoft.com/office/officeart/2005/8/layout/orgChart1"/>
    <dgm:cxn modelId="{3710CB49-17BF-4F1A-9216-3713800DBA93}" type="presParOf" srcId="{C0C776D2-B6FD-4813-A723-50E62672EB30}" destId="{DBA89F9D-73E8-4A0D-8327-077481BD0AEC}" srcOrd="0" destOrd="0" presId="urn:microsoft.com/office/officeart/2005/8/layout/orgChart1"/>
    <dgm:cxn modelId="{E769CD8E-AFAA-4756-80E1-3B35AD640BD5}" type="presParOf" srcId="{DBA89F9D-73E8-4A0D-8327-077481BD0AEC}" destId="{D29044B6-296F-43E9-9A97-6C76EB922610}" srcOrd="0" destOrd="0" presId="urn:microsoft.com/office/officeart/2005/8/layout/orgChart1"/>
    <dgm:cxn modelId="{B038375D-F665-45B2-9554-5A24D157E0FD}" type="presParOf" srcId="{DBA89F9D-73E8-4A0D-8327-077481BD0AEC}" destId="{A054C64C-5610-4BB3-99DE-F3FB705E364F}" srcOrd="1" destOrd="0" presId="urn:microsoft.com/office/officeart/2005/8/layout/orgChart1"/>
    <dgm:cxn modelId="{4AE98C9B-EEE6-4434-BD15-10066AC67A55}" type="presParOf" srcId="{C0C776D2-B6FD-4813-A723-50E62672EB30}" destId="{223A5FD3-3627-4485-AE36-0CC4C7731A2C}" srcOrd="1" destOrd="0" presId="urn:microsoft.com/office/officeart/2005/8/layout/orgChart1"/>
    <dgm:cxn modelId="{A0AF0DEC-F3EE-4F5B-BE81-79FC448DF8A3}" type="presParOf" srcId="{C0C776D2-B6FD-4813-A723-50E62672EB30}" destId="{81465FEB-EE36-435D-81BF-7B2635A2FE04}" srcOrd="2" destOrd="0" presId="urn:microsoft.com/office/officeart/2005/8/layout/orgChart1"/>
    <dgm:cxn modelId="{4E60A771-C976-4697-A918-305A59E1FBCA}" type="presParOf" srcId="{AEAB85E9-A70C-4405-877A-25C8499667A5}" destId="{95B5BBEB-17E4-4B5B-83D2-81DDC4ED57BB}" srcOrd="2" destOrd="0" presId="urn:microsoft.com/office/officeart/2005/8/layout/orgChart1"/>
    <dgm:cxn modelId="{E346C084-1FFA-4834-AFBC-2A2794B855F7}" type="presParOf" srcId="{95B5BBEB-17E4-4B5B-83D2-81DDC4ED57BB}" destId="{41581643-F527-4F9C-957D-21B7BF397099}" srcOrd="0" destOrd="0" presId="urn:microsoft.com/office/officeart/2005/8/layout/orgChart1"/>
    <dgm:cxn modelId="{222FCE1C-A221-45D5-BF70-D240AA83096D}" type="presParOf" srcId="{95B5BBEB-17E4-4B5B-83D2-81DDC4ED57BB}" destId="{C5EA1ACB-DEC6-4F8B-811A-104723B463BB}" srcOrd="1" destOrd="0" presId="urn:microsoft.com/office/officeart/2005/8/layout/orgChart1"/>
    <dgm:cxn modelId="{07BBA5AD-F34B-40D5-86A5-016F7ACAAAEB}" type="presParOf" srcId="{C5EA1ACB-DEC6-4F8B-811A-104723B463BB}" destId="{FB2F67A2-905A-42BF-B413-4F2E541F5E18}" srcOrd="0" destOrd="0" presId="urn:microsoft.com/office/officeart/2005/8/layout/orgChart1"/>
    <dgm:cxn modelId="{8704432A-205B-4050-A75B-8C82A9AD5B5C}" type="presParOf" srcId="{FB2F67A2-905A-42BF-B413-4F2E541F5E18}" destId="{52201AFD-8388-4F09-A422-24B3ED7819C8}" srcOrd="0" destOrd="0" presId="urn:microsoft.com/office/officeart/2005/8/layout/orgChart1"/>
    <dgm:cxn modelId="{550AEA8F-5E8B-43B7-B7C9-66733FBA2085}" type="presParOf" srcId="{FB2F67A2-905A-42BF-B413-4F2E541F5E18}" destId="{C3C2DE37-B416-45F4-9DB8-F5463E7725D0}" srcOrd="1" destOrd="0" presId="urn:microsoft.com/office/officeart/2005/8/layout/orgChart1"/>
    <dgm:cxn modelId="{4356733B-44D9-4A34-B1F8-365351187648}" type="presParOf" srcId="{C5EA1ACB-DEC6-4F8B-811A-104723B463BB}" destId="{4CD26D1C-9196-4A2E-B06C-EF86E7DFABC4}" srcOrd="1" destOrd="0" presId="urn:microsoft.com/office/officeart/2005/8/layout/orgChart1"/>
    <dgm:cxn modelId="{2CD531AB-744B-48BC-B74A-E8D92EA53D5C}" type="presParOf" srcId="{C5EA1ACB-DEC6-4F8B-811A-104723B463BB}" destId="{329B6400-28E8-4BB2-9A96-73D1CB749F89}" srcOrd="2" destOrd="0" presId="urn:microsoft.com/office/officeart/2005/8/layout/orgChart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B8F574D-2549-48EE-A494-3BDF5EFAFDFB}">
      <dsp:nvSpPr>
        <dsp:cNvPr id="0" name=""/>
        <dsp:cNvSpPr/>
      </dsp:nvSpPr>
      <dsp:spPr>
        <a:xfrm>
          <a:off x="5630114" y="1002485"/>
          <a:ext cx="1348989" cy="17641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76415"/>
              </a:lnTo>
              <a:lnTo>
                <a:pt x="1348989" y="176415"/>
              </a:lnTo>
            </a:path>
          </a:pathLst>
        </a:custGeom>
        <a:noFill/>
        <a:ln w="381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4664688-559F-4662-A72A-DF835209CD27}">
      <dsp:nvSpPr>
        <dsp:cNvPr id="0" name=""/>
        <dsp:cNvSpPr/>
      </dsp:nvSpPr>
      <dsp:spPr>
        <a:xfrm>
          <a:off x="9784532" y="4350822"/>
          <a:ext cx="161913" cy="79914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799143"/>
              </a:lnTo>
              <a:lnTo>
                <a:pt x="161913" y="799143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8947DF3-F26C-4AA9-A2A9-A7D9763CF728}">
      <dsp:nvSpPr>
        <dsp:cNvPr id="0" name=""/>
        <dsp:cNvSpPr/>
      </dsp:nvSpPr>
      <dsp:spPr>
        <a:xfrm>
          <a:off x="10170582" y="3341873"/>
          <a:ext cx="91440" cy="237829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37829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DF92AF4-0D65-40DE-8D71-D58D9EEA2B1F}">
      <dsp:nvSpPr>
        <dsp:cNvPr id="0" name=""/>
        <dsp:cNvSpPr/>
      </dsp:nvSpPr>
      <dsp:spPr>
        <a:xfrm>
          <a:off x="9115826" y="2428745"/>
          <a:ext cx="1100476" cy="26361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50277"/>
              </a:lnTo>
              <a:lnTo>
                <a:pt x="1100476" y="150277"/>
              </a:lnTo>
              <a:lnTo>
                <a:pt x="1100476" y="263617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E3C6DA40-0164-4E21-A22C-6CE63583D97D}">
      <dsp:nvSpPr>
        <dsp:cNvPr id="0" name=""/>
        <dsp:cNvSpPr/>
      </dsp:nvSpPr>
      <dsp:spPr>
        <a:xfrm>
          <a:off x="8207277" y="4361973"/>
          <a:ext cx="161913" cy="78609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786099"/>
              </a:lnTo>
              <a:lnTo>
                <a:pt x="161913" y="786099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862E9566-7B2C-4E20-9072-A206352353D9}">
      <dsp:nvSpPr>
        <dsp:cNvPr id="0" name=""/>
        <dsp:cNvSpPr/>
      </dsp:nvSpPr>
      <dsp:spPr>
        <a:xfrm>
          <a:off x="7932385" y="3341873"/>
          <a:ext cx="706661" cy="24898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35640"/>
              </a:lnTo>
              <a:lnTo>
                <a:pt x="706661" y="135640"/>
              </a:lnTo>
              <a:lnTo>
                <a:pt x="706661" y="248980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230424A-EF84-4B61-94B6-A21103AF4BEC}">
      <dsp:nvSpPr>
        <dsp:cNvPr id="0" name=""/>
        <dsp:cNvSpPr/>
      </dsp:nvSpPr>
      <dsp:spPr>
        <a:xfrm>
          <a:off x="6793954" y="4361973"/>
          <a:ext cx="161913" cy="78960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789609"/>
              </a:lnTo>
              <a:lnTo>
                <a:pt x="161913" y="789609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8A06E381-8819-4037-A125-902EA70F0BD6}">
      <dsp:nvSpPr>
        <dsp:cNvPr id="0" name=""/>
        <dsp:cNvSpPr/>
      </dsp:nvSpPr>
      <dsp:spPr>
        <a:xfrm>
          <a:off x="7225723" y="3341873"/>
          <a:ext cx="706661" cy="248980"/>
        </a:xfrm>
        <a:custGeom>
          <a:avLst/>
          <a:gdLst/>
          <a:ahLst/>
          <a:cxnLst/>
          <a:rect l="0" t="0" r="0" b="0"/>
          <a:pathLst>
            <a:path>
              <a:moveTo>
                <a:pt x="706661" y="0"/>
              </a:moveTo>
              <a:lnTo>
                <a:pt x="706661" y="135640"/>
              </a:lnTo>
              <a:lnTo>
                <a:pt x="0" y="135640"/>
              </a:lnTo>
              <a:lnTo>
                <a:pt x="0" y="248980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967BE9E-1271-4178-BBCF-D43AA34D64C1}">
      <dsp:nvSpPr>
        <dsp:cNvPr id="0" name=""/>
        <dsp:cNvSpPr/>
      </dsp:nvSpPr>
      <dsp:spPr>
        <a:xfrm>
          <a:off x="7932385" y="2428745"/>
          <a:ext cx="1183440" cy="263617"/>
        </a:xfrm>
        <a:custGeom>
          <a:avLst/>
          <a:gdLst/>
          <a:ahLst/>
          <a:cxnLst/>
          <a:rect l="0" t="0" r="0" b="0"/>
          <a:pathLst>
            <a:path>
              <a:moveTo>
                <a:pt x="1183440" y="0"/>
              </a:moveTo>
              <a:lnTo>
                <a:pt x="1183440" y="150277"/>
              </a:lnTo>
              <a:lnTo>
                <a:pt x="0" y="150277"/>
              </a:lnTo>
              <a:lnTo>
                <a:pt x="0" y="263617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34C4E21-1952-4E8E-9318-1E0F6325910B}">
      <dsp:nvSpPr>
        <dsp:cNvPr id="0" name=""/>
        <dsp:cNvSpPr/>
      </dsp:nvSpPr>
      <dsp:spPr>
        <a:xfrm>
          <a:off x="5630114" y="1002485"/>
          <a:ext cx="3485711" cy="88654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773208"/>
              </a:lnTo>
              <a:lnTo>
                <a:pt x="3485711" y="773208"/>
              </a:lnTo>
              <a:lnTo>
                <a:pt x="3485711" y="886547"/>
              </a:lnTo>
            </a:path>
          </a:pathLst>
        </a:custGeom>
        <a:noFill/>
        <a:ln w="381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51F999EF-5198-4604-9932-B54113933E43}">
      <dsp:nvSpPr>
        <dsp:cNvPr id="0" name=""/>
        <dsp:cNvSpPr/>
      </dsp:nvSpPr>
      <dsp:spPr>
        <a:xfrm>
          <a:off x="5400406" y="4361973"/>
          <a:ext cx="161913" cy="173273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732737"/>
              </a:lnTo>
              <a:lnTo>
                <a:pt x="161913" y="1732737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8CB00494-7F74-4467-A3BD-5E2ABAF8B091}">
      <dsp:nvSpPr>
        <dsp:cNvPr id="0" name=""/>
        <dsp:cNvSpPr/>
      </dsp:nvSpPr>
      <dsp:spPr>
        <a:xfrm>
          <a:off x="5400406" y="4361973"/>
          <a:ext cx="161913" cy="78649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786493"/>
              </a:lnTo>
              <a:lnTo>
                <a:pt x="161913" y="786493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8026F8C-44C8-445C-A43A-3675FF2FF054}">
      <dsp:nvSpPr>
        <dsp:cNvPr id="0" name=""/>
        <dsp:cNvSpPr/>
      </dsp:nvSpPr>
      <dsp:spPr>
        <a:xfrm>
          <a:off x="5118579" y="3341873"/>
          <a:ext cx="713596" cy="24898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35640"/>
              </a:lnTo>
              <a:lnTo>
                <a:pt x="713596" y="135640"/>
              </a:lnTo>
              <a:lnTo>
                <a:pt x="713596" y="248980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9F787B1-4285-40D5-A18E-FE58585EB3EA}">
      <dsp:nvSpPr>
        <dsp:cNvPr id="0" name=""/>
        <dsp:cNvSpPr/>
      </dsp:nvSpPr>
      <dsp:spPr>
        <a:xfrm>
          <a:off x="3973212" y="4361973"/>
          <a:ext cx="161913" cy="80771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807714"/>
              </a:lnTo>
              <a:lnTo>
                <a:pt x="161913" y="807714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A5C067F-FEAA-48F0-96BD-C976B883AD03}">
      <dsp:nvSpPr>
        <dsp:cNvPr id="0" name=""/>
        <dsp:cNvSpPr/>
      </dsp:nvSpPr>
      <dsp:spPr>
        <a:xfrm>
          <a:off x="4404982" y="3341873"/>
          <a:ext cx="713596" cy="248980"/>
        </a:xfrm>
        <a:custGeom>
          <a:avLst/>
          <a:gdLst/>
          <a:ahLst/>
          <a:cxnLst/>
          <a:rect l="0" t="0" r="0" b="0"/>
          <a:pathLst>
            <a:path>
              <a:moveTo>
                <a:pt x="713596" y="0"/>
              </a:moveTo>
              <a:lnTo>
                <a:pt x="713596" y="135640"/>
              </a:lnTo>
              <a:lnTo>
                <a:pt x="0" y="135640"/>
              </a:lnTo>
              <a:lnTo>
                <a:pt x="0" y="248980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8F3B591-9307-4E9A-BD2C-F5D348511BEA}">
      <dsp:nvSpPr>
        <dsp:cNvPr id="0" name=""/>
        <dsp:cNvSpPr/>
      </dsp:nvSpPr>
      <dsp:spPr>
        <a:xfrm>
          <a:off x="3494493" y="2428745"/>
          <a:ext cx="1624086" cy="26361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50277"/>
              </a:lnTo>
              <a:lnTo>
                <a:pt x="1624086" y="150277"/>
              </a:lnTo>
              <a:lnTo>
                <a:pt x="1624086" y="263617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E2BB12F0-4365-4D10-BBA4-7BD9CA3A1C8C}">
      <dsp:nvSpPr>
        <dsp:cNvPr id="0" name=""/>
        <dsp:cNvSpPr/>
      </dsp:nvSpPr>
      <dsp:spPr>
        <a:xfrm>
          <a:off x="2128465" y="4383793"/>
          <a:ext cx="161913" cy="173398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733984"/>
              </a:lnTo>
              <a:lnTo>
                <a:pt x="161913" y="1733984"/>
              </a:lnTo>
            </a:path>
          </a:pathLst>
        </a:custGeom>
        <a:noFill/>
        <a:ln w="381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AAE962B-FC4E-4E88-9802-C684323DA4FE}">
      <dsp:nvSpPr>
        <dsp:cNvPr id="0" name=""/>
        <dsp:cNvSpPr/>
      </dsp:nvSpPr>
      <dsp:spPr>
        <a:xfrm>
          <a:off x="2128465" y="4383793"/>
          <a:ext cx="161913" cy="77182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771823"/>
              </a:lnTo>
              <a:lnTo>
                <a:pt x="161913" y="771823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5E9E6AB-8EBF-4489-A9AD-B18731334C84}">
      <dsp:nvSpPr>
        <dsp:cNvPr id="0" name=""/>
        <dsp:cNvSpPr/>
      </dsp:nvSpPr>
      <dsp:spPr>
        <a:xfrm>
          <a:off x="1837878" y="3385995"/>
          <a:ext cx="722356" cy="22667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13339"/>
              </a:lnTo>
              <a:lnTo>
                <a:pt x="722356" y="113339"/>
              </a:lnTo>
              <a:lnTo>
                <a:pt x="722356" y="226679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D731950-665B-474A-9284-81BABEADB935}">
      <dsp:nvSpPr>
        <dsp:cNvPr id="0" name=""/>
        <dsp:cNvSpPr/>
      </dsp:nvSpPr>
      <dsp:spPr>
        <a:xfrm>
          <a:off x="683752" y="4383793"/>
          <a:ext cx="150763" cy="79281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792815"/>
              </a:lnTo>
              <a:lnTo>
                <a:pt x="150763" y="792815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5F4DF28-B57F-4699-9BED-B162015FDD41}">
      <dsp:nvSpPr>
        <dsp:cNvPr id="0" name=""/>
        <dsp:cNvSpPr/>
      </dsp:nvSpPr>
      <dsp:spPr>
        <a:xfrm>
          <a:off x="1115522" y="3385995"/>
          <a:ext cx="722356" cy="226679"/>
        </a:xfrm>
        <a:custGeom>
          <a:avLst/>
          <a:gdLst/>
          <a:ahLst/>
          <a:cxnLst/>
          <a:rect l="0" t="0" r="0" b="0"/>
          <a:pathLst>
            <a:path>
              <a:moveTo>
                <a:pt x="722356" y="0"/>
              </a:moveTo>
              <a:lnTo>
                <a:pt x="722356" y="113339"/>
              </a:lnTo>
              <a:lnTo>
                <a:pt x="0" y="113339"/>
              </a:lnTo>
              <a:lnTo>
                <a:pt x="0" y="226679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6F95800-F6FC-432A-8192-5DDFB4692B6C}">
      <dsp:nvSpPr>
        <dsp:cNvPr id="0" name=""/>
        <dsp:cNvSpPr/>
      </dsp:nvSpPr>
      <dsp:spPr>
        <a:xfrm>
          <a:off x="1837878" y="2428745"/>
          <a:ext cx="1656614" cy="263617"/>
        </a:xfrm>
        <a:custGeom>
          <a:avLst/>
          <a:gdLst/>
          <a:ahLst/>
          <a:cxnLst/>
          <a:rect l="0" t="0" r="0" b="0"/>
          <a:pathLst>
            <a:path>
              <a:moveTo>
                <a:pt x="1656614" y="0"/>
              </a:moveTo>
              <a:lnTo>
                <a:pt x="1656614" y="150277"/>
              </a:lnTo>
              <a:lnTo>
                <a:pt x="0" y="150277"/>
              </a:lnTo>
              <a:lnTo>
                <a:pt x="0" y="263617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FFD1586-C99D-4845-8FB7-33978BBFEBB3}">
      <dsp:nvSpPr>
        <dsp:cNvPr id="0" name=""/>
        <dsp:cNvSpPr/>
      </dsp:nvSpPr>
      <dsp:spPr>
        <a:xfrm>
          <a:off x="3494493" y="1002485"/>
          <a:ext cx="2135621" cy="886547"/>
        </a:xfrm>
        <a:custGeom>
          <a:avLst/>
          <a:gdLst/>
          <a:ahLst/>
          <a:cxnLst/>
          <a:rect l="0" t="0" r="0" b="0"/>
          <a:pathLst>
            <a:path>
              <a:moveTo>
                <a:pt x="2135621" y="0"/>
              </a:moveTo>
              <a:lnTo>
                <a:pt x="2135621" y="773208"/>
              </a:lnTo>
              <a:lnTo>
                <a:pt x="0" y="773208"/>
              </a:lnTo>
              <a:lnTo>
                <a:pt x="0" y="886547"/>
              </a:lnTo>
            </a:path>
          </a:pathLst>
        </a:custGeom>
        <a:noFill/>
        <a:ln w="381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56AF28E-5690-4043-AF44-3ACC12D0BDB0}">
      <dsp:nvSpPr>
        <dsp:cNvPr id="0" name=""/>
        <dsp:cNvSpPr/>
      </dsp:nvSpPr>
      <dsp:spPr>
        <a:xfrm>
          <a:off x="5090402" y="462773"/>
          <a:ext cx="1079424" cy="539712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AED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6</a:t>
          </a:r>
        </a:p>
      </dsp:txBody>
      <dsp:txXfrm>
        <a:off x="5090402" y="462773"/>
        <a:ext cx="1079424" cy="539712"/>
      </dsp:txXfrm>
    </dsp:sp>
    <dsp:sp modelId="{C6924E3E-37F0-45BB-A9D6-33A3FF05B21C}">
      <dsp:nvSpPr>
        <dsp:cNvPr id="0" name=""/>
        <dsp:cNvSpPr/>
      </dsp:nvSpPr>
      <dsp:spPr>
        <a:xfrm>
          <a:off x="2328525" y="1889033"/>
          <a:ext cx="2331934" cy="539712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ilateral frontal lesions (+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1</a:t>
          </a:r>
        </a:p>
      </dsp:txBody>
      <dsp:txXfrm>
        <a:off x="2328525" y="1889033"/>
        <a:ext cx="2331934" cy="539712"/>
      </dsp:txXfrm>
    </dsp:sp>
    <dsp:sp modelId="{0296FC5F-E378-4904-93B2-00D4ACF73593}">
      <dsp:nvSpPr>
        <dsp:cNvPr id="0" name=""/>
        <dsp:cNvSpPr/>
      </dsp:nvSpPr>
      <dsp:spPr>
        <a:xfrm>
          <a:off x="915035" y="2692362"/>
          <a:ext cx="1845686" cy="693632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ilateral prefrontal lesions (+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7</a:t>
          </a:r>
        </a:p>
      </dsp:txBody>
      <dsp:txXfrm>
        <a:off x="915035" y="2692362"/>
        <a:ext cx="1845686" cy="693632"/>
      </dsp:txXfrm>
    </dsp:sp>
    <dsp:sp modelId="{B8C1EDF1-DB2A-4D33-AA78-22955DE770C3}">
      <dsp:nvSpPr>
        <dsp:cNvPr id="0" name=""/>
        <dsp:cNvSpPr/>
      </dsp:nvSpPr>
      <dsp:spPr>
        <a:xfrm>
          <a:off x="575809" y="3612674"/>
          <a:ext cx="1079424" cy="771119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+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</a:p>
      </dsp:txBody>
      <dsp:txXfrm>
        <a:off x="575809" y="3612674"/>
        <a:ext cx="1079424" cy="771119"/>
      </dsp:txXfrm>
    </dsp:sp>
    <dsp:sp modelId="{53371C62-A9F4-424A-A2C3-5285FF0AAA6F}">
      <dsp:nvSpPr>
        <dsp:cNvPr id="0" name=""/>
        <dsp:cNvSpPr/>
      </dsp:nvSpPr>
      <dsp:spPr>
        <a:xfrm>
          <a:off x="834515" y="4733127"/>
          <a:ext cx="1218033" cy="886963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N.D.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 n = 2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GB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3, 8</a:t>
          </a: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05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834515" y="4733127"/>
        <a:ext cx="1218033" cy="886963"/>
      </dsp:txXfrm>
    </dsp:sp>
    <dsp:sp modelId="{1428E6BE-2F58-417D-9CB2-2888832E0161}">
      <dsp:nvSpPr>
        <dsp:cNvPr id="0" name=""/>
        <dsp:cNvSpPr/>
      </dsp:nvSpPr>
      <dsp:spPr>
        <a:xfrm>
          <a:off x="2020522" y="3612674"/>
          <a:ext cx="1079424" cy="771119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5</a:t>
          </a:r>
        </a:p>
      </dsp:txBody>
      <dsp:txXfrm>
        <a:off x="2020522" y="3612674"/>
        <a:ext cx="1079424" cy="771119"/>
      </dsp:txXfrm>
    </dsp:sp>
    <dsp:sp modelId="{8110C399-8F20-4AB5-BD7D-22095B9142B3}">
      <dsp:nvSpPr>
        <dsp:cNvPr id="0" name=""/>
        <dsp:cNvSpPr/>
      </dsp:nvSpPr>
      <dsp:spPr>
        <a:xfrm>
          <a:off x="2290378" y="4733127"/>
          <a:ext cx="1618068" cy="844978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985" tIns="6985" rIns="6985" bIns="6985" numCol="1" spcCol="1270" anchor="ctr" anchorCtr="0">
          <a:noAutofit/>
        </a:bodyPr>
        <a:lstStyle/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05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N.D.</a:t>
          </a:r>
          <a:r>
            <a:rPr lang="en-GB" altLang="ja-JP" sz="1200" kern="1200" dirty="0">
              <a:solidFill>
                <a:schemeClr val="tx1"/>
              </a:solidFill>
              <a:latin typeface="Arial" panose="020B0604020202020204" pitchFamily="34" charset="0"/>
              <a:cs typeface="Times New Roman" panose="02020603050405020304" pitchFamily="18" charset="0"/>
            </a:rPr>
            <a:t> </a:t>
          </a:r>
          <a:endParaRPr lang="en-GB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4</a:t>
          </a:r>
        </a:p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GB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1, 2, 6, 10</a:t>
          </a: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05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290378" y="4733127"/>
        <a:ext cx="1618068" cy="844978"/>
      </dsp:txXfrm>
    </dsp:sp>
    <dsp:sp modelId="{F5F3FF49-23FD-4723-B11F-E4F06DC6090E}">
      <dsp:nvSpPr>
        <dsp:cNvPr id="0" name=""/>
        <dsp:cNvSpPr/>
      </dsp:nvSpPr>
      <dsp:spPr>
        <a:xfrm>
          <a:off x="2290378" y="5760920"/>
          <a:ext cx="1079424" cy="713715"/>
        </a:xfrm>
        <a:prstGeom prst="rect">
          <a:avLst/>
        </a:prstGeom>
        <a:noFill/>
        <a:ln w="381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(+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9</a:t>
          </a: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290378" y="5760920"/>
        <a:ext cx="1079424" cy="713715"/>
      </dsp:txXfrm>
    </dsp:sp>
    <dsp:sp modelId="{87A60063-46AC-4CA6-8AFB-C646FC058C41}">
      <dsp:nvSpPr>
        <dsp:cNvPr id="0" name=""/>
        <dsp:cNvSpPr/>
      </dsp:nvSpPr>
      <dsp:spPr>
        <a:xfrm>
          <a:off x="4163207" y="2692362"/>
          <a:ext cx="1910743" cy="649511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ilateral prefrontal lesions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4</a:t>
          </a:r>
        </a:p>
      </dsp:txBody>
      <dsp:txXfrm>
        <a:off x="4163207" y="2692362"/>
        <a:ext cx="1910743" cy="649511"/>
      </dsp:txXfrm>
    </dsp:sp>
    <dsp:sp modelId="{8325B952-ADFE-4612-856B-08695AAA247D}">
      <dsp:nvSpPr>
        <dsp:cNvPr id="0" name=""/>
        <dsp:cNvSpPr/>
      </dsp:nvSpPr>
      <dsp:spPr>
        <a:xfrm>
          <a:off x="3865270" y="3590853"/>
          <a:ext cx="1079424" cy="771119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+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</dsp:txBody>
      <dsp:txXfrm>
        <a:off x="3865270" y="3590853"/>
        <a:ext cx="1079424" cy="771119"/>
      </dsp:txXfrm>
    </dsp:sp>
    <dsp:sp modelId="{765E4F2B-E403-446B-A07D-1C67F1398557}">
      <dsp:nvSpPr>
        <dsp:cNvPr id="0" name=""/>
        <dsp:cNvSpPr/>
      </dsp:nvSpPr>
      <dsp:spPr>
        <a:xfrm>
          <a:off x="4135126" y="4723655"/>
          <a:ext cx="1200514" cy="892063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N.D.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GB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11</a:t>
          </a: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4135126" y="4723655"/>
        <a:ext cx="1200514" cy="892063"/>
      </dsp:txXfrm>
    </dsp:sp>
    <dsp:sp modelId="{A458EDC1-D4A9-4E83-B3D9-1337FCD6336E}">
      <dsp:nvSpPr>
        <dsp:cNvPr id="0" name=""/>
        <dsp:cNvSpPr/>
      </dsp:nvSpPr>
      <dsp:spPr>
        <a:xfrm>
          <a:off x="5292463" y="3590853"/>
          <a:ext cx="1079424" cy="771119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3</a:t>
          </a:r>
        </a:p>
      </dsp:txBody>
      <dsp:txXfrm>
        <a:off x="5292463" y="3590853"/>
        <a:ext cx="1079424" cy="771119"/>
      </dsp:txXfrm>
    </dsp:sp>
    <dsp:sp modelId="{84ECF355-7DD3-4860-A18D-4CDD20866068}">
      <dsp:nvSpPr>
        <dsp:cNvPr id="0" name=""/>
        <dsp:cNvSpPr/>
      </dsp:nvSpPr>
      <dsp:spPr>
        <a:xfrm>
          <a:off x="5562319" y="4689006"/>
          <a:ext cx="1166868" cy="918919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N.D.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GB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4</a:t>
          </a: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5562319" y="4689006"/>
        <a:ext cx="1166868" cy="918919"/>
      </dsp:txXfrm>
    </dsp:sp>
    <dsp:sp modelId="{8766715A-D510-4EE8-AD86-94BC512AC9E6}">
      <dsp:nvSpPr>
        <dsp:cNvPr id="0" name=""/>
        <dsp:cNvSpPr/>
      </dsp:nvSpPr>
      <dsp:spPr>
        <a:xfrm>
          <a:off x="5562319" y="5714785"/>
          <a:ext cx="1149371" cy="759850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en-GB" altLang="ja-JP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GB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GB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GB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5, 7</a:t>
          </a: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5562319" y="5714785"/>
        <a:ext cx="1149371" cy="759850"/>
      </dsp:txXfrm>
    </dsp:sp>
    <dsp:sp modelId="{D29044B6-296F-43E9-9A97-6C76EB922610}">
      <dsp:nvSpPr>
        <dsp:cNvPr id="0" name=""/>
        <dsp:cNvSpPr/>
      </dsp:nvSpPr>
      <dsp:spPr>
        <a:xfrm>
          <a:off x="7850691" y="1889033"/>
          <a:ext cx="2530268" cy="539712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ilateral frontal lesions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4</a:t>
          </a:r>
          <a:endParaRPr lang="en-GB" sz="1200" b="1" kern="1200" dirty="0">
            <a:solidFill>
              <a:srgbClr val="FF0000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7850691" y="1889033"/>
        <a:ext cx="2530268" cy="539712"/>
      </dsp:txXfrm>
    </dsp:sp>
    <dsp:sp modelId="{F3963130-01C5-4F4B-8C80-55CA0768ED6D}">
      <dsp:nvSpPr>
        <dsp:cNvPr id="0" name=""/>
        <dsp:cNvSpPr/>
      </dsp:nvSpPr>
      <dsp:spPr>
        <a:xfrm>
          <a:off x="6973230" y="2692362"/>
          <a:ext cx="1918310" cy="649511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Unilateral prefrontal lesions (+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3</a:t>
          </a:r>
        </a:p>
      </dsp:txBody>
      <dsp:txXfrm>
        <a:off x="6973230" y="2692362"/>
        <a:ext cx="1918310" cy="649511"/>
      </dsp:txXfrm>
    </dsp:sp>
    <dsp:sp modelId="{FEEE0391-2F66-4C25-B135-60F552ABA19C}">
      <dsp:nvSpPr>
        <dsp:cNvPr id="0" name=""/>
        <dsp:cNvSpPr/>
      </dsp:nvSpPr>
      <dsp:spPr>
        <a:xfrm>
          <a:off x="6686011" y="3590853"/>
          <a:ext cx="1079424" cy="771119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+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</dsp:txBody>
      <dsp:txXfrm>
        <a:off x="6686011" y="3590853"/>
        <a:ext cx="1079424" cy="771119"/>
      </dsp:txXfrm>
    </dsp:sp>
    <dsp:sp modelId="{148A377F-FBE0-41AA-9F47-1AD7E47589A0}">
      <dsp:nvSpPr>
        <dsp:cNvPr id="0" name=""/>
        <dsp:cNvSpPr/>
      </dsp:nvSpPr>
      <dsp:spPr>
        <a:xfrm>
          <a:off x="6955867" y="4689006"/>
          <a:ext cx="1186643" cy="925153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N.D.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GB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13</a:t>
          </a: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6955867" y="4689006"/>
        <a:ext cx="1186643" cy="925153"/>
      </dsp:txXfrm>
    </dsp:sp>
    <dsp:sp modelId="{EF31350D-14A7-44C8-A461-3E7A3A6B8F1A}">
      <dsp:nvSpPr>
        <dsp:cNvPr id="0" name=""/>
        <dsp:cNvSpPr/>
      </dsp:nvSpPr>
      <dsp:spPr>
        <a:xfrm>
          <a:off x="8099334" y="3590853"/>
          <a:ext cx="1079424" cy="771119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</a:p>
      </dsp:txBody>
      <dsp:txXfrm>
        <a:off x="8099334" y="3590853"/>
        <a:ext cx="1079424" cy="771119"/>
      </dsp:txXfrm>
    </dsp:sp>
    <dsp:sp modelId="{AF4ED730-3812-4A53-9CB4-52489E7CD8D0}">
      <dsp:nvSpPr>
        <dsp:cNvPr id="0" name=""/>
        <dsp:cNvSpPr/>
      </dsp:nvSpPr>
      <dsp:spPr>
        <a:xfrm>
          <a:off x="8369190" y="4689006"/>
          <a:ext cx="1350576" cy="918131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GB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12, 14</a:t>
          </a: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en-US" altLang="ja-JP" sz="1200" b="1" kern="1200" dirty="0">
            <a:solidFill>
              <a:srgbClr val="FF0000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8369190" y="4689006"/>
        <a:ext cx="1350576" cy="918131"/>
      </dsp:txXfrm>
    </dsp:sp>
    <dsp:sp modelId="{9735BBE2-731E-4A6A-A9DC-FABB30A5B699}">
      <dsp:nvSpPr>
        <dsp:cNvPr id="0" name=""/>
        <dsp:cNvSpPr/>
      </dsp:nvSpPr>
      <dsp:spPr>
        <a:xfrm>
          <a:off x="9174182" y="2692362"/>
          <a:ext cx="2084239" cy="649511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Unilateral prefrontal lesions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</dsp:txBody>
      <dsp:txXfrm>
        <a:off x="9174182" y="2692362"/>
        <a:ext cx="2084239" cy="649511"/>
      </dsp:txXfrm>
    </dsp:sp>
    <dsp:sp modelId="{7608DE48-B886-49F4-839C-63DDC3306FE1}">
      <dsp:nvSpPr>
        <dsp:cNvPr id="0" name=""/>
        <dsp:cNvSpPr/>
      </dsp:nvSpPr>
      <dsp:spPr>
        <a:xfrm>
          <a:off x="9676589" y="3579703"/>
          <a:ext cx="1079424" cy="771119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</dsp:txBody>
      <dsp:txXfrm>
        <a:off x="9676589" y="3579703"/>
        <a:ext cx="1079424" cy="771119"/>
      </dsp:txXfrm>
    </dsp:sp>
    <dsp:sp modelId="{BD750659-6154-46D5-BA03-1754BA762AEF}">
      <dsp:nvSpPr>
        <dsp:cNvPr id="0" name=""/>
        <dsp:cNvSpPr/>
      </dsp:nvSpPr>
      <dsp:spPr>
        <a:xfrm>
          <a:off x="9946446" y="4689006"/>
          <a:ext cx="1347067" cy="921920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GB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15</a:t>
          </a: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9946446" y="4689006"/>
        <a:ext cx="1347067" cy="921920"/>
      </dsp:txXfrm>
    </dsp:sp>
    <dsp:sp modelId="{4F790CF3-DC77-46DD-959C-2556C4356DAC}">
      <dsp:nvSpPr>
        <dsp:cNvPr id="0" name=""/>
        <dsp:cNvSpPr/>
      </dsp:nvSpPr>
      <dsp:spPr>
        <a:xfrm>
          <a:off x="6979103" y="713868"/>
          <a:ext cx="2957040" cy="930064"/>
        </a:xfrm>
        <a:prstGeom prst="rect">
          <a:avLst/>
        </a:prstGeom>
        <a:noFill/>
        <a:ln w="381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255" tIns="8255" rIns="8255" bIns="8255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3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Instability could not be evaluated in a sitting position due to insufficient development milestones</a:t>
          </a:r>
        </a:p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3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</dsp:txBody>
      <dsp:txXfrm>
        <a:off x="6979103" y="713868"/>
        <a:ext cx="2957040" cy="930064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1581643-F527-4F9C-957D-21B7BF397099}">
      <dsp:nvSpPr>
        <dsp:cNvPr id="0" name=""/>
        <dsp:cNvSpPr/>
      </dsp:nvSpPr>
      <dsp:spPr>
        <a:xfrm>
          <a:off x="5896765" y="1189278"/>
          <a:ext cx="887413" cy="249433"/>
        </a:xfrm>
        <a:custGeom>
          <a:avLst/>
          <a:gdLst/>
          <a:ahLst/>
          <a:cxnLst/>
          <a:rect l="0" t="0" r="0" b="0"/>
          <a:pathLst>
            <a:path>
              <a:moveTo>
                <a:pt x="887413" y="0"/>
              </a:moveTo>
              <a:lnTo>
                <a:pt x="887413" y="249433"/>
              </a:lnTo>
              <a:lnTo>
                <a:pt x="0" y="249433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34C4E21-1952-4E8E-9318-1E0F6325910B}">
      <dsp:nvSpPr>
        <dsp:cNvPr id="0" name=""/>
        <dsp:cNvSpPr/>
      </dsp:nvSpPr>
      <dsp:spPr>
        <a:xfrm>
          <a:off x="6784178" y="1189278"/>
          <a:ext cx="2807211" cy="688401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519146"/>
              </a:lnTo>
              <a:lnTo>
                <a:pt x="2807211" y="519146"/>
              </a:lnTo>
              <a:lnTo>
                <a:pt x="2807211" y="688401"/>
              </a:lnTo>
            </a:path>
          </a:pathLst>
        </a:custGeom>
        <a:noFill/>
        <a:ln w="381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70CE079-92F9-4FED-AEE1-6E589D8BDEB5}">
      <dsp:nvSpPr>
        <dsp:cNvPr id="0" name=""/>
        <dsp:cNvSpPr/>
      </dsp:nvSpPr>
      <dsp:spPr>
        <a:xfrm>
          <a:off x="10013960" y="5641425"/>
          <a:ext cx="132131" cy="794218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794218"/>
              </a:lnTo>
              <a:lnTo>
                <a:pt x="132131" y="794218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8CB00494-7F74-4467-A3BD-5E2ABAF8B091}">
      <dsp:nvSpPr>
        <dsp:cNvPr id="0" name=""/>
        <dsp:cNvSpPr/>
      </dsp:nvSpPr>
      <dsp:spPr>
        <a:xfrm>
          <a:off x="10613022" y="4603825"/>
          <a:ext cx="91440" cy="326283"/>
        </a:xfrm>
        <a:custGeom>
          <a:avLst/>
          <a:gdLst/>
          <a:ahLst/>
          <a:cxnLst/>
          <a:rect l="0" t="0" r="0" b="0"/>
          <a:pathLst>
            <a:path>
              <a:moveTo>
                <a:pt x="47315" y="0"/>
              </a:moveTo>
              <a:lnTo>
                <a:pt x="47315" y="157028"/>
              </a:lnTo>
              <a:lnTo>
                <a:pt x="45720" y="157028"/>
              </a:lnTo>
              <a:lnTo>
                <a:pt x="45720" y="326283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8026F8C-44C8-445C-A43A-3675FF2FF054}">
      <dsp:nvSpPr>
        <dsp:cNvPr id="0" name=""/>
        <dsp:cNvSpPr/>
      </dsp:nvSpPr>
      <dsp:spPr>
        <a:xfrm>
          <a:off x="9634328" y="3560665"/>
          <a:ext cx="1026009" cy="343918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74663"/>
              </a:lnTo>
              <a:lnTo>
                <a:pt x="1026009" y="174663"/>
              </a:lnTo>
              <a:lnTo>
                <a:pt x="1026009" y="343918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5287358E-0C59-473E-8247-5C0CFFAC1AFD}">
      <dsp:nvSpPr>
        <dsp:cNvPr id="0" name=""/>
        <dsp:cNvSpPr/>
      </dsp:nvSpPr>
      <dsp:spPr>
        <a:xfrm>
          <a:off x="7962167" y="5631882"/>
          <a:ext cx="131906" cy="79729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797297"/>
              </a:lnTo>
              <a:lnTo>
                <a:pt x="131906" y="797297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9F787B1-4285-40D5-A18E-FE58585EB3EA}">
      <dsp:nvSpPr>
        <dsp:cNvPr id="0" name=""/>
        <dsp:cNvSpPr/>
      </dsp:nvSpPr>
      <dsp:spPr>
        <a:xfrm>
          <a:off x="8561229" y="4603825"/>
          <a:ext cx="91440" cy="321238"/>
        </a:xfrm>
        <a:custGeom>
          <a:avLst/>
          <a:gdLst/>
          <a:ahLst/>
          <a:cxnLst/>
          <a:rect l="0" t="0" r="0" b="0"/>
          <a:pathLst>
            <a:path>
              <a:moveTo>
                <a:pt x="47090" y="0"/>
              </a:moveTo>
              <a:lnTo>
                <a:pt x="47090" y="151983"/>
              </a:lnTo>
              <a:lnTo>
                <a:pt x="45720" y="151983"/>
              </a:lnTo>
              <a:lnTo>
                <a:pt x="45720" y="321238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A5C067F-FEAA-48F0-96BD-C976B883AD03}">
      <dsp:nvSpPr>
        <dsp:cNvPr id="0" name=""/>
        <dsp:cNvSpPr/>
      </dsp:nvSpPr>
      <dsp:spPr>
        <a:xfrm>
          <a:off x="8608319" y="3560665"/>
          <a:ext cx="1026009" cy="343918"/>
        </a:xfrm>
        <a:custGeom>
          <a:avLst/>
          <a:gdLst/>
          <a:ahLst/>
          <a:cxnLst/>
          <a:rect l="0" t="0" r="0" b="0"/>
          <a:pathLst>
            <a:path>
              <a:moveTo>
                <a:pt x="1026009" y="0"/>
              </a:moveTo>
              <a:lnTo>
                <a:pt x="1026009" y="174663"/>
              </a:lnTo>
              <a:lnTo>
                <a:pt x="0" y="174663"/>
              </a:lnTo>
              <a:lnTo>
                <a:pt x="0" y="343918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8F3B591-9307-4E9A-BD2C-F5D348511BEA}">
      <dsp:nvSpPr>
        <dsp:cNvPr id="0" name=""/>
        <dsp:cNvSpPr/>
      </dsp:nvSpPr>
      <dsp:spPr>
        <a:xfrm>
          <a:off x="6779681" y="2690588"/>
          <a:ext cx="2854647" cy="32931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60059"/>
              </a:lnTo>
              <a:lnTo>
                <a:pt x="2854647" y="160059"/>
              </a:lnTo>
              <a:lnTo>
                <a:pt x="2854647" y="329314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ECD91E9F-914B-4692-AEB7-CF13D6B0301E}">
      <dsp:nvSpPr>
        <dsp:cNvPr id="0" name=""/>
        <dsp:cNvSpPr/>
      </dsp:nvSpPr>
      <dsp:spPr>
        <a:xfrm>
          <a:off x="6100439" y="5646470"/>
          <a:ext cx="130374" cy="75657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756579"/>
              </a:lnTo>
              <a:lnTo>
                <a:pt x="130374" y="756579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ACCD6B2-FB3B-4F92-BBD9-D318FF429818}">
      <dsp:nvSpPr>
        <dsp:cNvPr id="0" name=""/>
        <dsp:cNvSpPr/>
      </dsp:nvSpPr>
      <dsp:spPr>
        <a:xfrm>
          <a:off x="5682621" y="4570522"/>
          <a:ext cx="1062600" cy="35831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89058"/>
              </a:lnTo>
              <a:lnTo>
                <a:pt x="1062600" y="189058"/>
              </a:lnTo>
              <a:lnTo>
                <a:pt x="1062600" y="358313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5166AAF-32C8-49C3-845B-E6BDE1B03191}">
      <dsp:nvSpPr>
        <dsp:cNvPr id="0" name=""/>
        <dsp:cNvSpPr/>
      </dsp:nvSpPr>
      <dsp:spPr>
        <a:xfrm>
          <a:off x="4206570" y="5636266"/>
          <a:ext cx="107469" cy="78041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780415"/>
              </a:lnTo>
              <a:lnTo>
                <a:pt x="107469" y="780415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AAE962B-FC4E-4E88-9802-C684323DA4FE}">
      <dsp:nvSpPr>
        <dsp:cNvPr id="0" name=""/>
        <dsp:cNvSpPr/>
      </dsp:nvSpPr>
      <dsp:spPr>
        <a:xfrm>
          <a:off x="4851352" y="4570522"/>
          <a:ext cx="831269" cy="366760"/>
        </a:xfrm>
        <a:custGeom>
          <a:avLst/>
          <a:gdLst/>
          <a:ahLst/>
          <a:cxnLst/>
          <a:rect l="0" t="0" r="0" b="0"/>
          <a:pathLst>
            <a:path>
              <a:moveTo>
                <a:pt x="831269" y="0"/>
              </a:moveTo>
              <a:lnTo>
                <a:pt x="831269" y="197504"/>
              </a:lnTo>
              <a:lnTo>
                <a:pt x="0" y="197504"/>
              </a:lnTo>
              <a:lnTo>
                <a:pt x="0" y="366760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5E9E6AB-8EBF-4489-A9AD-B18731334C84}">
      <dsp:nvSpPr>
        <dsp:cNvPr id="0" name=""/>
        <dsp:cNvSpPr/>
      </dsp:nvSpPr>
      <dsp:spPr>
        <a:xfrm>
          <a:off x="3732155" y="3527362"/>
          <a:ext cx="1950465" cy="343918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74663"/>
              </a:lnTo>
              <a:lnTo>
                <a:pt x="1950465" y="174663"/>
              </a:lnTo>
              <a:lnTo>
                <a:pt x="1950465" y="343918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3EA5D40-5517-4377-8544-329A518F7557}">
      <dsp:nvSpPr>
        <dsp:cNvPr id="0" name=""/>
        <dsp:cNvSpPr/>
      </dsp:nvSpPr>
      <dsp:spPr>
        <a:xfrm>
          <a:off x="2112140" y="5612506"/>
          <a:ext cx="125635" cy="78311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783115"/>
              </a:lnTo>
              <a:lnTo>
                <a:pt x="125635" y="783115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5E480686-E077-4A2E-87C9-6F692723D508}">
      <dsp:nvSpPr>
        <dsp:cNvPr id="0" name=""/>
        <dsp:cNvSpPr/>
      </dsp:nvSpPr>
      <dsp:spPr>
        <a:xfrm>
          <a:off x="1781690" y="4570522"/>
          <a:ext cx="975232" cy="35838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89130"/>
              </a:lnTo>
              <a:lnTo>
                <a:pt x="975232" y="189130"/>
              </a:lnTo>
              <a:lnTo>
                <a:pt x="975232" y="358385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82CAE2F5-6413-4F95-9925-7BD8906E8C59}">
      <dsp:nvSpPr>
        <dsp:cNvPr id="0" name=""/>
        <dsp:cNvSpPr/>
      </dsp:nvSpPr>
      <dsp:spPr>
        <a:xfrm>
          <a:off x="180535" y="5607533"/>
          <a:ext cx="106775" cy="785376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785376"/>
              </a:lnTo>
              <a:lnTo>
                <a:pt x="106775" y="785376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D731950-665B-474A-9284-81BABEADB935}">
      <dsp:nvSpPr>
        <dsp:cNvPr id="0" name=""/>
        <dsp:cNvSpPr/>
      </dsp:nvSpPr>
      <dsp:spPr>
        <a:xfrm>
          <a:off x="825317" y="4570522"/>
          <a:ext cx="956372" cy="359377"/>
        </a:xfrm>
        <a:custGeom>
          <a:avLst/>
          <a:gdLst/>
          <a:ahLst/>
          <a:cxnLst/>
          <a:rect l="0" t="0" r="0" b="0"/>
          <a:pathLst>
            <a:path>
              <a:moveTo>
                <a:pt x="956372" y="0"/>
              </a:moveTo>
              <a:lnTo>
                <a:pt x="956372" y="190122"/>
              </a:lnTo>
              <a:lnTo>
                <a:pt x="0" y="190122"/>
              </a:lnTo>
              <a:lnTo>
                <a:pt x="0" y="359377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5F4DF28-B57F-4699-9BED-B162015FDD41}">
      <dsp:nvSpPr>
        <dsp:cNvPr id="0" name=""/>
        <dsp:cNvSpPr/>
      </dsp:nvSpPr>
      <dsp:spPr>
        <a:xfrm>
          <a:off x="1781690" y="3527362"/>
          <a:ext cx="1950465" cy="343918"/>
        </a:xfrm>
        <a:custGeom>
          <a:avLst/>
          <a:gdLst/>
          <a:ahLst/>
          <a:cxnLst/>
          <a:rect l="0" t="0" r="0" b="0"/>
          <a:pathLst>
            <a:path>
              <a:moveTo>
                <a:pt x="1950465" y="0"/>
              </a:moveTo>
              <a:lnTo>
                <a:pt x="1950465" y="174663"/>
              </a:lnTo>
              <a:lnTo>
                <a:pt x="0" y="174663"/>
              </a:lnTo>
              <a:lnTo>
                <a:pt x="0" y="343918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6F95800-F6FC-432A-8192-5DDFB4692B6C}">
      <dsp:nvSpPr>
        <dsp:cNvPr id="0" name=""/>
        <dsp:cNvSpPr/>
      </dsp:nvSpPr>
      <dsp:spPr>
        <a:xfrm>
          <a:off x="3732155" y="2690588"/>
          <a:ext cx="3047525" cy="329314"/>
        </a:xfrm>
        <a:custGeom>
          <a:avLst/>
          <a:gdLst/>
          <a:ahLst/>
          <a:cxnLst/>
          <a:rect l="0" t="0" r="0" b="0"/>
          <a:pathLst>
            <a:path>
              <a:moveTo>
                <a:pt x="3047525" y="0"/>
              </a:moveTo>
              <a:lnTo>
                <a:pt x="3047525" y="160059"/>
              </a:lnTo>
              <a:lnTo>
                <a:pt x="0" y="160059"/>
              </a:lnTo>
              <a:lnTo>
                <a:pt x="0" y="329314"/>
              </a:lnTo>
            </a:path>
          </a:pathLst>
        </a:cu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FFD1586-C99D-4845-8FB7-33978BBFEBB3}">
      <dsp:nvSpPr>
        <dsp:cNvPr id="0" name=""/>
        <dsp:cNvSpPr/>
      </dsp:nvSpPr>
      <dsp:spPr>
        <a:xfrm>
          <a:off x="6733961" y="1189278"/>
          <a:ext cx="91440" cy="907506"/>
        </a:xfrm>
        <a:custGeom>
          <a:avLst/>
          <a:gdLst/>
          <a:ahLst/>
          <a:cxnLst/>
          <a:rect l="0" t="0" r="0" b="0"/>
          <a:pathLst>
            <a:path>
              <a:moveTo>
                <a:pt x="50217" y="0"/>
              </a:moveTo>
              <a:lnTo>
                <a:pt x="50217" y="738251"/>
              </a:lnTo>
              <a:lnTo>
                <a:pt x="45720" y="738251"/>
              </a:lnTo>
              <a:lnTo>
                <a:pt x="45720" y="907506"/>
              </a:lnTo>
            </a:path>
          </a:pathLst>
        </a:custGeom>
        <a:noFill/>
        <a:ln w="381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56AF28E-5690-4043-AF44-3ACC12D0BDB0}">
      <dsp:nvSpPr>
        <dsp:cNvPr id="0" name=""/>
        <dsp:cNvSpPr/>
      </dsp:nvSpPr>
      <dsp:spPr>
        <a:xfrm>
          <a:off x="6149197" y="661814"/>
          <a:ext cx="1269962" cy="527463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AED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6</a:t>
          </a:r>
        </a:p>
      </dsp:txBody>
      <dsp:txXfrm>
        <a:off x="6149197" y="661814"/>
        <a:ext cx="1269962" cy="527463"/>
      </dsp:txXfrm>
    </dsp:sp>
    <dsp:sp modelId="{C6924E3E-37F0-45BB-A9D6-33A3FF05B21C}">
      <dsp:nvSpPr>
        <dsp:cNvPr id="0" name=""/>
        <dsp:cNvSpPr/>
      </dsp:nvSpPr>
      <dsp:spPr>
        <a:xfrm>
          <a:off x="5909652" y="2096784"/>
          <a:ext cx="1740056" cy="593803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cond phase (+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0</a:t>
          </a:r>
        </a:p>
      </dsp:txBody>
      <dsp:txXfrm>
        <a:off x="5909652" y="2096784"/>
        <a:ext cx="1740056" cy="593803"/>
      </dsp:txXfrm>
    </dsp:sp>
    <dsp:sp modelId="{0296FC5F-E378-4904-93B2-00D4ACF73593}">
      <dsp:nvSpPr>
        <dsp:cNvPr id="0" name=""/>
        <dsp:cNvSpPr/>
      </dsp:nvSpPr>
      <dsp:spPr>
        <a:xfrm>
          <a:off x="2354030" y="3019902"/>
          <a:ext cx="2756249" cy="507459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ilateral frontal lesions (+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8</a:t>
          </a:r>
        </a:p>
      </dsp:txBody>
      <dsp:txXfrm>
        <a:off x="2354030" y="3019902"/>
        <a:ext cx="2756249" cy="507459"/>
      </dsp:txXfrm>
    </dsp:sp>
    <dsp:sp modelId="{B8C1EDF1-DB2A-4D33-AA78-22955DE770C3}">
      <dsp:nvSpPr>
        <dsp:cNvPr id="0" name=""/>
        <dsp:cNvSpPr/>
      </dsp:nvSpPr>
      <dsp:spPr>
        <a:xfrm>
          <a:off x="924936" y="3871281"/>
          <a:ext cx="1713508" cy="699241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ilateral prefrontal lesions (+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5</a:t>
          </a:r>
        </a:p>
      </dsp:txBody>
      <dsp:txXfrm>
        <a:off x="924936" y="3871281"/>
        <a:ext cx="1713508" cy="699241"/>
      </dsp:txXfrm>
    </dsp:sp>
    <dsp:sp modelId="{53371C62-A9F4-424A-A2C3-5285FF0AAA6F}">
      <dsp:nvSpPr>
        <dsp:cNvPr id="0" name=""/>
        <dsp:cNvSpPr/>
      </dsp:nvSpPr>
      <dsp:spPr>
        <a:xfrm>
          <a:off x="19339" y="4929900"/>
          <a:ext cx="1611954" cy="677633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+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3</a:t>
          </a:r>
          <a:endParaRPr lang="en-GB" sz="105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9339" y="4929900"/>
        <a:ext cx="1611954" cy="677633"/>
      </dsp:txXfrm>
    </dsp:sp>
    <dsp:sp modelId="{02FBF771-ADB1-4196-8CAA-4A17793F4EA7}">
      <dsp:nvSpPr>
        <dsp:cNvPr id="0" name=""/>
        <dsp:cNvSpPr/>
      </dsp:nvSpPr>
      <dsp:spPr>
        <a:xfrm>
          <a:off x="287311" y="5988124"/>
          <a:ext cx="1611954" cy="809572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N.D.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3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</a:t>
          </a: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ent No. 3</a:t>
          </a:r>
          <a:r>
            <a:rPr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, 6, 10</a:t>
          </a:r>
          <a:endParaRPr lang="en-GB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87311" y="5988124"/>
        <a:ext cx="1611954" cy="809572"/>
      </dsp:txXfrm>
    </dsp:sp>
    <dsp:sp modelId="{7AAAAC82-FC0D-43C2-9837-370A07F8A35C}">
      <dsp:nvSpPr>
        <dsp:cNvPr id="0" name=""/>
        <dsp:cNvSpPr/>
      </dsp:nvSpPr>
      <dsp:spPr>
        <a:xfrm>
          <a:off x="1950945" y="4928908"/>
          <a:ext cx="1611954" cy="683597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</a:p>
      </dsp:txBody>
      <dsp:txXfrm>
        <a:off x="1950945" y="4928908"/>
        <a:ext cx="1611954" cy="683597"/>
      </dsp:txXfrm>
    </dsp:sp>
    <dsp:sp modelId="{574D0AF8-7A16-4358-A4D4-0A9F71E32AB6}">
      <dsp:nvSpPr>
        <dsp:cNvPr id="0" name=""/>
        <dsp:cNvSpPr/>
      </dsp:nvSpPr>
      <dsp:spPr>
        <a:xfrm>
          <a:off x="2237776" y="5994088"/>
          <a:ext cx="1611954" cy="803067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(+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1</a:t>
          </a:r>
          <a:r>
            <a:rPr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, 2</a:t>
          </a:r>
          <a:endParaRPr lang="en-GB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237776" y="5994088"/>
        <a:ext cx="1611954" cy="803067"/>
      </dsp:txXfrm>
    </dsp:sp>
    <dsp:sp modelId="{1428E6BE-2F58-417D-9CB2-2888832E0161}">
      <dsp:nvSpPr>
        <dsp:cNvPr id="0" name=""/>
        <dsp:cNvSpPr/>
      </dsp:nvSpPr>
      <dsp:spPr>
        <a:xfrm>
          <a:off x="4825867" y="3871281"/>
          <a:ext cx="1713508" cy="699241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ilateral prefrontal lesions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3</a:t>
          </a:r>
        </a:p>
      </dsp:txBody>
      <dsp:txXfrm>
        <a:off x="4825867" y="3871281"/>
        <a:ext cx="1713508" cy="699241"/>
      </dsp:txXfrm>
    </dsp:sp>
    <dsp:sp modelId="{8110C399-8F20-4AB5-BD7D-22095B9142B3}">
      <dsp:nvSpPr>
        <dsp:cNvPr id="0" name=""/>
        <dsp:cNvSpPr/>
      </dsp:nvSpPr>
      <dsp:spPr>
        <a:xfrm>
          <a:off x="4045374" y="4937282"/>
          <a:ext cx="1611954" cy="698983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+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  <a:endParaRPr lang="en-GB" sz="105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4045374" y="4937282"/>
        <a:ext cx="1611954" cy="698983"/>
      </dsp:txXfrm>
    </dsp:sp>
    <dsp:sp modelId="{AD85E944-2472-4D72-9B7F-B6CF170BE523}">
      <dsp:nvSpPr>
        <dsp:cNvPr id="0" name=""/>
        <dsp:cNvSpPr/>
      </dsp:nvSpPr>
      <dsp:spPr>
        <a:xfrm>
          <a:off x="4314039" y="6005082"/>
          <a:ext cx="1470473" cy="823201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N.D.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4</a:t>
          </a:r>
          <a:r>
            <a:rPr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, 5</a:t>
          </a:r>
          <a:endParaRPr lang="en-GB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4314039" y="6005082"/>
        <a:ext cx="1470473" cy="823201"/>
      </dsp:txXfrm>
    </dsp:sp>
    <dsp:sp modelId="{C73811CB-CB56-4712-8C2D-8D9895AB323B}">
      <dsp:nvSpPr>
        <dsp:cNvPr id="0" name=""/>
        <dsp:cNvSpPr/>
      </dsp:nvSpPr>
      <dsp:spPr>
        <a:xfrm>
          <a:off x="5939244" y="4928836"/>
          <a:ext cx="1611954" cy="717634"/>
        </a:xfrm>
        <a:prstGeom prst="rect">
          <a:avLst/>
        </a:prstGeom>
        <a:noFill/>
        <a:ln w="381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en-US" altLang="ja-JP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 sitting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  <a:endParaRPr kumimoji="1" lang="ja-JP" altLang="ja-JP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1000" kern="1200" dirty="0"/>
        </a:p>
      </dsp:txBody>
      <dsp:txXfrm>
        <a:off x="5939244" y="4928836"/>
        <a:ext cx="1611954" cy="717634"/>
      </dsp:txXfrm>
    </dsp:sp>
    <dsp:sp modelId="{B3787398-3726-450B-A2F2-03118F71D247}">
      <dsp:nvSpPr>
        <dsp:cNvPr id="0" name=""/>
        <dsp:cNvSpPr/>
      </dsp:nvSpPr>
      <dsp:spPr>
        <a:xfrm>
          <a:off x="6230814" y="6000060"/>
          <a:ext cx="1611954" cy="805977"/>
        </a:xfrm>
        <a:prstGeom prst="rect">
          <a:avLst/>
        </a:prstGeom>
        <a:noFill/>
        <a:ln w="381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7</a:t>
          </a: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6230814" y="6000060"/>
        <a:ext cx="1611954" cy="805977"/>
      </dsp:txXfrm>
    </dsp:sp>
    <dsp:sp modelId="{87A60063-46AC-4CA6-8AFB-C646FC058C41}">
      <dsp:nvSpPr>
        <dsp:cNvPr id="0" name=""/>
        <dsp:cNvSpPr/>
      </dsp:nvSpPr>
      <dsp:spPr>
        <a:xfrm>
          <a:off x="8207627" y="3019902"/>
          <a:ext cx="2853402" cy="540762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Bilateral frontal lesions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2</a:t>
          </a:r>
          <a:endParaRPr lang="en-GB" sz="1200" b="1" kern="1200" dirty="0">
            <a:solidFill>
              <a:srgbClr val="FF0000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8207627" y="3019902"/>
        <a:ext cx="2853402" cy="540762"/>
      </dsp:txXfrm>
    </dsp:sp>
    <dsp:sp modelId="{8325B952-ADFE-4612-856B-08695AAA247D}">
      <dsp:nvSpPr>
        <dsp:cNvPr id="0" name=""/>
        <dsp:cNvSpPr/>
      </dsp:nvSpPr>
      <dsp:spPr>
        <a:xfrm>
          <a:off x="7751565" y="3904584"/>
          <a:ext cx="1713508" cy="699241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Unilateral prefrontal lesion (+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  <a:endParaRPr lang="en-GB" sz="1200" b="1" kern="1200" dirty="0">
            <a:solidFill>
              <a:srgbClr val="FF0000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7751565" y="3904584"/>
        <a:ext cx="1713508" cy="699241"/>
      </dsp:txXfrm>
    </dsp:sp>
    <dsp:sp modelId="{765E4F2B-E403-446B-A07D-1C67F1398557}">
      <dsp:nvSpPr>
        <dsp:cNvPr id="0" name=""/>
        <dsp:cNvSpPr/>
      </dsp:nvSpPr>
      <dsp:spPr>
        <a:xfrm>
          <a:off x="7800971" y="4925064"/>
          <a:ext cx="1611954" cy="706818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  <a:endParaRPr kumimoji="1" lang="ja-JP" altLang="en-US" sz="1200" b="1" kern="1200" dirty="0">
            <a:solidFill>
              <a:srgbClr val="FF0000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7800971" y="4925064"/>
        <a:ext cx="1611954" cy="706818"/>
      </dsp:txXfrm>
    </dsp:sp>
    <dsp:sp modelId="{5A7379F8-0FE0-4810-B536-55D1FA7C51BC}">
      <dsp:nvSpPr>
        <dsp:cNvPr id="0" name=""/>
        <dsp:cNvSpPr/>
      </dsp:nvSpPr>
      <dsp:spPr>
        <a:xfrm>
          <a:off x="8094073" y="6024441"/>
          <a:ext cx="1611954" cy="809475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12</a:t>
          </a: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8094073" y="6024441"/>
        <a:ext cx="1611954" cy="809475"/>
      </dsp:txXfrm>
    </dsp:sp>
    <dsp:sp modelId="{A458EDC1-D4A9-4E83-B3D9-1337FCD6336E}">
      <dsp:nvSpPr>
        <dsp:cNvPr id="0" name=""/>
        <dsp:cNvSpPr/>
      </dsp:nvSpPr>
      <dsp:spPr>
        <a:xfrm>
          <a:off x="9803583" y="3904584"/>
          <a:ext cx="1713508" cy="699241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Unilateral prefrontal lesion (-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  <a:endParaRPr lang="en-GB" sz="1200" b="1" kern="1200" dirty="0">
            <a:solidFill>
              <a:srgbClr val="FF0000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9803583" y="3904584"/>
        <a:ext cx="1713508" cy="699241"/>
      </dsp:txXfrm>
    </dsp:sp>
    <dsp:sp modelId="{84ECF355-7DD3-4860-A18D-4CDD20866068}">
      <dsp:nvSpPr>
        <dsp:cNvPr id="0" name=""/>
        <dsp:cNvSpPr/>
      </dsp:nvSpPr>
      <dsp:spPr>
        <a:xfrm>
          <a:off x="9852764" y="4930109"/>
          <a:ext cx="1611954" cy="711315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vere instability in sitting (+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9852764" y="4930109"/>
        <a:ext cx="1611954" cy="711315"/>
      </dsp:txXfrm>
    </dsp:sp>
    <dsp:sp modelId="{2367E8B8-6E6D-48A8-BDF8-16FE3316FE75}">
      <dsp:nvSpPr>
        <dsp:cNvPr id="0" name=""/>
        <dsp:cNvSpPr/>
      </dsp:nvSpPr>
      <dsp:spPr>
        <a:xfrm>
          <a:off x="10146091" y="6040972"/>
          <a:ext cx="1611954" cy="789342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Titubation N.D.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</a:t>
          </a:r>
          <a:r>
            <a:rPr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15</a:t>
          </a:r>
          <a:r>
            <a:rPr lang="en-US" altLang="ja-JP" sz="1200" b="1" kern="1200" dirty="0">
              <a:latin typeface="Arial" panose="020B0604020202020204" pitchFamily="34" charset="0"/>
              <a:cs typeface="Arial" panose="020B0604020202020204" pitchFamily="34" charset="0"/>
            </a:rPr>
            <a:t>6</a:t>
          </a: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0146091" y="6040972"/>
        <a:ext cx="1611954" cy="789342"/>
      </dsp:txXfrm>
    </dsp:sp>
    <dsp:sp modelId="{D29044B6-296F-43E9-9A97-6C76EB922610}">
      <dsp:nvSpPr>
        <dsp:cNvPr id="0" name=""/>
        <dsp:cNvSpPr/>
      </dsp:nvSpPr>
      <dsp:spPr>
        <a:xfrm>
          <a:off x="7916069" y="1877679"/>
          <a:ext cx="3350641" cy="784256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Second phase (-) 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(including the Early-Hypo group)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5, </a:t>
          </a:r>
          <a:r>
            <a:rPr kumimoji="1" lang="en-GB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atient No. 8, 9, 11, 13, 14</a:t>
          </a:r>
          <a:endParaRPr kumimoji="1" lang="ja-JP" altLang="en-US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7916069" y="1877679"/>
        <a:ext cx="3350641" cy="784256"/>
      </dsp:txXfrm>
    </dsp:sp>
    <dsp:sp modelId="{52201AFD-8388-4F09-A422-24B3ED7819C8}">
      <dsp:nvSpPr>
        <dsp:cNvPr id="0" name=""/>
        <dsp:cNvSpPr/>
      </dsp:nvSpPr>
      <dsp:spPr>
        <a:xfrm>
          <a:off x="2879056" y="1118207"/>
          <a:ext cx="3017708" cy="641009"/>
        </a:xfrm>
        <a:prstGeom prst="rect">
          <a:avLst/>
        </a:prstGeom>
        <a:noFill/>
        <a:ln w="3810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" tIns="7620" rIns="7620" bIns="7620" numCol="1" spcCol="1270" anchor="ctr" anchorCtr="0">
          <a:noAutofit/>
        </a:bodyPr>
        <a:lstStyle/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US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Instability could not be evaluated due to </a:t>
          </a:r>
          <a:r>
            <a:rPr kumimoji="1" lang="en-GB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insufficient development milestones</a:t>
          </a:r>
        </a:p>
        <a:p>
          <a:pPr marL="0" lvl="0" indent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en-GB" altLang="ja-JP" sz="1200" b="1" kern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n = 1</a:t>
          </a:r>
          <a:endParaRPr kumimoji="1" lang="ja-JP" altLang="ja-JP" sz="1200" b="1" kern="1200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879056" y="1118207"/>
        <a:ext cx="3017708" cy="641009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orgChart1">
  <dgm:title val=""/>
  <dgm:desc val=""/>
  <dgm:catLst>
    <dgm:cat type="hierarchy" pri="1000"/>
    <dgm:cat type="convert" pri="6000"/>
  </dgm:catLst>
  <dgm:sampData>
    <dgm:dataModel>
      <dgm:ptLst>
        <dgm:pt modelId="0" type="doc"/>
        <dgm:pt modelId="1">
          <dgm:prSet phldr="1"/>
        </dgm:pt>
        <dgm:pt modelId="2" type="asst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5" srcId="0" destId="1" srcOrd="0" destOrd="0"/>
        <dgm:cxn modelId="6" srcId="1" destId="2" srcOrd="0" destOrd="0"/>
        <dgm:cxn modelId="7" srcId="1" destId="3" srcOrd="1" destOrd="0"/>
        <dgm:cxn modelId="8" srcId="1" destId="4" srcOrd="2" destOrd="0"/>
        <dgm:cxn modelId="9" srcId="1" destId="5" srcOrd="3" destOrd="0"/>
      </dgm:cxnLst>
      <dgm:bg/>
      <dgm:whole/>
    </dgm:dataModel>
  </dgm:sampData>
  <dgm:styleData>
    <dgm:dataModel>
      <dgm:ptLst>
        <dgm:pt modelId="0" type="doc"/>
        <dgm:pt modelId="1"/>
        <dgm:pt modelId="12"/>
        <dgm:pt modelId="13"/>
      </dgm:ptLst>
      <dgm:cxnLst>
        <dgm:cxn modelId="2" srcId="0" destId="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 type="asst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clrData>
  <dgm:layoutNode name="hierChild1">
    <dgm:varLst>
      <dgm:orgChart val="1"/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des" forName="rootComposite1" refType="w" fact="10"/>
      <dgm:constr type="h" for="des" forName="rootComposite1" refType="w" refFor="des" refForName="rootComposite1" fact="0.5"/>
      <dgm:constr type="w" for="des" forName="rootComposite" refType="w" fact="10"/>
      <dgm:constr type="h" for="des" forName="rootComposite" refType="w" refFor="des" refForName="rootComposite1" fact="0.5"/>
      <dgm:constr type="w" for="des" forName="rootComposite3" refType="w" fact="10"/>
      <dgm:constr type="h" for="des" forName="rootComposite3" refType="w" refFor="des" refForName="rootComposite1" fact="0.5"/>
      <dgm:constr type="primFontSz" for="des" ptType="node" op="equ"/>
      <dgm:constr type="sp" for="des" op="equ"/>
      <dgm:constr type="sp" for="des" forName="hierRoot1" refType="w" refFor="des" refForName="rootComposite1" fact="0.21"/>
      <dgm:constr type="sp" for="des" forName="hierRoot2" refType="sp" refFor="des" refForName="hierRoot1"/>
      <dgm:constr type="sp" for="des" forName="hierRoot3" refType="sp" refFor="des" refForName="hierRoot1"/>
      <dgm:constr type="sibSp" refType="w" refFor="des" refForName="rootComposite1" fact="0.2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ibSp" for="des" forName="hierChild7" refType="sibSp"/>
      <dgm:constr type="secSibSp" refType="w" refFor="des" refForName="rootComposite1" fact="0.21"/>
      <dgm:constr type="secSibSp" for="des" forName="hierChild2" refType="secSibSp"/>
      <dgm:constr type="secSibSp" for="des" forName="hierChild3" refType="secSibSp"/>
      <dgm:constr type="secSibSp" for="des" forName="hierChild4" refType="secSibSp"/>
      <dgm:constr type="secSibSp" for="des" forName="hierChild5" refType="secSibSp"/>
      <dgm:constr type="secSibSp" for="des" forName="hierChild6" refType="secSibSp"/>
      <dgm:constr type="secSibSp" for="des" forName="hierChild7" refType="secSibSp"/>
    </dgm:constrLst>
    <dgm:ruleLst/>
    <dgm:forEach name="Name3" axis="ch">
      <dgm:forEach name="Name4" axis="self" ptType="node">
        <dgm:layoutNode name="hierRoot1">
          <dgm:varLst>
            <dgm:hierBranch val="init"/>
          </dgm:varLst>
          <dgm:choose name="Name5">
            <dgm:if name="Name6" func="var" arg="hierBranch" op="equ" val="l">
              <dgm:choose name="Name7">
                <dgm:if name="Name8" axis="ch" ptType="asst" func="cnt" op="gte" val="1">
                  <dgm:alg type="hierRoot">
                    <dgm:param type="hierAlign" val="tR"/>
                  </dgm:alg>
                  <dgm:constrLst>
                    <dgm:constr type="alignOff" val="0.65"/>
                  </dgm:constrLst>
                </dgm:if>
                <dgm:else name="Name9">
                  <dgm:alg type="hierRoot">
                    <dgm:param type="hierAlign" val="tR"/>
                  </dgm:alg>
                  <dgm:constrLst>
                    <dgm:constr type="alignOff" val="0.25"/>
                  </dgm:constrLst>
                </dgm:else>
              </dgm:choose>
            </dgm:if>
            <dgm:if name="Name10" func="var" arg="hierBranch" op="equ" val="r">
              <dgm:choose name="Name11">
                <dgm:if name="Name12" axis="ch" ptType="asst" func="cnt" op="gte" val="1">
                  <dgm:alg type="hierRoot">
                    <dgm:param type="hierAlign" val="tL"/>
                  </dgm:alg>
                  <dgm:constrLst>
                    <dgm:constr type="alignOff" val="0.65"/>
                  </dgm:constrLst>
                </dgm:if>
                <dgm:else name="Name13">
                  <dgm:alg type="hierRoot">
                    <dgm:param type="hierAlign" val="tL"/>
                  </dgm:alg>
                  <dgm:constrLst>
                    <dgm:constr type="alignOff" val="0.25"/>
                  </dgm:constrLst>
                </dgm:else>
              </dgm:choose>
            </dgm:if>
            <dgm:if name="Name14" func="var" arg="hierBranch" op="equ" val="hang">
              <dgm:alg type="hierRoot"/>
              <dgm:constrLst>
                <dgm:constr type="alignOff" val="0.65"/>
              </dgm:constrLst>
            </dgm:if>
            <dgm:else name="Name15">
              <dgm:alg type="hierRoot"/>
              <dgm:constrLst>
                <dgm:constr type="alignOff"/>
                <dgm:constr type="bendDist" for="des" ptType="parTrans" refType="sp" fact="0.5"/>
              </dgm:constrLst>
            </dgm:else>
          </dgm:choose>
          <dgm:shape xmlns:r="http://schemas.openxmlformats.org/officeDocument/2006/relationships" r:blip="">
            <dgm:adjLst/>
          </dgm:shape>
          <dgm:presOf/>
          <dgm:ruleLst/>
          <dgm:layoutNode name="rootComposite1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16">
              <dgm:if name="Name17" func="var" arg="hierBranch" op="equ" val="init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8" func="var" arg="hierBranch" op="equ" val="l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9" func="var" arg="hierBranch" op="equ" val="r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else name="Name20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else>
            </dgm:choose>
            <dgm:ruleLst/>
            <dgm:layoutNode name="rootText1" styleLbl="node0">
              <dgm:varLst>
                <dgm:chPref val="3"/>
              </dgm:varLst>
              <dgm:alg type="tx"/>
              <dgm:shape xmlns:r="http://schemas.openxmlformats.org/officeDocument/2006/relationships" type="rect" r:blip="">
                <dgm:adjLst/>
              </dgm:shape>
              <dgm:presOf axis="self" ptType="node" cnt="1"/>
              <dgm:constrLst>
                <dgm:constr type="primFontSz" val="65"/>
                <dgm:constr type="lMarg" refType="primFontSz" fact="0.05"/>
                <dgm:constr type="rMarg" refType="primFontSz" fact="0.05"/>
                <dgm:constr type="tMarg" refType="primFontSz" fact="0.05"/>
                <dgm:constr type="bMarg" refType="primFontSz" fact="0.05"/>
              </dgm:constrLst>
              <dgm:ruleLst>
                <dgm:rule type="primFontSz" val="5" fact="NaN" max="NaN"/>
              </dgm:ruleLst>
            </dgm:layoutNode>
            <dgm:layoutNode name="rootConnector1" moveWith="rootText1">
              <dgm:alg type="sp"/>
              <dgm:shape xmlns:r="http://schemas.openxmlformats.org/officeDocument/2006/relationships" type="rect" r:blip="" hideGeom="1">
                <dgm:adjLst/>
              </dgm:shape>
              <dgm:presOf axis="self" ptType="node" cnt="1"/>
              <dgm:constrLst/>
              <dgm:ruleLst/>
            </dgm:layoutNode>
          </dgm:layoutNode>
          <dgm:layoutNode name="hierChild2">
            <dgm:choose name="Name21">
              <dgm:if name="Name22" func="var" arg="hierBranch" op="equ" val="l">
                <dgm:alg type="hierChild">
                  <dgm:param type="chAlign" val="r"/>
                  <dgm:param type="linDir" val="fromT"/>
                </dgm:alg>
              </dgm:if>
              <dgm:if name="Name23" func="var" arg="hierBranch" op="equ" val="r">
                <dgm:alg type="hierChild">
                  <dgm:param type="chAlign" val="l"/>
                  <dgm:param type="linDir" val="fromT"/>
                </dgm:alg>
              </dgm:if>
              <dgm:if name="Name24" func="var" arg="hierBranch" op="equ" val="hang">
                <dgm:choose name="Name25">
                  <dgm:if name="Name26" func="var" arg="dir" op="equ" val="norm">
                    <dgm:alg type="hierChild">
                      <dgm:param type="chAlign" val="l"/>
                      <dgm:param type="linDir" val="fromL"/>
                      <dgm:param type="secChAlign" val="t"/>
                      <dgm:param type="secLinDir" val="fromT"/>
                    </dgm:alg>
                  </dgm:if>
                  <dgm:else name="Name27">
                    <dgm:alg type="hierChild">
                      <dgm:param type="chAlign" val="l"/>
                      <dgm:param type="linDir" val="fromR"/>
                      <dgm:param type="secChAlign" val="t"/>
                      <dgm:param type="secLinDir" val="fromT"/>
                    </dgm:alg>
                  </dgm:else>
                </dgm:choose>
              </dgm:if>
              <dgm:else name="Name28">
                <dgm:choose name="Name29">
                  <dgm:if name="Name30" func="var" arg="dir" op="equ" val="norm">
                    <dgm:alg type="hierChild"/>
                  </dgm:if>
                  <dgm:else name="Name31">
                    <dgm:alg type="hierChild">
                      <dgm:param type="linDir" val="fromR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a" axis="ch" ptType="nonAsst">
              <dgm:forEach name="Name32" axis="precedSib" ptType="parTrans" st="-1" cnt="1">
                <dgm:choose name="Name33">
                  <dgm:if name="Name34" func="var" arg="hierBranch" op="equ" val="std">
                    <dgm:layoutNode name="Name35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tCtr"/>
                        <dgm:param type="bendPt" val="end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36" func="var" arg="hierBranch" op="equ" val="init">
                    <dgm:layoutNode name="Name37">
                      <dgm:choose name="Name38">
                        <dgm:if name="Name39" axis="self" func="depth" op="lte" val="2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</dgm:alg>
                        </dgm:if>
                        <dgm:else name="Name40">
                          <dgm:choose name="Name41">
                            <dgm:if name="Name42" axis="par des" func="maxDepth" op="lte" val="1">
                              <dgm:choose name="Name43">
                                <dgm:if name="Name44" axis="par ch" ptType="node asst" func="cnt" op="gte" val="1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</dgm:alg>
                                </dgm:if>
                                <dgm:else name="Name45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  <dgm:param type="srcNode" val="rootConnector"/>
                                  </dgm:alg>
                                </dgm:else>
                              </dgm:choose>
                            </dgm:if>
                            <dgm:else name="Name46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47" func="var" arg="hierBranch" op="equ" val="hang">
                    <dgm:layoutNode name="Name48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midL midR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else name="Name49">
                    <dgm:layoutNode name="Name50">
                      <dgm:choose name="Name51">
                        <dgm:if name="Name52" axis="self" func="depth" op="lte" val="2">
                          <dgm:choose name="Name53">
                            <dgm:if name="Name54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5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1"/>
                              </dgm:alg>
                            </dgm:else>
                          </dgm:choose>
                        </dgm:if>
                        <dgm:else name="Name56">
                          <dgm:choose name="Name57">
                            <dgm:if name="Name58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9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else>
                </dgm:choose>
              </dgm:forEach>
              <dgm:layoutNode name="hierRoot2">
                <dgm:varLst>
                  <dgm:hierBranch val="init"/>
                </dgm:varLst>
                <dgm:choose name="Name60">
                  <dgm:if name="Name61" func="var" arg="hierBranch" op="equ" val="l">
                    <dgm:choose name="Name62">
                      <dgm:if name="Name63" axis="ch" ptType="asst" func="cnt" op="gte" val="1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4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5" func="var" arg="hierBranch" op="equ" val="r">
                    <dgm:choose name="Name66">
                      <dgm:if name="Name67" axis="ch" ptType="asst" func="cnt" op="g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8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9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70" func="var" arg="hierBranch" op="equ" val="init">
                    <dgm:choose name="Name71">
                      <dgm:if name="Name72" axis="des" func="maxDepth" op="lte" val="1">
                        <dgm:choose name="Name73">
                          <dgm:if name="Name74" axis="ch" ptType="asst" func="cnt" op="gte" val="1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65"/>
                            </dgm:constrLst>
                          </dgm:if>
                          <dgm:else name="Name75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25"/>
                            </dgm:constrLst>
                          </dgm:else>
                        </dgm:choose>
                      </dgm:if>
                      <dgm:else name="Name76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77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else>
                </dgm:choose>
                <dgm:ruleLst/>
                <dgm:layoutNode name="rootComposite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78">
                    <dgm:if name="Name79" func="var" arg="hierBranch" op="equ" val="init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0" func="var" arg="hierBranch" op="equ" val="l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1" func="var" arg="hierBranch" op="equ" val="r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else name="Name82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else>
                  </dgm:choose>
                  <dgm:ruleLst/>
                  <dgm:layoutNode name="rootText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" moveWith="rootText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4">
                  <dgm:choose name="Name83">
                    <dgm:if name="Name84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85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86" func="var" arg="hierBranch" op="equ" val="hang">
                      <dgm:choose name="Name87">
                        <dgm:if name="Name88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89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90" func="var" arg="hierBranch" op="equ" val="std">
                      <dgm:choose name="Name91">
                        <dgm:if name="Name92" func="var" arg="dir" op="equ" val="norm">
                          <dgm:alg type="hierChild"/>
                        </dgm:if>
                        <dgm:else name="Name93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94" func="var" arg="hierBranch" op="equ" val="init">
                      <dgm:choose name="Name95">
                        <dgm:if name="Name96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97">
                          <dgm:choose name="Name98">
                            <dgm:if name="Name99" func="var" arg="dir" op="equ" val="norm">
                              <dgm:alg type="hierChild"/>
                            </dgm:if>
                            <dgm:else name="Name100">
                              <dgm:alg type="hierChild">
                                <dgm:param type="linDir" val="fromR"/>
                              </dgm:alg>
                            </dgm:else>
                          </dgm:choose>
                        </dgm:else>
                      </dgm:choose>
                    </dgm:if>
                    <dgm:else name="Name101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2" ref="rep2a"/>
                </dgm:layoutNode>
                <dgm:layoutNode name="hierChild5">
                  <dgm:choose name="Name103">
                    <dgm:if name="Name104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05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6" ref="rep2b"/>
                </dgm:layoutNode>
              </dgm:layoutNode>
            </dgm:forEach>
          </dgm:layoutNode>
          <dgm:layoutNode name="hierChild3">
            <dgm:choose name="Name107">
              <dgm:if name="Name108" func="var" arg="dir" op="equ" val="norm">
                <dgm:alg type="hierChild">
                  <dgm:param type="chAlign" val="l"/>
                  <dgm:param type="linDir" val="fromL"/>
                  <dgm:param type="secChAlign" val="t"/>
                  <dgm:param type="secLinDir" val="fromT"/>
                </dgm:alg>
              </dgm:if>
              <dgm:else name="Name109">
                <dgm:alg type="hierChild">
                  <dgm:param type="chAlign" val="l"/>
                  <dgm:param type="linDir" val="fromR"/>
                  <dgm:param type="secChAlign" val="t"/>
                  <dgm:param type="secLinDir" val="fromT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b" axis="ch" ptType="asst">
              <dgm:forEach name="Name110" axis="precedSib" ptType="parTrans" st="-1" cnt="1">
                <dgm:layoutNode name="Name111">
                  <dgm:alg type="conn">
                    <dgm:param type="connRout" val="bend"/>
                    <dgm:param type="dim" val="1D"/>
                    <dgm:param type="endSty" val="noArr"/>
                    <dgm:param type="begPts" val="bCtr"/>
                    <dgm:param type="endPts" val="midL midR"/>
                  </dgm:alg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layoutNode name="hierRoot3">
                <dgm:varLst>
                  <dgm:hierBranch val="init"/>
                </dgm:varLst>
                <dgm:choose name="Name112">
                  <dgm:if name="Name113" func="var" arg="hierBranch" op="equ" val="l">
                    <dgm:alg type="hierRoot">
                      <dgm:param type="hierAlign" val="tR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4" func="var" arg="hierBranch" op="equ" val="r">
                    <dgm:alg type="hierRoot">
                      <dgm:param type="hierAlign" val="tL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5" func="var" arg="hierBranch" op="equ" val="hang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6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117" func="var" arg="hierBranch" op="equ" val="init">
                    <dgm:choose name="Name118">
                      <dgm:if name="Name119" axis="des" func="maxDepth" op="l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120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121"/>
                </dgm:choose>
                <dgm:ruleLst/>
                <dgm:layoutNode name="rootComposite3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122">
                    <dgm:if name="Name123" func="var" arg="hierBranch" op="equ" val="init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4" func="var" arg="hierBranch" op="equ" val="l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5" func="var" arg="hierBranch" op="equ" val="r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else name="Name126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else>
                  </dgm:choose>
                  <dgm:ruleLst/>
                  <dgm:layoutNode name="rootText3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3" moveWith="rootText1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6">
                  <dgm:choose name="Name127">
                    <dgm:if name="Name128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129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130" func="var" arg="hierBranch" op="equ" val="hang">
                      <dgm:choose name="Name131">
                        <dgm:if name="Name132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133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134" func="var" arg="hierBranch" op="equ" val="std">
                      <dgm:choose name="Name135">
                        <dgm:if name="Name136" func="var" arg="dir" op="equ" val="norm">
                          <dgm:alg type="hierChild"/>
                        </dgm:if>
                        <dgm:else name="Name137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138" func="var" arg="hierBranch" op="equ" val="init">
                      <dgm:choose name="Name139">
                        <dgm:if name="Name140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141">
                          <dgm:alg type="hierChild"/>
                        </dgm:else>
                      </dgm:choose>
                    </dgm:if>
                    <dgm:else name="Name142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3" ref="rep2a"/>
                </dgm:layoutNode>
                <dgm:layoutNode name="hierChild7">
                  <dgm:choose name="Name144">
                    <dgm:if name="Name145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46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7" ref="rep2b"/>
                </dgm:layoutNode>
              </dgm:layoutNode>
            </dgm:forEach>
          </dgm:layoutNode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orgChart1">
  <dgm:title val=""/>
  <dgm:desc val=""/>
  <dgm:catLst>
    <dgm:cat type="hierarchy" pri="1000"/>
    <dgm:cat type="convert" pri="6000"/>
  </dgm:catLst>
  <dgm:sampData>
    <dgm:dataModel>
      <dgm:ptLst>
        <dgm:pt modelId="0" type="doc"/>
        <dgm:pt modelId="1">
          <dgm:prSet phldr="1"/>
        </dgm:pt>
        <dgm:pt modelId="2" type="asst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5" srcId="0" destId="1" srcOrd="0" destOrd="0"/>
        <dgm:cxn modelId="6" srcId="1" destId="2" srcOrd="0" destOrd="0"/>
        <dgm:cxn modelId="7" srcId="1" destId="3" srcOrd="1" destOrd="0"/>
        <dgm:cxn modelId="8" srcId="1" destId="4" srcOrd="2" destOrd="0"/>
        <dgm:cxn modelId="9" srcId="1" destId="5" srcOrd="3" destOrd="0"/>
      </dgm:cxnLst>
      <dgm:bg/>
      <dgm:whole/>
    </dgm:dataModel>
  </dgm:sampData>
  <dgm:styleData>
    <dgm:dataModel>
      <dgm:ptLst>
        <dgm:pt modelId="0" type="doc"/>
        <dgm:pt modelId="1"/>
        <dgm:pt modelId="12"/>
        <dgm:pt modelId="13"/>
      </dgm:ptLst>
      <dgm:cxnLst>
        <dgm:cxn modelId="2" srcId="0" destId="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 type="asst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clrData>
  <dgm:layoutNode name="hierChild1">
    <dgm:varLst>
      <dgm:orgChart val="1"/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des" forName="rootComposite1" refType="w" fact="10"/>
      <dgm:constr type="h" for="des" forName="rootComposite1" refType="w" refFor="des" refForName="rootComposite1" fact="0.5"/>
      <dgm:constr type="w" for="des" forName="rootComposite" refType="w" fact="10"/>
      <dgm:constr type="h" for="des" forName="rootComposite" refType="w" refFor="des" refForName="rootComposite1" fact="0.5"/>
      <dgm:constr type="w" for="des" forName="rootComposite3" refType="w" fact="10"/>
      <dgm:constr type="h" for="des" forName="rootComposite3" refType="w" refFor="des" refForName="rootComposite1" fact="0.5"/>
      <dgm:constr type="primFontSz" for="des" ptType="node" op="equ"/>
      <dgm:constr type="sp" for="des" op="equ"/>
      <dgm:constr type="sp" for="des" forName="hierRoot1" refType="w" refFor="des" refForName="rootComposite1" fact="0.21"/>
      <dgm:constr type="sp" for="des" forName="hierRoot2" refType="sp" refFor="des" refForName="hierRoot1"/>
      <dgm:constr type="sp" for="des" forName="hierRoot3" refType="sp" refFor="des" refForName="hierRoot1"/>
      <dgm:constr type="sibSp" refType="w" refFor="des" refForName="rootComposite1" fact="0.2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ibSp" for="des" forName="hierChild7" refType="sibSp"/>
      <dgm:constr type="secSibSp" refType="w" refFor="des" refForName="rootComposite1" fact="0.21"/>
      <dgm:constr type="secSibSp" for="des" forName="hierChild2" refType="secSibSp"/>
      <dgm:constr type="secSibSp" for="des" forName="hierChild3" refType="secSibSp"/>
      <dgm:constr type="secSibSp" for="des" forName="hierChild4" refType="secSibSp"/>
      <dgm:constr type="secSibSp" for="des" forName="hierChild5" refType="secSibSp"/>
      <dgm:constr type="secSibSp" for="des" forName="hierChild6" refType="secSibSp"/>
      <dgm:constr type="secSibSp" for="des" forName="hierChild7" refType="secSibSp"/>
    </dgm:constrLst>
    <dgm:ruleLst/>
    <dgm:forEach name="Name3" axis="ch">
      <dgm:forEach name="Name4" axis="self" ptType="node">
        <dgm:layoutNode name="hierRoot1">
          <dgm:varLst>
            <dgm:hierBranch val="init"/>
          </dgm:varLst>
          <dgm:choose name="Name5">
            <dgm:if name="Name6" func="var" arg="hierBranch" op="equ" val="l">
              <dgm:choose name="Name7">
                <dgm:if name="Name8" axis="ch" ptType="asst" func="cnt" op="gte" val="1">
                  <dgm:alg type="hierRoot">
                    <dgm:param type="hierAlign" val="tR"/>
                  </dgm:alg>
                  <dgm:constrLst>
                    <dgm:constr type="alignOff" val="0.65"/>
                  </dgm:constrLst>
                </dgm:if>
                <dgm:else name="Name9">
                  <dgm:alg type="hierRoot">
                    <dgm:param type="hierAlign" val="tR"/>
                  </dgm:alg>
                  <dgm:constrLst>
                    <dgm:constr type="alignOff" val="0.25"/>
                  </dgm:constrLst>
                </dgm:else>
              </dgm:choose>
            </dgm:if>
            <dgm:if name="Name10" func="var" arg="hierBranch" op="equ" val="r">
              <dgm:choose name="Name11">
                <dgm:if name="Name12" axis="ch" ptType="asst" func="cnt" op="gte" val="1">
                  <dgm:alg type="hierRoot">
                    <dgm:param type="hierAlign" val="tL"/>
                  </dgm:alg>
                  <dgm:constrLst>
                    <dgm:constr type="alignOff" val="0.65"/>
                  </dgm:constrLst>
                </dgm:if>
                <dgm:else name="Name13">
                  <dgm:alg type="hierRoot">
                    <dgm:param type="hierAlign" val="tL"/>
                  </dgm:alg>
                  <dgm:constrLst>
                    <dgm:constr type="alignOff" val="0.25"/>
                  </dgm:constrLst>
                </dgm:else>
              </dgm:choose>
            </dgm:if>
            <dgm:if name="Name14" func="var" arg="hierBranch" op="equ" val="hang">
              <dgm:alg type="hierRoot"/>
              <dgm:constrLst>
                <dgm:constr type="alignOff" val="0.65"/>
              </dgm:constrLst>
            </dgm:if>
            <dgm:else name="Name15">
              <dgm:alg type="hierRoot"/>
              <dgm:constrLst>
                <dgm:constr type="alignOff"/>
                <dgm:constr type="bendDist" for="des" ptType="parTrans" refType="sp" fact="0.5"/>
              </dgm:constrLst>
            </dgm:else>
          </dgm:choose>
          <dgm:shape xmlns:r="http://schemas.openxmlformats.org/officeDocument/2006/relationships" r:blip="">
            <dgm:adjLst/>
          </dgm:shape>
          <dgm:presOf/>
          <dgm:ruleLst/>
          <dgm:layoutNode name="rootComposite1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16">
              <dgm:if name="Name17" func="var" arg="hierBranch" op="equ" val="init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8" func="var" arg="hierBranch" op="equ" val="l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9" func="var" arg="hierBranch" op="equ" val="r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else name="Name20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else>
            </dgm:choose>
            <dgm:ruleLst/>
            <dgm:layoutNode name="rootText1" styleLbl="node0">
              <dgm:varLst>
                <dgm:chPref val="3"/>
              </dgm:varLst>
              <dgm:alg type="tx"/>
              <dgm:shape xmlns:r="http://schemas.openxmlformats.org/officeDocument/2006/relationships" type="rect" r:blip="">
                <dgm:adjLst/>
              </dgm:shape>
              <dgm:presOf axis="self" ptType="node" cnt="1"/>
              <dgm:constrLst>
                <dgm:constr type="primFontSz" val="65"/>
                <dgm:constr type="lMarg" refType="primFontSz" fact="0.05"/>
                <dgm:constr type="rMarg" refType="primFontSz" fact="0.05"/>
                <dgm:constr type="tMarg" refType="primFontSz" fact="0.05"/>
                <dgm:constr type="bMarg" refType="primFontSz" fact="0.05"/>
              </dgm:constrLst>
              <dgm:ruleLst>
                <dgm:rule type="primFontSz" val="5" fact="NaN" max="NaN"/>
              </dgm:ruleLst>
            </dgm:layoutNode>
            <dgm:layoutNode name="rootConnector1" moveWith="rootText1">
              <dgm:alg type="sp"/>
              <dgm:shape xmlns:r="http://schemas.openxmlformats.org/officeDocument/2006/relationships" type="rect" r:blip="" hideGeom="1">
                <dgm:adjLst/>
              </dgm:shape>
              <dgm:presOf axis="self" ptType="node" cnt="1"/>
              <dgm:constrLst/>
              <dgm:ruleLst/>
            </dgm:layoutNode>
          </dgm:layoutNode>
          <dgm:layoutNode name="hierChild2">
            <dgm:choose name="Name21">
              <dgm:if name="Name22" func="var" arg="hierBranch" op="equ" val="l">
                <dgm:alg type="hierChild">
                  <dgm:param type="chAlign" val="r"/>
                  <dgm:param type="linDir" val="fromT"/>
                </dgm:alg>
              </dgm:if>
              <dgm:if name="Name23" func="var" arg="hierBranch" op="equ" val="r">
                <dgm:alg type="hierChild">
                  <dgm:param type="chAlign" val="l"/>
                  <dgm:param type="linDir" val="fromT"/>
                </dgm:alg>
              </dgm:if>
              <dgm:if name="Name24" func="var" arg="hierBranch" op="equ" val="hang">
                <dgm:choose name="Name25">
                  <dgm:if name="Name26" func="var" arg="dir" op="equ" val="norm">
                    <dgm:alg type="hierChild">
                      <dgm:param type="chAlign" val="l"/>
                      <dgm:param type="linDir" val="fromL"/>
                      <dgm:param type="secChAlign" val="t"/>
                      <dgm:param type="secLinDir" val="fromT"/>
                    </dgm:alg>
                  </dgm:if>
                  <dgm:else name="Name27">
                    <dgm:alg type="hierChild">
                      <dgm:param type="chAlign" val="l"/>
                      <dgm:param type="linDir" val="fromR"/>
                      <dgm:param type="secChAlign" val="t"/>
                      <dgm:param type="secLinDir" val="fromT"/>
                    </dgm:alg>
                  </dgm:else>
                </dgm:choose>
              </dgm:if>
              <dgm:else name="Name28">
                <dgm:choose name="Name29">
                  <dgm:if name="Name30" func="var" arg="dir" op="equ" val="norm">
                    <dgm:alg type="hierChild"/>
                  </dgm:if>
                  <dgm:else name="Name31">
                    <dgm:alg type="hierChild">
                      <dgm:param type="linDir" val="fromR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a" axis="ch" ptType="nonAsst">
              <dgm:forEach name="Name32" axis="precedSib" ptType="parTrans" st="-1" cnt="1">
                <dgm:choose name="Name33">
                  <dgm:if name="Name34" func="var" arg="hierBranch" op="equ" val="std">
                    <dgm:layoutNode name="Name35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tCtr"/>
                        <dgm:param type="bendPt" val="end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36" func="var" arg="hierBranch" op="equ" val="init">
                    <dgm:layoutNode name="Name37">
                      <dgm:choose name="Name38">
                        <dgm:if name="Name39" axis="self" func="depth" op="lte" val="2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</dgm:alg>
                        </dgm:if>
                        <dgm:else name="Name40">
                          <dgm:choose name="Name41">
                            <dgm:if name="Name42" axis="par des" func="maxDepth" op="lte" val="1">
                              <dgm:choose name="Name43">
                                <dgm:if name="Name44" axis="par ch" ptType="node asst" func="cnt" op="gte" val="1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</dgm:alg>
                                </dgm:if>
                                <dgm:else name="Name45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  <dgm:param type="srcNode" val="rootConnector"/>
                                  </dgm:alg>
                                </dgm:else>
                              </dgm:choose>
                            </dgm:if>
                            <dgm:else name="Name46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47" func="var" arg="hierBranch" op="equ" val="hang">
                    <dgm:layoutNode name="Name48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midL midR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else name="Name49">
                    <dgm:layoutNode name="Name50">
                      <dgm:choose name="Name51">
                        <dgm:if name="Name52" axis="self" func="depth" op="lte" val="2">
                          <dgm:choose name="Name53">
                            <dgm:if name="Name54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5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1"/>
                              </dgm:alg>
                            </dgm:else>
                          </dgm:choose>
                        </dgm:if>
                        <dgm:else name="Name56">
                          <dgm:choose name="Name57">
                            <dgm:if name="Name58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9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else>
                </dgm:choose>
              </dgm:forEach>
              <dgm:layoutNode name="hierRoot2">
                <dgm:varLst>
                  <dgm:hierBranch val="init"/>
                </dgm:varLst>
                <dgm:choose name="Name60">
                  <dgm:if name="Name61" func="var" arg="hierBranch" op="equ" val="l">
                    <dgm:choose name="Name62">
                      <dgm:if name="Name63" axis="ch" ptType="asst" func="cnt" op="gte" val="1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4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5" func="var" arg="hierBranch" op="equ" val="r">
                    <dgm:choose name="Name66">
                      <dgm:if name="Name67" axis="ch" ptType="asst" func="cnt" op="g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8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9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70" func="var" arg="hierBranch" op="equ" val="init">
                    <dgm:choose name="Name71">
                      <dgm:if name="Name72" axis="des" func="maxDepth" op="lte" val="1">
                        <dgm:choose name="Name73">
                          <dgm:if name="Name74" axis="ch" ptType="asst" func="cnt" op="gte" val="1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65"/>
                            </dgm:constrLst>
                          </dgm:if>
                          <dgm:else name="Name75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25"/>
                            </dgm:constrLst>
                          </dgm:else>
                        </dgm:choose>
                      </dgm:if>
                      <dgm:else name="Name76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77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else>
                </dgm:choose>
                <dgm:ruleLst/>
                <dgm:layoutNode name="rootComposite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78">
                    <dgm:if name="Name79" func="var" arg="hierBranch" op="equ" val="init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0" func="var" arg="hierBranch" op="equ" val="l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1" func="var" arg="hierBranch" op="equ" val="r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else name="Name82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else>
                  </dgm:choose>
                  <dgm:ruleLst/>
                  <dgm:layoutNode name="rootText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" moveWith="rootText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4">
                  <dgm:choose name="Name83">
                    <dgm:if name="Name84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85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86" func="var" arg="hierBranch" op="equ" val="hang">
                      <dgm:choose name="Name87">
                        <dgm:if name="Name88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89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90" func="var" arg="hierBranch" op="equ" val="std">
                      <dgm:choose name="Name91">
                        <dgm:if name="Name92" func="var" arg="dir" op="equ" val="norm">
                          <dgm:alg type="hierChild"/>
                        </dgm:if>
                        <dgm:else name="Name93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94" func="var" arg="hierBranch" op="equ" val="init">
                      <dgm:choose name="Name95">
                        <dgm:if name="Name96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97">
                          <dgm:choose name="Name98">
                            <dgm:if name="Name99" func="var" arg="dir" op="equ" val="norm">
                              <dgm:alg type="hierChild"/>
                            </dgm:if>
                            <dgm:else name="Name100">
                              <dgm:alg type="hierChild">
                                <dgm:param type="linDir" val="fromR"/>
                              </dgm:alg>
                            </dgm:else>
                          </dgm:choose>
                        </dgm:else>
                      </dgm:choose>
                    </dgm:if>
                    <dgm:else name="Name101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2" ref="rep2a"/>
                </dgm:layoutNode>
                <dgm:layoutNode name="hierChild5">
                  <dgm:choose name="Name103">
                    <dgm:if name="Name104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05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6" ref="rep2b"/>
                </dgm:layoutNode>
              </dgm:layoutNode>
            </dgm:forEach>
          </dgm:layoutNode>
          <dgm:layoutNode name="hierChild3">
            <dgm:choose name="Name107">
              <dgm:if name="Name108" func="var" arg="dir" op="equ" val="norm">
                <dgm:alg type="hierChild">
                  <dgm:param type="chAlign" val="l"/>
                  <dgm:param type="linDir" val="fromL"/>
                  <dgm:param type="secChAlign" val="t"/>
                  <dgm:param type="secLinDir" val="fromT"/>
                </dgm:alg>
              </dgm:if>
              <dgm:else name="Name109">
                <dgm:alg type="hierChild">
                  <dgm:param type="chAlign" val="l"/>
                  <dgm:param type="linDir" val="fromR"/>
                  <dgm:param type="secChAlign" val="t"/>
                  <dgm:param type="secLinDir" val="fromT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b" axis="ch" ptType="asst">
              <dgm:forEach name="Name110" axis="precedSib" ptType="parTrans" st="-1" cnt="1">
                <dgm:layoutNode name="Name111">
                  <dgm:alg type="conn">
                    <dgm:param type="connRout" val="bend"/>
                    <dgm:param type="dim" val="1D"/>
                    <dgm:param type="endSty" val="noArr"/>
                    <dgm:param type="begPts" val="bCtr"/>
                    <dgm:param type="endPts" val="midL midR"/>
                  </dgm:alg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layoutNode name="hierRoot3">
                <dgm:varLst>
                  <dgm:hierBranch val="init"/>
                </dgm:varLst>
                <dgm:choose name="Name112">
                  <dgm:if name="Name113" func="var" arg="hierBranch" op="equ" val="l">
                    <dgm:alg type="hierRoot">
                      <dgm:param type="hierAlign" val="tR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4" func="var" arg="hierBranch" op="equ" val="r">
                    <dgm:alg type="hierRoot">
                      <dgm:param type="hierAlign" val="tL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5" func="var" arg="hierBranch" op="equ" val="hang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6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117" func="var" arg="hierBranch" op="equ" val="init">
                    <dgm:choose name="Name118">
                      <dgm:if name="Name119" axis="des" func="maxDepth" op="l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120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121"/>
                </dgm:choose>
                <dgm:ruleLst/>
                <dgm:layoutNode name="rootComposite3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122">
                    <dgm:if name="Name123" func="var" arg="hierBranch" op="equ" val="init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4" func="var" arg="hierBranch" op="equ" val="l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5" func="var" arg="hierBranch" op="equ" val="r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else name="Name126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else>
                  </dgm:choose>
                  <dgm:ruleLst/>
                  <dgm:layoutNode name="rootText3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3" moveWith="rootText1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6">
                  <dgm:choose name="Name127">
                    <dgm:if name="Name128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129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130" func="var" arg="hierBranch" op="equ" val="hang">
                      <dgm:choose name="Name131">
                        <dgm:if name="Name132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133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134" func="var" arg="hierBranch" op="equ" val="std">
                      <dgm:choose name="Name135">
                        <dgm:if name="Name136" func="var" arg="dir" op="equ" val="norm">
                          <dgm:alg type="hierChild"/>
                        </dgm:if>
                        <dgm:else name="Name137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138" func="var" arg="hierBranch" op="equ" val="init">
                      <dgm:choose name="Name139">
                        <dgm:if name="Name140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141">
                          <dgm:alg type="hierChild"/>
                        </dgm:else>
                      </dgm:choose>
                    </dgm:if>
                    <dgm:else name="Name142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3" ref="rep2a"/>
                </dgm:layoutNode>
                <dgm:layoutNode name="hierChild7">
                  <dgm:choose name="Name144">
                    <dgm:if name="Name145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46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7" ref="rep2b"/>
                </dgm:layoutNode>
              </dgm:layoutNode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en-GB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035204-C7AB-427A-933C-F3F02440874A}" type="datetimeFigureOut">
              <a:rPr kumimoji="1" lang="en-GB" smtClean="0"/>
              <a:t>18/08/2021</a:t>
            </a:fld>
            <a:endParaRPr kumimoji="1" lang="en-GB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en-GB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en-GB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CB86EC-7987-49AF-BB1F-498B7039799E}" type="slidenum">
              <a:rPr kumimoji="1" lang="en-GB" smtClean="0"/>
              <a:t>‹#›</a:t>
            </a:fld>
            <a:endParaRPr kumimoji="1" lang="en-GB" dirty="0"/>
          </a:p>
        </p:txBody>
      </p:sp>
    </p:spTree>
    <p:extLst>
      <p:ext uri="{BB962C8B-B14F-4D97-AF65-F5344CB8AC3E}">
        <p14:creationId xmlns:p14="http://schemas.microsoft.com/office/powerpoint/2010/main" val="18277917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GB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CB86EC-7987-49AF-BB1F-498B7039799E}" type="slidenum">
              <a:rPr kumimoji="1" lang="en-GB" smtClean="0"/>
              <a:t>1</a:t>
            </a:fld>
            <a:endParaRPr kumimoji="1" lang="en-GB" dirty="0"/>
          </a:p>
        </p:txBody>
      </p:sp>
    </p:spTree>
    <p:extLst>
      <p:ext uri="{BB962C8B-B14F-4D97-AF65-F5344CB8AC3E}">
        <p14:creationId xmlns:p14="http://schemas.microsoft.com/office/powerpoint/2010/main" val="10502147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GB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CB86EC-7987-49AF-BB1F-498B7039799E}" type="slidenum">
              <a:rPr kumimoji="1" lang="en-GB" smtClean="0"/>
              <a:t>2</a:t>
            </a:fld>
            <a:endParaRPr kumimoji="1" lang="en-GB" dirty="0"/>
          </a:p>
        </p:txBody>
      </p:sp>
    </p:spTree>
    <p:extLst>
      <p:ext uri="{BB962C8B-B14F-4D97-AF65-F5344CB8AC3E}">
        <p14:creationId xmlns:p14="http://schemas.microsoft.com/office/powerpoint/2010/main" val="42054958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GB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CB86EC-7987-49AF-BB1F-498B7039799E}" type="slidenum">
              <a:rPr kumimoji="1" lang="en-GB" smtClean="0"/>
              <a:t>3</a:t>
            </a:fld>
            <a:endParaRPr kumimoji="1" lang="en-GB" dirty="0"/>
          </a:p>
        </p:txBody>
      </p:sp>
    </p:spTree>
    <p:extLst>
      <p:ext uri="{BB962C8B-B14F-4D97-AF65-F5344CB8AC3E}">
        <p14:creationId xmlns:p14="http://schemas.microsoft.com/office/powerpoint/2010/main" val="193990058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CB86EC-7987-49AF-BB1F-498B7039799E}" type="slidenum">
              <a:rPr kumimoji="1" lang="en-GB" smtClean="0"/>
              <a:t>4</a:t>
            </a:fld>
            <a:endParaRPr kumimoji="1" lang="en-GB" dirty="0"/>
          </a:p>
        </p:txBody>
      </p:sp>
    </p:spTree>
    <p:extLst>
      <p:ext uri="{BB962C8B-B14F-4D97-AF65-F5344CB8AC3E}">
        <p14:creationId xmlns:p14="http://schemas.microsoft.com/office/powerpoint/2010/main" val="5126745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8DEB958-3D0F-4269-8529-0366B4ECD08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C10A527-9AFB-4602-8D3C-06B2ABEC6F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9584126-C185-4817-8F6D-BD6F77C2CB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38B17-BD87-4701-865E-7F137BD710EB}" type="datetimeFigureOut">
              <a:rPr kumimoji="1" lang="ja-JP" altLang="en-US" smtClean="0"/>
              <a:t>2021/8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5EE88A6-C120-4FC9-B60C-EB4A63D6BE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A3C8A48-FF07-4CBD-9084-4C9E4B606B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BABC-C2E6-4CA2-946E-E44A5C1DA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42354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DCBEDE-759D-4047-A642-5D2C6FC1F5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93AE447-C956-40DC-94DD-88894BD9B6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543802-33FF-49CA-B616-118BB29B4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38B17-BD87-4701-865E-7F137BD710EB}" type="datetimeFigureOut">
              <a:rPr kumimoji="1" lang="ja-JP" altLang="en-US" smtClean="0"/>
              <a:t>2021/8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D942CE3-E9A0-4A85-ABC9-C0C5975A99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B18852-17D1-4E49-9292-872618096D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BABC-C2E6-4CA2-946E-E44A5C1DA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5179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07DEE84-EC80-4FDE-9039-5A2B71D764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4C8565A-192F-4D56-AD68-5F31E6E3CA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FB66E90-EB6A-43AA-A3CF-90907C7E73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38B17-BD87-4701-865E-7F137BD710EB}" type="datetimeFigureOut">
              <a:rPr kumimoji="1" lang="ja-JP" altLang="en-US" smtClean="0"/>
              <a:t>2021/8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E0A5908-7C1A-4442-8986-996A913A93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E88DBC0-CCEF-4EAB-AE48-A04352AD1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BABC-C2E6-4CA2-946E-E44A5C1DA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095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C1C453-2DDB-4CC7-AA6B-428F161370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01B59AD-F37B-4029-8AD3-F4F6B068A06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9A3A3F5-AE94-4A6F-A2CA-3BEC24B45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38B17-BD87-4701-865E-7F137BD710EB}" type="datetimeFigureOut">
              <a:rPr kumimoji="1" lang="ja-JP" altLang="en-US" smtClean="0"/>
              <a:t>2021/8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1A1438A-BBEE-49D3-BFE7-53CB410F0C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F472767-06AE-45FE-8359-479F0CD9C2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BABC-C2E6-4CA2-946E-E44A5C1DA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5194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4810247-125A-45B2-8ABE-2C5F16A276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3B6B9CC-62DE-4C08-A463-D49F303459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3647B9B-027C-4A3F-BF2B-D5E0F5455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38B17-BD87-4701-865E-7F137BD710EB}" type="datetimeFigureOut">
              <a:rPr kumimoji="1" lang="ja-JP" altLang="en-US" smtClean="0"/>
              <a:t>2021/8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0D9317-99AD-4D63-9718-8A1D11619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BB3A134-E903-41C9-82E0-3C8CA294F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BABC-C2E6-4CA2-946E-E44A5C1DA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4265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A85DB7E-4866-4000-BD81-975F48457F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9ECC17D-EBED-4751-853E-87BCCCAD50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242A5CF-69EC-4DB2-8C6A-E631EFC513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972E04B-2942-4A45-AFC2-173E9E4519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38B17-BD87-4701-865E-7F137BD710EB}" type="datetimeFigureOut">
              <a:rPr kumimoji="1" lang="ja-JP" altLang="en-US" smtClean="0"/>
              <a:t>2021/8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222BE97-183E-451F-9A38-F71727B2D7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39F455-EBAA-40CB-A2BE-A4C4334412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BABC-C2E6-4CA2-946E-E44A5C1DA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5370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FA9636-5C4F-4A71-B1BE-9EC730C801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E697CC6-E985-4986-8B2C-4DC8A6B7E8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EF53269-B3DD-476A-9CE9-827E261096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A307EA4-C85F-4124-8C43-595216482C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C8845F1-7A68-4AA6-ADF1-3DA7CCFDFB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EAE56AF-1DD3-4618-BF1F-A7E75084A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38B17-BD87-4701-865E-7F137BD710EB}" type="datetimeFigureOut">
              <a:rPr kumimoji="1" lang="ja-JP" altLang="en-US" smtClean="0"/>
              <a:t>2021/8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DF87B4A-AEAF-4CDB-95A2-E2A63F268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045D360-0AD4-4C38-8DF8-3970092FE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BABC-C2E6-4CA2-946E-E44A5C1DA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5943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BE09AF2-26CB-4630-A976-E5257D04FC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5F4EB2E-C41A-4F07-B290-F9C877F2F0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38B17-BD87-4701-865E-7F137BD710EB}" type="datetimeFigureOut">
              <a:rPr kumimoji="1" lang="ja-JP" altLang="en-US" smtClean="0"/>
              <a:t>2021/8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A3EC1ED-5C4A-4A46-A99A-5F4A6CBD9F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59EBCDA-8020-44E1-8FBE-BF2786E5E3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BABC-C2E6-4CA2-946E-E44A5C1DA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9053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4045BDB-56CB-49BA-B81A-962ED280E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38B17-BD87-4701-865E-7F137BD710EB}" type="datetimeFigureOut">
              <a:rPr kumimoji="1" lang="ja-JP" altLang="en-US" smtClean="0"/>
              <a:t>2021/8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A86603A-7614-43DE-BEA3-D9796F25EB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C8DFBA2-A589-4D3D-B31F-493348A235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BABC-C2E6-4CA2-946E-E44A5C1DA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3161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60BF11-2701-4CB6-A861-FACFC41A0B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C0DC6F4-BDCC-4D31-8DC5-8499C772EE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ACE9660-74F9-43A6-90B7-14E3667810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7C6F1E1-A393-4CD7-9E8D-5D56EEBA70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38B17-BD87-4701-865E-7F137BD710EB}" type="datetimeFigureOut">
              <a:rPr kumimoji="1" lang="ja-JP" altLang="en-US" smtClean="0"/>
              <a:t>2021/8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09D4054-CDA3-4D5A-AF2B-E462DE4CE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3A89693-2402-48E0-875A-08DF92D49E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BABC-C2E6-4CA2-946E-E44A5C1DA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441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4D7610-F6FF-4D31-995A-BF222A8294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EC48EA4-0BCA-4BC3-8577-8112CFE4A9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9CFA0A2-E7DC-4ABE-80EF-0AA06CAB57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EDED102-6AA7-4269-BC60-BD9FC760F5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38B17-BD87-4701-865E-7F137BD710EB}" type="datetimeFigureOut">
              <a:rPr kumimoji="1" lang="ja-JP" altLang="en-US" smtClean="0"/>
              <a:t>2021/8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E7B94E8-9705-4731-B5AD-A912415132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E02B93B-50CD-4217-B246-868D859CD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7BABC-C2E6-4CA2-946E-E44A5C1DA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5513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3458A06-0B2D-4033-A646-2660B44A6E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D2982E3-49CE-43EB-B7F4-F81A26C05B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02BA159-5C21-459B-B812-1D8D592CAB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338B17-BD87-4701-865E-7F137BD710EB}" type="datetimeFigureOut">
              <a:rPr kumimoji="1" lang="ja-JP" altLang="en-US" smtClean="0"/>
              <a:t>2021/8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649ECA-4429-4D3C-82BC-1A30B76267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63ED1A1-6DAF-47F4-B539-8BB4CC9E08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67BABC-C2E6-4CA2-946E-E44A5C1DAD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7882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2.xml"/><Relationship Id="rId7" Type="http://schemas.microsoft.com/office/2007/relationships/diagramDrawing" Target="../diagrams/drawing2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2.xml"/><Relationship Id="rId5" Type="http://schemas.openxmlformats.org/officeDocument/2006/relationships/diagramQuickStyle" Target="../diagrams/quickStyle2.xml"/><Relationship Id="rId4" Type="http://schemas.openxmlformats.org/officeDocument/2006/relationships/diagramLayout" Target="../diagrams/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id="{50E1F4CE-8589-4BC3-9B12-C129F7A401C3}"/>
              </a:ext>
            </a:extLst>
          </p:cNvPr>
          <p:cNvGraphicFramePr>
            <a:graphicFrameLocks noGrp="1"/>
          </p:cNvGraphicFramePr>
          <p:nvPr/>
        </p:nvGraphicFramePr>
        <p:xfrm>
          <a:off x="481262" y="551233"/>
          <a:ext cx="11213438" cy="57990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9614">
                  <a:extLst>
                    <a:ext uri="{9D8B030D-6E8A-4147-A177-3AD203B41FA5}">
                      <a16:colId xmlns:a16="http://schemas.microsoft.com/office/drawing/2014/main" val="938857003"/>
                    </a:ext>
                  </a:extLst>
                </a:gridCol>
                <a:gridCol w="659614">
                  <a:extLst>
                    <a:ext uri="{9D8B030D-6E8A-4147-A177-3AD203B41FA5}">
                      <a16:colId xmlns:a16="http://schemas.microsoft.com/office/drawing/2014/main" val="1816013784"/>
                    </a:ext>
                  </a:extLst>
                </a:gridCol>
                <a:gridCol w="659614">
                  <a:extLst>
                    <a:ext uri="{9D8B030D-6E8A-4147-A177-3AD203B41FA5}">
                      <a16:colId xmlns:a16="http://schemas.microsoft.com/office/drawing/2014/main" val="3266330615"/>
                    </a:ext>
                  </a:extLst>
                </a:gridCol>
                <a:gridCol w="659614">
                  <a:extLst>
                    <a:ext uri="{9D8B030D-6E8A-4147-A177-3AD203B41FA5}">
                      <a16:colId xmlns:a16="http://schemas.microsoft.com/office/drawing/2014/main" val="2545821841"/>
                    </a:ext>
                  </a:extLst>
                </a:gridCol>
                <a:gridCol w="659614">
                  <a:extLst>
                    <a:ext uri="{9D8B030D-6E8A-4147-A177-3AD203B41FA5}">
                      <a16:colId xmlns:a16="http://schemas.microsoft.com/office/drawing/2014/main" val="908476546"/>
                    </a:ext>
                  </a:extLst>
                </a:gridCol>
                <a:gridCol w="659614">
                  <a:extLst>
                    <a:ext uri="{9D8B030D-6E8A-4147-A177-3AD203B41FA5}">
                      <a16:colId xmlns:a16="http://schemas.microsoft.com/office/drawing/2014/main" val="4246578571"/>
                    </a:ext>
                  </a:extLst>
                </a:gridCol>
                <a:gridCol w="659614">
                  <a:extLst>
                    <a:ext uri="{9D8B030D-6E8A-4147-A177-3AD203B41FA5}">
                      <a16:colId xmlns:a16="http://schemas.microsoft.com/office/drawing/2014/main" val="3073982384"/>
                    </a:ext>
                  </a:extLst>
                </a:gridCol>
                <a:gridCol w="659614">
                  <a:extLst>
                    <a:ext uri="{9D8B030D-6E8A-4147-A177-3AD203B41FA5}">
                      <a16:colId xmlns:a16="http://schemas.microsoft.com/office/drawing/2014/main" val="3632413380"/>
                    </a:ext>
                  </a:extLst>
                </a:gridCol>
                <a:gridCol w="659614">
                  <a:extLst>
                    <a:ext uri="{9D8B030D-6E8A-4147-A177-3AD203B41FA5}">
                      <a16:colId xmlns:a16="http://schemas.microsoft.com/office/drawing/2014/main" val="3530638022"/>
                    </a:ext>
                  </a:extLst>
                </a:gridCol>
                <a:gridCol w="659614">
                  <a:extLst>
                    <a:ext uri="{9D8B030D-6E8A-4147-A177-3AD203B41FA5}">
                      <a16:colId xmlns:a16="http://schemas.microsoft.com/office/drawing/2014/main" val="4212792797"/>
                    </a:ext>
                  </a:extLst>
                </a:gridCol>
                <a:gridCol w="659614">
                  <a:extLst>
                    <a:ext uri="{9D8B030D-6E8A-4147-A177-3AD203B41FA5}">
                      <a16:colId xmlns:a16="http://schemas.microsoft.com/office/drawing/2014/main" val="2659660382"/>
                    </a:ext>
                  </a:extLst>
                </a:gridCol>
                <a:gridCol w="659614">
                  <a:extLst>
                    <a:ext uri="{9D8B030D-6E8A-4147-A177-3AD203B41FA5}">
                      <a16:colId xmlns:a16="http://schemas.microsoft.com/office/drawing/2014/main" val="3332737881"/>
                    </a:ext>
                  </a:extLst>
                </a:gridCol>
                <a:gridCol w="659614">
                  <a:extLst>
                    <a:ext uri="{9D8B030D-6E8A-4147-A177-3AD203B41FA5}">
                      <a16:colId xmlns:a16="http://schemas.microsoft.com/office/drawing/2014/main" val="198496426"/>
                    </a:ext>
                  </a:extLst>
                </a:gridCol>
                <a:gridCol w="659614">
                  <a:extLst>
                    <a:ext uri="{9D8B030D-6E8A-4147-A177-3AD203B41FA5}">
                      <a16:colId xmlns:a16="http://schemas.microsoft.com/office/drawing/2014/main" val="2439820907"/>
                    </a:ext>
                  </a:extLst>
                </a:gridCol>
                <a:gridCol w="659614">
                  <a:extLst>
                    <a:ext uri="{9D8B030D-6E8A-4147-A177-3AD203B41FA5}">
                      <a16:colId xmlns:a16="http://schemas.microsoft.com/office/drawing/2014/main" val="3484970889"/>
                    </a:ext>
                  </a:extLst>
                </a:gridCol>
                <a:gridCol w="659614">
                  <a:extLst>
                    <a:ext uri="{9D8B030D-6E8A-4147-A177-3AD203B41FA5}">
                      <a16:colId xmlns:a16="http://schemas.microsoft.com/office/drawing/2014/main" val="1904593902"/>
                    </a:ext>
                  </a:extLst>
                </a:gridCol>
                <a:gridCol w="659614">
                  <a:extLst>
                    <a:ext uri="{9D8B030D-6E8A-4147-A177-3AD203B41FA5}">
                      <a16:colId xmlns:a16="http://schemas.microsoft.com/office/drawing/2014/main" val="341259769"/>
                    </a:ext>
                  </a:extLst>
                </a:gridCol>
              </a:tblGrid>
              <a:tr h="315213"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atient Number</a:t>
                      </a:r>
                      <a:endParaRPr kumimoji="1" lang="ja-JP" altLang="en-US" sz="105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8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rontal lobe lesions</a:t>
                      </a:r>
                      <a:endParaRPr kumimoji="1" lang="ja-JP" altLang="en-US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gridSpan="2">
                  <a:txBody>
                    <a:bodyPr/>
                    <a:lstStyle/>
                    <a:p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ietal lesions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gridSpan="2">
                  <a:txBody>
                    <a:bodyPr/>
                    <a:lstStyle/>
                    <a:p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mporal lesions 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gridSpan="2">
                  <a:txBody>
                    <a:bodyPr/>
                    <a:lstStyle/>
                    <a:p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cipital lesions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gridSpan="2">
                  <a:txBody>
                    <a:bodyPr/>
                    <a:lstStyle/>
                    <a:p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rebellar lesions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8016873"/>
                  </a:ext>
                </a:extLst>
              </a:tr>
              <a:tr h="440435">
                <a:tc vMerge="1"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frontal area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ementary motor area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motor area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 motor area</a:t>
                      </a:r>
                      <a:endParaRPr kumimoji="1" lang="ja-JP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 vMerge="1">
                  <a:txBody>
                    <a:bodyPr/>
                    <a:lstStyle/>
                    <a:p>
                      <a:endParaRPr kumimoji="1" lang="ja-JP" altLang="en-US" sz="14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 vMerge="1">
                  <a:txBody>
                    <a:bodyPr/>
                    <a:lstStyle/>
                    <a:p>
                      <a:endParaRPr kumimoji="1" lang="ja-JP" altLang="en-US" sz="14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 vMerge="1">
                  <a:txBody>
                    <a:bodyPr/>
                    <a:lstStyle/>
                    <a:p>
                      <a:endParaRPr kumimoji="1" lang="ja-JP" altLang="en-US" sz="14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 vMerge="1">
                  <a:txBody>
                    <a:bodyPr/>
                    <a:lstStyle/>
                    <a:p>
                      <a:endParaRPr kumimoji="1" lang="ja-JP" altLang="en-US" sz="14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974574"/>
                  </a:ext>
                </a:extLst>
              </a:tr>
              <a:tr h="315213">
                <a:tc vMerge="1">
                  <a:txBody>
                    <a:bodyPr/>
                    <a:lstStyle/>
                    <a:p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3258271"/>
                  </a:ext>
                </a:extLst>
              </a:tr>
              <a:tr h="31521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a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4560166"/>
                  </a:ext>
                </a:extLst>
              </a:tr>
              <a:tr h="31521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7361848"/>
                  </a:ext>
                </a:extLst>
              </a:tr>
              <a:tr h="31521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1561503"/>
                  </a:ext>
                </a:extLst>
              </a:tr>
              <a:tr h="31521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723700"/>
                  </a:ext>
                </a:extLst>
              </a:tr>
              <a:tr h="31521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1895424"/>
                  </a:ext>
                </a:extLst>
              </a:tr>
              <a:tr h="31521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6621982"/>
                  </a:ext>
                </a:extLst>
              </a:tr>
              <a:tr h="31521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1310627"/>
                  </a:ext>
                </a:extLst>
              </a:tr>
              <a:tr h="31521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5008534"/>
                  </a:ext>
                </a:extLst>
              </a:tr>
              <a:tr h="31521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5627980"/>
                  </a:ext>
                </a:extLst>
              </a:tr>
              <a:tr h="31521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7451079"/>
                  </a:ext>
                </a:extLst>
              </a:tr>
              <a:tr h="31521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377799"/>
                  </a:ext>
                </a:extLst>
              </a:tr>
              <a:tr h="31521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6872569"/>
                  </a:ext>
                </a:extLst>
              </a:tr>
              <a:tr h="31521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3184306"/>
                  </a:ext>
                </a:extLst>
              </a:tr>
              <a:tr h="31521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089448"/>
                  </a:ext>
                </a:extLst>
              </a:tr>
              <a:tr h="31521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kumimoji="1" lang="ja-JP" alt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9293716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11E08CE-EEBA-4076-B439-1737EE3E2393}"/>
              </a:ext>
            </a:extLst>
          </p:cNvPr>
          <p:cNvSpPr txBox="1"/>
          <p:nvPr/>
        </p:nvSpPr>
        <p:spPr>
          <a:xfrm>
            <a:off x="525522" y="154879"/>
            <a:ext cx="99178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Table S1: D</a:t>
            </a:r>
            <a:r>
              <a:rPr lang="en-GB" altLang="ja-JP" sz="18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stribution of brain lesions on the magnetic resonance images</a:t>
            </a:r>
            <a:endParaRPr kumimoji="1"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31581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コンテンツ プレースホルダー 3">
            <a:extLst>
              <a:ext uri="{FF2B5EF4-FFF2-40B4-BE49-F238E27FC236}">
                <a16:creationId xmlns:a16="http://schemas.microsoft.com/office/drawing/2014/main" id="{FEEB2A97-E768-4438-A032-074BACD4554B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936703241"/>
              </p:ext>
            </p:extLst>
          </p:nvPr>
        </p:nvGraphicFramePr>
        <p:xfrm>
          <a:off x="226424" y="252549"/>
          <a:ext cx="11869324" cy="647463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1F90A8E-26CF-4D15-99E9-C9401C954F42}"/>
              </a:ext>
            </a:extLst>
          </p:cNvPr>
          <p:cNvSpPr txBox="1"/>
          <p:nvPr/>
        </p:nvSpPr>
        <p:spPr>
          <a:xfrm>
            <a:off x="525522" y="130815"/>
            <a:ext cx="89192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: Instabilitiy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he first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eizure in a sitting position</a:t>
            </a:r>
            <a:endParaRPr kumimoji="1"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CD96709-40E4-4B79-8459-8E8DCDA7839C}"/>
              </a:ext>
            </a:extLst>
          </p:cNvPr>
          <p:cNvSpPr txBox="1"/>
          <p:nvPr/>
        </p:nvSpPr>
        <p:spPr>
          <a:xfrm>
            <a:off x="3732130" y="4923029"/>
            <a:ext cx="3092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2000" b="1" dirty="0">
                <a:latin typeface="Arial" panose="020B0604020202020204" pitchFamily="34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57F7A7B-5105-4A14-B53A-DF10FAC8D427}"/>
              </a:ext>
            </a:extLst>
          </p:cNvPr>
          <p:cNvSpPr txBox="1"/>
          <p:nvPr/>
        </p:nvSpPr>
        <p:spPr>
          <a:xfrm>
            <a:off x="7459573" y="5914204"/>
            <a:ext cx="459779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2000" b="1" dirty="0">
                <a:latin typeface="Arial" panose="020B0604020202020204" pitchFamily="34" charset="0"/>
                <a:cs typeface="Times New Roman" panose="02020603050405020304" pitchFamily="18" charset="0"/>
              </a:rPr>
              <a:t>*</a:t>
            </a:r>
            <a:r>
              <a:rPr lang="ja-JP" altLang="en-US" sz="2000" b="1" dirty="0">
                <a:latin typeface="Arial" panose="020B0604020202020204" pitchFamily="34" charset="0"/>
                <a:cs typeface="Times New Roman" panose="02020603050405020304" pitchFamily="18" charset="0"/>
              </a:rPr>
              <a:t> </a:t>
            </a:r>
            <a:r>
              <a:rPr lang="en-GB" altLang="ja-JP" sz="1200" b="1" dirty="0">
                <a:latin typeface="Arial" panose="020B0604020202020204" pitchFamily="34" charset="0"/>
                <a:cs typeface="Times New Roman" panose="02020603050405020304" pitchFamily="18" charset="0"/>
              </a:rPr>
              <a:t>Titubation was not determined as the patient was transferred to our hospital after the second phase</a:t>
            </a:r>
            <a:endParaRPr lang="en-GB" altLang="ja-JP" sz="2000" b="1" dirty="0">
              <a:latin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EEAFD69-2BAC-4327-AD82-C95E7B80143E}"/>
              </a:ext>
            </a:extLst>
          </p:cNvPr>
          <p:cNvSpPr txBox="1"/>
          <p:nvPr/>
        </p:nvSpPr>
        <p:spPr>
          <a:xfrm>
            <a:off x="6749892" y="4914318"/>
            <a:ext cx="3092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2000" b="1" dirty="0">
                <a:latin typeface="Arial" panose="020B0604020202020204" pitchFamily="34" charset="0"/>
                <a:cs typeface="Times New Roman" panose="02020603050405020304" pitchFamily="18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5394455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コンテンツ プレースホルダー 3">
            <a:extLst>
              <a:ext uri="{FF2B5EF4-FFF2-40B4-BE49-F238E27FC236}">
                <a16:creationId xmlns:a16="http://schemas.microsoft.com/office/drawing/2014/main" id="{FEEB2A97-E768-4438-A032-074BACD4554B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624359097"/>
              </p:ext>
            </p:extLst>
          </p:nvPr>
        </p:nvGraphicFramePr>
        <p:xfrm>
          <a:off x="156750" y="17409"/>
          <a:ext cx="11869784" cy="694944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7D01495-BE9E-4C2F-9BA0-617A77A14A9A}"/>
              </a:ext>
            </a:extLst>
          </p:cNvPr>
          <p:cNvSpPr txBox="1"/>
          <p:nvPr/>
        </p:nvSpPr>
        <p:spPr>
          <a:xfrm>
            <a:off x="347261" y="130505"/>
            <a:ext cx="97472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: Instabilitiy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econd phas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in a sitting position</a:t>
            </a:r>
            <a:endParaRPr kumimoji="1"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06429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写真, 時計, ブラック, ホワイト が含まれている画像&#10;&#10;自動的に生成された説明">
            <a:extLst>
              <a:ext uri="{FF2B5EF4-FFF2-40B4-BE49-F238E27FC236}">
                <a16:creationId xmlns:a16="http://schemas.microsoft.com/office/drawing/2014/main" id="{3BB25FFF-B6F3-4F6E-9ECB-044D3A0BFC2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4917" y="1053835"/>
            <a:ext cx="5679828" cy="5456293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AF893E3-D174-48CB-89B0-DBDA8536331E}"/>
              </a:ext>
            </a:extLst>
          </p:cNvPr>
          <p:cNvSpPr txBox="1"/>
          <p:nvPr/>
        </p:nvSpPr>
        <p:spPr>
          <a:xfrm>
            <a:off x="347260" y="130505"/>
            <a:ext cx="114845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  <a:r>
              <a:rPr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Diffusion-weighted images of patient No. 2</a:t>
            </a:r>
            <a:endParaRPr lang="en-US" altLang="ja-JP" strike="sngStrike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usion-weighted image acquired 8 days after the first seizure revealed lesions in the bilateral globus pallidus</a:t>
            </a:r>
            <a:endParaRPr kumimoji="1" lang="en-GB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0710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961</TotalTime>
  <Words>823</Words>
  <Application>Microsoft Office PowerPoint</Application>
  <PresentationFormat>ワイド画面</PresentationFormat>
  <Paragraphs>413</Paragraphs>
  <Slides>4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wano Go</dc:creator>
  <cp:lastModifiedBy>Kawano Go</cp:lastModifiedBy>
  <cp:revision>82</cp:revision>
  <cp:lastPrinted>2021-06-11T10:38:40Z</cp:lastPrinted>
  <dcterms:created xsi:type="dcterms:W3CDTF">2020-05-05T21:47:28Z</dcterms:created>
  <dcterms:modified xsi:type="dcterms:W3CDTF">2021-08-17T16:02:38Z</dcterms:modified>
</cp:coreProperties>
</file>